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3.png" ContentType="image/png"/>
  <Override PartName="/ppt/media/image52.png" ContentType="image/png"/>
  <Override PartName="/ppt/media/image51.png" ContentType="image/png"/>
  <Override PartName="/ppt/media/image4.jpeg" ContentType="image/jpeg"/>
  <Override PartName="/ppt/media/image50.png" ContentType="image/png"/>
  <Override PartName="/ppt/media/image46.png" ContentType="image/png"/>
  <Override PartName="/ppt/media/image45.png" ContentType="image/png"/>
  <Override PartName="/ppt/media/image115.jpeg" ContentType="image/jpeg"/>
  <Override PartName="/ppt/media/image44.png" ContentType="image/png"/>
  <Override PartName="/ppt/media/image75.jpeg" ContentType="image/jpeg"/>
  <Override PartName="/ppt/media/image43.png" ContentType="image/png"/>
  <Override PartName="/ppt/media/image42.png" ContentType="image/png"/>
  <Override PartName="/ppt/media/image41.png" ContentType="image/png"/>
  <Override PartName="/ppt/media/image37.png" ContentType="image/png"/>
  <Override PartName="/ppt/media/image36.png" ContentType="image/png"/>
  <Override PartName="/ppt/media/image34.png" ContentType="image/png"/>
  <Override PartName="/ppt/media/image30.png" ContentType="image/png"/>
  <Override PartName="/ppt/media/image49.png" ContentType="image/png"/>
  <Override PartName="/ppt/media/image100.png" ContentType="image/png"/>
  <Override PartName="/ppt/media/image12.png" ContentType="image/png"/>
  <Override PartName="/ppt/media/image109.png" ContentType="image/png"/>
  <Override PartName="/ppt/media/image39.png" ContentType="image/png"/>
  <Override PartName="/ppt/media/image61.wmf" ContentType="image/x-wmf"/>
  <Override PartName="/ppt/media/image9.png" ContentType="image/png"/>
  <Override PartName="/ppt/media/image56.png" ContentType="image/png"/>
  <Override PartName="/ppt/media/image17.wmf" ContentType="image/x-wmf"/>
  <Override PartName="/ppt/media/image86.jpeg" ContentType="image/jpeg"/>
  <Override PartName="/ppt/media/image111.png" ContentType="image/png"/>
  <Override PartName="/ppt/media/image48.png" ContentType="image/png"/>
  <Override PartName="/ppt/media/image11.png" ContentType="image/png"/>
  <Override PartName="/ppt/media/image108.png" ContentType="image/png"/>
  <Override PartName="/ppt/media/image13.png" ContentType="image/png"/>
  <Override PartName="/ppt/media/image1.png" ContentType="image/png"/>
  <Override PartName="/ppt/media/image38.png" ContentType="image/png"/>
  <Override PartName="/ppt/media/image8.png" ContentType="image/png"/>
  <Override PartName="/ppt/media/image85.png" ContentType="image/png"/>
  <Override PartName="/ppt/media/image55.png" ContentType="image/png"/>
  <Override PartName="/ppt/media/image116.jpeg" ContentType="image/jpeg"/>
  <Override PartName="/ppt/media/image16.wmf" ContentType="image/x-wmf"/>
  <Override PartName="/ppt/media/image59.png" ContentType="image/png"/>
  <Override PartName="/ppt/media/image110.png" ContentType="image/png"/>
  <Override PartName="/ppt/media/image6.jpeg" ContentType="image/jpeg"/>
  <Override PartName="/ppt/media/image71.png" ContentType="image/png"/>
  <Override PartName="/ppt/media/image47.png" ContentType="image/png"/>
  <Override PartName="/ppt/media/image10.png" ContentType="image/png"/>
  <Override PartName="/ppt/media/image107.png" ContentType="image/png"/>
  <Override PartName="/ppt/media/image35.png" ContentType="image/png"/>
  <Override PartName="/ppt/media/image114.jpeg" ContentType="image/jpeg"/>
  <Override PartName="/ppt/media/image5.png" ContentType="image/png"/>
  <Override PartName="/ppt/media/image82.png" ContentType="image/png"/>
  <Override PartName="/ppt/media/image7.jpeg" ContentType="image/jpeg"/>
  <Override PartName="/ppt/media/image81.png" ContentType="image/png"/>
  <Override PartName="/ppt/media/image28.png" ContentType="image/png"/>
  <Override PartName="/ppt/media/image93.png" ContentType="image/png"/>
  <Override PartName="/ppt/media/image40.png" ContentType="image/png"/>
  <Override PartName="/ppt/media/image32.png" ContentType="image/png"/>
  <Override PartName="/ppt/media/image2.png" ContentType="image/png"/>
  <Override PartName="/ppt/media/image14.png" ContentType="image/png"/>
  <Override PartName="/ppt/media/image25.png" ContentType="image/png"/>
  <Override PartName="/ppt/media/image33.png" ContentType="image/png"/>
  <Override PartName="/ppt/media/image3.png" ContentType="image/png"/>
  <Override PartName="/ppt/media/image80.png" ContentType="image/png"/>
  <Override PartName="/ppt/media/image92.jpeg" ContentType="image/jpeg"/>
  <Override PartName="/ppt/media/image68.png" ContentType="image/png"/>
  <Override PartName="/ppt/media/image31.png" ContentType="image/png"/>
  <Override PartName="/ppt/media/image70.jpeg" ContentType="image/jpeg"/>
  <Override PartName="/ppt/media/image72.png" ContentType="image/png"/>
  <Override PartName="/ppt/media/image74.png" ContentType="image/png"/>
  <Override PartName="/ppt/media/image77.png" ContentType="image/png"/>
  <Override PartName="/ppt/media/image78.png" ContentType="image/png"/>
  <Override PartName="/ppt/media/image73.png" ContentType="image/png"/>
  <Override PartName="/ppt/media/image121.png" ContentType="image/png"/>
  <Override PartName="/ppt/media/image87.jpeg" ContentType="image/jpeg"/>
  <Override PartName="/ppt/media/image83.png" ContentType="image/png"/>
  <Override PartName="/ppt/media/image88.png" ContentType="image/png"/>
  <Override PartName="/ppt/media/image67.png" ContentType="image/png"/>
  <Override PartName="/ppt/media/image91.jpeg" ContentType="image/jpeg"/>
  <Override PartName="/ppt/media/image122.png" ContentType="image/png"/>
  <Override PartName="/ppt/media/image96.png" ContentType="image/png"/>
  <Override PartName="/ppt/media/image103.png" ContentType="image/png"/>
  <Override PartName="/ppt/media/image113.png" ContentType="image/png"/>
  <Override PartName="/ppt/media/image27.png" ContentType="image/png"/>
  <Override PartName="/ppt/media/image79.png" ContentType="image/png"/>
  <Override PartName="/ppt/media/image101.png" ContentType="image/png"/>
  <Override PartName="/ppt/media/image99.png" ContentType="image/png"/>
  <Override PartName="/ppt/media/image106.png" ContentType="image/png"/>
  <Override PartName="/ppt/media/image62.png" ContentType="image/png"/>
  <Override PartName="/ppt/media/image105.png" ContentType="image/png"/>
  <Override PartName="/ppt/media/image98.png" ContentType="image/png"/>
  <Override PartName="/ppt/media/image104.png" ContentType="image/png"/>
  <Override PartName="/ppt/media/image97.png" ContentType="image/png"/>
  <Override PartName="/ppt/media/image90.jpeg" ContentType="image/jpeg"/>
  <Override PartName="/ppt/media/image60.png" ContentType="image/png"/>
  <Override PartName="/ppt/media/image102.png" ContentType="image/png"/>
  <Override PartName="/ppt/media/image95.png" ContentType="image/png"/>
  <Override PartName="/ppt/media/image69.png" ContentType="image/png"/>
  <Override PartName="/ppt/media/image120.png" ContentType="image/png"/>
  <Override PartName="/ppt/media/image66.png" ContentType="image/png"/>
  <Override PartName="/ppt/media/image65.png" ContentType="image/png"/>
  <Override PartName="/ppt/media/image64.png" ContentType="image/png"/>
  <Override PartName="/ppt/media/image63.png" ContentType="image/png"/>
  <Override PartName="/ppt/media/image94.png" ContentType="image/png"/>
  <Override PartName="/ppt/media/image29.png" ContentType="image/png"/>
  <Override PartName="/ppt/media/image23.png" ContentType="image/png"/>
  <Override PartName="/ppt/media/image119.png" ContentType="image/png"/>
  <Override PartName="/ppt/media/image22.png" ContentType="image/png"/>
  <Override PartName="/ppt/media/image76.jpeg" ContentType="image/jpeg"/>
  <Override PartName="/ppt/media/image54.png" ContentType="image/png"/>
  <Override PartName="/ppt/media/image118.png" ContentType="image/png"/>
  <Override PartName="/ppt/media/image89.jpeg" ContentType="image/jpeg"/>
  <Override PartName="/ppt/media/image21.png" ContentType="image/png"/>
  <Override PartName="/ppt/media/image15.wmf" ContentType="image/x-wmf"/>
  <Override PartName="/ppt/media/image58.png" ContentType="image/png"/>
  <Override PartName="/ppt/media/image19.png" ContentType="image/png"/>
  <Override PartName="/ppt/media/image84.png" ContentType="image/png"/>
  <Override PartName="/ppt/media/image26.png" ContentType="image/png"/>
  <Override PartName="/ppt/media/image112.png" ContentType="image/png"/>
  <Override PartName="/ppt/media/image18.wmf" ContentType="image/x-wmf"/>
  <Override PartName="/ppt/media/image117.png" ContentType="image/png"/>
  <Override PartName="/ppt/media/image20.png" ContentType="image/png"/>
  <Override PartName="/ppt/media/image57.png" ContentType="image/png"/>
  <Override PartName="/ppt/media/image2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</p:sldIdLst>
  <p:sldSz cx="7772400" cy="10058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  <a:defRPr b="0" lang="en-I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03480" y="685440"/>
            <a:ext cx="26510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49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  <a:defRPr b="0" lang="en-I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fld id="{BFE8E958-5BC5-4418-9755-B4E528151F5E}" type="slidenum">
              <a:rPr b="0" lang="en-I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7" name="PlaceHolder 1"/>
          <p:cNvSpPr>
            <a:spLocks noGrp="1"/>
          </p:cNvSpPr>
          <p:nvPr>
            <p:ph type="sldImg"/>
          </p:nvPr>
        </p:nvSpPr>
        <p:spPr>
          <a:xfrm>
            <a:off x="2104920" y="685800"/>
            <a:ext cx="2648160" cy="3429000"/>
          </a:xfrm>
          <a:prstGeom prst="rect">
            <a:avLst/>
          </a:prstGeom>
          <a:ln w="0">
            <a:noFill/>
          </a:ln>
        </p:spPr>
      </p:sp>
      <p:sp>
        <p:nvSpPr>
          <p:cNvPr id="97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fld id="{A3E88988-6C1B-4CA0-9682-1FA225475EDE}" type="slidenum">
              <a:rPr b="0" lang="en-IN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01E745-1CCF-4BC3-87A9-ACA6070721E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88800" y="2347560"/>
            <a:ext cx="699624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88800" y="5815440"/>
            <a:ext cx="699624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FC9D34-D20F-464F-A102-4F10EF20FB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88800" y="234756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73680" y="234756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88800" y="581544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73680" y="581544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3475DB-A00A-4958-848A-57980E1BDE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88800" y="2347560"/>
            <a:ext cx="225252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54360" y="2347560"/>
            <a:ext cx="225252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119920" y="2347560"/>
            <a:ext cx="225252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88800" y="5815440"/>
            <a:ext cx="225252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54360" y="5815440"/>
            <a:ext cx="225252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119920" y="5815440"/>
            <a:ext cx="225252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4B2AEF-3509-46D9-94DD-8562D5697B4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88800" y="2347560"/>
            <a:ext cx="6996240" cy="6638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01"/>
              </a:spcBef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AA4A76-CD2A-448D-82AE-1BB8BA2E18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88800" y="2347560"/>
            <a:ext cx="6996240" cy="6638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EF2B7F-9123-40E8-A7D3-23B717D9D6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88800" y="2347560"/>
            <a:ext cx="3413880" cy="6638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73680" y="2347560"/>
            <a:ext cx="3413880" cy="6638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FF6467-261F-443B-B901-7309615D15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88136F-DAD1-418E-9A56-3D66202E55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88800" y="402840"/>
            <a:ext cx="6996240" cy="7772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01"/>
              </a:spcBef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6398BF-D2ED-4625-9201-E4BDEA9CBA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88800" y="234756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73680" y="2347560"/>
            <a:ext cx="3413880" cy="6638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88800" y="581544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5FFC33-499A-4852-8A08-DADC4B1902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88800" y="2347560"/>
            <a:ext cx="3413880" cy="6638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73680" y="234756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73680" y="581544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A5ED84-DD53-4B15-B6A2-2148CF2E04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88800" y="234756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73680" y="234756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88800" y="5815440"/>
            <a:ext cx="699624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94B174-5B71-4957-97C5-C315F216F8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49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88800" y="2347560"/>
            <a:ext cx="6996240" cy="6638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marL="380880" indent="-380880"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1" marL="826920" indent="-317160">
              <a:spcBef>
                <a:spcPts val="901"/>
              </a:spcBef>
              <a:buClr>
                <a:srgbClr val="000000"/>
              </a:buClr>
              <a:buFont typeface="Arial"/>
              <a:buChar char="–"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2" marL="1273320" indent="-254160"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3" marL="1782720" indent="-253800">
              <a:spcBef>
                <a:spcPts val="901"/>
              </a:spcBef>
              <a:buClr>
                <a:srgbClr val="000000"/>
              </a:buClr>
              <a:buFont typeface="Arial"/>
              <a:buChar char="–"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4" marL="2292480" indent="-254160">
              <a:spcBef>
                <a:spcPts val="901"/>
              </a:spcBef>
              <a:buClr>
                <a:srgbClr val="000000"/>
              </a:buClr>
              <a:buFont typeface="Arial"/>
              <a:buChar char="»"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5" marL="2292480" indent="-254160">
              <a:spcBef>
                <a:spcPts val="901"/>
              </a:spcBef>
              <a:buClr>
                <a:srgbClr val="000000"/>
              </a:buClr>
              <a:buFont typeface="Arial"/>
              <a:buChar char="»"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6" marL="2292480" indent="-254160">
              <a:spcBef>
                <a:spcPts val="901"/>
              </a:spcBef>
              <a:buClr>
                <a:srgbClr val="000000"/>
              </a:buClr>
              <a:buFont typeface="Arial"/>
              <a:buChar char="»"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88800" y="9322920"/>
            <a:ext cx="1812960" cy="536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lstStyle>
            <a:lvl1pPr indent="0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  <a:defRPr b="0" lang="en-IN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IN" sz="13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55720" y="9322920"/>
            <a:ext cx="2462400" cy="536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572080" y="9322920"/>
            <a:ext cx="1812960" cy="536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lstStyle>
            <a:lvl1pPr indent="0" algn="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  <a:defRPr b="0" lang="en-IN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fld id="{144DE39C-F4AE-41A0-A8B8-13807D0E48F4}" type="slidenum">
              <a:rPr b="0" lang="en-IN" sz="13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image" Target="../media/image16.wmf"/><Relationship Id="rId3" Type="http://schemas.openxmlformats.org/officeDocument/2006/relationships/image" Target="../media/image17.wmf"/><Relationship Id="rId4" Type="http://schemas.openxmlformats.org/officeDocument/2006/relationships/image" Target="../media/image18.wmf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image" Target="../media/image22.png"/><Relationship Id="rId5" Type="http://schemas.openxmlformats.org/officeDocument/2006/relationships/image" Target="../media/image23.png"/><Relationship Id="rId6" Type="http://schemas.openxmlformats.org/officeDocument/2006/relationships/image" Target="../media/image24.png"/><Relationship Id="rId7" Type="http://schemas.openxmlformats.org/officeDocument/2006/relationships/image" Target="../media/image25.png"/><Relationship Id="rId8" Type="http://schemas.openxmlformats.org/officeDocument/2006/relationships/image" Target="../media/image26.png"/><Relationship Id="rId9" Type="http://schemas.openxmlformats.org/officeDocument/2006/relationships/image" Target="../media/image27.png"/><Relationship Id="rId10" Type="http://schemas.openxmlformats.org/officeDocument/2006/relationships/image" Target="../media/image28.png"/><Relationship Id="rId11" Type="http://schemas.openxmlformats.org/officeDocument/2006/relationships/image" Target="../media/image29.png"/><Relationship Id="rId12" Type="http://schemas.openxmlformats.org/officeDocument/2006/relationships/image" Target="../media/image30.png"/><Relationship Id="rId13" Type="http://schemas.openxmlformats.org/officeDocument/2006/relationships/image" Target="../media/image31.png"/><Relationship Id="rId14" Type="http://schemas.openxmlformats.org/officeDocument/2006/relationships/image" Target="../media/image32.png"/><Relationship Id="rId15" Type="http://schemas.openxmlformats.org/officeDocument/2006/relationships/image" Target="../media/image33.png"/><Relationship Id="rId16" Type="http://schemas.openxmlformats.org/officeDocument/2006/relationships/image" Target="../media/image34.png"/><Relationship Id="rId17" Type="http://schemas.openxmlformats.org/officeDocument/2006/relationships/image" Target="../media/image35.png"/><Relationship Id="rId18" Type="http://schemas.openxmlformats.org/officeDocument/2006/relationships/image" Target="../media/image36.png"/><Relationship Id="rId19" Type="http://schemas.openxmlformats.org/officeDocument/2006/relationships/image" Target="../media/image37.png"/><Relationship Id="rId20" Type="http://schemas.openxmlformats.org/officeDocument/2006/relationships/image" Target="../media/image38.png"/><Relationship Id="rId21" Type="http://schemas.openxmlformats.org/officeDocument/2006/relationships/image" Target="../media/image39.png"/><Relationship Id="rId22" Type="http://schemas.openxmlformats.org/officeDocument/2006/relationships/image" Target="../media/image40.png"/><Relationship Id="rId23" Type="http://schemas.openxmlformats.org/officeDocument/2006/relationships/image" Target="../media/image41.png"/><Relationship Id="rId24" Type="http://schemas.openxmlformats.org/officeDocument/2006/relationships/image" Target="../media/image42.png"/><Relationship Id="rId25" Type="http://schemas.openxmlformats.org/officeDocument/2006/relationships/image" Target="../media/image43.png"/><Relationship Id="rId26" Type="http://schemas.openxmlformats.org/officeDocument/2006/relationships/image" Target="../media/image44.png"/><Relationship Id="rId27" Type="http://schemas.openxmlformats.org/officeDocument/2006/relationships/image" Target="../media/image45.png"/><Relationship Id="rId28" Type="http://schemas.openxmlformats.org/officeDocument/2006/relationships/image" Target="../media/image46.png"/><Relationship Id="rId29" Type="http://schemas.openxmlformats.org/officeDocument/2006/relationships/image" Target="../media/image47.png"/><Relationship Id="rId30" Type="http://schemas.openxmlformats.org/officeDocument/2006/relationships/image" Target="../media/image48.png"/><Relationship Id="rId31" Type="http://schemas.openxmlformats.org/officeDocument/2006/relationships/image" Target="../media/image49.png"/><Relationship Id="rId32" Type="http://schemas.openxmlformats.org/officeDocument/2006/relationships/image" Target="../media/image50.png"/><Relationship Id="rId33" Type="http://schemas.openxmlformats.org/officeDocument/2006/relationships/image" Target="../media/image51.png"/><Relationship Id="rId34" Type="http://schemas.openxmlformats.org/officeDocument/2006/relationships/image" Target="../media/image52.png"/><Relationship Id="rId35" Type="http://schemas.openxmlformats.org/officeDocument/2006/relationships/image" Target="../media/image53.png"/><Relationship Id="rId36" Type="http://schemas.openxmlformats.org/officeDocument/2006/relationships/image" Target="../media/image54.png"/><Relationship Id="rId37" Type="http://schemas.openxmlformats.org/officeDocument/2006/relationships/image" Target="../media/image55.png"/><Relationship Id="rId38" Type="http://schemas.openxmlformats.org/officeDocument/2006/relationships/image" Target="../media/image56.png"/><Relationship Id="rId39" Type="http://schemas.openxmlformats.org/officeDocument/2006/relationships/image" Target="../media/image57.png"/><Relationship Id="rId40" Type="http://schemas.openxmlformats.org/officeDocument/2006/relationships/image" Target="../media/image58.png"/><Relationship Id="rId41" Type="http://schemas.openxmlformats.org/officeDocument/2006/relationships/image" Target="../media/image59.png"/><Relationship Id="rId42" Type="http://schemas.openxmlformats.org/officeDocument/2006/relationships/image" Target="../media/image60.png"/><Relationship Id="rId4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1.wmf"/><Relationship Id="rId2" Type="http://schemas.openxmlformats.org/officeDocument/2006/relationships/image" Target="../media/image62.png"/><Relationship Id="rId3" Type="http://schemas.openxmlformats.org/officeDocument/2006/relationships/image" Target="../media/image62.png"/><Relationship Id="rId4" Type="http://schemas.openxmlformats.org/officeDocument/2006/relationships/image" Target="../media/image62.png"/><Relationship Id="rId5" Type="http://schemas.openxmlformats.org/officeDocument/2006/relationships/image" Target="../media/image62.png"/><Relationship Id="rId6" Type="http://schemas.openxmlformats.org/officeDocument/2006/relationships/image" Target="../media/image62.png"/><Relationship Id="rId7" Type="http://schemas.openxmlformats.org/officeDocument/2006/relationships/image" Target="../media/image62.png"/><Relationship Id="rId8" Type="http://schemas.openxmlformats.org/officeDocument/2006/relationships/image" Target="../media/image62.png"/><Relationship Id="rId9" Type="http://schemas.openxmlformats.org/officeDocument/2006/relationships/image" Target="../media/image63.png"/><Relationship Id="rId10" Type="http://schemas.openxmlformats.org/officeDocument/2006/relationships/image" Target="../media/image64.png"/><Relationship Id="rId11" Type="http://schemas.openxmlformats.org/officeDocument/2006/relationships/image" Target="../media/image65.png"/><Relationship Id="rId12" Type="http://schemas.openxmlformats.org/officeDocument/2006/relationships/image" Target="../media/image66.png"/><Relationship Id="rId13" Type="http://schemas.openxmlformats.org/officeDocument/2006/relationships/image" Target="../media/image66.png"/><Relationship Id="rId14" Type="http://schemas.openxmlformats.org/officeDocument/2006/relationships/image" Target="../media/image67.png"/><Relationship Id="rId15" Type="http://schemas.openxmlformats.org/officeDocument/2006/relationships/image" Target="../media/image68.png"/><Relationship Id="rId16" Type="http://schemas.openxmlformats.org/officeDocument/2006/relationships/image" Target="../media/image69.png"/><Relationship Id="rId17" Type="http://schemas.openxmlformats.org/officeDocument/2006/relationships/image" Target="../media/image68.png"/><Relationship Id="rId18" Type="http://schemas.openxmlformats.org/officeDocument/2006/relationships/image" Target="../media/image68.png"/><Relationship Id="rId19" Type="http://schemas.openxmlformats.org/officeDocument/2006/relationships/image" Target="../media/image69.png"/><Relationship Id="rId20" Type="http://schemas.openxmlformats.org/officeDocument/2006/relationships/image" Target="../media/image68.png"/><Relationship Id="rId21" Type="http://schemas.openxmlformats.org/officeDocument/2006/relationships/image" Target="../media/image69.png"/><Relationship Id="rId22" Type="http://schemas.openxmlformats.org/officeDocument/2006/relationships/image" Target="../media/image69.png"/><Relationship Id="rId23" Type="http://schemas.openxmlformats.org/officeDocument/2006/relationships/image" Target="../media/image69.png"/><Relationship Id="rId24" Type="http://schemas.openxmlformats.org/officeDocument/2006/relationships/image" Target="../media/image68.png"/><Relationship Id="rId25" Type="http://schemas.openxmlformats.org/officeDocument/2006/relationships/image" Target="../media/image69.png"/><Relationship Id="rId26" Type="http://schemas.openxmlformats.org/officeDocument/2006/relationships/image" Target="../media/image69.png"/><Relationship Id="rId27" Type="http://schemas.openxmlformats.org/officeDocument/2006/relationships/image" Target="../media/image70.jpeg"/><Relationship Id="rId28" Type="http://schemas.openxmlformats.org/officeDocument/2006/relationships/image" Target="../media/image71.png"/><Relationship Id="rId29" Type="http://schemas.openxmlformats.org/officeDocument/2006/relationships/image" Target="../media/image72.png"/><Relationship Id="rId30" Type="http://schemas.openxmlformats.org/officeDocument/2006/relationships/image" Target="../media/image73.png"/><Relationship Id="rId31" Type="http://schemas.openxmlformats.org/officeDocument/2006/relationships/image" Target="../media/image74.png"/><Relationship Id="rId32" Type="http://schemas.openxmlformats.org/officeDocument/2006/relationships/image" Target="../media/image75.jpeg"/><Relationship Id="rId33" Type="http://schemas.openxmlformats.org/officeDocument/2006/relationships/image" Target="../media/image76.jpeg"/><Relationship Id="rId34" Type="http://schemas.openxmlformats.org/officeDocument/2006/relationships/image" Target="../media/image77.png"/><Relationship Id="rId35" Type="http://schemas.openxmlformats.org/officeDocument/2006/relationships/image" Target="../media/image78.png"/><Relationship Id="rId36" Type="http://schemas.openxmlformats.org/officeDocument/2006/relationships/image" Target="../media/image79.png"/><Relationship Id="rId37" Type="http://schemas.openxmlformats.org/officeDocument/2006/relationships/image" Target="../media/image80.png"/><Relationship Id="rId38" Type="http://schemas.openxmlformats.org/officeDocument/2006/relationships/image" Target="../media/image81.png"/><Relationship Id="rId39" Type="http://schemas.openxmlformats.org/officeDocument/2006/relationships/image" Target="../media/image82.png"/><Relationship Id="rId40" Type="http://schemas.openxmlformats.org/officeDocument/2006/relationships/image" Target="../media/image83.png"/><Relationship Id="rId41" Type="http://schemas.openxmlformats.org/officeDocument/2006/relationships/image" Target="../media/image84.png"/><Relationship Id="rId42" Type="http://schemas.openxmlformats.org/officeDocument/2006/relationships/image" Target="../media/image85.png"/><Relationship Id="rId43" Type="http://schemas.openxmlformats.org/officeDocument/2006/relationships/slideLayout" Target="../slideLayouts/slideLayout1.xml"/><Relationship Id="rId44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6.jpeg"/><Relationship Id="rId2" Type="http://schemas.openxmlformats.org/officeDocument/2006/relationships/image" Target="../media/image87.jpeg"/><Relationship Id="rId3" Type="http://schemas.openxmlformats.org/officeDocument/2006/relationships/image" Target="../media/image88.png"/><Relationship Id="rId4" Type="http://schemas.openxmlformats.org/officeDocument/2006/relationships/image" Target="../media/image88.png"/><Relationship Id="rId5" Type="http://schemas.openxmlformats.org/officeDocument/2006/relationships/image" Target="../media/image89.jpeg"/><Relationship Id="rId6" Type="http://schemas.openxmlformats.org/officeDocument/2006/relationships/image" Target="../media/image90.jpeg"/><Relationship Id="rId7" Type="http://schemas.openxmlformats.org/officeDocument/2006/relationships/image" Target="../media/image91.jpeg"/><Relationship Id="rId8" Type="http://schemas.openxmlformats.org/officeDocument/2006/relationships/image" Target="../media/image88.png"/><Relationship Id="rId9" Type="http://schemas.openxmlformats.org/officeDocument/2006/relationships/image" Target="../media/image92.jpeg"/><Relationship Id="rId10" Type="http://schemas.openxmlformats.org/officeDocument/2006/relationships/image" Target="../media/image88.png"/><Relationship Id="rId1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93.png"/><Relationship Id="rId2" Type="http://schemas.openxmlformats.org/officeDocument/2006/relationships/image" Target="../media/image94.png"/><Relationship Id="rId3" Type="http://schemas.openxmlformats.org/officeDocument/2006/relationships/image" Target="../media/image95.png"/><Relationship Id="rId4" Type="http://schemas.openxmlformats.org/officeDocument/2006/relationships/image" Target="../media/image96.png"/><Relationship Id="rId5" Type="http://schemas.openxmlformats.org/officeDocument/2006/relationships/image" Target="../media/image97.png"/><Relationship Id="rId6" Type="http://schemas.openxmlformats.org/officeDocument/2006/relationships/image" Target="../media/image98.png"/><Relationship Id="rId7" Type="http://schemas.openxmlformats.org/officeDocument/2006/relationships/image" Target="../media/image99.png"/><Relationship Id="rId8" Type="http://schemas.openxmlformats.org/officeDocument/2006/relationships/image" Target="../media/image100.png"/><Relationship Id="rId9" Type="http://schemas.openxmlformats.org/officeDocument/2006/relationships/image" Target="../media/image101.png"/><Relationship Id="rId10" Type="http://schemas.openxmlformats.org/officeDocument/2006/relationships/image" Target="../media/image99.png"/><Relationship Id="rId11" Type="http://schemas.openxmlformats.org/officeDocument/2006/relationships/image" Target="../media/image102.png"/><Relationship Id="rId12" Type="http://schemas.openxmlformats.org/officeDocument/2006/relationships/image" Target="../media/image103.png"/><Relationship Id="rId13" Type="http://schemas.openxmlformats.org/officeDocument/2006/relationships/image" Target="../media/image104.png"/><Relationship Id="rId14" Type="http://schemas.openxmlformats.org/officeDocument/2006/relationships/image" Target="../media/image104.png"/><Relationship Id="rId15" Type="http://schemas.openxmlformats.org/officeDocument/2006/relationships/image" Target="../media/image105.png"/><Relationship Id="rId16" Type="http://schemas.openxmlformats.org/officeDocument/2006/relationships/image" Target="../media/image104.png"/><Relationship Id="rId17" Type="http://schemas.openxmlformats.org/officeDocument/2006/relationships/image" Target="../media/image104.png"/><Relationship Id="rId18" Type="http://schemas.openxmlformats.org/officeDocument/2006/relationships/image" Target="../media/image106.png"/><Relationship Id="rId19" Type="http://schemas.openxmlformats.org/officeDocument/2006/relationships/image" Target="../media/image107.png"/><Relationship Id="rId20" Type="http://schemas.openxmlformats.org/officeDocument/2006/relationships/image" Target="../media/image108.png"/><Relationship Id="rId21" Type="http://schemas.openxmlformats.org/officeDocument/2006/relationships/image" Target="../media/image109.png"/><Relationship Id="rId22" Type="http://schemas.openxmlformats.org/officeDocument/2006/relationships/image" Target="../media/image110.png"/><Relationship Id="rId23" Type="http://schemas.openxmlformats.org/officeDocument/2006/relationships/image" Target="../media/image111.png"/><Relationship Id="rId24" Type="http://schemas.openxmlformats.org/officeDocument/2006/relationships/image" Target="../media/image112.png"/><Relationship Id="rId25" Type="http://schemas.openxmlformats.org/officeDocument/2006/relationships/image" Target="../media/image113.png"/><Relationship Id="rId26" Type="http://schemas.openxmlformats.org/officeDocument/2006/relationships/image" Target="../media/image114.jpeg"/><Relationship Id="rId27" Type="http://schemas.openxmlformats.org/officeDocument/2006/relationships/image" Target="../media/image115.jpeg"/><Relationship Id="rId28" Type="http://schemas.openxmlformats.org/officeDocument/2006/relationships/image" Target="../media/image116.jpeg"/><Relationship Id="rId29" Type="http://schemas.openxmlformats.org/officeDocument/2006/relationships/image" Target="../media/image117.png"/><Relationship Id="rId30" Type="http://schemas.openxmlformats.org/officeDocument/2006/relationships/image" Target="../media/image117.png"/><Relationship Id="rId31" Type="http://schemas.openxmlformats.org/officeDocument/2006/relationships/image" Target="../media/image118.png"/><Relationship Id="rId32" Type="http://schemas.openxmlformats.org/officeDocument/2006/relationships/image" Target="../media/image119.png"/><Relationship Id="rId33" Type="http://schemas.openxmlformats.org/officeDocument/2006/relationships/image" Target="../media/image119.png"/><Relationship Id="rId34" Type="http://schemas.openxmlformats.org/officeDocument/2006/relationships/image" Target="../media/image119.png"/><Relationship Id="rId35" Type="http://schemas.openxmlformats.org/officeDocument/2006/relationships/image" Target="../media/image120.png"/><Relationship Id="rId36" Type="http://schemas.openxmlformats.org/officeDocument/2006/relationships/image" Target="../media/image121.png"/><Relationship Id="rId37" Type="http://schemas.openxmlformats.org/officeDocument/2006/relationships/image" Target="../media/image121.png"/><Relationship Id="rId38" Type="http://schemas.openxmlformats.org/officeDocument/2006/relationships/image" Target="../media/image121.png"/><Relationship Id="rId39" Type="http://schemas.openxmlformats.org/officeDocument/2006/relationships/image" Target="../media/image121.png"/><Relationship Id="rId40" Type="http://schemas.openxmlformats.org/officeDocument/2006/relationships/image" Target="../media/image122.png"/><Relationship Id="rId4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7"/>
          <p:cNvGrpSpPr/>
          <p:nvPr/>
        </p:nvGrpSpPr>
        <p:grpSpPr>
          <a:xfrm>
            <a:off x="479520" y="474840"/>
            <a:ext cx="6738840" cy="5625360"/>
            <a:chOff x="479520" y="474840"/>
            <a:chExt cx="6738840" cy="5625360"/>
          </a:xfrm>
        </p:grpSpPr>
        <p:grpSp>
          <p:nvGrpSpPr>
            <p:cNvPr id="49" name="Group 3"/>
            <p:cNvGrpSpPr/>
            <p:nvPr/>
          </p:nvGrpSpPr>
          <p:grpSpPr>
            <a:xfrm>
              <a:off x="479520" y="474840"/>
              <a:ext cx="6738840" cy="5625360"/>
              <a:chOff x="479520" y="474840"/>
              <a:chExt cx="6738840" cy="5625360"/>
            </a:xfrm>
          </p:grpSpPr>
          <p:grpSp>
            <p:nvGrpSpPr>
              <p:cNvPr id="50" name="Group 1"/>
              <p:cNvGrpSpPr/>
              <p:nvPr/>
            </p:nvGrpSpPr>
            <p:grpSpPr>
              <a:xfrm>
                <a:off x="479520" y="474840"/>
                <a:ext cx="6738840" cy="5625360"/>
                <a:chOff x="479520" y="474840"/>
                <a:chExt cx="6738840" cy="5625360"/>
              </a:xfrm>
            </p:grpSpPr>
            <p:pic>
              <p:nvPicPr>
                <p:cNvPr id="51" name="Picture 2" descr=""/>
                <p:cNvPicPr/>
                <p:nvPr/>
              </p:nvPicPr>
              <p:blipFill>
                <a:blip r:embed="rId1"/>
                <a:srcRect l="4401" t="44613" r="53856" b="19787"/>
                <a:stretch/>
              </p:blipFill>
              <p:spPr>
                <a:xfrm>
                  <a:off x="4493520" y="3118680"/>
                  <a:ext cx="1411560" cy="72396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52" name="Group 40"/>
                <p:cNvGrpSpPr/>
                <p:nvPr/>
              </p:nvGrpSpPr>
              <p:grpSpPr>
                <a:xfrm>
                  <a:off x="819360" y="923400"/>
                  <a:ext cx="6399000" cy="2501640"/>
                  <a:chOff x="819360" y="923400"/>
                  <a:chExt cx="6399000" cy="2501640"/>
                </a:xfrm>
              </p:grpSpPr>
              <p:sp>
                <p:nvSpPr>
                  <p:cNvPr id="53" name="Right Arrow 60"/>
                  <p:cNvSpPr/>
                  <p:nvPr/>
                </p:nvSpPr>
                <p:spPr>
                  <a:xfrm rot="803400">
                    <a:off x="5087520" y="1806480"/>
                    <a:ext cx="263520" cy="44280"/>
                  </a:xfrm>
                  <a:prstGeom prst="rightArrow">
                    <a:avLst>
                      <a:gd name="adj1" fmla="val 50000"/>
                      <a:gd name="adj2" fmla="val 53699"/>
                    </a:avLst>
                  </a:prstGeom>
                  <a:solidFill>
                    <a:srgbClr val="c00000"/>
                  </a:solidFill>
                  <a:ln w="25560">
                    <a:solidFill>
                      <a:srgbClr val="c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480" bIns="-2448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pic>
                <p:nvPicPr>
                  <p:cNvPr id="54" name="Picture 1" descr="C:\Users\ELIZABETH\Desktop\BIO-RENDER IMAGES\FIGURE S1A (CROPPED).png"/>
                  <p:cNvPicPr/>
                  <p:nvPr/>
                </p:nvPicPr>
                <p:blipFill>
                  <a:blip r:embed="rId2"/>
                  <a:srcRect l="3891" t="0" r="4937" b="5382"/>
                  <a:stretch/>
                </p:blipFill>
                <p:spPr>
                  <a:xfrm>
                    <a:off x="874800" y="1259280"/>
                    <a:ext cx="2569680" cy="1859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55" name="TextBox 3"/>
                  <p:cNvSpPr/>
                  <p:nvPr/>
                </p:nvSpPr>
                <p:spPr>
                  <a:xfrm flipH="1">
                    <a:off x="819360" y="3209400"/>
                    <a:ext cx="232488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 u="sng">
                        <a:solidFill>
                          <a:srgbClr val="00004c"/>
                        </a:solidFill>
                        <a:uFillTx/>
                        <a:latin typeface="Times New Roman"/>
                        <a:ea typeface="Times New Roman"/>
                      </a:rPr>
                      <a:t>Ovarian Cancer Patients visiting CNCI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grpSp>
                <p:nvGrpSpPr>
                  <p:cNvPr id="56" name="Group 24"/>
                  <p:cNvGrpSpPr/>
                  <p:nvPr/>
                </p:nvGrpSpPr>
                <p:grpSpPr>
                  <a:xfrm>
                    <a:off x="3720960" y="1931760"/>
                    <a:ext cx="1625400" cy="1179720"/>
                    <a:chOff x="3720960" y="1931760"/>
                    <a:chExt cx="1625400" cy="1179720"/>
                  </a:xfrm>
                </p:grpSpPr>
                <p:sp>
                  <p:nvSpPr>
                    <p:cNvPr id="57" name="TextBox 35851"/>
                    <p:cNvSpPr/>
                    <p:nvPr/>
                  </p:nvSpPr>
                  <p:spPr>
                    <a:xfrm>
                      <a:off x="3720960" y="1931760"/>
                      <a:ext cx="1625400" cy="232200"/>
                    </a:xfrm>
                    <a:prstGeom prst="rect">
                      <a:avLst/>
                    </a:prstGeom>
                    <a:solidFill>
                      <a:srgbClr val="fcd5b5">
                        <a:alpha val="50000"/>
                      </a:srgbClr>
                    </a:solidFill>
                    <a:ln w="9360">
                      <a:solidFill>
                        <a:srgbClr val="0046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800" spc="-1" strike="noStrike">
                          <a:solidFill>
                            <a:srgbClr val="004600"/>
                          </a:solidFill>
                          <a:latin typeface="Times New Roman"/>
                          <a:ea typeface="Times New Roman"/>
                        </a:rPr>
                        <a:t>Most Prevalent(</a:t>
                      </a:r>
                      <a:r>
                        <a:rPr b="1" lang="en-IN" sz="800" spc="-1" strike="noStrike" baseline="-25000">
                          <a:solidFill>
                            <a:srgbClr val="004600"/>
                          </a:solidFill>
                          <a:latin typeface="Times New Roman"/>
                          <a:ea typeface="Times New Roman"/>
                        </a:rPr>
                        <a:t>˜</a:t>
                      </a:r>
                      <a:r>
                        <a:rPr b="1" lang="en-IN" sz="800" spc="-1" strike="noStrike">
                          <a:solidFill>
                            <a:srgbClr val="004600"/>
                          </a:solidFill>
                          <a:latin typeface="Times New Roman"/>
                          <a:ea typeface="Times New Roman"/>
                        </a:rPr>
                        <a:t>75%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58" name="TextBox 35851"/>
                    <p:cNvSpPr/>
                    <p:nvPr/>
                  </p:nvSpPr>
                  <p:spPr>
                    <a:xfrm>
                      <a:off x="3721680" y="2172600"/>
                      <a:ext cx="1624680" cy="215640"/>
                    </a:xfrm>
                    <a:prstGeom prst="rect">
                      <a:avLst/>
                    </a:prstGeom>
                    <a:solidFill>
                      <a:srgbClr val="ffb3b3">
                        <a:alpha val="50000"/>
                      </a:srgbClr>
                    </a:solidFill>
                    <a:ln w="9360">
                      <a:solidFill>
                        <a:srgbClr val="bc008b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800" spc="-1" strike="noStrike">
                          <a:solidFill>
                            <a:srgbClr val="bc008b"/>
                          </a:solidFill>
                          <a:latin typeface="Times New Roman"/>
                          <a:ea typeface="Times New Roman"/>
                        </a:rPr>
                        <a:t>Poor Prognosi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59" name="TextBox 35851"/>
                    <p:cNvSpPr/>
                    <p:nvPr/>
                  </p:nvSpPr>
                  <p:spPr>
                    <a:xfrm>
                      <a:off x="3721680" y="2774160"/>
                      <a:ext cx="1624680" cy="337320"/>
                    </a:xfrm>
                    <a:prstGeom prst="rect">
                      <a:avLst/>
                    </a:prstGeom>
                    <a:solidFill>
                      <a:srgbClr val="ffb871">
                        <a:alpha val="50000"/>
                      </a:srgbClr>
                    </a:solidFill>
                    <a:ln w="9360">
                      <a:solidFill>
                        <a:srgbClr val="884106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800" spc="-1" strike="noStrike">
                          <a:solidFill>
                            <a:srgbClr val="884106"/>
                          </a:solidFill>
                          <a:latin typeface="Times New Roman"/>
                          <a:ea typeface="Times New Roman"/>
                        </a:rPr>
                        <a:t>Higher Relapse and Recurrence Report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60" name="TextBox 35851"/>
                    <p:cNvSpPr/>
                    <p:nvPr/>
                  </p:nvSpPr>
                  <p:spPr>
                    <a:xfrm>
                      <a:off x="3720960" y="2410920"/>
                      <a:ext cx="1625400" cy="337320"/>
                    </a:xfrm>
                    <a:prstGeom prst="rect">
                      <a:avLst/>
                    </a:prstGeom>
                    <a:solidFill>
                      <a:srgbClr val="e6b9b8">
                        <a:alpha val="50000"/>
                      </a:srgbClr>
                    </a:solidFill>
                    <a:ln w="9360">
                      <a:solidFill>
                        <a:srgbClr val="bc47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800" spc="-1" strike="noStrike">
                          <a:solidFill>
                            <a:srgbClr val="bc4744"/>
                          </a:solidFill>
                          <a:latin typeface="Times New Roman"/>
                          <a:ea typeface="Times New Roman"/>
                        </a:rPr>
                        <a:t>Upregulated PI3K/Akt/mTOR pathwa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grpSp>
                <p:nvGrpSpPr>
                  <p:cNvPr id="61" name="Group 27"/>
                  <p:cNvGrpSpPr/>
                  <p:nvPr/>
                </p:nvGrpSpPr>
                <p:grpSpPr>
                  <a:xfrm>
                    <a:off x="3330000" y="1170720"/>
                    <a:ext cx="2012400" cy="640440"/>
                    <a:chOff x="3330000" y="1170720"/>
                    <a:chExt cx="2012400" cy="640440"/>
                  </a:xfrm>
                </p:grpSpPr>
                <p:sp>
                  <p:nvSpPr>
                    <p:cNvPr id="62" name="Right Arrow 73"/>
                    <p:cNvSpPr/>
                    <p:nvPr/>
                  </p:nvSpPr>
                  <p:spPr>
                    <a:xfrm rot="20727000">
                      <a:off x="5079960" y="1312200"/>
                      <a:ext cx="260280" cy="50760"/>
                    </a:xfrm>
                    <a:prstGeom prst="rightArrow">
                      <a:avLst>
                        <a:gd name="adj1" fmla="val 50000"/>
                        <a:gd name="adj2" fmla="val 53532"/>
                      </a:avLst>
                    </a:prstGeom>
                    <a:solidFill>
                      <a:srgbClr val="c00000"/>
                    </a:solidFill>
                    <a:ln w="25560">
                      <a:solidFill>
                        <a:srgbClr val="c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1240" bIns="-2124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grpSp>
                  <p:nvGrpSpPr>
                    <p:cNvPr id="63" name="Group 5"/>
                    <p:cNvGrpSpPr/>
                    <p:nvPr/>
                  </p:nvGrpSpPr>
                  <p:grpSpPr>
                    <a:xfrm>
                      <a:off x="3330000" y="1170720"/>
                      <a:ext cx="1742760" cy="640440"/>
                      <a:chOff x="3330000" y="1170720"/>
                      <a:chExt cx="1742760" cy="640440"/>
                    </a:xfrm>
                  </p:grpSpPr>
                  <p:sp>
                    <p:nvSpPr>
                      <p:cNvPr id="64" name="TextBox 4"/>
                      <p:cNvSpPr/>
                      <p:nvPr/>
                    </p:nvSpPr>
                    <p:spPr>
                      <a:xfrm>
                        <a:off x="3859560" y="1352160"/>
                        <a:ext cx="1213200" cy="459000"/>
                      </a:xfrm>
                      <a:prstGeom prst="rect">
                        <a:avLst/>
                      </a:prstGeom>
                      <a:noFill/>
                      <a:ln w="19080">
                        <a:solidFill>
                          <a:srgbClr val="c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r>
                          <a:rPr b="1" lang="en-IN" sz="800" spc="-1" strike="noStrike">
                            <a:solidFill>
                              <a:srgbClr val="c00000"/>
                            </a:solidFill>
                            <a:latin typeface="Times New Roman"/>
                            <a:ea typeface="Times New Roman"/>
                          </a:rPr>
                          <a:t>High Grade Serous Ovarian Carcinoma (HGSOC) Cases</a:t>
                        </a:r>
                        <a:endParaRPr b="0" lang="en-US" sz="8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65" name="Freeform 75"/>
                      <p:cNvSpPr/>
                      <p:nvPr/>
                    </p:nvSpPr>
                    <p:spPr>
                      <a:xfrm rot="957600">
                        <a:off x="3351240" y="1234440"/>
                        <a:ext cx="496800" cy="225360"/>
                      </a:xfrm>
                      <a:custGeom>
                        <a:avLst/>
                        <a:gdLst/>
                        <a:ahLst/>
                        <a:rect l="l" t="t" r="r" b="b"/>
                        <a:pathLst>
                          <a:path w="553251" h="293219">
                            <a:moveTo>
                              <a:pt x="0" y="293219"/>
                            </a:moveTo>
                            <a:cubicBezTo>
                              <a:pt x="84524" y="174757"/>
                              <a:pt x="169049" y="56295"/>
                              <a:pt x="261257" y="16594"/>
                            </a:cubicBezTo>
                            <a:cubicBezTo>
                              <a:pt x="353466" y="-23107"/>
                              <a:pt x="453358" y="15953"/>
                              <a:pt x="553251" y="55014"/>
                            </a:cubicBezTo>
                          </a:path>
                        </a:pathLst>
                      </a:custGeom>
                      <a:noFill/>
                      <a:ln w="12600">
                        <a:solidFill>
                          <a:srgbClr val="000042"/>
                        </a:solidFill>
                        <a:round/>
                        <a:tailEnd len="med" type="stealth" w="med"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ctr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</p:grpSp>
              <p:grpSp>
                <p:nvGrpSpPr>
                  <p:cNvPr id="66" name="Group 36"/>
                  <p:cNvGrpSpPr/>
                  <p:nvPr/>
                </p:nvGrpSpPr>
                <p:grpSpPr>
                  <a:xfrm>
                    <a:off x="5451480" y="923400"/>
                    <a:ext cx="1766880" cy="2061720"/>
                    <a:chOff x="5451480" y="923400"/>
                    <a:chExt cx="1766880" cy="2061720"/>
                  </a:xfrm>
                </p:grpSpPr>
                <p:grpSp>
                  <p:nvGrpSpPr>
                    <p:cNvPr id="67" name="Group 28"/>
                    <p:cNvGrpSpPr/>
                    <p:nvPr/>
                  </p:nvGrpSpPr>
                  <p:grpSpPr>
                    <a:xfrm>
                      <a:off x="5451480" y="923400"/>
                      <a:ext cx="1766880" cy="791280"/>
                      <a:chOff x="5451480" y="923400"/>
                      <a:chExt cx="1766880" cy="791280"/>
                    </a:xfrm>
                  </p:grpSpPr>
                  <p:sp>
                    <p:nvSpPr>
                      <p:cNvPr id="68" name="TextBox 35851"/>
                      <p:cNvSpPr/>
                      <p:nvPr/>
                    </p:nvSpPr>
                    <p:spPr>
                      <a:xfrm>
                        <a:off x="5451480" y="923400"/>
                        <a:ext cx="1766880" cy="215640"/>
                      </a:xfrm>
                      <a:prstGeom prst="rect">
                        <a:avLst/>
                      </a:prstGeom>
                      <a:solidFill>
                        <a:srgbClr val="89ff89">
                          <a:alpha val="35000"/>
                        </a:srgbClr>
                      </a:solidFill>
                      <a:ln w="9360">
                        <a:solidFill>
                          <a:srgbClr val="0046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r>
                          <a:rPr b="1" lang="en-IN" sz="800" spc="-1" strike="noStrike">
                            <a:solidFill>
                              <a:srgbClr val="004600"/>
                            </a:solidFill>
                            <a:latin typeface="Times New Roman"/>
                            <a:ea typeface="Times New Roman"/>
                          </a:rPr>
                          <a:t>Inclusion Criteria</a:t>
                        </a:r>
                        <a:endParaRPr b="0" lang="en-US" sz="8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69" name="TextBox 35851"/>
                      <p:cNvSpPr/>
                      <p:nvPr/>
                    </p:nvSpPr>
                    <p:spPr>
                      <a:xfrm>
                        <a:off x="5451480" y="1163520"/>
                        <a:ext cx="1766880" cy="551160"/>
                      </a:xfrm>
                      <a:prstGeom prst="rect">
                        <a:avLst/>
                      </a:prstGeom>
                      <a:solidFill>
                        <a:srgbClr val="d7e4bd">
                          <a:alpha val="10000"/>
                        </a:srgbClr>
                      </a:solidFill>
                      <a:ln w="9360">
                        <a:solidFill>
                          <a:srgbClr val="4f6228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r>
                          <a:rPr b="1" lang="en-IN" sz="600" spc="-1" strike="noStrike">
                            <a:solidFill>
                              <a:srgbClr val="004600"/>
                            </a:solidFill>
                            <a:latin typeface="Times New Roman"/>
                            <a:ea typeface="Times New Roman"/>
                          </a:rPr>
                          <a:t>√ </a:t>
                        </a:r>
                        <a:r>
                          <a:rPr b="1" lang="en-IN" sz="600" spc="-1" strike="noStrike">
                            <a:solidFill>
                              <a:srgbClr val="004600"/>
                            </a:solidFill>
                            <a:latin typeface="Times New Roman"/>
                            <a:ea typeface="Times New Roman"/>
                          </a:rPr>
                          <a:t>Clinically Annotated HGSOC-subjects.</a:t>
                        </a:r>
                        <a:endParaRPr b="0" lang="en-US" sz="6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r>
                          <a:rPr b="1" lang="en-IN" sz="600" spc="-1" strike="noStrike">
                            <a:solidFill>
                              <a:srgbClr val="004600"/>
                            </a:solidFill>
                            <a:latin typeface="Times New Roman"/>
                            <a:ea typeface="Times New Roman"/>
                          </a:rPr>
                          <a:t>   √ </a:t>
                        </a:r>
                        <a:r>
                          <a:rPr b="1" lang="en-IN" sz="600" spc="-1" strike="noStrike">
                            <a:solidFill>
                              <a:srgbClr val="004600"/>
                            </a:solidFill>
                            <a:latin typeface="Times New Roman"/>
                            <a:ea typeface="Times New Roman"/>
                          </a:rPr>
                          <a:t>Patients of age-group 30-65years.</a:t>
                        </a:r>
                        <a:endParaRPr b="0" lang="en-US" sz="6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r>
                          <a:rPr b="1" lang="en-IN" sz="600" spc="-1" strike="noStrike">
                            <a:solidFill>
                              <a:srgbClr val="004600"/>
                            </a:solidFill>
                            <a:latin typeface="Times New Roman"/>
                            <a:ea typeface="Times New Roman"/>
                          </a:rPr>
                          <a:t>√</a:t>
                        </a:r>
                        <a:r>
                          <a:rPr b="1" lang="en-IN" sz="600" spc="-1" strike="noStrike">
                            <a:solidFill>
                              <a:srgbClr val="004600"/>
                            </a:solidFill>
                            <a:latin typeface="Times New Roman"/>
                            <a:ea typeface="Times New Roman"/>
                          </a:rPr>
                          <a:t>Patients displaying Eastern  Cooperative Oncology Group (ECOG) performance status between 0 to1.</a:t>
                        </a:r>
                        <a:endParaRPr b="0" lang="en-US" sz="6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grpSp>
                  <p:nvGrpSpPr>
                    <p:cNvPr id="70" name="Group 33"/>
                    <p:cNvGrpSpPr/>
                    <p:nvPr/>
                  </p:nvGrpSpPr>
                  <p:grpSpPr>
                    <a:xfrm>
                      <a:off x="5451480" y="1823760"/>
                      <a:ext cx="1766880" cy="1161360"/>
                      <a:chOff x="5451480" y="1823760"/>
                      <a:chExt cx="1766880" cy="1161360"/>
                    </a:xfrm>
                  </p:grpSpPr>
                  <p:sp>
                    <p:nvSpPr>
                      <p:cNvPr id="71" name="TextBox 35851"/>
                      <p:cNvSpPr/>
                      <p:nvPr/>
                    </p:nvSpPr>
                    <p:spPr>
                      <a:xfrm>
                        <a:off x="5451480" y="1823760"/>
                        <a:ext cx="1766880" cy="215640"/>
                      </a:xfrm>
                      <a:prstGeom prst="rect">
                        <a:avLst/>
                      </a:prstGeom>
                      <a:solidFill>
                        <a:srgbClr val="ff81ff">
                          <a:alpha val="30000"/>
                        </a:srgbClr>
                      </a:solidFill>
                      <a:ln w="9360">
                        <a:solidFill>
                          <a:srgbClr val="740074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r>
                          <a:rPr b="1" lang="en-IN" sz="800" spc="-1" strike="noStrike">
                            <a:solidFill>
                              <a:srgbClr val="740074"/>
                            </a:solidFill>
                            <a:latin typeface="Times New Roman"/>
                            <a:ea typeface="Times New Roman"/>
                          </a:rPr>
                          <a:t>Exclusion Criteria</a:t>
                        </a:r>
                        <a:endParaRPr b="0" lang="en-US" sz="8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72" name="TextBox 35851"/>
                      <p:cNvSpPr/>
                      <p:nvPr/>
                    </p:nvSpPr>
                    <p:spPr>
                      <a:xfrm>
                        <a:off x="5451480" y="2068200"/>
                        <a:ext cx="1766880" cy="916920"/>
                      </a:xfrm>
                      <a:prstGeom prst="rect">
                        <a:avLst/>
                      </a:prstGeom>
                      <a:solidFill>
                        <a:srgbClr val="ff81ff">
                          <a:alpha val="10000"/>
                        </a:srgbClr>
                      </a:solidFill>
                      <a:ln w="9360">
                        <a:solidFill>
                          <a:srgbClr val="740074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r>
                          <a:rPr b="1" lang="en-IN" sz="600" spc="-1" strike="noStrike">
                            <a:solidFill>
                              <a:srgbClr val="740074"/>
                            </a:solidFill>
                            <a:latin typeface="Times New Roman"/>
                            <a:ea typeface="Times New Roman"/>
                          </a:rPr>
                          <a:t>Patients with low malignant potential   tumors.</a:t>
                        </a:r>
                        <a:endParaRPr b="0" lang="en-US" sz="6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r>
                          <a:rPr b="1" lang="en-IN" sz="600" spc="-1" strike="noStrike">
                            <a:solidFill>
                              <a:srgbClr val="740074"/>
                            </a:solidFill>
                            <a:latin typeface="Times New Roman"/>
                            <a:ea typeface="Times New Roman"/>
                          </a:rPr>
                          <a:t>NACT patients or those with history of anthracycline, vinorelbine, aspirin, statin or radiation treatment.</a:t>
                        </a:r>
                        <a:endParaRPr b="0" lang="en-US" sz="6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r>
                          <a:rPr b="1" lang="en-IN" sz="600" spc="-1" strike="noStrike">
                            <a:solidFill>
                              <a:srgbClr val="740074"/>
                            </a:solidFill>
                            <a:latin typeface="Times New Roman"/>
                            <a:ea typeface="Times New Roman"/>
                          </a:rPr>
                          <a:t>Pregnant or Nursing Women.</a:t>
                        </a:r>
                        <a:endParaRPr b="0" lang="en-US" sz="6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r>
                          <a:rPr b="1" lang="en-IN" sz="600" spc="-1" strike="noStrike">
                            <a:solidFill>
                              <a:srgbClr val="740074"/>
                            </a:solidFill>
                            <a:latin typeface="Times New Roman"/>
                            <a:ea typeface="Times New Roman"/>
                          </a:rPr>
                          <a:t>Smokers/Alcohol Intakers/Non-HGSOCs/Concurrent Dislipidemia Subjects.</a:t>
                        </a:r>
                        <a:endParaRPr b="0" lang="en-US" sz="6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6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sp>
                  <p:nvSpPr>
                    <p:cNvPr id="73" name="5-Point Star 64"/>
                    <p:cNvSpPr/>
                    <p:nvPr/>
                  </p:nvSpPr>
                  <p:spPr>
                    <a:xfrm>
                      <a:off x="5500800" y="2116080"/>
                      <a:ext cx="48960" cy="60120"/>
                    </a:xfrm>
                    <a:custGeom>
                      <a:avLst/>
                      <a:gdLst/>
                      <a:ahLst/>
                      <a:rect l="l" t="t" r="r" b="b"/>
                      <a:pathLst>
                        <a:path w="45994" h="60329">
                          <a:moveTo>
                            <a:pt x="0" y="23044"/>
                          </a:moveTo>
                          <a:lnTo>
                            <a:pt x="17568" y="23044"/>
                          </a:lnTo>
                          <a:lnTo>
                            <a:pt x="22997" y="0"/>
                          </a:lnTo>
                          <a:lnTo>
                            <a:pt x="28426" y="23044"/>
                          </a:lnTo>
                          <a:lnTo>
                            <a:pt x="-19542" y="23044"/>
                          </a:lnTo>
                          <a:lnTo>
                            <a:pt x="31781" y="-28251"/>
                          </a:lnTo>
                          <a:lnTo>
                            <a:pt x="-28326" y="-5207"/>
                          </a:lnTo>
                          <a:lnTo>
                            <a:pt x="22997" y="-19449"/>
                          </a:lnTo>
                          <a:lnTo>
                            <a:pt x="8784" y="-5207"/>
                          </a:lnTo>
                          <a:lnTo>
                            <a:pt x="14213" y="-28251"/>
                          </a:lnTo>
                          <a:lnTo>
                            <a:pt x="0" y="23044"/>
                          </a:lnTo>
                          <a:close/>
                        </a:path>
                      </a:pathLst>
                    </a:custGeom>
                    <a:solidFill>
                      <a:srgbClr val="403152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3320" bIns="13320" anchor="ctr">
                      <a:noAutofit/>
                    </a:bodyPr>
                    <a:p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74" name="5-Point Star 65"/>
                    <p:cNvSpPr/>
                    <p:nvPr/>
                  </p:nvSpPr>
                  <p:spPr>
                    <a:xfrm>
                      <a:off x="5497560" y="2289240"/>
                      <a:ext cx="47520" cy="61560"/>
                    </a:xfrm>
                    <a:custGeom>
                      <a:avLst/>
                      <a:gdLst/>
                      <a:ahLst/>
                      <a:rect l="l" t="t" r="r" b="b"/>
                      <a:pathLst>
                        <a:path w="44511" h="61917">
                          <a:moveTo>
                            <a:pt x="0" y="23650"/>
                          </a:moveTo>
                          <a:lnTo>
                            <a:pt x="17002" y="23650"/>
                          </a:lnTo>
                          <a:lnTo>
                            <a:pt x="22256" y="0"/>
                          </a:lnTo>
                          <a:lnTo>
                            <a:pt x="27509" y="23650"/>
                          </a:lnTo>
                          <a:lnTo>
                            <a:pt x="-21025" y="23650"/>
                          </a:lnTo>
                          <a:lnTo>
                            <a:pt x="30756" y="-27269"/>
                          </a:lnTo>
                          <a:lnTo>
                            <a:pt x="-29526" y="-3619"/>
                          </a:lnTo>
                          <a:lnTo>
                            <a:pt x="22256" y="-18236"/>
                          </a:lnTo>
                          <a:lnTo>
                            <a:pt x="8501" y="-3619"/>
                          </a:lnTo>
                          <a:lnTo>
                            <a:pt x="13755" y="-27269"/>
                          </a:lnTo>
                          <a:lnTo>
                            <a:pt x="0" y="23650"/>
                          </a:lnTo>
                          <a:close/>
                        </a:path>
                      </a:pathLst>
                    </a:custGeom>
                    <a:solidFill>
                      <a:srgbClr val="403152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4760" bIns="14760" anchor="ctr">
                      <a:noAutofit/>
                    </a:bodyPr>
                    <a:p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75" name="5-Point Star 66"/>
                    <p:cNvSpPr/>
                    <p:nvPr/>
                  </p:nvSpPr>
                  <p:spPr>
                    <a:xfrm>
                      <a:off x="5497560" y="2562120"/>
                      <a:ext cx="48960" cy="60120"/>
                    </a:xfrm>
                    <a:custGeom>
                      <a:avLst/>
                      <a:gdLst/>
                      <a:ahLst/>
                      <a:rect l="l" t="t" r="r" b="b"/>
                      <a:pathLst>
                        <a:path w="45994" h="60329">
                          <a:moveTo>
                            <a:pt x="0" y="23044"/>
                          </a:moveTo>
                          <a:lnTo>
                            <a:pt x="17568" y="23044"/>
                          </a:lnTo>
                          <a:lnTo>
                            <a:pt x="22997" y="0"/>
                          </a:lnTo>
                          <a:lnTo>
                            <a:pt x="28426" y="23044"/>
                          </a:lnTo>
                          <a:lnTo>
                            <a:pt x="-19542" y="23044"/>
                          </a:lnTo>
                          <a:lnTo>
                            <a:pt x="31781" y="-28251"/>
                          </a:lnTo>
                          <a:lnTo>
                            <a:pt x="-28326" y="-5207"/>
                          </a:lnTo>
                          <a:lnTo>
                            <a:pt x="22997" y="-19449"/>
                          </a:lnTo>
                          <a:lnTo>
                            <a:pt x="8784" y="-5207"/>
                          </a:lnTo>
                          <a:lnTo>
                            <a:pt x="14213" y="-28251"/>
                          </a:lnTo>
                          <a:lnTo>
                            <a:pt x="0" y="23044"/>
                          </a:lnTo>
                          <a:close/>
                        </a:path>
                      </a:pathLst>
                    </a:custGeom>
                    <a:solidFill>
                      <a:srgbClr val="403152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3320" bIns="13320" anchor="ctr">
                      <a:noAutofit/>
                    </a:bodyPr>
                    <a:p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76" name="5-Point Star 67"/>
                    <p:cNvSpPr/>
                    <p:nvPr/>
                  </p:nvSpPr>
                  <p:spPr>
                    <a:xfrm>
                      <a:off x="5496120" y="2655720"/>
                      <a:ext cx="48960" cy="60120"/>
                    </a:xfrm>
                    <a:custGeom>
                      <a:avLst/>
                      <a:gdLst/>
                      <a:ahLst/>
                      <a:rect l="l" t="t" r="r" b="b"/>
                      <a:pathLst>
                        <a:path w="45995" h="60329">
                          <a:moveTo>
                            <a:pt x="0" y="23044"/>
                          </a:moveTo>
                          <a:lnTo>
                            <a:pt x="17569" y="23044"/>
                          </a:lnTo>
                          <a:lnTo>
                            <a:pt x="22998" y="0"/>
                          </a:lnTo>
                          <a:lnTo>
                            <a:pt x="28426" y="23044"/>
                          </a:lnTo>
                          <a:lnTo>
                            <a:pt x="-19541" y="23044"/>
                          </a:lnTo>
                          <a:lnTo>
                            <a:pt x="31782" y="-28251"/>
                          </a:lnTo>
                          <a:lnTo>
                            <a:pt x="-28325" y="-5207"/>
                          </a:lnTo>
                          <a:lnTo>
                            <a:pt x="22998" y="-19449"/>
                          </a:lnTo>
                          <a:lnTo>
                            <a:pt x="8784" y="-5207"/>
                          </a:lnTo>
                          <a:lnTo>
                            <a:pt x="14213" y="-28251"/>
                          </a:lnTo>
                          <a:lnTo>
                            <a:pt x="0" y="23044"/>
                          </a:lnTo>
                          <a:close/>
                        </a:path>
                      </a:pathLst>
                    </a:custGeom>
                    <a:solidFill>
                      <a:srgbClr val="403152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3320" bIns="13320" anchor="ctr">
                      <a:noAutofit/>
                    </a:bodyPr>
                    <a:p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</p:grpSp>
            <p:grpSp>
              <p:nvGrpSpPr>
                <p:cNvPr id="77" name="Group 43"/>
                <p:cNvGrpSpPr/>
                <p:nvPr/>
              </p:nvGrpSpPr>
              <p:grpSpPr>
                <a:xfrm>
                  <a:off x="5973840" y="2991960"/>
                  <a:ext cx="458640" cy="554760"/>
                  <a:chOff x="5973840" y="2991960"/>
                  <a:chExt cx="458640" cy="554760"/>
                </a:xfrm>
              </p:grpSpPr>
              <p:sp>
                <p:nvSpPr>
                  <p:cNvPr id="78" name="Straight Connector 54"/>
                  <p:cNvSpPr/>
                  <p:nvPr/>
                </p:nvSpPr>
                <p:spPr>
                  <a:xfrm>
                    <a:off x="6432480" y="2991960"/>
                    <a:ext cx="0" cy="554760"/>
                  </a:xfrm>
                  <a:prstGeom prst="line">
                    <a:avLst/>
                  </a:prstGeom>
                  <a:ln w="19080">
                    <a:solidFill>
                      <a:srgbClr val="6c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" name="Straight Connector 55"/>
                  <p:cNvSpPr/>
                  <p:nvPr/>
                </p:nvSpPr>
                <p:spPr>
                  <a:xfrm>
                    <a:off x="5973840" y="3543840"/>
                    <a:ext cx="458640" cy="0"/>
                  </a:xfrm>
                  <a:prstGeom prst="line">
                    <a:avLst/>
                  </a:prstGeom>
                  <a:ln w="19080">
                    <a:solidFill>
                      <a:srgbClr val="6c0000"/>
                    </a:solidFill>
                    <a:miter/>
                    <a:headEnd len="med" type="triangle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80" name="Oval 5"/>
                <p:cNvSpPr/>
                <p:nvPr/>
              </p:nvSpPr>
              <p:spPr>
                <a:xfrm>
                  <a:off x="4772160" y="4013280"/>
                  <a:ext cx="1274760" cy="296640"/>
                </a:xfrm>
                <a:prstGeom prst="ellipse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4c"/>
                      </a:solidFill>
                      <a:latin typeface="Times New Roman"/>
                      <a:ea typeface="Times New Roman"/>
                    </a:rPr>
                    <a:t>Sample Collection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81" name="Group 4"/>
                <p:cNvGrpSpPr/>
                <p:nvPr/>
              </p:nvGrpSpPr>
              <p:grpSpPr>
                <a:xfrm>
                  <a:off x="4870800" y="3958560"/>
                  <a:ext cx="1083240" cy="247680"/>
                  <a:chOff x="4870800" y="3958560"/>
                  <a:chExt cx="1083240" cy="247680"/>
                </a:xfrm>
              </p:grpSpPr>
              <p:sp>
                <p:nvSpPr>
                  <p:cNvPr id="82" name="Freeform 52"/>
                  <p:cNvSpPr/>
                  <p:nvPr/>
                </p:nvSpPr>
                <p:spPr>
                  <a:xfrm flipH="1">
                    <a:off x="5412600" y="3958560"/>
                    <a:ext cx="541080" cy="247680"/>
                  </a:xfrm>
                  <a:custGeom>
                    <a:avLst/>
                    <a:gdLst/>
                    <a:ahLst/>
                    <a:rect l="l" t="t" r="r" b="b"/>
                    <a:pathLst>
                      <a:path w="507492" h="246888">
                        <a:moveTo>
                          <a:pt x="507492" y="0"/>
                        </a:moveTo>
                        <a:cubicBezTo>
                          <a:pt x="401193" y="13716"/>
                          <a:pt x="294894" y="27432"/>
                          <a:pt x="210312" y="68580"/>
                        </a:cubicBezTo>
                        <a:cubicBezTo>
                          <a:pt x="125730" y="109728"/>
                          <a:pt x="62865" y="178308"/>
                          <a:pt x="0" y="246888"/>
                        </a:cubicBezTo>
                      </a:path>
                    </a:pathLst>
                  </a:custGeom>
                  <a:noFill/>
                  <a:ln w="19080">
                    <a:solidFill>
                      <a:srgbClr val="000042"/>
                    </a:solidFill>
                    <a:round/>
                    <a:tailEnd len="med" type="triangle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" name="Freeform 53"/>
                  <p:cNvSpPr/>
                  <p:nvPr/>
                </p:nvSpPr>
                <p:spPr>
                  <a:xfrm>
                    <a:off x="4870800" y="3958560"/>
                    <a:ext cx="542520" cy="236880"/>
                  </a:xfrm>
                  <a:custGeom>
                    <a:avLst/>
                    <a:gdLst/>
                    <a:ahLst/>
                    <a:rect l="l" t="t" r="r" b="b"/>
                    <a:pathLst>
                      <a:path w="507492" h="246888">
                        <a:moveTo>
                          <a:pt x="507492" y="0"/>
                        </a:moveTo>
                        <a:cubicBezTo>
                          <a:pt x="401193" y="13716"/>
                          <a:pt x="294894" y="27432"/>
                          <a:pt x="210312" y="68580"/>
                        </a:cubicBezTo>
                        <a:cubicBezTo>
                          <a:pt x="125730" y="109728"/>
                          <a:pt x="62865" y="178308"/>
                          <a:pt x="0" y="246888"/>
                        </a:cubicBezTo>
                      </a:path>
                    </a:pathLst>
                  </a:custGeom>
                  <a:noFill/>
                  <a:ln w="19080">
                    <a:solidFill>
                      <a:srgbClr val="000042"/>
                    </a:solidFill>
                    <a:round/>
                    <a:tailEnd len="med" type="triangle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84" name="Group 18"/>
                <p:cNvGrpSpPr/>
                <p:nvPr/>
              </p:nvGrpSpPr>
              <p:grpSpPr>
                <a:xfrm>
                  <a:off x="4486680" y="4223880"/>
                  <a:ext cx="302040" cy="567360"/>
                  <a:chOff x="4486680" y="4223880"/>
                  <a:chExt cx="302040" cy="567360"/>
                </a:xfrm>
              </p:grpSpPr>
              <p:grpSp>
                <p:nvGrpSpPr>
                  <p:cNvPr id="85" name="Group 7"/>
                  <p:cNvGrpSpPr/>
                  <p:nvPr/>
                </p:nvGrpSpPr>
                <p:grpSpPr>
                  <a:xfrm>
                    <a:off x="4516920" y="4368960"/>
                    <a:ext cx="246240" cy="422280"/>
                    <a:chOff x="4516920" y="4368960"/>
                    <a:chExt cx="246240" cy="422280"/>
                  </a:xfrm>
                </p:grpSpPr>
                <p:sp>
                  <p:nvSpPr>
                    <p:cNvPr id="86" name="Flowchart: Delay 46"/>
                    <p:cNvSpPr/>
                    <p:nvPr/>
                  </p:nvSpPr>
                  <p:spPr>
                    <a:xfrm rot="5400000">
                      <a:off x="4577040" y="4606920"/>
                      <a:ext cx="123840" cy="244440"/>
                    </a:xfrm>
                    <a:prstGeom prst="flowChartDelay">
                      <a:avLst/>
                    </a:prstGeom>
                    <a:gradFill rotWithShape="0">
                      <a:gsLst>
                        <a:gs pos="0">
                          <a:srgbClr val="770000"/>
                        </a:gs>
                        <a:gs pos="100000">
                          <a:srgbClr val="ce0000"/>
                        </a:gs>
                      </a:gsLst>
                      <a:lin ang="10800000"/>
                    </a:gradFill>
                    <a:ln w="1908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87" name="Rectangle 47"/>
                    <p:cNvSpPr/>
                    <p:nvPr/>
                  </p:nvSpPr>
                  <p:spPr>
                    <a:xfrm>
                      <a:off x="4517280" y="4584960"/>
                      <a:ext cx="244440" cy="133200"/>
                    </a:xfrm>
                    <a:prstGeom prst="rect">
                      <a:avLst/>
                    </a:prstGeom>
                    <a:gradFill rotWithShape="0">
                      <a:gsLst>
                        <a:gs pos="0">
                          <a:srgbClr val="770000"/>
                        </a:gs>
                        <a:gs pos="100000">
                          <a:srgbClr val="ce0000"/>
                        </a:gs>
                      </a:gsLst>
                      <a:lin ang="0"/>
                    </a:gra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88" name="Rectangle 48"/>
                    <p:cNvSpPr/>
                    <p:nvPr/>
                  </p:nvSpPr>
                  <p:spPr>
                    <a:xfrm>
                      <a:off x="4517280" y="4498920"/>
                      <a:ext cx="244440" cy="85680"/>
                    </a:xfrm>
                    <a:prstGeom prst="rect">
                      <a:avLst/>
                    </a:prstGeom>
                    <a:gradFill rotWithShape="0">
                      <a:gsLst>
                        <a:gs pos="0">
                          <a:srgbClr val="770000"/>
                        </a:gs>
                        <a:gs pos="100000">
                          <a:srgbClr val="ce0000"/>
                        </a:gs>
                      </a:gsLst>
                      <a:lin ang="0"/>
                    </a:gra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8880" bIns="3888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89" name="Oval 49"/>
                    <p:cNvSpPr/>
                    <p:nvPr/>
                  </p:nvSpPr>
                  <p:spPr>
                    <a:xfrm>
                      <a:off x="4517280" y="4368960"/>
                      <a:ext cx="245880" cy="34920"/>
                    </a:xfrm>
                    <a:prstGeom prst="ellipse">
                      <a:avLst/>
                    </a:prstGeom>
                    <a:noFill/>
                    <a:ln w="1908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1960" bIns="-219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90" name="Straight Connector 50"/>
                    <p:cNvSpPr/>
                    <p:nvPr/>
                  </p:nvSpPr>
                  <p:spPr>
                    <a:xfrm>
                      <a:off x="4517280" y="4386240"/>
                      <a:ext cx="0" cy="343080"/>
                    </a:xfrm>
                    <a:prstGeom prst="line">
                      <a:avLst/>
                    </a:prstGeom>
                    <a:ln w="1908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91" name="Straight Connector 51"/>
                    <p:cNvSpPr/>
                    <p:nvPr/>
                  </p:nvSpPr>
                  <p:spPr>
                    <a:xfrm>
                      <a:off x="4761720" y="4390920"/>
                      <a:ext cx="0" cy="338400"/>
                    </a:xfrm>
                    <a:prstGeom prst="line">
                      <a:avLst/>
                    </a:prstGeom>
                    <a:ln w="1908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grpSp>
                <p:nvGrpSpPr>
                  <p:cNvPr id="92" name="Group 17"/>
                  <p:cNvGrpSpPr/>
                  <p:nvPr/>
                </p:nvGrpSpPr>
                <p:grpSpPr>
                  <a:xfrm>
                    <a:off x="4486680" y="4223880"/>
                    <a:ext cx="302040" cy="190800"/>
                    <a:chOff x="4486680" y="4223880"/>
                    <a:chExt cx="302040" cy="190800"/>
                  </a:xfrm>
                </p:grpSpPr>
                <p:sp>
                  <p:nvSpPr>
                    <p:cNvPr id="93" name="Oval 44"/>
                    <p:cNvSpPr/>
                    <p:nvPr/>
                  </p:nvSpPr>
                  <p:spPr>
                    <a:xfrm>
                      <a:off x="4486680" y="4223880"/>
                      <a:ext cx="302040" cy="29880"/>
                    </a:xfrm>
                    <a:prstGeom prst="ellipse">
                      <a:avLst/>
                    </a:prstGeom>
                    <a:solidFill>
                      <a:srgbClr val="b3a2c7"/>
                    </a:solidFill>
                    <a:ln w="19080">
                      <a:solidFill>
                        <a:srgbClr val="604a7b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560" bIns="-255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94" name="Rounded Rectangle 45"/>
                    <p:cNvSpPr/>
                    <p:nvPr/>
                  </p:nvSpPr>
                  <p:spPr>
                    <a:xfrm>
                      <a:off x="4486680" y="4253760"/>
                      <a:ext cx="302040" cy="160920"/>
                    </a:xfrm>
                    <a:prstGeom prst="roundRect">
                      <a:avLst>
                        <a:gd name="adj" fmla="val 16667"/>
                      </a:avLst>
                    </a:prstGeom>
                    <a:solidFill>
                      <a:srgbClr val="b3a2c7"/>
                    </a:solidFill>
                    <a:ln w="19080">
                      <a:solidFill>
                        <a:srgbClr val="604a7b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</p:grpSp>
            <p:sp>
              <p:nvSpPr>
                <p:cNvPr id="95" name="TextBox 62"/>
                <p:cNvSpPr/>
                <p:nvPr/>
              </p:nvSpPr>
              <p:spPr>
                <a:xfrm flipH="1">
                  <a:off x="3858840" y="4792320"/>
                  <a:ext cx="163764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c00000"/>
                      </a:solidFill>
                      <a:latin typeface="Times New Roman"/>
                      <a:ea typeface="Times New Roman"/>
                    </a:rPr>
                    <a:t>Blood Collection </a:t>
                  </a:r>
                  <a:r>
                    <a:rPr b="1" lang="en-IN" sz="800" spc="-1" strike="noStrike" u="sng">
                      <a:solidFill>
                        <a:srgbClr val="c00000"/>
                      </a:solidFill>
                      <a:uFillTx/>
                      <a:latin typeface="Times New Roman"/>
                      <a:ea typeface="Times New Roman"/>
                    </a:rPr>
                    <a:t>prior to primary debulking surgery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6" name="TextBox 9"/>
                <p:cNvSpPr/>
                <p:nvPr/>
              </p:nvSpPr>
              <p:spPr>
                <a:xfrm flipH="1">
                  <a:off x="5553000" y="4710600"/>
                  <a:ext cx="1591560" cy="459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ff742f"/>
                      </a:solidFill>
                      <a:latin typeface="Times New Roman"/>
                      <a:ea typeface="Times New Roman"/>
                    </a:rPr>
                    <a:t>Collection of tumor samples from patients </a:t>
                  </a:r>
                  <a:r>
                    <a:rPr b="1" lang="en-IN" sz="800" spc="-1" strike="noStrike" u="sng">
                      <a:solidFill>
                        <a:srgbClr val="ff742f"/>
                      </a:solidFill>
                      <a:uFillTx/>
                      <a:latin typeface="Times New Roman"/>
                      <a:ea typeface="Times New Roman"/>
                    </a:rPr>
                    <a:t>following</a:t>
                  </a:r>
                  <a:r>
                    <a:rPr b="1" lang="en-IN" sz="800" spc="-1" strike="noStrike">
                      <a:solidFill>
                        <a:srgbClr val="ff742f"/>
                      </a:solidFill>
                      <a:latin typeface="Times New Roman"/>
                      <a:ea typeface="Times New Roman"/>
                    </a:rPr>
                    <a:t> </a:t>
                  </a:r>
                  <a:r>
                    <a:rPr b="1" lang="en-IN" sz="800" spc="-1" strike="noStrike" u="sng">
                      <a:solidFill>
                        <a:srgbClr val="ff742f"/>
                      </a:solidFill>
                      <a:uFillTx/>
                      <a:latin typeface="Times New Roman"/>
                      <a:ea typeface="Times New Roman"/>
                    </a:rPr>
                    <a:t>primary debulking surgery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7" name="TextBox 32"/>
                <p:cNvSpPr/>
                <p:nvPr/>
              </p:nvSpPr>
              <p:spPr>
                <a:xfrm>
                  <a:off x="847440" y="474840"/>
                  <a:ext cx="6329880" cy="398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1000" spc="-1" strike="noStrike">
                      <a:solidFill>
                        <a:srgbClr val="00004c"/>
                      </a:solidFill>
                      <a:latin typeface="Times New Roman"/>
                      <a:ea typeface="Times New Roman"/>
                    </a:rPr>
                    <a:t>Prediction of Platinum Therapy Response in High Grade Serous Ovarian Cancer Cases with reference to  Cholesterol Enrichment and PI3K/Akt/mTOR Pathway Deregulations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8" name="Straight Connector 11"/>
                <p:cNvSpPr/>
                <p:nvPr/>
              </p:nvSpPr>
              <p:spPr>
                <a:xfrm flipV="1">
                  <a:off x="3797280" y="828720"/>
                  <a:ext cx="0" cy="290160"/>
                </a:xfrm>
                <a:prstGeom prst="line">
                  <a:avLst/>
                </a:prstGeom>
                <a:ln w="19080">
                  <a:solidFill>
                    <a:srgbClr val="000066"/>
                  </a:solidFill>
                  <a:miter/>
                  <a:head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9" name="Straight Connector 13"/>
                <p:cNvSpPr/>
                <p:nvPr/>
              </p:nvSpPr>
              <p:spPr>
                <a:xfrm flipV="1">
                  <a:off x="2695680" y="5084640"/>
                  <a:ext cx="0" cy="222120"/>
                </a:xfrm>
                <a:prstGeom prst="line">
                  <a:avLst/>
                </a:prstGeom>
                <a:ln w="12600">
                  <a:solidFill>
                    <a:srgbClr val="884106"/>
                  </a:solidFill>
                  <a:prstDash val="sysDash"/>
                  <a:miter/>
                  <a:head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0" name="TextBox 72"/>
                <p:cNvSpPr/>
                <p:nvPr/>
              </p:nvSpPr>
              <p:spPr>
                <a:xfrm>
                  <a:off x="841320" y="4878720"/>
                  <a:ext cx="720000" cy="215640"/>
                </a:xfrm>
                <a:prstGeom prst="rect">
                  <a:avLst/>
                </a:prstGeom>
                <a:noFill/>
                <a:ln w="12600">
                  <a:solidFill>
                    <a:srgbClr val="c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c00000"/>
                      </a:solidFill>
                      <a:latin typeface="Times New Roman"/>
                      <a:ea typeface="Times New Roman"/>
                    </a:rPr>
                    <a:t>Blood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1" name="TextBox 73"/>
                <p:cNvSpPr/>
                <p:nvPr/>
              </p:nvSpPr>
              <p:spPr>
                <a:xfrm flipH="1">
                  <a:off x="479520" y="3913560"/>
                  <a:ext cx="15876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4c"/>
                      </a:solidFill>
                      <a:latin typeface="Times New Roman"/>
                      <a:ea typeface="Times New Roman"/>
                    </a:rPr>
                    <a:t>Normal Volunteer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2" name="TextBox 75"/>
                <p:cNvSpPr/>
                <p:nvPr/>
              </p:nvSpPr>
              <p:spPr>
                <a:xfrm flipH="1">
                  <a:off x="1764000" y="3907440"/>
                  <a:ext cx="15876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4c"/>
                      </a:solidFill>
                      <a:latin typeface="Times New Roman"/>
                      <a:ea typeface="Times New Roman"/>
                    </a:rPr>
                    <a:t>Other Cancer Subject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3" name="Rectangle 19"/>
                <p:cNvSpPr/>
                <p:nvPr/>
              </p:nvSpPr>
              <p:spPr>
                <a:xfrm>
                  <a:off x="1116000" y="3502080"/>
                  <a:ext cx="1658880" cy="287280"/>
                </a:xfrm>
                <a:prstGeom prst="rect">
                  <a:avLst/>
                </a:prstGeom>
                <a:solidFill>
                  <a:srgbClr val="dbeef4"/>
                </a:solidFill>
                <a:ln w="12600">
                  <a:solidFill>
                    <a:srgbClr val="10253f"/>
                  </a:solidFill>
                  <a:prstDash val="sysDash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10253f"/>
                      </a:solidFill>
                      <a:latin typeface="Times New Roman"/>
                      <a:ea typeface="Times New Roman"/>
                    </a:rPr>
                    <a:t>References Only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4" name="Freeform 20"/>
                <p:cNvSpPr/>
                <p:nvPr/>
              </p:nvSpPr>
              <p:spPr>
                <a:xfrm rot="239400">
                  <a:off x="1103400" y="3768840"/>
                  <a:ext cx="539640" cy="236520"/>
                </a:xfrm>
                <a:custGeom>
                  <a:avLst/>
                  <a:gdLst/>
                  <a:ahLst/>
                  <a:rect l="l" t="t" r="r" b="b"/>
                  <a:pathLst>
                    <a:path w="507492" h="246888">
                      <a:moveTo>
                        <a:pt x="507492" y="0"/>
                      </a:moveTo>
                      <a:cubicBezTo>
                        <a:pt x="401193" y="13716"/>
                        <a:pt x="294894" y="27432"/>
                        <a:pt x="210312" y="68580"/>
                      </a:cubicBezTo>
                      <a:cubicBezTo>
                        <a:pt x="125730" y="109728"/>
                        <a:pt x="62865" y="178308"/>
                        <a:pt x="0" y="246888"/>
                      </a:cubicBezTo>
                    </a:path>
                  </a:pathLst>
                </a:custGeom>
                <a:noFill/>
                <a:ln w="12600">
                  <a:solidFill>
                    <a:srgbClr val="10253f"/>
                  </a:solidFill>
                  <a:prstDash val="sysDash"/>
                  <a:round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5" name="Freeform 21"/>
                <p:cNvSpPr/>
                <p:nvPr/>
              </p:nvSpPr>
              <p:spPr>
                <a:xfrm flipH="1" rot="21372600">
                  <a:off x="2219760" y="3772080"/>
                  <a:ext cx="555480" cy="214200"/>
                </a:xfrm>
                <a:custGeom>
                  <a:avLst/>
                  <a:gdLst/>
                  <a:ahLst/>
                  <a:rect l="l" t="t" r="r" b="b"/>
                  <a:pathLst>
                    <a:path w="507492" h="246888">
                      <a:moveTo>
                        <a:pt x="507492" y="0"/>
                      </a:moveTo>
                      <a:cubicBezTo>
                        <a:pt x="401193" y="13716"/>
                        <a:pt x="294894" y="27432"/>
                        <a:pt x="210312" y="68580"/>
                      </a:cubicBezTo>
                      <a:cubicBezTo>
                        <a:pt x="125730" y="109728"/>
                        <a:pt x="62865" y="178308"/>
                        <a:pt x="0" y="246888"/>
                      </a:cubicBezTo>
                    </a:path>
                  </a:pathLst>
                </a:custGeom>
                <a:noFill/>
                <a:ln w="12600">
                  <a:solidFill>
                    <a:srgbClr val="10253f"/>
                  </a:solidFill>
                  <a:prstDash val="sysDash"/>
                  <a:round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6" name="Freeform 22"/>
                <p:cNvSpPr/>
                <p:nvPr/>
              </p:nvSpPr>
              <p:spPr>
                <a:xfrm>
                  <a:off x="1562040" y="4543560"/>
                  <a:ext cx="853920" cy="323640"/>
                </a:xfrm>
                <a:custGeom>
                  <a:avLst/>
                  <a:gdLst/>
                  <a:ahLst/>
                  <a:rect l="l" t="t" r="r" b="b"/>
                  <a:pathLst>
                    <a:path w="507492" h="246888">
                      <a:moveTo>
                        <a:pt x="507492" y="0"/>
                      </a:moveTo>
                      <a:cubicBezTo>
                        <a:pt x="401193" y="13716"/>
                        <a:pt x="294894" y="27432"/>
                        <a:pt x="210312" y="68580"/>
                      </a:cubicBezTo>
                      <a:cubicBezTo>
                        <a:pt x="125730" y="109728"/>
                        <a:pt x="62865" y="178308"/>
                        <a:pt x="0" y="246888"/>
                      </a:cubicBezTo>
                    </a:path>
                  </a:pathLst>
                </a:custGeom>
                <a:noFill/>
                <a:ln w="12600">
                  <a:solidFill>
                    <a:srgbClr val="c00000"/>
                  </a:solidFill>
                  <a:prstDash val="sysDash"/>
                  <a:round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7" name="Straight Connector 23"/>
                <p:cNvSpPr/>
                <p:nvPr/>
              </p:nvSpPr>
              <p:spPr>
                <a:xfrm flipV="1">
                  <a:off x="1208160" y="4643280"/>
                  <a:ext cx="0" cy="223560"/>
                </a:xfrm>
                <a:prstGeom prst="line">
                  <a:avLst/>
                </a:prstGeom>
                <a:ln w="12600">
                  <a:solidFill>
                    <a:srgbClr val="c00000"/>
                  </a:solidFill>
                  <a:prstDash val="sysDash"/>
                  <a:miter/>
                  <a:head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8" name="TextBox 24"/>
                <p:cNvSpPr/>
                <p:nvPr/>
              </p:nvSpPr>
              <p:spPr>
                <a:xfrm>
                  <a:off x="1989000" y="4869000"/>
                  <a:ext cx="1396800" cy="215640"/>
                </a:xfrm>
                <a:prstGeom prst="rect">
                  <a:avLst/>
                </a:prstGeom>
                <a:noFill/>
                <a:ln w="12600">
                  <a:solidFill>
                    <a:srgbClr val="ff742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ff742f"/>
                      </a:solidFill>
                      <a:latin typeface="Times New Roman"/>
                      <a:ea typeface="Times New Roman"/>
                    </a:rPr>
                    <a:t>Normal Ovarian Tissue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9" name="Straight Connector 25"/>
                <p:cNvSpPr/>
                <p:nvPr/>
              </p:nvSpPr>
              <p:spPr>
                <a:xfrm flipV="1">
                  <a:off x="2695680" y="4635360"/>
                  <a:ext cx="0" cy="222120"/>
                </a:xfrm>
                <a:prstGeom prst="line">
                  <a:avLst/>
                </a:prstGeom>
                <a:ln w="12600">
                  <a:solidFill>
                    <a:srgbClr val="c00000"/>
                  </a:solidFill>
                  <a:prstDash val="sysDash"/>
                  <a:miter/>
                  <a:head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0" name="TextBox 90"/>
                <p:cNvSpPr/>
                <p:nvPr/>
              </p:nvSpPr>
              <p:spPr>
                <a:xfrm>
                  <a:off x="616680" y="5276160"/>
                  <a:ext cx="1210320" cy="824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884106"/>
                      </a:solidFill>
                      <a:latin typeface="Times New Roman"/>
                      <a:ea typeface="Times New Roman"/>
                    </a:rPr>
                    <a:t>Cohort Separation based on a Diverse Reference Range of Blood Cholesterol Titre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1" name="TextBox 93"/>
                <p:cNvSpPr/>
                <p:nvPr/>
              </p:nvSpPr>
              <p:spPr>
                <a:xfrm>
                  <a:off x="1921680" y="5306760"/>
                  <a:ext cx="1550520" cy="580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884106"/>
                      </a:solidFill>
                      <a:latin typeface="Times New Roman"/>
                      <a:ea typeface="Times New Roman"/>
                    </a:rPr>
                    <a:t>Establishing Reference Range for Comparative Assessment of Cholesterol Abundance in Tissues 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2" name="TextBox 3"/>
                <p:cNvSpPr/>
                <p:nvPr/>
              </p:nvSpPr>
              <p:spPr>
                <a:xfrm flipH="1">
                  <a:off x="885240" y="1524600"/>
                  <a:ext cx="6537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d1d31"/>
                      </a:solidFill>
                      <a:latin typeface="Times New Roman"/>
                      <a:ea typeface="Times New Roman"/>
                    </a:rPr>
                    <a:t>Serous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3" name="TextBox 3"/>
                <p:cNvSpPr/>
                <p:nvPr/>
              </p:nvSpPr>
              <p:spPr>
                <a:xfrm flipH="1">
                  <a:off x="1563120" y="1616760"/>
                  <a:ext cx="6537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d1d31"/>
                      </a:solidFill>
                      <a:latin typeface="Times New Roman"/>
                      <a:ea typeface="Times New Roman"/>
                    </a:rPr>
                    <a:t>Mucinous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4" name="TextBox 3"/>
                <p:cNvSpPr/>
                <p:nvPr/>
              </p:nvSpPr>
              <p:spPr>
                <a:xfrm flipH="1">
                  <a:off x="1789200" y="1270440"/>
                  <a:ext cx="6537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d1d31"/>
                      </a:solidFill>
                      <a:latin typeface="Times New Roman"/>
                      <a:ea typeface="Times New Roman"/>
                    </a:rPr>
                    <a:t>Serous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5" name="TextBox 3"/>
                <p:cNvSpPr/>
                <p:nvPr/>
              </p:nvSpPr>
              <p:spPr>
                <a:xfrm flipH="1">
                  <a:off x="1179360" y="1121400"/>
                  <a:ext cx="6537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d1d31"/>
                      </a:solidFill>
                      <a:latin typeface="Times New Roman"/>
                      <a:ea typeface="Times New Roman"/>
                    </a:rPr>
                    <a:t>Mucinous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6" name="TextBox 3"/>
                <p:cNvSpPr/>
                <p:nvPr/>
              </p:nvSpPr>
              <p:spPr>
                <a:xfrm flipH="1">
                  <a:off x="2084760" y="1587960"/>
                  <a:ext cx="6537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d1d31"/>
                      </a:solidFill>
                      <a:latin typeface="Times New Roman"/>
                      <a:ea typeface="Times New Roman"/>
                    </a:rPr>
                    <a:t>HGSOC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7" name="TextBox 3"/>
                <p:cNvSpPr/>
                <p:nvPr/>
              </p:nvSpPr>
              <p:spPr>
                <a:xfrm flipH="1">
                  <a:off x="2247840" y="1740600"/>
                  <a:ext cx="6537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d1d31"/>
                      </a:solidFill>
                      <a:latin typeface="Times New Roman"/>
                      <a:ea typeface="Times New Roman"/>
                    </a:rPr>
                    <a:t>HGSOC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8" name="TextBox 3"/>
                <p:cNvSpPr/>
                <p:nvPr/>
              </p:nvSpPr>
              <p:spPr>
                <a:xfrm flipH="1">
                  <a:off x="2261520" y="1307160"/>
                  <a:ext cx="6537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d1d31"/>
                      </a:solidFill>
                      <a:latin typeface="Times New Roman"/>
                      <a:ea typeface="Times New Roman"/>
                    </a:rPr>
                    <a:t>HGSOC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9" name="TextBox 3"/>
                <p:cNvSpPr/>
                <p:nvPr/>
              </p:nvSpPr>
              <p:spPr>
                <a:xfrm flipH="1">
                  <a:off x="2424600" y="1459440"/>
                  <a:ext cx="6537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d1d31"/>
                      </a:solidFill>
                      <a:latin typeface="Times New Roman"/>
                      <a:ea typeface="Times New Roman"/>
                    </a:rPr>
                    <a:t>HGSOC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0" name="TextBox 3"/>
                <p:cNvSpPr/>
                <p:nvPr/>
              </p:nvSpPr>
              <p:spPr>
                <a:xfrm flipH="1">
                  <a:off x="2732040" y="1203840"/>
                  <a:ext cx="6537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d1d31"/>
                      </a:solidFill>
                      <a:latin typeface="Times New Roman"/>
                      <a:ea typeface="Times New Roman"/>
                    </a:rPr>
                    <a:t>HGSOC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1" name="TextBox 3"/>
                <p:cNvSpPr/>
                <p:nvPr/>
              </p:nvSpPr>
              <p:spPr>
                <a:xfrm flipH="1">
                  <a:off x="2711520" y="1587960"/>
                  <a:ext cx="6537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d1d31"/>
                      </a:solidFill>
                      <a:latin typeface="Times New Roman"/>
                      <a:ea typeface="Times New Roman"/>
                    </a:rPr>
                    <a:t>HGSOC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" name="Oval 39"/>
                <p:cNvSpPr/>
                <p:nvPr/>
              </p:nvSpPr>
              <p:spPr>
                <a:xfrm>
                  <a:off x="2044800" y="1120680"/>
                  <a:ext cx="1555560" cy="2087280"/>
                </a:xfrm>
                <a:prstGeom prst="ellipse">
                  <a:avLst/>
                </a:prstGeom>
                <a:solidFill>
                  <a:srgbClr val="558ed5">
                    <a:alpha val="10000"/>
                  </a:srgbClr>
                </a:solidFill>
                <a:ln w="12600">
                  <a:solidFill>
                    <a:srgbClr val="000042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3" name="TextBox 3"/>
                <p:cNvSpPr/>
                <p:nvPr/>
              </p:nvSpPr>
              <p:spPr>
                <a:xfrm flipH="1">
                  <a:off x="3740400" y="3731760"/>
                  <a:ext cx="33447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4c"/>
                      </a:solidFill>
                      <a:latin typeface="Times New Roman"/>
                      <a:ea typeface="Times New Roman"/>
                    </a:rPr>
                    <a:t>HGSOC Patients to be taken for </a:t>
                  </a:r>
                  <a:r>
                    <a:rPr b="1" lang="en-IN" sz="800" spc="-1" strike="noStrike" u="sng">
                      <a:solidFill>
                        <a:srgbClr val="00004c"/>
                      </a:solidFill>
                      <a:uFillTx/>
                      <a:latin typeface="Times New Roman"/>
                      <a:ea typeface="Times New Roman"/>
                    </a:rPr>
                    <a:t>Primary Debulking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124" name="Freeform 41"/>
                <p:cNvGrpSpPr/>
                <p:nvPr/>
              </p:nvGrpSpPr>
              <p:grpSpPr>
                <a:xfrm>
                  <a:off x="5766840" y="4181760"/>
                  <a:ext cx="810720" cy="493560"/>
                  <a:chOff x="5766840" y="4181760"/>
                  <a:chExt cx="810720" cy="493560"/>
                </a:xfrm>
              </p:grpSpPr>
              <p:pic>
                <p:nvPicPr>
                  <p:cNvPr id="125" name="Freeform 41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5766840" y="4181760"/>
                    <a:ext cx="810720" cy="493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126" name=""/>
                  <p:cNvSpPr/>
                  <p:nvPr/>
                </p:nvSpPr>
                <p:spPr>
                  <a:xfrm>
                    <a:off x="5774760" y="4188240"/>
                    <a:ext cx="796320" cy="483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pic>
            <p:nvPicPr>
              <p:cNvPr id="127" name="Picture 87" descr=""/>
              <p:cNvPicPr/>
              <p:nvPr/>
            </p:nvPicPr>
            <p:blipFill>
              <a:blip r:embed="rId4"/>
              <a:srcRect l="69695" t="0" r="3070" b="72988"/>
              <a:stretch/>
            </p:blipFill>
            <p:spPr>
              <a:xfrm>
                <a:off x="891360" y="4096800"/>
                <a:ext cx="632160" cy="552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8" name="Picture 87" descr=""/>
              <p:cNvPicPr/>
              <p:nvPr/>
            </p:nvPicPr>
            <p:blipFill>
              <a:blip r:embed="rId5"/>
              <a:srcRect l="34002" t="0" r="33002" b="72988"/>
              <a:stretch/>
            </p:blipFill>
            <p:spPr>
              <a:xfrm>
                <a:off x="2379240" y="4072680"/>
                <a:ext cx="633600" cy="552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9" name="Rectangle 1"/>
              <p:cNvSpPr/>
              <p:nvPr/>
            </p:nvSpPr>
            <p:spPr>
              <a:xfrm>
                <a:off x="4406400" y="5375880"/>
                <a:ext cx="2160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800" spc="-1" strike="noStrike">
                    <a:solidFill>
                      <a:srgbClr val="884106"/>
                    </a:solidFill>
                    <a:latin typeface="Times New Roman"/>
                    <a:ea typeface="Times New Roman"/>
                  </a:rPr>
                  <a:t>For Cohort Specific Cholesterol Estimation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" name="Freeform 83"/>
              <p:cNvSpPr/>
              <p:nvPr/>
            </p:nvSpPr>
            <p:spPr>
              <a:xfrm flipH="1">
                <a:off x="5453280" y="5122800"/>
                <a:ext cx="542880" cy="247320"/>
              </a:xfrm>
              <a:custGeom>
                <a:avLst/>
                <a:gdLst/>
                <a:ahLst/>
                <a:rect l="l" t="t" r="r" b="b"/>
                <a:pathLst>
                  <a:path w="507492" h="246888">
                    <a:moveTo>
                      <a:pt x="507492" y="0"/>
                    </a:moveTo>
                    <a:cubicBezTo>
                      <a:pt x="401193" y="13716"/>
                      <a:pt x="294894" y="27432"/>
                      <a:pt x="210312" y="68580"/>
                    </a:cubicBezTo>
                    <a:cubicBezTo>
                      <a:pt x="125730" y="109728"/>
                      <a:pt x="62865" y="178308"/>
                      <a:pt x="0" y="246888"/>
                    </a:cubicBezTo>
                  </a:path>
                </a:pathLst>
              </a:custGeom>
              <a:noFill/>
              <a:ln w="19080">
                <a:solidFill>
                  <a:srgbClr val="884106"/>
                </a:solidFill>
                <a:round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Freeform 84"/>
              <p:cNvSpPr/>
              <p:nvPr/>
            </p:nvSpPr>
            <p:spPr>
              <a:xfrm>
                <a:off x="4910400" y="5122800"/>
                <a:ext cx="542880" cy="236520"/>
              </a:xfrm>
              <a:custGeom>
                <a:avLst/>
                <a:gdLst/>
                <a:ahLst/>
                <a:rect l="l" t="t" r="r" b="b"/>
                <a:pathLst>
                  <a:path w="507492" h="246888">
                    <a:moveTo>
                      <a:pt x="507492" y="0"/>
                    </a:moveTo>
                    <a:cubicBezTo>
                      <a:pt x="401193" y="13716"/>
                      <a:pt x="294894" y="27432"/>
                      <a:pt x="210312" y="68580"/>
                    </a:cubicBezTo>
                    <a:cubicBezTo>
                      <a:pt x="125730" y="109728"/>
                      <a:pt x="62865" y="178308"/>
                      <a:pt x="0" y="246888"/>
                    </a:cubicBezTo>
                  </a:path>
                </a:pathLst>
              </a:custGeom>
              <a:noFill/>
              <a:ln w="19080">
                <a:solidFill>
                  <a:srgbClr val="884106"/>
                </a:solidFill>
                <a:round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32" name="Straight Connector 87"/>
            <p:cNvSpPr/>
            <p:nvPr/>
          </p:nvSpPr>
          <p:spPr>
            <a:xfrm flipV="1">
              <a:off x="1184040" y="5097240"/>
              <a:ext cx="0" cy="222120"/>
            </a:xfrm>
            <a:prstGeom prst="line">
              <a:avLst/>
            </a:prstGeom>
            <a:ln w="12600">
              <a:solidFill>
                <a:srgbClr val="884106"/>
              </a:solidFill>
              <a:prstDash val="sysDash"/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Straight Connector 88"/>
            <p:cNvSpPr/>
            <p:nvPr/>
          </p:nvSpPr>
          <p:spPr>
            <a:xfrm flipH="1">
              <a:off x="3512880" y="5481720"/>
              <a:ext cx="952200" cy="0"/>
            </a:xfrm>
            <a:prstGeom prst="line">
              <a:avLst/>
            </a:prstGeom>
            <a:ln w="12600">
              <a:solidFill>
                <a:srgbClr val="632523"/>
              </a:solidFill>
              <a:prstDash val="sysDash"/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4" name="TextBox 117"/>
          <p:cNvSpPr/>
          <p:nvPr/>
        </p:nvSpPr>
        <p:spPr>
          <a:xfrm>
            <a:off x="1440" y="9680400"/>
            <a:ext cx="1436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Box 40"/>
          <p:cNvSpPr/>
          <p:nvPr/>
        </p:nvSpPr>
        <p:spPr>
          <a:xfrm>
            <a:off x="176040" y="546120"/>
            <a:ext cx="32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1" lang="en-IN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6" name="Group 3"/>
          <p:cNvGrpSpPr/>
          <p:nvPr/>
        </p:nvGrpSpPr>
        <p:grpSpPr>
          <a:xfrm>
            <a:off x="239760" y="6372360"/>
            <a:ext cx="2112840" cy="2095200"/>
            <a:chOff x="239760" y="6372360"/>
            <a:chExt cx="2112840" cy="2095200"/>
          </a:xfrm>
        </p:grpSpPr>
        <p:grpSp>
          <p:nvGrpSpPr>
            <p:cNvPr id="137" name="Group 2"/>
            <p:cNvGrpSpPr/>
            <p:nvPr/>
          </p:nvGrpSpPr>
          <p:grpSpPr>
            <a:xfrm>
              <a:off x="239760" y="6372360"/>
              <a:ext cx="2112840" cy="2095200"/>
              <a:chOff x="239760" y="6372360"/>
              <a:chExt cx="2112840" cy="2095200"/>
            </a:xfrm>
          </p:grpSpPr>
          <p:grpSp>
            <p:nvGrpSpPr>
              <p:cNvPr id="138" name="Group 1"/>
              <p:cNvGrpSpPr/>
              <p:nvPr/>
            </p:nvGrpSpPr>
            <p:grpSpPr>
              <a:xfrm>
                <a:off x="495000" y="6372360"/>
                <a:ext cx="1857600" cy="2095200"/>
                <a:chOff x="495000" y="6372360"/>
                <a:chExt cx="1857600" cy="2095200"/>
              </a:xfrm>
            </p:grpSpPr>
            <p:pic>
              <p:nvPicPr>
                <p:cNvPr id="139" name="Picture 88" descr="C:\Users\ELIZABETH\Desktop\OVARIAN CANCER COMPLETE FOLDER\Canvas Final Images\Figure S1B_page-0001.jpg"/>
                <p:cNvPicPr/>
                <p:nvPr/>
              </p:nvPicPr>
              <p:blipFill>
                <a:blip r:embed="rId6"/>
                <a:srcRect l="21875" t="30985" r="37340" b="36950"/>
                <a:stretch/>
              </p:blipFill>
              <p:spPr>
                <a:xfrm>
                  <a:off x="495000" y="6372360"/>
                  <a:ext cx="1857600" cy="20952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40" name="TextBox 105"/>
                <p:cNvSpPr/>
                <p:nvPr/>
              </p:nvSpPr>
              <p:spPr>
                <a:xfrm>
                  <a:off x="1827720" y="6812280"/>
                  <a:ext cx="462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**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1" name="TextBox 107"/>
                <p:cNvSpPr/>
                <p:nvPr/>
              </p:nvSpPr>
              <p:spPr>
                <a:xfrm>
                  <a:off x="725400" y="7333200"/>
                  <a:ext cx="462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**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2" name="TextBox 106"/>
                <p:cNvSpPr/>
                <p:nvPr/>
              </p:nvSpPr>
              <p:spPr>
                <a:xfrm>
                  <a:off x="1265760" y="7261200"/>
                  <a:ext cx="462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***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43" name="TextBox 5123"/>
              <p:cNvSpPr/>
              <p:nvPr/>
            </p:nvSpPr>
            <p:spPr>
              <a:xfrm flipH="1" flipV="1" rot="5400000">
                <a:off x="-393480" y="7180920"/>
                <a:ext cx="16034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otal Plasma Cholesterol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(Fold Change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44" name="TextBox 40"/>
            <p:cNvSpPr/>
            <p:nvPr/>
          </p:nvSpPr>
          <p:spPr>
            <a:xfrm>
              <a:off x="337680" y="6431400"/>
              <a:ext cx="241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45" name="Group 7"/>
          <p:cNvGrpSpPr/>
          <p:nvPr/>
        </p:nvGrpSpPr>
        <p:grpSpPr>
          <a:xfrm>
            <a:off x="5253120" y="6437160"/>
            <a:ext cx="2090520" cy="2183040"/>
            <a:chOff x="5253120" y="6437160"/>
            <a:chExt cx="2090520" cy="2183040"/>
          </a:xfrm>
        </p:grpSpPr>
        <p:grpSp>
          <p:nvGrpSpPr>
            <p:cNvPr id="146" name="Group 6"/>
            <p:cNvGrpSpPr/>
            <p:nvPr/>
          </p:nvGrpSpPr>
          <p:grpSpPr>
            <a:xfrm>
              <a:off x="5310000" y="6437160"/>
              <a:ext cx="2033640" cy="2183040"/>
              <a:chOff x="5310000" y="6437160"/>
              <a:chExt cx="2033640" cy="2183040"/>
            </a:xfrm>
          </p:grpSpPr>
          <p:grpSp>
            <p:nvGrpSpPr>
              <p:cNvPr id="147" name="Group 4"/>
              <p:cNvGrpSpPr/>
              <p:nvPr/>
            </p:nvGrpSpPr>
            <p:grpSpPr>
              <a:xfrm>
                <a:off x="5310000" y="6437160"/>
                <a:ext cx="2033640" cy="2183040"/>
                <a:chOff x="5310000" y="6437160"/>
                <a:chExt cx="2033640" cy="2183040"/>
              </a:xfrm>
            </p:grpSpPr>
            <p:pic>
              <p:nvPicPr>
                <p:cNvPr id="148" name="Picture 89" descr="C:\Users\ELIZABETH\Desktop\OVARIAN CANCER COMPLETE FOLDER\Canvas Final Images\Figure S1C_page-0001.jpg"/>
                <p:cNvPicPr/>
                <p:nvPr/>
              </p:nvPicPr>
              <p:blipFill>
                <a:blip r:embed="rId7"/>
                <a:srcRect l="18756" t="31620" r="34736" b="30444"/>
                <a:stretch/>
              </p:blipFill>
              <p:spPr>
                <a:xfrm>
                  <a:off x="5484240" y="6437160"/>
                  <a:ext cx="1859400" cy="21830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49" name="TextBox 5123"/>
                <p:cNvSpPr/>
                <p:nvPr/>
              </p:nvSpPr>
              <p:spPr>
                <a:xfrm flipH="1" flipV="1" rot="5400000">
                  <a:off x="4735080" y="7136280"/>
                  <a:ext cx="148644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Total Tissue Cholesterol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(Fold Change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50" name="TextBox 107"/>
              <p:cNvSpPr/>
              <p:nvPr/>
            </p:nvSpPr>
            <p:spPr>
              <a:xfrm>
                <a:off x="5697000" y="6824880"/>
                <a:ext cx="462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1" name="TextBox 108"/>
              <p:cNvSpPr/>
              <p:nvPr/>
            </p:nvSpPr>
            <p:spPr>
              <a:xfrm>
                <a:off x="6687360" y="6703560"/>
                <a:ext cx="462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*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2" name="TextBox 109"/>
              <p:cNvSpPr/>
              <p:nvPr/>
            </p:nvSpPr>
            <p:spPr>
              <a:xfrm>
                <a:off x="6215400" y="6830640"/>
                <a:ext cx="462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*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53" name="TextBox 40"/>
            <p:cNvSpPr/>
            <p:nvPr/>
          </p:nvSpPr>
          <p:spPr>
            <a:xfrm>
              <a:off x="5253120" y="6467760"/>
              <a:ext cx="241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54" name="Group 5164"/>
          <p:cNvGrpSpPr/>
          <p:nvPr/>
        </p:nvGrpSpPr>
        <p:grpSpPr>
          <a:xfrm>
            <a:off x="2662200" y="5819040"/>
            <a:ext cx="2270160" cy="3506040"/>
            <a:chOff x="2662200" y="5819040"/>
            <a:chExt cx="2270160" cy="3506040"/>
          </a:xfrm>
        </p:grpSpPr>
        <p:grpSp>
          <p:nvGrpSpPr>
            <p:cNvPr id="155" name="Group 29"/>
            <p:cNvGrpSpPr/>
            <p:nvPr/>
          </p:nvGrpSpPr>
          <p:grpSpPr>
            <a:xfrm>
              <a:off x="2662200" y="5819040"/>
              <a:ext cx="2270160" cy="3506040"/>
              <a:chOff x="2662200" y="5819040"/>
              <a:chExt cx="2270160" cy="3506040"/>
            </a:xfrm>
          </p:grpSpPr>
          <p:grpSp>
            <p:nvGrpSpPr>
              <p:cNvPr id="156" name="Group 18"/>
              <p:cNvGrpSpPr/>
              <p:nvPr/>
            </p:nvGrpSpPr>
            <p:grpSpPr>
              <a:xfrm>
                <a:off x="2662200" y="5819040"/>
                <a:ext cx="2270160" cy="3506040"/>
                <a:chOff x="2662200" y="5819040"/>
                <a:chExt cx="2270160" cy="3506040"/>
              </a:xfrm>
            </p:grpSpPr>
            <p:grpSp>
              <p:nvGrpSpPr>
                <p:cNvPr id="157" name="Group 10"/>
                <p:cNvGrpSpPr/>
                <p:nvPr/>
              </p:nvGrpSpPr>
              <p:grpSpPr>
                <a:xfrm>
                  <a:off x="3008160" y="7570080"/>
                  <a:ext cx="1916280" cy="1755000"/>
                  <a:chOff x="3008160" y="7570080"/>
                  <a:chExt cx="1916280" cy="1755000"/>
                </a:xfrm>
              </p:grpSpPr>
              <p:grpSp>
                <p:nvGrpSpPr>
                  <p:cNvPr id="158" name="Group 9"/>
                  <p:cNvGrpSpPr/>
                  <p:nvPr/>
                </p:nvGrpSpPr>
                <p:grpSpPr>
                  <a:xfrm>
                    <a:off x="3008160" y="7570080"/>
                    <a:ext cx="1916280" cy="909000"/>
                    <a:chOff x="3008160" y="7570080"/>
                    <a:chExt cx="1916280" cy="909000"/>
                  </a:xfrm>
                </p:grpSpPr>
                <p:pic>
                  <p:nvPicPr>
                    <p:cNvPr id="159" name="Picture 92" descr="C:\Users\ELIZABETH\Desktop\OVARY\TUMOR\40x Field1G WITH SCALE BAR.jpg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4044960" y="7810560"/>
                      <a:ext cx="879480" cy="668520"/>
                    </a:xfrm>
                    <a:prstGeom prst="rect">
                      <a:avLst/>
                    </a:prstGeom>
                    <a:ln w="6480">
                      <a:solidFill>
                        <a:srgbClr val="1e1c11"/>
                      </a:solidFill>
                      <a:miter/>
                    </a:ln>
                  </p:spPr>
                </p:pic>
                <p:grpSp>
                  <p:nvGrpSpPr>
                    <p:cNvPr id="160" name="Group 8"/>
                    <p:cNvGrpSpPr/>
                    <p:nvPr/>
                  </p:nvGrpSpPr>
                  <p:grpSpPr>
                    <a:xfrm>
                      <a:off x="3008160" y="7570080"/>
                      <a:ext cx="1480320" cy="909000"/>
                      <a:chOff x="3008160" y="7570080"/>
                      <a:chExt cx="1480320" cy="909000"/>
                    </a:xfrm>
                  </p:grpSpPr>
                  <p:pic>
                    <p:nvPicPr>
                      <p:cNvPr id="161" name="Picture 91" descr="C:\Users\ELIZABETH\Desktop\OVARY\TUMOR\40x Field1C WITH SCALE BAR.jpg"/>
                      <p:cNvPicPr/>
                      <p:nvPr/>
                    </p:nvPicPr>
                    <p:blipFill>
                      <a:blip r:embed="rId9"/>
                      <a:stretch/>
                    </p:blipFill>
                    <p:spPr>
                      <a:xfrm>
                        <a:off x="3008160" y="7810560"/>
                        <a:ext cx="879840" cy="668520"/>
                      </a:xfrm>
                      <a:prstGeom prst="rect">
                        <a:avLst/>
                      </a:prstGeom>
                      <a:ln w="6480">
                        <a:solidFill>
                          <a:srgbClr val="1e1c11"/>
                        </a:solidFill>
                        <a:miter/>
                      </a:ln>
                    </p:spPr>
                  </p:pic>
                  <p:sp>
                    <p:nvSpPr>
                      <p:cNvPr id="162" name="TextBox 5123"/>
                      <p:cNvSpPr/>
                      <p:nvPr/>
                    </p:nvSpPr>
                    <p:spPr>
                      <a:xfrm flipH="1" flipV="1" rot="10800000">
                        <a:off x="3358080" y="7569720"/>
                        <a:ext cx="1130040" cy="2156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r>
                          <a:rPr b="1" lang="en-IN" sz="800" spc="-1" strike="noStrike">
                            <a:solidFill>
                              <a:srgbClr val="000000"/>
                            </a:solidFill>
                            <a:latin typeface="Times New Roman"/>
                            <a:ea typeface="Times New Roman"/>
                          </a:rPr>
                          <a:t>HGSOC (high)</a:t>
                        </a:r>
                        <a:endParaRPr b="0" lang="en-US" sz="8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</p:grpSp>
              <p:pic>
                <p:nvPicPr>
                  <p:cNvPr id="163" name="Picture 93" descr="C:\Users\ELIZABETH\Desktop\OVARY\TUMOR\40x Field1A WITH SCALE BAR.jpg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3460680" y="8579160"/>
                    <a:ext cx="973080" cy="745920"/>
                  </a:xfrm>
                  <a:prstGeom prst="rect">
                    <a:avLst/>
                  </a:prstGeom>
                  <a:ln w="6480">
                    <a:solidFill>
                      <a:srgbClr val="1e1c11"/>
                    </a:solidFill>
                    <a:miter/>
                  </a:ln>
                </p:spPr>
              </p:pic>
            </p:grpSp>
            <p:grpSp>
              <p:nvGrpSpPr>
                <p:cNvPr id="164" name="Group 16"/>
                <p:cNvGrpSpPr/>
                <p:nvPr/>
              </p:nvGrpSpPr>
              <p:grpSpPr>
                <a:xfrm>
                  <a:off x="3008160" y="6734160"/>
                  <a:ext cx="1916280" cy="821520"/>
                  <a:chOff x="3008160" y="6734160"/>
                  <a:chExt cx="1916280" cy="821520"/>
                </a:xfrm>
              </p:grpSpPr>
              <p:grpSp>
                <p:nvGrpSpPr>
                  <p:cNvPr id="165" name="Group 15"/>
                  <p:cNvGrpSpPr/>
                  <p:nvPr/>
                </p:nvGrpSpPr>
                <p:grpSpPr>
                  <a:xfrm>
                    <a:off x="3008160" y="6965280"/>
                    <a:ext cx="1916280" cy="590400"/>
                    <a:chOff x="3008160" y="6965280"/>
                    <a:chExt cx="1916280" cy="590400"/>
                  </a:xfrm>
                </p:grpSpPr>
                <p:pic>
                  <p:nvPicPr>
                    <p:cNvPr id="166" name="Picture 98" descr="C:\Users\ELIZABETH\Desktop\OVARY\TUMOR\40X Field3C WITH SCALE BAR.jpg"/>
                    <p:cNvPicPr/>
                    <p:nvPr/>
                  </p:nvPicPr>
                  <p:blipFill>
                    <a:blip r:embed="rId11"/>
                    <a:stretch/>
                  </p:blipFill>
                  <p:spPr>
                    <a:xfrm>
                      <a:off x="3008160" y="6965280"/>
                      <a:ext cx="879480" cy="590400"/>
                    </a:xfrm>
                    <a:prstGeom prst="rect">
                      <a:avLst/>
                    </a:prstGeom>
                    <a:ln w="6480">
                      <a:solidFill>
                        <a:srgbClr val="1e1c11"/>
                      </a:solidFill>
                      <a:miter/>
                    </a:ln>
                  </p:spPr>
                </p:pic>
                <p:pic>
                  <p:nvPicPr>
                    <p:cNvPr id="167" name="Picture 94" descr="C:\Users\ELIZABETH\Desktop\OVARY\TUMOR\40X Field3B WITH SCALE BAR.jpg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4049640" y="6965280"/>
                      <a:ext cx="874800" cy="584280"/>
                    </a:xfrm>
                    <a:prstGeom prst="rect">
                      <a:avLst/>
                    </a:prstGeom>
                    <a:ln w="6480">
                      <a:solidFill>
                        <a:srgbClr val="1e1c11"/>
                      </a:solidFill>
                      <a:miter/>
                    </a:ln>
                  </p:spPr>
                </p:pic>
              </p:grpSp>
              <p:sp>
                <p:nvSpPr>
                  <p:cNvPr id="168" name="TextBox 5123"/>
                  <p:cNvSpPr/>
                  <p:nvPr/>
                </p:nvSpPr>
                <p:spPr>
                  <a:xfrm flipH="1" flipV="1" rot="10800000">
                    <a:off x="3267720" y="6733800"/>
                    <a:ext cx="14418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HGSOC (Borderline)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69" name="Group 17"/>
                <p:cNvGrpSpPr/>
                <p:nvPr/>
              </p:nvGrpSpPr>
              <p:grpSpPr>
                <a:xfrm>
                  <a:off x="3008160" y="5819040"/>
                  <a:ext cx="1924200" cy="891720"/>
                  <a:chOff x="3008160" y="5819040"/>
                  <a:chExt cx="1924200" cy="891720"/>
                </a:xfrm>
              </p:grpSpPr>
              <p:grpSp>
                <p:nvGrpSpPr>
                  <p:cNvPr id="170" name="Group 14"/>
                  <p:cNvGrpSpPr/>
                  <p:nvPr/>
                </p:nvGrpSpPr>
                <p:grpSpPr>
                  <a:xfrm>
                    <a:off x="3223080" y="5819040"/>
                    <a:ext cx="1709280" cy="885600"/>
                    <a:chOff x="3223080" y="5819040"/>
                    <a:chExt cx="1709280" cy="885600"/>
                  </a:xfrm>
                </p:grpSpPr>
                <p:pic>
                  <p:nvPicPr>
                    <p:cNvPr id="171" name="Picture 96" descr="C:\Users\ELIZABETH\Desktop\OVARY\TUMOR\40X Field2C WITH SCALE BAR.jpg"/>
                    <p:cNvPicPr/>
                    <p:nvPr/>
                  </p:nvPicPr>
                  <p:blipFill>
                    <a:blip r:embed="rId13"/>
                    <a:stretch/>
                  </p:blipFill>
                  <p:spPr>
                    <a:xfrm>
                      <a:off x="4049280" y="6027120"/>
                      <a:ext cx="883080" cy="677520"/>
                    </a:xfrm>
                    <a:prstGeom prst="rect">
                      <a:avLst/>
                    </a:prstGeom>
                    <a:ln w="6480">
                      <a:solidFill>
                        <a:srgbClr val="000000"/>
                      </a:solidFill>
                      <a:miter/>
                    </a:ln>
                  </p:spPr>
                </p:pic>
                <p:sp>
                  <p:nvSpPr>
                    <p:cNvPr id="172" name="TextBox 5123"/>
                    <p:cNvSpPr/>
                    <p:nvPr/>
                  </p:nvSpPr>
                  <p:spPr>
                    <a:xfrm flipH="1" flipV="1" rot="10800000">
                      <a:off x="3222720" y="5818680"/>
                      <a:ext cx="144180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GSOC (Optimum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pic>
                <p:nvPicPr>
                  <p:cNvPr id="173" name="Picture 100" descr="C:\Users\ELIZABETH\Desktop\OVARY\TUMOR\40X Field2B WITH SCALE BAR.jpg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3008160" y="6021360"/>
                    <a:ext cx="833400" cy="689400"/>
                  </a:xfrm>
                  <a:prstGeom prst="rect">
                    <a:avLst/>
                  </a:prstGeom>
                  <a:ln w="6480">
                    <a:solidFill>
                      <a:srgbClr val="1e1c11"/>
                    </a:solidFill>
                    <a:miter/>
                  </a:ln>
                </p:spPr>
              </p:pic>
            </p:grpSp>
            <p:sp>
              <p:nvSpPr>
                <p:cNvPr id="174" name="TextBox 40"/>
                <p:cNvSpPr/>
                <p:nvPr/>
              </p:nvSpPr>
              <p:spPr>
                <a:xfrm>
                  <a:off x="2662200" y="5938920"/>
                  <a:ext cx="2934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cxnSp>
            <p:nvCxnSpPr>
              <p:cNvPr id="175" name="Straight Arrow Connector 26"/>
              <p:cNvCxnSpPr/>
              <p:nvPr/>
            </p:nvCxnSpPr>
            <p:spPr>
              <a:xfrm>
                <a:off x="4103640" y="6262560"/>
                <a:ext cx="173520" cy="89280"/>
              </a:xfrm>
              <a:prstGeom prst="straightConnector1">
                <a:avLst/>
              </a:prstGeom>
              <a:ln cap="rnd" w="6480">
                <a:solidFill>
                  <a:srgbClr val="c00000"/>
                </a:solidFill>
                <a:miter/>
                <a:tailEnd len="med" type="stealth" w="med"/>
              </a:ln>
            </p:spPr>
          </p:cxnSp>
          <p:cxnSp>
            <p:nvCxnSpPr>
              <p:cNvPr id="176" name="Straight Arrow Connector 140"/>
              <p:cNvCxnSpPr/>
              <p:nvPr/>
            </p:nvCxnSpPr>
            <p:spPr>
              <a:xfrm>
                <a:off x="4263840" y="6056280"/>
                <a:ext cx="175320" cy="89280"/>
              </a:xfrm>
              <a:prstGeom prst="straightConnector1">
                <a:avLst/>
              </a:prstGeom>
              <a:ln cap="rnd" w="6480">
                <a:solidFill>
                  <a:srgbClr val="c00000"/>
                </a:solidFill>
                <a:miter/>
                <a:tailEnd len="med" type="stealth" w="med"/>
              </a:ln>
            </p:spPr>
          </p:cxnSp>
          <p:cxnSp>
            <p:nvCxnSpPr>
              <p:cNvPr id="177" name="Straight Arrow Connector 141"/>
              <p:cNvCxnSpPr/>
              <p:nvPr/>
            </p:nvCxnSpPr>
            <p:spPr>
              <a:xfrm>
                <a:off x="3153960" y="7037280"/>
                <a:ext cx="175320" cy="87840"/>
              </a:xfrm>
              <a:prstGeom prst="straightConnector1">
                <a:avLst/>
              </a:prstGeom>
              <a:ln cap="rnd" w="6480">
                <a:solidFill>
                  <a:srgbClr val="c00000"/>
                </a:solidFill>
                <a:miter/>
                <a:tailEnd len="med" type="stealth" w="med"/>
              </a:ln>
            </p:spPr>
          </p:cxnSp>
          <p:cxnSp>
            <p:nvCxnSpPr>
              <p:cNvPr id="178" name="Straight Arrow Connector 142"/>
              <p:cNvCxnSpPr/>
              <p:nvPr/>
            </p:nvCxnSpPr>
            <p:spPr>
              <a:xfrm flipH="1">
                <a:off x="3688560" y="6884640"/>
                <a:ext cx="106920" cy="144720"/>
              </a:xfrm>
              <a:prstGeom prst="straightConnector1">
                <a:avLst/>
              </a:prstGeom>
              <a:ln cap="rnd" w="6480">
                <a:solidFill>
                  <a:srgbClr val="c00000"/>
                </a:solidFill>
                <a:miter/>
                <a:tailEnd len="med" type="stealth" w="med"/>
              </a:ln>
            </p:spPr>
          </p:cxnSp>
          <p:cxnSp>
            <p:nvCxnSpPr>
              <p:cNvPr id="179" name="Straight Arrow Connector 144"/>
              <p:cNvCxnSpPr/>
              <p:nvPr/>
            </p:nvCxnSpPr>
            <p:spPr>
              <a:xfrm flipH="1">
                <a:off x="4608000" y="7070400"/>
                <a:ext cx="108360" cy="144720"/>
              </a:xfrm>
              <a:prstGeom prst="straightConnector1">
                <a:avLst/>
              </a:prstGeom>
              <a:ln cap="rnd" w="6480">
                <a:solidFill>
                  <a:srgbClr val="c00000"/>
                </a:solidFill>
                <a:miter/>
                <a:tailEnd len="med" type="stealth" w="med"/>
              </a:ln>
            </p:spPr>
          </p:cxnSp>
          <p:sp>
            <p:nvSpPr>
              <p:cNvPr id="180" name="Oval 28"/>
              <p:cNvSpPr/>
              <p:nvPr/>
            </p:nvSpPr>
            <p:spPr>
              <a:xfrm>
                <a:off x="3122640" y="7923240"/>
                <a:ext cx="261720" cy="264960"/>
              </a:xfrm>
              <a:prstGeom prst="ellipse">
                <a:avLst/>
              </a:prstGeom>
              <a:noFill/>
              <a:ln w="6480">
                <a:solidFill>
                  <a:srgbClr val="c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" name="Oval 148"/>
              <p:cNvSpPr/>
              <p:nvPr/>
            </p:nvSpPr>
            <p:spPr>
              <a:xfrm>
                <a:off x="3576600" y="7845480"/>
                <a:ext cx="261720" cy="264960"/>
              </a:xfrm>
              <a:prstGeom prst="ellipse">
                <a:avLst/>
              </a:prstGeom>
              <a:noFill/>
              <a:ln w="6480">
                <a:solidFill>
                  <a:srgbClr val="c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" name="Oval 149"/>
              <p:cNvSpPr/>
              <p:nvPr/>
            </p:nvSpPr>
            <p:spPr>
              <a:xfrm>
                <a:off x="4321080" y="7880400"/>
                <a:ext cx="436320" cy="442800"/>
              </a:xfrm>
              <a:prstGeom prst="ellipse">
                <a:avLst/>
              </a:prstGeom>
              <a:noFill/>
              <a:ln w="6480">
                <a:solidFill>
                  <a:srgbClr val="c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cxnSp>
          <p:nvCxnSpPr>
            <p:cNvPr id="183" name="Straight Arrow Connector 151"/>
            <p:cNvCxnSpPr/>
            <p:nvPr/>
          </p:nvCxnSpPr>
          <p:spPr>
            <a:xfrm flipH="1" flipV="1">
              <a:off x="3395160" y="6398280"/>
              <a:ext cx="180000" cy="129240"/>
            </a:xfrm>
            <a:prstGeom prst="straightConnector1">
              <a:avLst/>
            </a:prstGeom>
            <a:ln cap="rnd" w="6480">
              <a:solidFill>
                <a:srgbClr val="c00000"/>
              </a:solidFill>
              <a:miter/>
              <a:tailEnd len="med" type="stealth" w="med"/>
            </a:ln>
          </p:spPr>
        </p:cxnSp>
        <p:cxnSp>
          <p:nvCxnSpPr>
            <p:cNvPr id="184" name="Straight Arrow Connector 153"/>
            <p:cNvCxnSpPr/>
            <p:nvPr/>
          </p:nvCxnSpPr>
          <p:spPr>
            <a:xfrm>
              <a:off x="3763800" y="8800920"/>
              <a:ext cx="49680" cy="176760"/>
            </a:xfrm>
            <a:prstGeom prst="straightConnector1">
              <a:avLst/>
            </a:prstGeom>
            <a:ln cap="rnd" w="6480">
              <a:solidFill>
                <a:srgbClr val="c00000"/>
              </a:solidFill>
              <a:miter/>
              <a:tailEnd len="med" type="stealth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5" name="Picture 4" descr=""/>
          <p:cNvPicPr/>
          <p:nvPr/>
        </p:nvPicPr>
        <p:blipFill>
          <a:blip r:embed="rId1"/>
          <a:stretch/>
        </p:blipFill>
        <p:spPr>
          <a:xfrm>
            <a:off x="1434960" y="441360"/>
            <a:ext cx="4853160" cy="3031920"/>
          </a:xfrm>
          <a:prstGeom prst="rect">
            <a:avLst/>
          </a:prstGeom>
          <a:ln w="0">
            <a:noFill/>
          </a:ln>
        </p:spPr>
      </p:pic>
      <p:grpSp>
        <p:nvGrpSpPr>
          <p:cNvPr id="186" name="Group 15"/>
          <p:cNvGrpSpPr/>
          <p:nvPr/>
        </p:nvGrpSpPr>
        <p:grpSpPr>
          <a:xfrm>
            <a:off x="2158920" y="6541920"/>
            <a:ext cx="3211560" cy="2152800"/>
            <a:chOff x="2158920" y="6541920"/>
            <a:chExt cx="3211560" cy="2152800"/>
          </a:xfrm>
        </p:grpSpPr>
        <p:grpSp>
          <p:nvGrpSpPr>
            <p:cNvPr id="187" name="Group 35"/>
            <p:cNvGrpSpPr/>
            <p:nvPr/>
          </p:nvGrpSpPr>
          <p:grpSpPr>
            <a:xfrm>
              <a:off x="4532400" y="7170120"/>
              <a:ext cx="360000" cy="185400"/>
              <a:chOff x="4532400" y="7170120"/>
              <a:chExt cx="360000" cy="185400"/>
            </a:xfrm>
          </p:grpSpPr>
          <p:sp>
            <p:nvSpPr>
              <p:cNvPr id="188" name="Straight Connector 36"/>
              <p:cNvSpPr/>
              <p:nvPr/>
            </p:nvSpPr>
            <p:spPr>
              <a:xfrm>
                <a:off x="4592520" y="7310160"/>
                <a:ext cx="230040" cy="0"/>
              </a:xfrm>
              <a:prstGeom prst="line">
                <a:avLst/>
              </a:prstGeom>
              <a:ln w="6480">
                <a:solidFill>
                  <a:srgbClr val="4f622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" name="TextBox 37"/>
              <p:cNvSpPr/>
              <p:nvPr/>
            </p:nvSpPr>
            <p:spPr>
              <a:xfrm>
                <a:off x="4532400" y="7170120"/>
                <a:ext cx="3600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600" spc="-1" strike="noStrike">
                    <a:solidFill>
                      <a:srgbClr val="4f6228"/>
                    </a:solidFill>
                    <a:latin typeface="Times New Roman"/>
                    <a:ea typeface="Times New Roman"/>
                  </a:rPr>
                  <a:t>***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90" name="Group 10"/>
            <p:cNvGrpSpPr/>
            <p:nvPr/>
          </p:nvGrpSpPr>
          <p:grpSpPr>
            <a:xfrm>
              <a:off x="2158920" y="6541920"/>
              <a:ext cx="3211560" cy="2152800"/>
              <a:chOff x="2158920" y="6541920"/>
              <a:chExt cx="3211560" cy="2152800"/>
            </a:xfrm>
          </p:grpSpPr>
          <p:grpSp>
            <p:nvGrpSpPr>
              <p:cNvPr id="191" name="Group 9"/>
              <p:cNvGrpSpPr/>
              <p:nvPr/>
            </p:nvGrpSpPr>
            <p:grpSpPr>
              <a:xfrm>
                <a:off x="2158920" y="6541920"/>
                <a:ext cx="3211560" cy="2152800"/>
                <a:chOff x="2158920" y="6541920"/>
                <a:chExt cx="3211560" cy="2152800"/>
              </a:xfrm>
            </p:grpSpPr>
            <p:grpSp>
              <p:nvGrpSpPr>
                <p:cNvPr id="192" name="Group 5"/>
                <p:cNvGrpSpPr/>
                <p:nvPr/>
              </p:nvGrpSpPr>
              <p:grpSpPr>
                <a:xfrm>
                  <a:off x="2158920" y="6541920"/>
                  <a:ext cx="3211560" cy="2152800"/>
                  <a:chOff x="2158920" y="6541920"/>
                  <a:chExt cx="3211560" cy="2152800"/>
                </a:xfrm>
              </p:grpSpPr>
              <p:grpSp>
                <p:nvGrpSpPr>
                  <p:cNvPr id="193" name="Group 5"/>
                  <p:cNvGrpSpPr/>
                  <p:nvPr/>
                </p:nvGrpSpPr>
                <p:grpSpPr>
                  <a:xfrm>
                    <a:off x="2158920" y="6541920"/>
                    <a:ext cx="3211560" cy="2152800"/>
                    <a:chOff x="2158920" y="6541920"/>
                    <a:chExt cx="3211560" cy="2152800"/>
                  </a:xfrm>
                </p:grpSpPr>
                <p:pic>
                  <p:nvPicPr>
                    <p:cNvPr id="194" name="Picture 3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551320" y="6774480"/>
                      <a:ext cx="2819160" cy="16772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195" name="TextBox 6"/>
                    <p:cNvSpPr/>
                    <p:nvPr/>
                  </p:nvSpPr>
                  <p:spPr>
                    <a:xfrm rot="16200000">
                      <a:off x="1255680" y="7444800"/>
                      <a:ext cx="2143440" cy="3373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800" spc="-1" strike="noStrike">
                          <a:solidFill>
                            <a:srgbClr val="10253f"/>
                          </a:solidFill>
                          <a:latin typeface="Times New Roman"/>
                          <a:ea typeface="Times New Roman"/>
                        </a:rPr>
                        <a:t>Relative Band Intensities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800" spc="-1" strike="noStrike">
                          <a:solidFill>
                            <a:srgbClr val="10253f"/>
                          </a:solidFill>
                          <a:latin typeface="Times New Roman"/>
                          <a:ea typeface="Times New Roman"/>
                        </a:rPr>
                        <a:t>Normalized Against </a:t>
                      </a:r>
                      <a:r>
                        <a:rPr b="1" lang="el-GR" sz="800" spc="-1" strike="noStrike">
                          <a:solidFill>
                            <a:srgbClr val="10253f"/>
                          </a:solidFill>
                          <a:latin typeface="Times New Roman"/>
                          <a:ea typeface="Times New Roman"/>
                        </a:rPr>
                        <a:t>β</a:t>
                      </a:r>
                      <a:r>
                        <a:rPr b="1" lang="en-IN" sz="800" spc="-1" strike="noStrike">
                          <a:solidFill>
                            <a:srgbClr val="10253f"/>
                          </a:solidFill>
                          <a:latin typeface="Times New Roman"/>
                          <a:ea typeface="Times New Roman"/>
                        </a:rPr>
                        <a:t>-actin (Fold Change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196" name="TextBox 6"/>
                    <p:cNvSpPr/>
                    <p:nvPr/>
                  </p:nvSpPr>
                  <p:spPr>
                    <a:xfrm>
                      <a:off x="2692080" y="8479080"/>
                      <a:ext cx="214308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800" spc="-1" strike="noStrike">
                          <a:solidFill>
                            <a:srgbClr val="10253f"/>
                          </a:solidFill>
                          <a:latin typeface="Times New Roman"/>
                          <a:ea typeface="Times New Roman"/>
                        </a:rPr>
                        <a:t>Sterol Metabolism Regulator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grpSp>
                <p:nvGrpSpPr>
                  <p:cNvPr id="197" name="Group 1"/>
                  <p:cNvGrpSpPr/>
                  <p:nvPr/>
                </p:nvGrpSpPr>
                <p:grpSpPr>
                  <a:xfrm>
                    <a:off x="2679840" y="7303320"/>
                    <a:ext cx="442800" cy="185400"/>
                    <a:chOff x="2679840" y="7303320"/>
                    <a:chExt cx="442800" cy="185400"/>
                  </a:xfrm>
                </p:grpSpPr>
                <p:sp>
                  <p:nvSpPr>
                    <p:cNvPr id="198" name="Straight Connector 11"/>
                    <p:cNvSpPr/>
                    <p:nvPr/>
                  </p:nvSpPr>
                  <p:spPr>
                    <a:xfrm>
                      <a:off x="2739960" y="7443360"/>
                      <a:ext cx="230040" cy="0"/>
                    </a:xfrm>
                    <a:prstGeom prst="line">
                      <a:avLst/>
                    </a:prstGeom>
                    <a:ln w="6480">
                      <a:solidFill>
                        <a:srgbClr val="4f6228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199" name="TextBox 12"/>
                    <p:cNvSpPr/>
                    <p:nvPr/>
                  </p:nvSpPr>
                  <p:spPr>
                    <a:xfrm>
                      <a:off x="2679840" y="7303320"/>
                      <a:ext cx="442800" cy="1854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4f6228"/>
                          </a:solidFill>
                          <a:latin typeface="Times New Roman"/>
                          <a:ea typeface="Times New Roman"/>
                        </a:rPr>
                        <a:t>ns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grpSp>
                <p:nvGrpSpPr>
                  <p:cNvPr id="200" name="Group 16"/>
                  <p:cNvGrpSpPr/>
                  <p:nvPr/>
                </p:nvGrpSpPr>
                <p:grpSpPr>
                  <a:xfrm>
                    <a:off x="2859480" y="7154280"/>
                    <a:ext cx="360000" cy="185400"/>
                    <a:chOff x="2859480" y="7154280"/>
                    <a:chExt cx="360000" cy="185400"/>
                  </a:xfrm>
                </p:grpSpPr>
                <p:sp>
                  <p:nvSpPr>
                    <p:cNvPr id="201" name="Straight Connector 17"/>
                    <p:cNvSpPr/>
                    <p:nvPr/>
                  </p:nvSpPr>
                  <p:spPr>
                    <a:xfrm>
                      <a:off x="2919600" y="7294320"/>
                      <a:ext cx="230040" cy="0"/>
                    </a:xfrm>
                    <a:prstGeom prst="line">
                      <a:avLst/>
                    </a:prstGeom>
                    <a:ln w="6480">
                      <a:solidFill>
                        <a:srgbClr val="4f6228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202" name="TextBox 18"/>
                    <p:cNvSpPr/>
                    <p:nvPr/>
                  </p:nvSpPr>
                  <p:spPr>
                    <a:xfrm>
                      <a:off x="2859480" y="7154280"/>
                      <a:ext cx="360000" cy="1854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4f6228"/>
                          </a:solidFill>
                          <a:latin typeface="Times New Roman"/>
                          <a:ea typeface="Times New Roman"/>
                        </a:rPr>
                        <a:t>ns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</p:grpSp>
            <p:grpSp>
              <p:nvGrpSpPr>
                <p:cNvPr id="203" name="Group 6"/>
                <p:cNvGrpSpPr/>
                <p:nvPr/>
              </p:nvGrpSpPr>
              <p:grpSpPr>
                <a:xfrm>
                  <a:off x="3254760" y="7168680"/>
                  <a:ext cx="461880" cy="415440"/>
                  <a:chOff x="3254760" y="7168680"/>
                  <a:chExt cx="461880" cy="415440"/>
                </a:xfrm>
              </p:grpSpPr>
              <p:grpSp>
                <p:nvGrpSpPr>
                  <p:cNvPr id="204" name="Group 23"/>
                  <p:cNvGrpSpPr/>
                  <p:nvPr/>
                </p:nvGrpSpPr>
                <p:grpSpPr>
                  <a:xfrm>
                    <a:off x="3254760" y="7357320"/>
                    <a:ext cx="317520" cy="226800"/>
                    <a:chOff x="3254760" y="7357320"/>
                    <a:chExt cx="317520" cy="226800"/>
                  </a:xfrm>
                </p:grpSpPr>
                <p:sp>
                  <p:nvSpPr>
                    <p:cNvPr id="205" name="Straight Connector 24"/>
                    <p:cNvSpPr/>
                    <p:nvPr/>
                  </p:nvSpPr>
                  <p:spPr>
                    <a:xfrm>
                      <a:off x="3310200" y="7584120"/>
                      <a:ext cx="203400" cy="0"/>
                    </a:xfrm>
                    <a:prstGeom prst="line">
                      <a:avLst/>
                    </a:prstGeom>
                    <a:ln w="6480">
                      <a:solidFill>
                        <a:srgbClr val="4f6228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206" name="TextBox 25"/>
                    <p:cNvSpPr/>
                    <p:nvPr/>
                  </p:nvSpPr>
                  <p:spPr>
                    <a:xfrm>
                      <a:off x="3254760" y="7357320"/>
                      <a:ext cx="317520" cy="1854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4f6228"/>
                          </a:solidFill>
                          <a:latin typeface="Times New Roman"/>
                          <a:ea typeface="Times New Roman"/>
                        </a:rPr>
                        <a:t>*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grpSp>
                <p:nvGrpSpPr>
                  <p:cNvPr id="207" name="Group 27"/>
                  <p:cNvGrpSpPr/>
                  <p:nvPr/>
                </p:nvGrpSpPr>
                <p:grpSpPr>
                  <a:xfrm>
                    <a:off x="3484800" y="7168680"/>
                    <a:ext cx="231840" cy="368280"/>
                    <a:chOff x="3484800" y="7168680"/>
                    <a:chExt cx="231840" cy="368280"/>
                  </a:xfrm>
                </p:grpSpPr>
                <p:sp>
                  <p:nvSpPr>
                    <p:cNvPr id="208" name="Straight Connector 28"/>
                    <p:cNvSpPr/>
                    <p:nvPr/>
                  </p:nvSpPr>
                  <p:spPr>
                    <a:xfrm>
                      <a:off x="3538800" y="7305120"/>
                      <a:ext cx="117360" cy="0"/>
                    </a:xfrm>
                    <a:prstGeom prst="line">
                      <a:avLst/>
                    </a:prstGeom>
                    <a:ln w="6480">
                      <a:solidFill>
                        <a:srgbClr val="4f6228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209" name="TextBox 29"/>
                    <p:cNvSpPr/>
                    <p:nvPr/>
                  </p:nvSpPr>
                  <p:spPr>
                    <a:xfrm>
                      <a:off x="3484800" y="7168680"/>
                      <a:ext cx="231840" cy="3682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4f6228"/>
                          </a:solidFill>
                          <a:latin typeface="Times New Roman"/>
                          <a:ea typeface="Times New Roman"/>
                        </a:rPr>
                        <a:t>***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</p:grpSp>
          </p:grpSp>
          <p:grpSp>
            <p:nvGrpSpPr>
              <p:cNvPr id="210" name="Group 32"/>
              <p:cNvGrpSpPr/>
              <p:nvPr/>
            </p:nvGrpSpPr>
            <p:grpSpPr>
              <a:xfrm>
                <a:off x="3970440" y="7170120"/>
                <a:ext cx="282240" cy="276840"/>
                <a:chOff x="3970440" y="7170120"/>
                <a:chExt cx="282240" cy="276840"/>
              </a:xfrm>
            </p:grpSpPr>
            <p:sp>
              <p:nvSpPr>
                <p:cNvPr id="211" name="Straight Connector 33"/>
                <p:cNvSpPr/>
                <p:nvPr/>
              </p:nvSpPr>
              <p:spPr>
                <a:xfrm>
                  <a:off x="4017960" y="7308360"/>
                  <a:ext cx="180720" cy="0"/>
                </a:xfrm>
                <a:prstGeom prst="line">
                  <a:avLst/>
                </a:prstGeom>
                <a:ln w="6480">
                  <a:solidFill>
                    <a:srgbClr val="4f6228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2" name="TextBox 34"/>
                <p:cNvSpPr/>
                <p:nvPr/>
              </p:nvSpPr>
              <p:spPr>
                <a:xfrm>
                  <a:off x="3970440" y="7170120"/>
                  <a:ext cx="282240" cy="2768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4f6228"/>
                      </a:solidFill>
                      <a:latin typeface="Times New Roman"/>
                      <a:ea typeface="Times New Roman"/>
                    </a:rPr>
                    <a:t>***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13" name="Group 38"/>
              <p:cNvGrpSpPr/>
              <p:nvPr/>
            </p:nvGrpSpPr>
            <p:grpSpPr>
              <a:xfrm>
                <a:off x="3781440" y="7444080"/>
                <a:ext cx="358920" cy="185400"/>
                <a:chOff x="3781440" y="7444080"/>
                <a:chExt cx="358920" cy="185400"/>
              </a:xfrm>
            </p:grpSpPr>
            <p:sp>
              <p:nvSpPr>
                <p:cNvPr id="214" name="Straight Connector 39"/>
                <p:cNvSpPr/>
                <p:nvPr/>
              </p:nvSpPr>
              <p:spPr>
                <a:xfrm>
                  <a:off x="3841560" y="7582320"/>
                  <a:ext cx="230400" cy="0"/>
                </a:xfrm>
                <a:prstGeom prst="line">
                  <a:avLst/>
                </a:prstGeom>
                <a:ln w="6480">
                  <a:solidFill>
                    <a:srgbClr val="4f6228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5" name="TextBox 40"/>
                <p:cNvSpPr/>
                <p:nvPr/>
              </p:nvSpPr>
              <p:spPr>
                <a:xfrm>
                  <a:off x="3781440" y="7444080"/>
                  <a:ext cx="35892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4f6228"/>
                      </a:solidFill>
                      <a:latin typeface="Times New Roman"/>
                      <a:ea typeface="Times New Roman"/>
                    </a:rPr>
                    <a:t>*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grpSp>
          <p:nvGrpSpPr>
            <p:cNvPr id="216" name="Group 42"/>
            <p:cNvGrpSpPr/>
            <p:nvPr/>
          </p:nvGrpSpPr>
          <p:grpSpPr>
            <a:xfrm>
              <a:off x="4322880" y="7444800"/>
              <a:ext cx="358560" cy="185400"/>
              <a:chOff x="4322880" y="7444800"/>
              <a:chExt cx="358560" cy="185400"/>
            </a:xfrm>
          </p:grpSpPr>
          <p:sp>
            <p:nvSpPr>
              <p:cNvPr id="217" name="Straight Connector 43"/>
              <p:cNvSpPr/>
              <p:nvPr/>
            </p:nvSpPr>
            <p:spPr>
              <a:xfrm>
                <a:off x="4383000" y="7583040"/>
                <a:ext cx="230040" cy="0"/>
              </a:xfrm>
              <a:prstGeom prst="line">
                <a:avLst/>
              </a:prstGeom>
              <a:ln w="6480">
                <a:solidFill>
                  <a:srgbClr val="4f622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8" name="TextBox 44"/>
              <p:cNvSpPr/>
              <p:nvPr/>
            </p:nvSpPr>
            <p:spPr>
              <a:xfrm>
                <a:off x="4322880" y="7444800"/>
                <a:ext cx="358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600" spc="-1" strike="noStrike">
                    <a:solidFill>
                      <a:srgbClr val="4f6228"/>
                    </a:solidFill>
                    <a:latin typeface="Times New Roman"/>
                    <a:ea typeface="Times New Roman"/>
                  </a:rPr>
                  <a:t>***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219" name="Group 5"/>
          <p:cNvGrpSpPr/>
          <p:nvPr/>
        </p:nvGrpSpPr>
        <p:grpSpPr>
          <a:xfrm>
            <a:off x="4400640" y="3978360"/>
            <a:ext cx="3017880" cy="2287440"/>
            <a:chOff x="4400640" y="3978360"/>
            <a:chExt cx="3017880" cy="2287440"/>
          </a:xfrm>
        </p:grpSpPr>
        <p:grpSp>
          <p:nvGrpSpPr>
            <p:cNvPr id="220" name="Group 3"/>
            <p:cNvGrpSpPr/>
            <p:nvPr/>
          </p:nvGrpSpPr>
          <p:grpSpPr>
            <a:xfrm>
              <a:off x="4400640" y="3978360"/>
              <a:ext cx="3017880" cy="2287440"/>
              <a:chOff x="4400640" y="3978360"/>
              <a:chExt cx="3017880" cy="2287440"/>
            </a:xfrm>
          </p:grpSpPr>
          <p:grpSp>
            <p:nvGrpSpPr>
              <p:cNvPr id="221" name="Group 1"/>
              <p:cNvGrpSpPr/>
              <p:nvPr/>
            </p:nvGrpSpPr>
            <p:grpSpPr>
              <a:xfrm>
                <a:off x="4400640" y="3978360"/>
                <a:ext cx="3017880" cy="2287440"/>
                <a:chOff x="4400640" y="3978360"/>
                <a:chExt cx="3017880" cy="2287440"/>
              </a:xfrm>
            </p:grpSpPr>
            <p:pic>
              <p:nvPicPr>
                <p:cNvPr id="222" name="Picture 2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4812120" y="4367160"/>
                  <a:ext cx="2606400" cy="15343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23" name="TextBox 6"/>
                <p:cNvSpPr/>
                <p:nvPr/>
              </p:nvSpPr>
              <p:spPr>
                <a:xfrm rot="16200000">
                  <a:off x="3425400" y="4953240"/>
                  <a:ext cx="228744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10253f"/>
                      </a:solidFill>
                      <a:latin typeface="Times New Roman"/>
                      <a:ea typeface="Times New Roman"/>
                    </a:rPr>
                    <a:t>Relative Band Intensities 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10253f"/>
                      </a:solidFill>
                      <a:latin typeface="Times New Roman"/>
                      <a:ea typeface="Times New Roman"/>
                    </a:rPr>
                    <a:t>Normalized Against </a:t>
                  </a:r>
                  <a:r>
                    <a:rPr b="1" lang="el-GR" sz="800" spc="-1" strike="noStrike">
                      <a:solidFill>
                        <a:srgbClr val="10253f"/>
                      </a:solidFill>
                      <a:latin typeface="Times New Roman"/>
                      <a:ea typeface="Times New Roman"/>
                    </a:rPr>
                    <a:t>β</a:t>
                  </a:r>
                  <a:r>
                    <a:rPr b="1" lang="en-IN" sz="800" spc="-1" strike="noStrike">
                      <a:solidFill>
                        <a:srgbClr val="10253f"/>
                      </a:solidFill>
                      <a:latin typeface="Times New Roman"/>
                      <a:ea typeface="Times New Roman"/>
                    </a:rPr>
                    <a:t>-actin(Fold Change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224" name="TextBox 6"/>
              <p:cNvSpPr/>
              <p:nvPr/>
            </p:nvSpPr>
            <p:spPr>
              <a:xfrm>
                <a:off x="4811760" y="5915160"/>
                <a:ext cx="2143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800" spc="-1" strike="noStrike">
                    <a:solidFill>
                      <a:srgbClr val="10253f"/>
                    </a:solidFill>
                    <a:latin typeface="Times New Roman"/>
                    <a:ea typeface="Times New Roman"/>
                  </a:rPr>
                  <a:t>Downstream Prosurvival Effector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25" name="Group 58"/>
            <p:cNvGrpSpPr/>
            <p:nvPr/>
          </p:nvGrpSpPr>
          <p:grpSpPr>
            <a:xfrm>
              <a:off x="4966920" y="4911840"/>
              <a:ext cx="358560" cy="185400"/>
              <a:chOff x="4966920" y="4911840"/>
              <a:chExt cx="358560" cy="185400"/>
            </a:xfrm>
          </p:grpSpPr>
          <p:sp>
            <p:nvSpPr>
              <p:cNvPr id="226" name="Straight Connector 59"/>
              <p:cNvSpPr/>
              <p:nvPr/>
            </p:nvSpPr>
            <p:spPr>
              <a:xfrm>
                <a:off x="5027040" y="5046480"/>
                <a:ext cx="230040" cy="0"/>
              </a:xfrm>
              <a:prstGeom prst="line">
                <a:avLst/>
              </a:prstGeom>
              <a:ln w="6480">
                <a:solidFill>
                  <a:srgbClr val="4f622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7" name="TextBox 60"/>
              <p:cNvSpPr/>
              <p:nvPr/>
            </p:nvSpPr>
            <p:spPr>
              <a:xfrm>
                <a:off x="4966920" y="4911840"/>
                <a:ext cx="358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600" spc="-1" strike="noStrike">
                    <a:solidFill>
                      <a:srgbClr val="4f6228"/>
                    </a:solidFill>
                    <a:latin typeface="Times New Roman"/>
                    <a:ea typeface="Times New Roman"/>
                  </a:rPr>
                  <a:t>***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28" name="Group 61"/>
            <p:cNvGrpSpPr/>
            <p:nvPr/>
          </p:nvGrpSpPr>
          <p:grpSpPr>
            <a:xfrm>
              <a:off x="5182920" y="4726080"/>
              <a:ext cx="287280" cy="276840"/>
              <a:chOff x="5182920" y="4726080"/>
              <a:chExt cx="287280" cy="276840"/>
            </a:xfrm>
          </p:grpSpPr>
          <p:sp>
            <p:nvSpPr>
              <p:cNvPr id="229" name="Straight Connector 62"/>
              <p:cNvSpPr/>
              <p:nvPr/>
            </p:nvSpPr>
            <p:spPr>
              <a:xfrm>
                <a:off x="5231880" y="4863600"/>
                <a:ext cx="182520" cy="0"/>
              </a:xfrm>
              <a:prstGeom prst="line">
                <a:avLst/>
              </a:prstGeom>
              <a:ln w="6480">
                <a:solidFill>
                  <a:srgbClr val="4f622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0" name="TextBox 63"/>
              <p:cNvSpPr/>
              <p:nvPr/>
            </p:nvSpPr>
            <p:spPr>
              <a:xfrm>
                <a:off x="5182920" y="4726080"/>
                <a:ext cx="287280" cy="276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600" spc="-1" strike="noStrike">
                    <a:solidFill>
                      <a:srgbClr val="4f6228"/>
                    </a:solidFill>
                    <a:latin typeface="Times New Roman"/>
                    <a:ea typeface="Times New Roman"/>
                  </a:rPr>
                  <a:t>***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31" name="Group 64"/>
            <p:cNvGrpSpPr/>
            <p:nvPr/>
          </p:nvGrpSpPr>
          <p:grpSpPr>
            <a:xfrm>
              <a:off x="5702040" y="4791240"/>
              <a:ext cx="287280" cy="276840"/>
              <a:chOff x="5702040" y="4791240"/>
              <a:chExt cx="287280" cy="276840"/>
            </a:xfrm>
          </p:grpSpPr>
          <p:sp>
            <p:nvSpPr>
              <p:cNvPr id="232" name="Straight Connector 65"/>
              <p:cNvSpPr/>
              <p:nvPr/>
            </p:nvSpPr>
            <p:spPr>
              <a:xfrm>
                <a:off x="5751000" y="4930560"/>
                <a:ext cx="182520" cy="0"/>
              </a:xfrm>
              <a:prstGeom prst="line">
                <a:avLst/>
              </a:prstGeom>
              <a:ln w="6480">
                <a:solidFill>
                  <a:srgbClr val="4f622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3" name="TextBox 66"/>
              <p:cNvSpPr/>
              <p:nvPr/>
            </p:nvSpPr>
            <p:spPr>
              <a:xfrm>
                <a:off x="5702040" y="4791240"/>
                <a:ext cx="287280" cy="276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600" spc="-1" strike="noStrike">
                    <a:solidFill>
                      <a:srgbClr val="4f6228"/>
                    </a:solidFill>
                    <a:latin typeface="Times New Roman"/>
                    <a:ea typeface="Times New Roman"/>
                  </a:rPr>
                  <a:t>***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34" name="Group 67"/>
            <p:cNvGrpSpPr/>
            <p:nvPr/>
          </p:nvGrpSpPr>
          <p:grpSpPr>
            <a:xfrm>
              <a:off x="5854680" y="4646880"/>
              <a:ext cx="287280" cy="276840"/>
              <a:chOff x="5854680" y="4646880"/>
              <a:chExt cx="287280" cy="276840"/>
            </a:xfrm>
          </p:grpSpPr>
          <p:sp>
            <p:nvSpPr>
              <p:cNvPr id="235" name="Straight Connector 68"/>
              <p:cNvSpPr/>
              <p:nvPr/>
            </p:nvSpPr>
            <p:spPr>
              <a:xfrm>
                <a:off x="5903640" y="4784400"/>
                <a:ext cx="182520" cy="0"/>
              </a:xfrm>
              <a:prstGeom prst="line">
                <a:avLst/>
              </a:prstGeom>
              <a:ln w="6480">
                <a:solidFill>
                  <a:srgbClr val="4f622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6" name="TextBox 69"/>
              <p:cNvSpPr/>
              <p:nvPr/>
            </p:nvSpPr>
            <p:spPr>
              <a:xfrm>
                <a:off x="5854680" y="4646880"/>
                <a:ext cx="287280" cy="276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600" spc="-1" strike="noStrike">
                    <a:solidFill>
                      <a:srgbClr val="4f6228"/>
                    </a:solidFill>
                    <a:latin typeface="Times New Roman"/>
                    <a:ea typeface="Times New Roman"/>
                  </a:rPr>
                  <a:t>***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37" name="Group 70"/>
            <p:cNvGrpSpPr/>
            <p:nvPr/>
          </p:nvGrpSpPr>
          <p:grpSpPr>
            <a:xfrm>
              <a:off x="6350040" y="4794480"/>
              <a:ext cx="287280" cy="276840"/>
              <a:chOff x="6350040" y="4794480"/>
              <a:chExt cx="287280" cy="276840"/>
            </a:xfrm>
          </p:grpSpPr>
          <p:sp>
            <p:nvSpPr>
              <p:cNvPr id="238" name="Straight Connector 71"/>
              <p:cNvSpPr/>
              <p:nvPr/>
            </p:nvSpPr>
            <p:spPr>
              <a:xfrm>
                <a:off x="6399000" y="4932000"/>
                <a:ext cx="182520" cy="0"/>
              </a:xfrm>
              <a:prstGeom prst="line">
                <a:avLst/>
              </a:prstGeom>
              <a:ln w="6480">
                <a:solidFill>
                  <a:srgbClr val="4f622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9" name="TextBox 72"/>
              <p:cNvSpPr/>
              <p:nvPr/>
            </p:nvSpPr>
            <p:spPr>
              <a:xfrm>
                <a:off x="6350040" y="4794480"/>
                <a:ext cx="287280" cy="276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600" spc="-1" strike="noStrike">
                    <a:solidFill>
                      <a:srgbClr val="4f6228"/>
                    </a:solidFill>
                    <a:latin typeface="Times New Roman"/>
                    <a:ea typeface="Times New Roman"/>
                  </a:rPr>
                  <a:t>***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40" name="Group 73"/>
            <p:cNvGrpSpPr/>
            <p:nvPr/>
          </p:nvGrpSpPr>
          <p:grpSpPr>
            <a:xfrm>
              <a:off x="6569280" y="4645440"/>
              <a:ext cx="287280" cy="276840"/>
              <a:chOff x="6569280" y="4645440"/>
              <a:chExt cx="287280" cy="276840"/>
            </a:xfrm>
          </p:grpSpPr>
          <p:sp>
            <p:nvSpPr>
              <p:cNvPr id="241" name="Straight Connector 74"/>
              <p:cNvSpPr/>
              <p:nvPr/>
            </p:nvSpPr>
            <p:spPr>
              <a:xfrm>
                <a:off x="6618240" y="4784760"/>
                <a:ext cx="182520" cy="0"/>
              </a:xfrm>
              <a:prstGeom prst="line">
                <a:avLst/>
              </a:prstGeom>
              <a:ln w="6480">
                <a:solidFill>
                  <a:srgbClr val="4f622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2" name="TextBox 75"/>
              <p:cNvSpPr/>
              <p:nvPr/>
            </p:nvSpPr>
            <p:spPr>
              <a:xfrm>
                <a:off x="6569280" y="4645440"/>
                <a:ext cx="287280" cy="276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600" spc="-1" strike="noStrike">
                    <a:solidFill>
                      <a:srgbClr val="4f6228"/>
                    </a:solidFill>
                    <a:latin typeface="Times New Roman"/>
                    <a:ea typeface="Times New Roman"/>
                  </a:rPr>
                  <a:t>***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243" name="Group 5151"/>
          <p:cNvGrpSpPr/>
          <p:nvPr/>
        </p:nvGrpSpPr>
        <p:grpSpPr>
          <a:xfrm>
            <a:off x="395280" y="3905280"/>
            <a:ext cx="3467160" cy="2433600"/>
            <a:chOff x="395280" y="3905280"/>
            <a:chExt cx="3467160" cy="2433600"/>
          </a:xfrm>
        </p:grpSpPr>
        <p:grpSp>
          <p:nvGrpSpPr>
            <p:cNvPr id="244" name="Group 45"/>
            <p:cNvGrpSpPr/>
            <p:nvPr/>
          </p:nvGrpSpPr>
          <p:grpSpPr>
            <a:xfrm>
              <a:off x="3165480" y="5049720"/>
              <a:ext cx="317520" cy="185400"/>
              <a:chOff x="3165480" y="5049720"/>
              <a:chExt cx="317520" cy="185400"/>
            </a:xfrm>
          </p:grpSpPr>
          <p:sp>
            <p:nvSpPr>
              <p:cNvPr id="245" name="Straight Connector 85"/>
              <p:cNvSpPr/>
              <p:nvPr/>
            </p:nvSpPr>
            <p:spPr>
              <a:xfrm>
                <a:off x="3219480" y="5191560"/>
                <a:ext cx="203400" cy="0"/>
              </a:xfrm>
              <a:prstGeom prst="line">
                <a:avLst/>
              </a:prstGeom>
              <a:ln w="6480">
                <a:solidFill>
                  <a:srgbClr val="4f622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6" name="TextBox 86"/>
              <p:cNvSpPr/>
              <p:nvPr/>
            </p:nvSpPr>
            <p:spPr>
              <a:xfrm>
                <a:off x="3165480" y="5049720"/>
                <a:ext cx="31752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600" spc="-1" strike="noStrike">
                    <a:solidFill>
                      <a:srgbClr val="4f6228"/>
                    </a:solidFill>
                    <a:latin typeface="Times New Roman"/>
                    <a:ea typeface="Times New Roman"/>
                  </a:rPr>
                  <a:t>***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47" name="Group 30"/>
            <p:cNvGrpSpPr/>
            <p:nvPr/>
          </p:nvGrpSpPr>
          <p:grpSpPr>
            <a:xfrm>
              <a:off x="395280" y="3905280"/>
              <a:ext cx="3467160" cy="2433600"/>
              <a:chOff x="395280" y="3905280"/>
              <a:chExt cx="3467160" cy="2433600"/>
            </a:xfrm>
          </p:grpSpPr>
          <p:grpSp>
            <p:nvGrpSpPr>
              <p:cNvPr id="248" name="Group 52"/>
              <p:cNvGrpSpPr/>
              <p:nvPr/>
            </p:nvGrpSpPr>
            <p:grpSpPr>
              <a:xfrm>
                <a:off x="2701800" y="5154480"/>
                <a:ext cx="311040" cy="185400"/>
                <a:chOff x="2701800" y="5154480"/>
                <a:chExt cx="311040" cy="185400"/>
              </a:xfrm>
            </p:grpSpPr>
            <p:sp>
              <p:nvSpPr>
                <p:cNvPr id="249" name="Straight Connector 102"/>
                <p:cNvSpPr/>
                <p:nvPr/>
              </p:nvSpPr>
              <p:spPr>
                <a:xfrm>
                  <a:off x="2754000" y="5294520"/>
                  <a:ext cx="200160" cy="0"/>
                </a:xfrm>
                <a:prstGeom prst="line">
                  <a:avLst/>
                </a:prstGeom>
                <a:ln w="6480">
                  <a:solidFill>
                    <a:srgbClr val="4f6228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0" name="TextBox 103"/>
                <p:cNvSpPr/>
                <p:nvPr/>
              </p:nvSpPr>
              <p:spPr>
                <a:xfrm>
                  <a:off x="2701800" y="5154480"/>
                  <a:ext cx="31104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4f6228"/>
                      </a:solidFill>
                      <a:latin typeface="Times New Roman"/>
                      <a:ea typeface="Times New Roman"/>
                    </a:rPr>
                    <a:t>***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51" name="Group 27"/>
              <p:cNvGrpSpPr/>
              <p:nvPr/>
            </p:nvGrpSpPr>
            <p:grpSpPr>
              <a:xfrm>
                <a:off x="395280" y="3905280"/>
                <a:ext cx="3467160" cy="2433600"/>
                <a:chOff x="395280" y="3905280"/>
                <a:chExt cx="3467160" cy="2433600"/>
              </a:xfrm>
            </p:grpSpPr>
            <p:grpSp>
              <p:nvGrpSpPr>
                <p:cNvPr id="252" name="Group 23"/>
                <p:cNvGrpSpPr/>
                <p:nvPr/>
              </p:nvGrpSpPr>
              <p:grpSpPr>
                <a:xfrm>
                  <a:off x="395280" y="3905280"/>
                  <a:ext cx="3467160" cy="2433600"/>
                  <a:chOff x="395280" y="3905280"/>
                  <a:chExt cx="3467160" cy="2433600"/>
                </a:xfrm>
              </p:grpSpPr>
              <p:grpSp>
                <p:nvGrpSpPr>
                  <p:cNvPr id="253" name="Group 6"/>
                  <p:cNvGrpSpPr/>
                  <p:nvPr/>
                </p:nvGrpSpPr>
                <p:grpSpPr>
                  <a:xfrm>
                    <a:off x="395280" y="3905280"/>
                    <a:ext cx="3467160" cy="2433600"/>
                    <a:chOff x="395280" y="3905280"/>
                    <a:chExt cx="3467160" cy="2433600"/>
                  </a:xfrm>
                </p:grpSpPr>
                <p:grpSp>
                  <p:nvGrpSpPr>
                    <p:cNvPr id="254" name="Group 45"/>
                    <p:cNvGrpSpPr/>
                    <p:nvPr/>
                  </p:nvGrpSpPr>
                  <p:grpSpPr>
                    <a:xfrm>
                      <a:off x="891720" y="5203800"/>
                      <a:ext cx="304560" cy="185400"/>
                      <a:chOff x="891720" y="5203800"/>
                      <a:chExt cx="304560" cy="185400"/>
                    </a:xfrm>
                  </p:grpSpPr>
                  <p:sp>
                    <p:nvSpPr>
                      <p:cNvPr id="255" name="Straight Connector 46"/>
                      <p:cNvSpPr/>
                      <p:nvPr/>
                    </p:nvSpPr>
                    <p:spPr>
                      <a:xfrm>
                        <a:off x="942480" y="5345640"/>
                        <a:ext cx="195120" cy="0"/>
                      </a:xfrm>
                      <a:prstGeom prst="line">
                        <a:avLst/>
                      </a:prstGeom>
                      <a:ln w="6480">
                        <a:solidFill>
                          <a:srgbClr val="4f6228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800" bIns="-46800" anchor="t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256" name="TextBox 47"/>
                      <p:cNvSpPr/>
                      <p:nvPr/>
                    </p:nvSpPr>
                    <p:spPr>
                      <a:xfrm>
                        <a:off x="891720" y="5203800"/>
                        <a:ext cx="304560" cy="18540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r>
                          <a:rPr b="1" lang="en-IN" sz="600" spc="-1" strike="noStrike">
                            <a:solidFill>
                              <a:srgbClr val="4f6228"/>
                            </a:solidFill>
                            <a:latin typeface="Times New Roman"/>
                            <a:ea typeface="Times New Roman"/>
                          </a:rPr>
                          <a:t>***</a:t>
                        </a:r>
                        <a:endParaRPr b="0" lang="en-US" sz="6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grpSp>
                  <p:nvGrpSpPr>
                    <p:cNvPr id="257" name="Group 19"/>
                    <p:cNvGrpSpPr/>
                    <p:nvPr/>
                  </p:nvGrpSpPr>
                  <p:grpSpPr>
                    <a:xfrm>
                      <a:off x="395280" y="3905280"/>
                      <a:ext cx="3467160" cy="2433600"/>
                      <a:chOff x="395280" y="3905280"/>
                      <a:chExt cx="3467160" cy="2433600"/>
                    </a:xfrm>
                  </p:grpSpPr>
                  <p:pic>
                    <p:nvPicPr>
                      <p:cNvPr id="258" name="Picture 12" descr="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>
                      <a:xfrm>
                        <a:off x="740880" y="4064400"/>
                        <a:ext cx="3121560" cy="18309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  <p:sp>
                    <p:nvSpPr>
                      <p:cNvPr id="259" name="TextBox 6"/>
                      <p:cNvSpPr/>
                      <p:nvPr/>
                    </p:nvSpPr>
                    <p:spPr>
                      <a:xfrm rot="16200000">
                        <a:off x="-652680" y="4953240"/>
                        <a:ext cx="2433600" cy="33732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r>
                          <a:rPr b="1" lang="en-IN" sz="800" spc="-1" strike="noStrike">
                            <a:solidFill>
                              <a:srgbClr val="10253f"/>
                            </a:solidFill>
                            <a:latin typeface="Times New Roman"/>
                            <a:ea typeface="Times New Roman"/>
                          </a:rPr>
                          <a:t>Relative Band Intensities </a:t>
                        </a:r>
                        <a:endParaRPr b="0" lang="en-US" sz="8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r>
                          <a:rPr b="1" lang="en-IN" sz="800" spc="-1" strike="noStrike">
                            <a:solidFill>
                              <a:srgbClr val="10253f"/>
                            </a:solidFill>
                            <a:latin typeface="Times New Roman"/>
                            <a:ea typeface="Times New Roman"/>
                          </a:rPr>
                          <a:t>Normalized Against </a:t>
                        </a:r>
                        <a:r>
                          <a:rPr b="1" lang="el-GR" sz="800" spc="-1" strike="noStrike">
                            <a:solidFill>
                              <a:srgbClr val="10253f"/>
                            </a:solidFill>
                            <a:latin typeface="Times New Roman"/>
                            <a:ea typeface="Times New Roman"/>
                          </a:rPr>
                          <a:t>β</a:t>
                        </a:r>
                        <a:r>
                          <a:rPr b="1" lang="en-IN" sz="800" spc="-1" strike="noStrike">
                            <a:solidFill>
                              <a:srgbClr val="10253f"/>
                            </a:solidFill>
                            <a:latin typeface="Times New Roman"/>
                            <a:ea typeface="Times New Roman"/>
                          </a:rPr>
                          <a:t>-actin (Fold Change)</a:t>
                        </a:r>
                        <a:endParaRPr b="0" lang="en-US" sz="8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260" name="TextBox 6"/>
                      <p:cNvSpPr/>
                      <p:nvPr/>
                    </p:nvSpPr>
                    <p:spPr>
                      <a:xfrm>
                        <a:off x="1071360" y="5940720"/>
                        <a:ext cx="2143080" cy="2156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r>
                          <a:rPr b="1" lang="en-IN" sz="800" spc="-1" strike="noStrike">
                            <a:solidFill>
                              <a:srgbClr val="10253f"/>
                            </a:solidFill>
                            <a:latin typeface="Times New Roman"/>
                            <a:ea typeface="Times New Roman"/>
                          </a:rPr>
                          <a:t>Upstream Prosurvival Effectors</a:t>
                        </a:r>
                        <a:endParaRPr b="0" lang="en-US" sz="8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grpSp>
                  <p:nvGrpSpPr>
                    <p:cNvPr id="261" name="Group 45"/>
                    <p:cNvGrpSpPr/>
                    <p:nvPr/>
                  </p:nvGrpSpPr>
                  <p:grpSpPr>
                    <a:xfrm>
                      <a:off x="1015560" y="4897440"/>
                      <a:ext cx="342720" cy="185400"/>
                      <a:chOff x="1015560" y="4897440"/>
                      <a:chExt cx="342720" cy="185400"/>
                    </a:xfrm>
                  </p:grpSpPr>
                  <p:sp>
                    <p:nvSpPr>
                      <p:cNvPr id="262" name="Straight Connector 79"/>
                      <p:cNvSpPr/>
                      <p:nvPr/>
                    </p:nvSpPr>
                    <p:spPr>
                      <a:xfrm>
                        <a:off x="1128240" y="5012280"/>
                        <a:ext cx="114120" cy="0"/>
                      </a:xfrm>
                      <a:prstGeom prst="line">
                        <a:avLst/>
                      </a:prstGeom>
                      <a:ln w="6480">
                        <a:solidFill>
                          <a:srgbClr val="4f6228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800" bIns="-46800" anchor="t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263" name="TextBox 80"/>
                      <p:cNvSpPr/>
                      <p:nvPr/>
                    </p:nvSpPr>
                    <p:spPr>
                      <a:xfrm>
                        <a:off x="1015560" y="4897440"/>
                        <a:ext cx="342720" cy="18540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r>
                          <a:rPr b="1" lang="en-IN" sz="600" spc="-1" strike="noStrike">
                            <a:solidFill>
                              <a:srgbClr val="4f6228"/>
                            </a:solidFill>
                            <a:latin typeface="Times New Roman"/>
                            <a:ea typeface="Times New Roman"/>
                          </a:rPr>
                          <a:t>***</a:t>
                        </a:r>
                        <a:endParaRPr b="0" lang="en-US" sz="6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</p:grpSp>
              <p:grpSp>
                <p:nvGrpSpPr>
                  <p:cNvPr id="264" name="Group 45"/>
                  <p:cNvGrpSpPr/>
                  <p:nvPr/>
                </p:nvGrpSpPr>
                <p:grpSpPr>
                  <a:xfrm>
                    <a:off x="1317240" y="4894200"/>
                    <a:ext cx="342720" cy="185400"/>
                    <a:chOff x="1317240" y="4894200"/>
                    <a:chExt cx="342720" cy="185400"/>
                  </a:xfrm>
                </p:grpSpPr>
                <p:sp>
                  <p:nvSpPr>
                    <p:cNvPr id="265" name="Straight Connector 82"/>
                    <p:cNvSpPr/>
                    <p:nvPr/>
                  </p:nvSpPr>
                  <p:spPr>
                    <a:xfrm>
                      <a:off x="1414080" y="5010480"/>
                      <a:ext cx="145800" cy="0"/>
                    </a:xfrm>
                    <a:prstGeom prst="line">
                      <a:avLst/>
                    </a:prstGeom>
                    <a:ln w="6480">
                      <a:solidFill>
                        <a:srgbClr val="4f6228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266" name="TextBox 83"/>
                    <p:cNvSpPr/>
                    <p:nvPr/>
                  </p:nvSpPr>
                  <p:spPr>
                    <a:xfrm>
                      <a:off x="1317240" y="4894200"/>
                      <a:ext cx="342720" cy="1854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4f6228"/>
                          </a:solidFill>
                          <a:latin typeface="Times New Roman"/>
                          <a:ea typeface="Times New Roman"/>
                        </a:rPr>
                        <a:t>***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grpSp>
                <p:nvGrpSpPr>
                  <p:cNvPr id="267" name="Group 45"/>
                  <p:cNvGrpSpPr/>
                  <p:nvPr/>
                </p:nvGrpSpPr>
                <p:grpSpPr>
                  <a:xfrm>
                    <a:off x="1449360" y="4683240"/>
                    <a:ext cx="344520" cy="185400"/>
                    <a:chOff x="1449360" y="4683240"/>
                    <a:chExt cx="344520" cy="185400"/>
                  </a:xfrm>
                </p:grpSpPr>
                <p:sp>
                  <p:nvSpPr>
                    <p:cNvPr id="268" name="Straight Connector 98"/>
                    <p:cNvSpPr/>
                    <p:nvPr/>
                  </p:nvSpPr>
                  <p:spPr>
                    <a:xfrm>
                      <a:off x="1546200" y="4800960"/>
                      <a:ext cx="147600" cy="0"/>
                    </a:xfrm>
                    <a:prstGeom prst="line">
                      <a:avLst/>
                    </a:prstGeom>
                    <a:ln w="6480">
                      <a:solidFill>
                        <a:srgbClr val="4f6228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269" name="TextBox 99"/>
                    <p:cNvSpPr/>
                    <p:nvPr/>
                  </p:nvSpPr>
                  <p:spPr>
                    <a:xfrm>
                      <a:off x="1449360" y="4683240"/>
                      <a:ext cx="344520" cy="1854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4f6228"/>
                          </a:solidFill>
                          <a:latin typeface="Times New Roman"/>
                          <a:ea typeface="Times New Roman"/>
                        </a:rPr>
                        <a:t>***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</p:grpSp>
            <p:grpSp>
              <p:nvGrpSpPr>
                <p:cNvPr id="270" name="Group 52"/>
                <p:cNvGrpSpPr/>
                <p:nvPr/>
              </p:nvGrpSpPr>
              <p:grpSpPr>
                <a:xfrm>
                  <a:off x="1884240" y="4686120"/>
                  <a:ext cx="358560" cy="185400"/>
                  <a:chOff x="1884240" y="4686120"/>
                  <a:chExt cx="358560" cy="185400"/>
                </a:xfrm>
              </p:grpSpPr>
              <p:sp>
                <p:nvSpPr>
                  <p:cNvPr id="271" name="Straight Connector 105"/>
                  <p:cNvSpPr/>
                  <p:nvPr/>
                </p:nvSpPr>
                <p:spPr>
                  <a:xfrm>
                    <a:off x="1989000" y="4799160"/>
                    <a:ext cx="149040" cy="0"/>
                  </a:xfrm>
                  <a:prstGeom prst="line">
                    <a:avLst/>
                  </a:prstGeom>
                  <a:ln w="6480">
                    <a:solidFill>
                      <a:srgbClr val="4f6228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2" name="TextBox 106"/>
                  <p:cNvSpPr/>
                  <p:nvPr/>
                </p:nvSpPr>
                <p:spPr>
                  <a:xfrm>
                    <a:off x="1884240" y="4686120"/>
                    <a:ext cx="35856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600" spc="-1" strike="noStrike">
                        <a:solidFill>
                          <a:srgbClr val="4f6228"/>
                        </a:solidFill>
                        <a:latin typeface="Times New Roman"/>
                        <a:ea typeface="Times New Roman"/>
                      </a:rPr>
                      <a:t>***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73" name="Group 52"/>
                <p:cNvGrpSpPr/>
                <p:nvPr/>
              </p:nvGrpSpPr>
              <p:grpSpPr>
                <a:xfrm>
                  <a:off x="1795680" y="4893480"/>
                  <a:ext cx="358560" cy="185400"/>
                  <a:chOff x="1795680" y="4893480"/>
                  <a:chExt cx="358560" cy="185400"/>
                </a:xfrm>
              </p:grpSpPr>
              <p:sp>
                <p:nvSpPr>
                  <p:cNvPr id="274" name="Straight Connector 109"/>
                  <p:cNvSpPr/>
                  <p:nvPr/>
                </p:nvSpPr>
                <p:spPr>
                  <a:xfrm>
                    <a:off x="1900440" y="5006520"/>
                    <a:ext cx="149040" cy="0"/>
                  </a:xfrm>
                  <a:prstGeom prst="line">
                    <a:avLst/>
                  </a:prstGeom>
                  <a:ln w="6480">
                    <a:solidFill>
                      <a:srgbClr val="4f6228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5" name="TextBox 110"/>
                  <p:cNvSpPr/>
                  <p:nvPr/>
                </p:nvSpPr>
                <p:spPr>
                  <a:xfrm>
                    <a:off x="1795680" y="4893480"/>
                    <a:ext cx="35856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600" spc="-1" strike="noStrike">
                        <a:solidFill>
                          <a:srgbClr val="4f6228"/>
                        </a:solidFill>
                        <a:latin typeface="Times New Roman"/>
                        <a:ea typeface="Times New Roman"/>
                      </a:rPr>
                      <a:t>*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276" name="Group 55"/>
              <p:cNvGrpSpPr/>
              <p:nvPr/>
            </p:nvGrpSpPr>
            <p:grpSpPr>
              <a:xfrm>
                <a:off x="2301840" y="5442120"/>
                <a:ext cx="358560" cy="185400"/>
                <a:chOff x="2301840" y="5442120"/>
                <a:chExt cx="358560" cy="185400"/>
              </a:xfrm>
            </p:grpSpPr>
            <p:sp>
              <p:nvSpPr>
                <p:cNvPr id="277" name="Straight Connector 113"/>
                <p:cNvSpPr/>
                <p:nvPr/>
              </p:nvSpPr>
              <p:spPr>
                <a:xfrm>
                  <a:off x="2361960" y="5582160"/>
                  <a:ext cx="230040" cy="0"/>
                </a:xfrm>
                <a:prstGeom prst="line">
                  <a:avLst/>
                </a:prstGeom>
                <a:ln w="6480">
                  <a:solidFill>
                    <a:srgbClr val="4f6228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8" name="TextBox 114"/>
                <p:cNvSpPr/>
                <p:nvPr/>
              </p:nvSpPr>
              <p:spPr>
                <a:xfrm>
                  <a:off x="2301840" y="5442120"/>
                  <a:ext cx="3585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4f6228"/>
                      </a:solidFill>
                      <a:latin typeface="Times New Roman"/>
                      <a:ea typeface="Times New Roman"/>
                    </a:rPr>
                    <a:t>ns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79" name="Group 52"/>
              <p:cNvGrpSpPr/>
              <p:nvPr/>
            </p:nvGrpSpPr>
            <p:grpSpPr>
              <a:xfrm>
                <a:off x="2841840" y="4578120"/>
                <a:ext cx="298440" cy="185400"/>
                <a:chOff x="2841840" y="4578120"/>
                <a:chExt cx="298440" cy="185400"/>
              </a:xfrm>
            </p:grpSpPr>
            <p:sp>
              <p:nvSpPr>
                <p:cNvPr id="280" name="Straight Connector 116"/>
                <p:cNvSpPr/>
                <p:nvPr/>
              </p:nvSpPr>
              <p:spPr>
                <a:xfrm>
                  <a:off x="2892600" y="4718160"/>
                  <a:ext cx="190440" cy="0"/>
                </a:xfrm>
                <a:prstGeom prst="line">
                  <a:avLst/>
                </a:prstGeom>
                <a:ln w="6480">
                  <a:solidFill>
                    <a:srgbClr val="4f6228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1" name="TextBox 117"/>
                <p:cNvSpPr/>
                <p:nvPr/>
              </p:nvSpPr>
              <p:spPr>
                <a:xfrm>
                  <a:off x="2841840" y="4578120"/>
                  <a:ext cx="29844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4f6228"/>
                      </a:solidFill>
                      <a:latin typeface="Times New Roman"/>
                      <a:ea typeface="Times New Roman"/>
                    </a:rPr>
                    <a:t>***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grpSp>
          <p:nvGrpSpPr>
            <p:cNvPr id="282" name="Group 45"/>
            <p:cNvGrpSpPr/>
            <p:nvPr/>
          </p:nvGrpSpPr>
          <p:grpSpPr>
            <a:xfrm>
              <a:off x="3310200" y="4865760"/>
              <a:ext cx="315720" cy="185400"/>
              <a:chOff x="3310200" y="4865760"/>
              <a:chExt cx="315720" cy="185400"/>
            </a:xfrm>
          </p:grpSpPr>
          <p:sp>
            <p:nvSpPr>
              <p:cNvPr id="283" name="Straight Connector 120"/>
              <p:cNvSpPr/>
              <p:nvPr/>
            </p:nvSpPr>
            <p:spPr>
              <a:xfrm>
                <a:off x="3386160" y="5007600"/>
                <a:ext cx="174600" cy="0"/>
              </a:xfrm>
              <a:prstGeom prst="line">
                <a:avLst/>
              </a:prstGeom>
              <a:ln w="6480">
                <a:solidFill>
                  <a:srgbClr val="4f622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4" name="TextBox 121"/>
              <p:cNvSpPr/>
              <p:nvPr/>
            </p:nvSpPr>
            <p:spPr>
              <a:xfrm>
                <a:off x="3310200" y="4865760"/>
                <a:ext cx="31572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600" spc="-1" strike="noStrike">
                    <a:solidFill>
                      <a:srgbClr val="4f6228"/>
                    </a:solidFill>
                    <a:latin typeface="Times New Roman"/>
                    <a:ea typeface="Times New Roman"/>
                  </a:rPr>
                  <a:t>***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285" name="TextBox 117"/>
          <p:cNvSpPr/>
          <p:nvPr/>
        </p:nvSpPr>
        <p:spPr>
          <a:xfrm>
            <a:off x="-1440" y="9690120"/>
            <a:ext cx="1436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TextBox 40"/>
          <p:cNvSpPr/>
          <p:nvPr/>
        </p:nvSpPr>
        <p:spPr>
          <a:xfrm>
            <a:off x="1006560" y="600120"/>
            <a:ext cx="32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TextBox 40"/>
          <p:cNvSpPr/>
          <p:nvPr/>
        </p:nvSpPr>
        <p:spPr>
          <a:xfrm>
            <a:off x="388800" y="3627360"/>
            <a:ext cx="32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1" lang="en-IN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TextBox 40"/>
          <p:cNvSpPr/>
          <p:nvPr/>
        </p:nvSpPr>
        <p:spPr>
          <a:xfrm>
            <a:off x="4281480" y="368928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1" lang="en-IN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TextBox 40"/>
          <p:cNvSpPr/>
          <p:nvPr/>
        </p:nvSpPr>
        <p:spPr>
          <a:xfrm>
            <a:off x="1943280" y="647712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1" lang="en-IN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0" name="TextBox 117"/>
          <p:cNvSpPr/>
          <p:nvPr/>
        </p:nvSpPr>
        <p:spPr>
          <a:xfrm>
            <a:off x="-1440" y="9690120"/>
            <a:ext cx="1436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91" name="Group 8"/>
          <p:cNvGrpSpPr/>
          <p:nvPr/>
        </p:nvGrpSpPr>
        <p:grpSpPr>
          <a:xfrm>
            <a:off x="571680" y="471600"/>
            <a:ext cx="6211800" cy="1898640"/>
            <a:chOff x="571680" y="471600"/>
            <a:chExt cx="6211800" cy="1898640"/>
          </a:xfrm>
        </p:grpSpPr>
        <p:grpSp>
          <p:nvGrpSpPr>
            <p:cNvPr id="292" name="Group 5"/>
            <p:cNvGrpSpPr/>
            <p:nvPr/>
          </p:nvGrpSpPr>
          <p:grpSpPr>
            <a:xfrm>
              <a:off x="793080" y="566280"/>
              <a:ext cx="5990400" cy="1803960"/>
              <a:chOff x="793080" y="566280"/>
              <a:chExt cx="5990400" cy="1803960"/>
            </a:xfrm>
          </p:grpSpPr>
          <p:grpSp>
            <p:nvGrpSpPr>
              <p:cNvPr id="293" name="Group 3"/>
              <p:cNvGrpSpPr/>
              <p:nvPr/>
            </p:nvGrpSpPr>
            <p:grpSpPr>
              <a:xfrm>
                <a:off x="793080" y="566280"/>
                <a:ext cx="3830400" cy="1803960"/>
                <a:chOff x="793080" y="566280"/>
                <a:chExt cx="3830400" cy="1803960"/>
              </a:xfrm>
            </p:grpSpPr>
            <p:pic>
              <p:nvPicPr>
                <p:cNvPr id="294" name="Picture 1" descr=""/>
                <p:cNvPicPr/>
                <p:nvPr/>
              </p:nvPicPr>
              <p:blipFill>
                <a:blip r:embed="rId1"/>
                <a:srcRect l="3519" t="1631" r="3519" b="1631"/>
                <a:stretch/>
              </p:blipFill>
              <p:spPr>
                <a:xfrm>
                  <a:off x="793080" y="566280"/>
                  <a:ext cx="1729440" cy="17942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95" name="Picture 86" descr=""/>
                <p:cNvPicPr/>
                <p:nvPr/>
              </p:nvPicPr>
              <p:blipFill>
                <a:blip r:embed="rId2"/>
                <a:srcRect l="0" t="0" r="5633" b="0"/>
                <a:stretch/>
              </p:blipFill>
              <p:spPr>
                <a:xfrm>
                  <a:off x="2782080" y="579240"/>
                  <a:ext cx="1841400" cy="17910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pic>
            <p:nvPicPr>
              <p:cNvPr id="296" name="Picture 4" descr=""/>
              <p:cNvPicPr/>
              <p:nvPr/>
            </p:nvPicPr>
            <p:blipFill>
              <a:blip r:embed="rId3"/>
              <a:srcRect l="0" t="0" r="6952" b="0"/>
              <a:stretch/>
            </p:blipFill>
            <p:spPr>
              <a:xfrm>
                <a:off x="4765320" y="590760"/>
                <a:ext cx="2018160" cy="176832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297" name="TextBox 7"/>
            <p:cNvSpPr/>
            <p:nvPr/>
          </p:nvSpPr>
          <p:spPr>
            <a:xfrm>
              <a:off x="571680" y="471600"/>
              <a:ext cx="290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98" name="Group 20"/>
          <p:cNvGrpSpPr/>
          <p:nvPr/>
        </p:nvGrpSpPr>
        <p:grpSpPr>
          <a:xfrm>
            <a:off x="571680" y="2506680"/>
            <a:ext cx="5506920" cy="3021120"/>
            <a:chOff x="571680" y="2506680"/>
            <a:chExt cx="5506920" cy="3021120"/>
          </a:xfrm>
        </p:grpSpPr>
        <p:sp>
          <p:nvSpPr>
            <p:cNvPr id="299" name="Rectangle 10"/>
            <p:cNvSpPr/>
            <p:nvPr/>
          </p:nvSpPr>
          <p:spPr>
            <a:xfrm>
              <a:off x="2387520" y="2506680"/>
              <a:ext cx="2938320" cy="519120"/>
            </a:xfrm>
            <a:prstGeom prst="rect">
              <a:avLst/>
            </a:prstGeom>
            <a:gradFill rotWithShape="0">
              <a:gsLst>
                <a:gs pos="0">
                  <a:srgbClr val="ff9999"/>
                </a:gs>
                <a:gs pos="100000">
                  <a:srgbClr val="ffffff"/>
                </a:gs>
              </a:gsLst>
              <a:lin ang="18900000"/>
            </a:gradFill>
            <a:ln cap="rnd" w="6480">
              <a:solidFill>
                <a:srgbClr val="ff66ff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REBP2 being the ‘Growth Essential Factor’ for HGSOC Scenari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300" name="Group 14"/>
            <p:cNvGrpSpPr/>
            <p:nvPr/>
          </p:nvGrpSpPr>
          <p:grpSpPr>
            <a:xfrm>
              <a:off x="571680" y="3248280"/>
              <a:ext cx="5506920" cy="2279520"/>
              <a:chOff x="571680" y="3248280"/>
              <a:chExt cx="5506920" cy="2279520"/>
            </a:xfrm>
          </p:grpSpPr>
          <p:grpSp>
            <p:nvGrpSpPr>
              <p:cNvPr id="301" name="Group 12"/>
              <p:cNvGrpSpPr/>
              <p:nvPr/>
            </p:nvGrpSpPr>
            <p:grpSpPr>
              <a:xfrm>
                <a:off x="571680" y="3248280"/>
                <a:ext cx="5506920" cy="2279520"/>
                <a:chOff x="571680" y="3248280"/>
                <a:chExt cx="5506920" cy="2279520"/>
              </a:xfrm>
            </p:grpSpPr>
            <p:grpSp>
              <p:nvGrpSpPr>
                <p:cNvPr id="302" name="Group 9"/>
                <p:cNvGrpSpPr/>
                <p:nvPr/>
              </p:nvGrpSpPr>
              <p:grpSpPr>
                <a:xfrm>
                  <a:off x="571680" y="3248280"/>
                  <a:ext cx="3045960" cy="2177280"/>
                  <a:chOff x="571680" y="3248280"/>
                  <a:chExt cx="3045960" cy="2177280"/>
                </a:xfrm>
              </p:grpSpPr>
              <p:pic>
                <p:nvPicPr>
                  <p:cNvPr id="303" name="Picture 6" descr=""/>
                  <p:cNvPicPr/>
                  <p:nvPr/>
                </p:nvPicPr>
                <p:blipFill>
                  <a:blip r:embed="rId4"/>
                  <a:srcRect l="0" t="4275" r="1075" b="0"/>
                  <a:stretch/>
                </p:blipFill>
                <p:spPr>
                  <a:xfrm>
                    <a:off x="1427040" y="3569400"/>
                    <a:ext cx="2190600" cy="1856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304" name="TextBox 88"/>
                  <p:cNvSpPr/>
                  <p:nvPr/>
                </p:nvSpPr>
                <p:spPr>
                  <a:xfrm>
                    <a:off x="571680" y="3248280"/>
                    <a:ext cx="29016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b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pic>
              <p:nvPicPr>
                <p:cNvPr id="305" name="Picture 11" descr=""/>
                <p:cNvPicPr/>
                <p:nvPr/>
              </p:nvPicPr>
              <p:blipFill>
                <a:blip r:embed="rId5"/>
                <a:srcRect l="1997" t="7197" r="1516" b="-329"/>
                <a:stretch/>
              </p:blipFill>
              <p:spPr>
                <a:xfrm>
                  <a:off x="3741840" y="3534480"/>
                  <a:ext cx="2336760" cy="19933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306" name="TextBox 13"/>
              <p:cNvSpPr/>
              <p:nvPr/>
            </p:nvSpPr>
            <p:spPr>
              <a:xfrm>
                <a:off x="4678920" y="3323160"/>
                <a:ext cx="759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US" sz="1000" spc="-1" strike="noStrike">
                    <a:solidFill>
                      <a:srgbClr val="005800"/>
                    </a:solidFill>
                    <a:latin typeface="Times New Roman"/>
                    <a:ea typeface="Times New Roman"/>
                  </a:rPr>
                  <a:t>SEROUS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7" name="TextBox 98"/>
              <p:cNvSpPr/>
              <p:nvPr/>
            </p:nvSpPr>
            <p:spPr>
              <a:xfrm>
                <a:off x="2040120" y="3344400"/>
                <a:ext cx="1333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US" sz="1000" spc="-1" strike="noStrike">
                    <a:solidFill>
                      <a:srgbClr val="005800"/>
                    </a:solidFill>
                    <a:latin typeface="Times New Roman"/>
                    <a:ea typeface="Times New Roman"/>
                  </a:rPr>
                  <a:t>NON-SEROUS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08" name="Straight Connector 16"/>
            <p:cNvSpPr/>
            <p:nvPr/>
          </p:nvSpPr>
          <p:spPr>
            <a:xfrm>
              <a:off x="5326200" y="3025800"/>
              <a:ext cx="687240" cy="536400"/>
            </a:xfrm>
            <a:prstGeom prst="line">
              <a:avLst/>
            </a:prstGeom>
            <a:ln cap="rnd" w="9360">
              <a:solidFill>
                <a:srgbClr val="ff6699"/>
              </a:solidFill>
              <a:custDash>
                <a:ds d="3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9" name="Straight Connector 101"/>
            <p:cNvSpPr/>
            <p:nvPr/>
          </p:nvSpPr>
          <p:spPr>
            <a:xfrm flipH="1">
              <a:off x="1749600" y="3025800"/>
              <a:ext cx="637920" cy="542880"/>
            </a:xfrm>
            <a:prstGeom prst="line">
              <a:avLst/>
            </a:prstGeom>
            <a:ln cap="rnd" w="9360">
              <a:solidFill>
                <a:srgbClr val="ff6699"/>
              </a:solidFill>
              <a:custDash>
                <a:ds d="3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10" name="Group 21"/>
          <p:cNvGrpSpPr/>
          <p:nvPr/>
        </p:nvGrpSpPr>
        <p:grpSpPr>
          <a:xfrm>
            <a:off x="520560" y="5527800"/>
            <a:ext cx="4780080" cy="3606840"/>
            <a:chOff x="520560" y="5527800"/>
            <a:chExt cx="4780080" cy="3606840"/>
          </a:xfrm>
        </p:grpSpPr>
        <p:grpSp>
          <p:nvGrpSpPr>
            <p:cNvPr id="311" name="Group 81"/>
            <p:cNvGrpSpPr/>
            <p:nvPr/>
          </p:nvGrpSpPr>
          <p:grpSpPr>
            <a:xfrm>
              <a:off x="2000160" y="5901480"/>
              <a:ext cx="3300480" cy="3233160"/>
              <a:chOff x="2000160" y="5901480"/>
              <a:chExt cx="3300480" cy="3233160"/>
            </a:xfrm>
          </p:grpSpPr>
          <p:grpSp>
            <p:nvGrpSpPr>
              <p:cNvPr id="312" name="Group 73"/>
              <p:cNvGrpSpPr/>
              <p:nvPr/>
            </p:nvGrpSpPr>
            <p:grpSpPr>
              <a:xfrm>
                <a:off x="2000160" y="5901480"/>
                <a:ext cx="3300480" cy="2796480"/>
                <a:chOff x="2000160" y="5901480"/>
                <a:chExt cx="3300480" cy="2796480"/>
              </a:xfrm>
            </p:grpSpPr>
            <p:grpSp>
              <p:nvGrpSpPr>
                <p:cNvPr id="313" name="Group 3"/>
                <p:cNvGrpSpPr/>
                <p:nvPr/>
              </p:nvGrpSpPr>
              <p:grpSpPr>
                <a:xfrm>
                  <a:off x="2225520" y="6203880"/>
                  <a:ext cx="576000" cy="273600"/>
                  <a:chOff x="2225520" y="6203880"/>
                  <a:chExt cx="576000" cy="273600"/>
                </a:xfrm>
              </p:grpSpPr>
              <p:sp>
                <p:nvSpPr>
                  <p:cNvPr id="314" name="TextBox 107"/>
                  <p:cNvSpPr/>
                  <p:nvPr/>
                </p:nvSpPr>
                <p:spPr>
                  <a:xfrm>
                    <a:off x="2232360" y="6242400"/>
                    <a:ext cx="55476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403152"/>
                        </a:solidFill>
                        <a:latin typeface="Times New Roman"/>
                        <a:ea typeface="Times New Roman"/>
                      </a:rPr>
                      <a:t>Akt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grpSp>
                <p:nvGrpSpPr>
                  <p:cNvPr id="315" name="Oval 138"/>
                  <p:cNvGrpSpPr/>
                  <p:nvPr/>
                </p:nvGrpSpPr>
                <p:grpSpPr>
                  <a:xfrm>
                    <a:off x="2225520" y="6203880"/>
                    <a:ext cx="576000" cy="273600"/>
                    <a:chOff x="2225520" y="6203880"/>
                    <a:chExt cx="576000" cy="273600"/>
                  </a:xfrm>
                </p:grpSpPr>
                <p:pic>
                  <p:nvPicPr>
                    <p:cNvPr id="316" name="Oval 138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2225520" y="6203880"/>
                      <a:ext cx="576000" cy="2736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317" name=""/>
                    <p:cNvSpPr/>
                    <p:nvPr/>
                  </p:nvSpPr>
                  <p:spPr>
                    <a:xfrm>
                      <a:off x="2309400" y="6241320"/>
                      <a:ext cx="401040" cy="1890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</p:grpSp>
            <p:grpSp>
              <p:nvGrpSpPr>
                <p:cNvPr id="318" name="Freeform 74"/>
                <p:cNvGrpSpPr/>
                <p:nvPr/>
              </p:nvGrpSpPr>
              <p:grpSpPr>
                <a:xfrm>
                  <a:off x="2773800" y="6034680"/>
                  <a:ext cx="316440" cy="298440"/>
                  <a:chOff x="2773800" y="6034680"/>
                  <a:chExt cx="316440" cy="298440"/>
                </a:xfrm>
              </p:grpSpPr>
              <p:pic>
                <p:nvPicPr>
                  <p:cNvPr id="319" name="Freeform 74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2792160" y="6034680"/>
                    <a:ext cx="298080" cy="298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320" name=""/>
                  <p:cNvSpPr/>
                  <p:nvPr/>
                </p:nvSpPr>
                <p:spPr>
                  <a:xfrm rot="19186800">
                    <a:off x="2755080" y="6179040"/>
                    <a:ext cx="282600" cy="457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080" bIns="-108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21" name="Group 8"/>
                <p:cNvGrpSpPr/>
                <p:nvPr/>
              </p:nvGrpSpPr>
              <p:grpSpPr>
                <a:xfrm>
                  <a:off x="2926080" y="5901480"/>
                  <a:ext cx="630720" cy="237600"/>
                  <a:chOff x="2926080" y="5901480"/>
                  <a:chExt cx="630720" cy="237600"/>
                </a:xfrm>
              </p:grpSpPr>
              <p:grpSp>
                <p:nvGrpSpPr>
                  <p:cNvPr id="322" name="Oval 135"/>
                  <p:cNvGrpSpPr/>
                  <p:nvPr/>
                </p:nvGrpSpPr>
                <p:grpSpPr>
                  <a:xfrm>
                    <a:off x="2926080" y="5905800"/>
                    <a:ext cx="630720" cy="233280"/>
                    <a:chOff x="2926080" y="5905800"/>
                    <a:chExt cx="630720" cy="233280"/>
                  </a:xfrm>
                </p:grpSpPr>
                <p:pic>
                  <p:nvPicPr>
                    <p:cNvPr id="323" name="Oval 135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2926080" y="5905800"/>
                      <a:ext cx="630720" cy="2332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324" name=""/>
                    <p:cNvSpPr/>
                    <p:nvPr/>
                  </p:nvSpPr>
                  <p:spPr>
                    <a:xfrm>
                      <a:off x="3017160" y="5940360"/>
                      <a:ext cx="439560" cy="1602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325" name="TextBox 107"/>
                  <p:cNvSpPr/>
                  <p:nvPr/>
                </p:nvSpPr>
                <p:spPr>
                  <a:xfrm>
                    <a:off x="2936520" y="5901480"/>
                    <a:ext cx="5994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403152"/>
                        </a:solidFill>
                        <a:latin typeface="Times New Roman"/>
                        <a:ea typeface="Times New Roman"/>
                      </a:rPr>
                      <a:t>pAkt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26" name="Freeform 76"/>
                <p:cNvGrpSpPr/>
                <p:nvPr/>
              </p:nvGrpSpPr>
              <p:grpSpPr>
                <a:xfrm>
                  <a:off x="3553920" y="6063480"/>
                  <a:ext cx="243720" cy="270000"/>
                  <a:chOff x="3553920" y="6063480"/>
                  <a:chExt cx="243720" cy="270000"/>
                </a:xfrm>
              </p:grpSpPr>
              <p:pic>
                <p:nvPicPr>
                  <p:cNvPr id="327" name="Freeform 76" descr=""/>
                  <p:cNvPicPr/>
                  <p:nvPr/>
                </p:nvPicPr>
                <p:blipFill>
                  <a:blip r:embed="rId9"/>
                  <a:stretch/>
                </p:blipFill>
                <p:spPr>
                  <a:xfrm>
                    <a:off x="3553920" y="6084360"/>
                    <a:ext cx="243720" cy="249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328" name=""/>
                  <p:cNvSpPr/>
                  <p:nvPr/>
                </p:nvSpPr>
                <p:spPr>
                  <a:xfrm rot="3049200">
                    <a:off x="3545640" y="6141600"/>
                    <a:ext cx="224280" cy="46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720" bIns="-72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29" name="Group 10"/>
                <p:cNvGrpSpPr/>
                <p:nvPr/>
              </p:nvGrpSpPr>
              <p:grpSpPr>
                <a:xfrm>
                  <a:off x="3527640" y="6295320"/>
                  <a:ext cx="630720" cy="231840"/>
                  <a:chOff x="3527640" y="6295320"/>
                  <a:chExt cx="630720" cy="231840"/>
                </a:xfrm>
              </p:grpSpPr>
              <p:grpSp>
                <p:nvGrpSpPr>
                  <p:cNvPr id="330" name="Oval 133"/>
                  <p:cNvGrpSpPr/>
                  <p:nvPr/>
                </p:nvGrpSpPr>
                <p:grpSpPr>
                  <a:xfrm>
                    <a:off x="3527640" y="6295320"/>
                    <a:ext cx="630720" cy="231840"/>
                    <a:chOff x="3527640" y="6295320"/>
                    <a:chExt cx="630720" cy="231840"/>
                  </a:xfrm>
                </p:grpSpPr>
                <p:pic>
                  <p:nvPicPr>
                    <p:cNvPr id="331" name="Oval 133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3527640" y="6295320"/>
                      <a:ext cx="630720" cy="231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332" name=""/>
                    <p:cNvSpPr/>
                    <p:nvPr/>
                  </p:nvSpPr>
                  <p:spPr>
                    <a:xfrm>
                      <a:off x="3617640" y="6326640"/>
                      <a:ext cx="443880" cy="1598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333" name="TextBox 107"/>
                  <p:cNvSpPr/>
                  <p:nvPr/>
                </p:nvSpPr>
                <p:spPr>
                  <a:xfrm>
                    <a:off x="3579120" y="6307920"/>
                    <a:ext cx="54648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984807"/>
                        </a:solidFill>
                        <a:latin typeface="Times New Roman"/>
                        <a:ea typeface="Times New Roman"/>
                      </a:rPr>
                      <a:t>mTOR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34" name="Freeform 78"/>
                <p:cNvGrpSpPr/>
                <p:nvPr/>
              </p:nvGrpSpPr>
              <p:grpSpPr>
                <a:xfrm>
                  <a:off x="3669840" y="6546960"/>
                  <a:ext cx="176760" cy="335160"/>
                  <a:chOff x="3669840" y="6546960"/>
                  <a:chExt cx="176760" cy="335160"/>
                </a:xfrm>
              </p:grpSpPr>
              <p:pic>
                <p:nvPicPr>
                  <p:cNvPr id="335" name="Freeform 78" descr=""/>
                  <p:cNvPicPr/>
                  <p:nvPr/>
                </p:nvPicPr>
                <p:blipFill>
                  <a:blip r:embed="rId11"/>
                  <a:stretch/>
                </p:blipFill>
                <p:spPr>
                  <a:xfrm>
                    <a:off x="3669840" y="6546960"/>
                    <a:ext cx="164520" cy="335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336" name=""/>
                  <p:cNvSpPr/>
                  <p:nvPr/>
                </p:nvSpPr>
                <p:spPr>
                  <a:xfrm rot="6085200">
                    <a:off x="3672720" y="6659640"/>
                    <a:ext cx="252360" cy="46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720" bIns="-72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37" name="Group 14"/>
                <p:cNvGrpSpPr/>
                <p:nvPr/>
              </p:nvGrpSpPr>
              <p:grpSpPr>
                <a:xfrm>
                  <a:off x="3294720" y="6859080"/>
                  <a:ext cx="654840" cy="230400"/>
                  <a:chOff x="3294720" y="6859080"/>
                  <a:chExt cx="654840" cy="230400"/>
                </a:xfrm>
              </p:grpSpPr>
              <p:grpSp>
                <p:nvGrpSpPr>
                  <p:cNvPr id="338" name="Oval 131"/>
                  <p:cNvGrpSpPr/>
                  <p:nvPr/>
                </p:nvGrpSpPr>
                <p:grpSpPr>
                  <a:xfrm>
                    <a:off x="3321720" y="6859080"/>
                    <a:ext cx="627840" cy="230400"/>
                    <a:chOff x="3321720" y="6859080"/>
                    <a:chExt cx="627840" cy="230400"/>
                  </a:xfrm>
                </p:grpSpPr>
                <p:pic>
                  <p:nvPicPr>
                    <p:cNvPr id="339" name="Oval 131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3321720" y="6859080"/>
                      <a:ext cx="627840" cy="230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340" name=""/>
                    <p:cNvSpPr/>
                    <p:nvPr/>
                  </p:nvSpPr>
                  <p:spPr>
                    <a:xfrm>
                      <a:off x="3411000" y="6892920"/>
                      <a:ext cx="440640" cy="1580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341" name="TextBox 107"/>
                  <p:cNvSpPr/>
                  <p:nvPr/>
                </p:nvSpPr>
                <p:spPr>
                  <a:xfrm>
                    <a:off x="3294720" y="6868080"/>
                    <a:ext cx="64008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663300"/>
                        </a:solidFill>
                        <a:latin typeface="Times New Roman"/>
                        <a:ea typeface="Times New Roman"/>
                      </a:rPr>
                      <a:t>p-mTOR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42" name="Freeform 80"/>
                <p:cNvGrpSpPr/>
                <p:nvPr/>
              </p:nvGrpSpPr>
              <p:grpSpPr>
                <a:xfrm>
                  <a:off x="3322080" y="7101720"/>
                  <a:ext cx="302400" cy="310680"/>
                  <a:chOff x="3322080" y="7101720"/>
                  <a:chExt cx="302400" cy="310680"/>
                </a:xfrm>
              </p:grpSpPr>
              <p:pic>
                <p:nvPicPr>
                  <p:cNvPr id="343" name="Freeform 80" descr=""/>
                  <p:cNvPicPr/>
                  <p:nvPr/>
                </p:nvPicPr>
                <p:blipFill>
                  <a:blip r:embed="rId13"/>
                  <a:stretch/>
                </p:blipFill>
                <p:spPr>
                  <a:xfrm>
                    <a:off x="3322080" y="7101720"/>
                    <a:ext cx="286200" cy="310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344" name=""/>
                  <p:cNvSpPr/>
                  <p:nvPr/>
                </p:nvSpPr>
                <p:spPr>
                  <a:xfrm rot="8211000">
                    <a:off x="3364920" y="7217280"/>
                    <a:ext cx="285840" cy="352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1520" bIns="-1152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45" name="Group 20"/>
                <p:cNvGrpSpPr/>
                <p:nvPr/>
              </p:nvGrpSpPr>
              <p:grpSpPr>
                <a:xfrm>
                  <a:off x="2704680" y="7244280"/>
                  <a:ext cx="753840" cy="231840"/>
                  <a:chOff x="2704680" y="7244280"/>
                  <a:chExt cx="753840" cy="231840"/>
                </a:xfrm>
              </p:grpSpPr>
              <p:grpSp>
                <p:nvGrpSpPr>
                  <p:cNvPr id="346" name="Oval 129"/>
                  <p:cNvGrpSpPr/>
                  <p:nvPr/>
                </p:nvGrpSpPr>
                <p:grpSpPr>
                  <a:xfrm>
                    <a:off x="2761200" y="7244280"/>
                    <a:ext cx="640080" cy="231840"/>
                    <a:chOff x="2761200" y="7244280"/>
                    <a:chExt cx="640080" cy="231840"/>
                  </a:xfrm>
                </p:grpSpPr>
                <p:pic>
                  <p:nvPicPr>
                    <p:cNvPr id="347" name="Oval 129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2761200" y="7244280"/>
                      <a:ext cx="640080" cy="231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348" name=""/>
                    <p:cNvSpPr/>
                    <p:nvPr/>
                  </p:nvSpPr>
                  <p:spPr>
                    <a:xfrm>
                      <a:off x="2854080" y="7279560"/>
                      <a:ext cx="446040" cy="1598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349" name="TextBox 107"/>
                  <p:cNvSpPr/>
                  <p:nvPr/>
                </p:nvSpPr>
                <p:spPr>
                  <a:xfrm>
                    <a:off x="2704680" y="7254720"/>
                    <a:ext cx="75384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663300"/>
                        </a:solidFill>
                        <a:latin typeface="Times New Roman"/>
                        <a:ea typeface="Times New Roman"/>
                      </a:rPr>
                      <a:t>RS6K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50" name="Group 21"/>
                <p:cNvGrpSpPr/>
                <p:nvPr/>
              </p:nvGrpSpPr>
              <p:grpSpPr>
                <a:xfrm>
                  <a:off x="2255400" y="6612480"/>
                  <a:ext cx="903240" cy="231840"/>
                  <a:chOff x="2255400" y="6612480"/>
                  <a:chExt cx="903240" cy="231840"/>
                </a:xfrm>
              </p:grpSpPr>
              <p:grpSp>
                <p:nvGrpSpPr>
                  <p:cNvPr id="351" name="Oval 127"/>
                  <p:cNvGrpSpPr/>
                  <p:nvPr/>
                </p:nvGrpSpPr>
                <p:grpSpPr>
                  <a:xfrm>
                    <a:off x="2358360" y="6612480"/>
                    <a:ext cx="633960" cy="231840"/>
                    <a:chOff x="2358360" y="6612480"/>
                    <a:chExt cx="633960" cy="231840"/>
                  </a:xfrm>
                </p:grpSpPr>
                <p:pic>
                  <p:nvPicPr>
                    <p:cNvPr id="352" name="Oval 127" descr=""/>
                    <p:cNvPicPr/>
                    <p:nvPr/>
                  </p:nvPicPr>
                  <p:blipFill>
                    <a:blip r:embed="rId15"/>
                    <a:stretch/>
                  </p:blipFill>
                  <p:spPr>
                    <a:xfrm>
                      <a:off x="2358360" y="6612480"/>
                      <a:ext cx="633960" cy="231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353" name=""/>
                    <p:cNvSpPr/>
                    <p:nvPr/>
                  </p:nvSpPr>
                  <p:spPr>
                    <a:xfrm>
                      <a:off x="2449080" y="6643800"/>
                      <a:ext cx="444960" cy="1598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354" name="TextBox 107"/>
                  <p:cNvSpPr/>
                  <p:nvPr/>
                </p:nvSpPr>
                <p:spPr>
                  <a:xfrm>
                    <a:off x="2255400" y="6619680"/>
                    <a:ext cx="90324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50003b"/>
                        </a:solidFill>
                        <a:latin typeface="Times New Roman"/>
                        <a:ea typeface="Times New Roman"/>
                      </a:rPr>
                      <a:t>P38MAPK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55" name="Freeform 83"/>
                <p:cNvGrpSpPr/>
                <p:nvPr/>
              </p:nvGrpSpPr>
              <p:grpSpPr>
                <a:xfrm>
                  <a:off x="2950200" y="6632280"/>
                  <a:ext cx="390600" cy="329040"/>
                  <a:chOff x="2950200" y="6632280"/>
                  <a:chExt cx="390600" cy="329040"/>
                </a:xfrm>
              </p:grpSpPr>
              <p:pic>
                <p:nvPicPr>
                  <p:cNvPr id="356" name="Freeform 83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2950200" y="6632280"/>
                    <a:ext cx="365040" cy="329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357" name=""/>
                  <p:cNvSpPr/>
                  <p:nvPr/>
                </p:nvSpPr>
                <p:spPr>
                  <a:xfrm rot="2213400">
                    <a:off x="3000600" y="6778800"/>
                    <a:ext cx="357480" cy="615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4760" bIns="1476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58" name="Freeform 84"/>
                <p:cNvGrpSpPr/>
                <p:nvPr/>
              </p:nvGrpSpPr>
              <p:grpSpPr>
                <a:xfrm>
                  <a:off x="2897280" y="6839640"/>
                  <a:ext cx="430920" cy="286560"/>
                  <a:chOff x="2897280" y="6839640"/>
                  <a:chExt cx="430920" cy="286560"/>
                </a:xfrm>
              </p:grpSpPr>
              <p:pic>
                <p:nvPicPr>
                  <p:cNvPr id="359" name="Freeform 84" descr=""/>
                  <p:cNvPicPr/>
                  <p:nvPr/>
                </p:nvPicPr>
                <p:blipFill>
                  <a:blip r:embed="rId17"/>
                  <a:stretch/>
                </p:blipFill>
                <p:spPr>
                  <a:xfrm>
                    <a:off x="2918160" y="6839640"/>
                    <a:ext cx="410040" cy="286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360" name=""/>
                  <p:cNvSpPr/>
                  <p:nvPr/>
                </p:nvSpPr>
                <p:spPr>
                  <a:xfrm rot="12529200">
                    <a:off x="2889000" y="6942960"/>
                    <a:ext cx="373320" cy="615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4760" bIns="1476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pic>
              <p:nvPicPr>
                <p:cNvPr id="361" name="Straight Arrow Connector 85" descr=""/>
                <p:cNvPicPr/>
                <p:nvPr/>
              </p:nvPicPr>
              <p:blipFill>
                <a:blip r:embed="rId18"/>
                <a:stretch/>
              </p:blipFill>
              <p:spPr>
                <a:xfrm>
                  <a:off x="3017160" y="7498080"/>
                  <a:ext cx="158400" cy="37188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362" name="Group 29"/>
                <p:cNvGrpSpPr/>
                <p:nvPr/>
              </p:nvGrpSpPr>
              <p:grpSpPr>
                <a:xfrm>
                  <a:off x="2845800" y="7790760"/>
                  <a:ext cx="630720" cy="231480"/>
                  <a:chOff x="2845800" y="7790760"/>
                  <a:chExt cx="630720" cy="231480"/>
                </a:xfrm>
              </p:grpSpPr>
              <p:grpSp>
                <p:nvGrpSpPr>
                  <p:cNvPr id="363" name="Oval 125"/>
                  <p:cNvGrpSpPr/>
                  <p:nvPr/>
                </p:nvGrpSpPr>
                <p:grpSpPr>
                  <a:xfrm>
                    <a:off x="2845800" y="7790760"/>
                    <a:ext cx="630720" cy="231480"/>
                    <a:chOff x="2845800" y="7790760"/>
                    <a:chExt cx="630720" cy="231480"/>
                  </a:xfrm>
                </p:grpSpPr>
                <p:pic>
                  <p:nvPicPr>
                    <p:cNvPr id="364" name="Oval 125" descr=""/>
                    <p:cNvPicPr/>
                    <p:nvPr/>
                  </p:nvPicPr>
                  <p:blipFill>
                    <a:blip r:embed="rId19"/>
                    <a:stretch/>
                  </p:blipFill>
                  <p:spPr>
                    <a:xfrm>
                      <a:off x="2845800" y="7790760"/>
                      <a:ext cx="630720" cy="231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365" name=""/>
                    <p:cNvSpPr/>
                    <p:nvPr/>
                  </p:nvSpPr>
                  <p:spPr>
                    <a:xfrm>
                      <a:off x="2936880" y="7824600"/>
                      <a:ext cx="443880" cy="15876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366" name="TextBox 107"/>
                  <p:cNvSpPr/>
                  <p:nvPr/>
                </p:nvSpPr>
                <p:spPr>
                  <a:xfrm>
                    <a:off x="2849400" y="7790760"/>
                    <a:ext cx="6138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ff0000"/>
                        </a:solidFill>
                        <a:latin typeface="Times New Roman"/>
                        <a:ea typeface="Times New Roman"/>
                      </a:rPr>
                      <a:t>COX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pic>
              <p:nvPicPr>
                <p:cNvPr id="367" name="Straight Arrow Connector 87" descr=""/>
                <p:cNvPicPr/>
                <p:nvPr/>
              </p:nvPicPr>
              <p:blipFill>
                <a:blip r:embed="rId20"/>
                <a:stretch/>
              </p:blipFill>
              <p:spPr>
                <a:xfrm>
                  <a:off x="2432160" y="7406640"/>
                  <a:ext cx="365760" cy="23760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368" name="Group 33"/>
                <p:cNvGrpSpPr/>
                <p:nvPr/>
              </p:nvGrpSpPr>
              <p:grpSpPr>
                <a:xfrm>
                  <a:off x="2000160" y="7562160"/>
                  <a:ext cx="629280" cy="240120"/>
                  <a:chOff x="2000160" y="7562160"/>
                  <a:chExt cx="629280" cy="240120"/>
                </a:xfrm>
              </p:grpSpPr>
              <p:grpSp>
                <p:nvGrpSpPr>
                  <p:cNvPr id="369" name="Oval 123"/>
                  <p:cNvGrpSpPr/>
                  <p:nvPr/>
                </p:nvGrpSpPr>
                <p:grpSpPr>
                  <a:xfrm>
                    <a:off x="2000160" y="7562160"/>
                    <a:ext cx="629280" cy="231840"/>
                    <a:chOff x="2000160" y="7562160"/>
                    <a:chExt cx="629280" cy="231840"/>
                  </a:xfrm>
                </p:grpSpPr>
                <p:pic>
                  <p:nvPicPr>
                    <p:cNvPr id="370" name="Oval 123" descr=""/>
                    <p:cNvPicPr/>
                    <p:nvPr/>
                  </p:nvPicPr>
                  <p:blipFill>
                    <a:blip r:embed="rId21"/>
                    <a:stretch/>
                  </p:blipFill>
                  <p:spPr>
                    <a:xfrm>
                      <a:off x="2000160" y="7562160"/>
                      <a:ext cx="629280" cy="231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371" name=""/>
                    <p:cNvSpPr/>
                    <p:nvPr/>
                  </p:nvSpPr>
                  <p:spPr>
                    <a:xfrm>
                      <a:off x="2092320" y="7597080"/>
                      <a:ext cx="441720" cy="1558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372" name="TextBox 107"/>
                  <p:cNvSpPr/>
                  <p:nvPr/>
                </p:nvSpPr>
                <p:spPr>
                  <a:xfrm>
                    <a:off x="2057400" y="7586640"/>
                    <a:ext cx="52488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403152"/>
                        </a:solidFill>
                        <a:latin typeface="Times New Roman"/>
                        <a:ea typeface="Times New Roman"/>
                      </a:rPr>
                      <a:t>HIF-1</a:t>
                    </a:r>
                    <a:r>
                      <a:rPr b="1" lang="el-GR" sz="800" spc="-1" strike="noStrike">
                        <a:solidFill>
                          <a:srgbClr val="403152"/>
                        </a:solidFill>
                        <a:latin typeface="Times New Roman"/>
                        <a:ea typeface="Times New Roman"/>
                      </a:rPr>
                      <a:t>α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pic>
              <p:nvPicPr>
                <p:cNvPr id="373" name="Straight Arrow Connector 89" descr=""/>
                <p:cNvPicPr/>
                <p:nvPr/>
              </p:nvPicPr>
              <p:blipFill>
                <a:blip r:embed="rId22"/>
                <a:stretch/>
              </p:blipFill>
              <p:spPr>
                <a:xfrm>
                  <a:off x="3413520" y="7455600"/>
                  <a:ext cx="316800" cy="17064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374" name="Group 40"/>
                <p:cNvGrpSpPr/>
                <p:nvPr/>
              </p:nvGrpSpPr>
              <p:grpSpPr>
                <a:xfrm>
                  <a:off x="3743640" y="7503480"/>
                  <a:ext cx="629280" cy="235440"/>
                  <a:chOff x="3743640" y="7503480"/>
                  <a:chExt cx="629280" cy="235440"/>
                </a:xfrm>
              </p:grpSpPr>
              <p:grpSp>
                <p:nvGrpSpPr>
                  <p:cNvPr id="375" name="Oval 121"/>
                  <p:cNvGrpSpPr/>
                  <p:nvPr/>
                </p:nvGrpSpPr>
                <p:grpSpPr>
                  <a:xfrm>
                    <a:off x="3743640" y="7503480"/>
                    <a:ext cx="629280" cy="235440"/>
                    <a:chOff x="3743640" y="7503480"/>
                    <a:chExt cx="629280" cy="235440"/>
                  </a:xfrm>
                </p:grpSpPr>
                <p:pic>
                  <p:nvPicPr>
                    <p:cNvPr id="376" name="Oval 121" descr=""/>
                    <p:cNvPicPr/>
                    <p:nvPr/>
                  </p:nvPicPr>
                  <p:blipFill>
                    <a:blip r:embed="rId23"/>
                    <a:stretch/>
                  </p:blipFill>
                  <p:spPr>
                    <a:xfrm>
                      <a:off x="3743640" y="7503480"/>
                      <a:ext cx="629280" cy="235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377" name=""/>
                    <p:cNvSpPr/>
                    <p:nvPr/>
                  </p:nvSpPr>
                  <p:spPr>
                    <a:xfrm>
                      <a:off x="3835800" y="7539840"/>
                      <a:ext cx="441720" cy="16236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378" name="TextBox 107"/>
                  <p:cNvSpPr/>
                  <p:nvPr/>
                </p:nvSpPr>
                <p:spPr>
                  <a:xfrm>
                    <a:off x="3761280" y="7503480"/>
                    <a:ext cx="6019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403152"/>
                        </a:solidFill>
                        <a:latin typeface="Times New Roman"/>
                        <a:ea typeface="Times New Roman"/>
                      </a:rPr>
                      <a:t>VEGF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79" name="Group 40"/>
                <p:cNvGrpSpPr/>
                <p:nvPr/>
              </p:nvGrpSpPr>
              <p:grpSpPr>
                <a:xfrm>
                  <a:off x="2133360" y="6021720"/>
                  <a:ext cx="779040" cy="1463040"/>
                  <a:chOff x="2133360" y="6021720"/>
                  <a:chExt cx="779040" cy="1463040"/>
                </a:xfrm>
              </p:grpSpPr>
              <p:pic>
                <p:nvPicPr>
                  <p:cNvPr id="380" name="Straight Arrow Connector 118" descr=""/>
                  <p:cNvPicPr/>
                  <p:nvPr/>
                </p:nvPicPr>
                <p:blipFill>
                  <a:blip r:embed="rId24"/>
                  <a:stretch/>
                </p:blipFill>
                <p:spPr>
                  <a:xfrm>
                    <a:off x="2133360" y="6338520"/>
                    <a:ext cx="142560" cy="1146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381" name="Straight Arrow Connector 119" descr=""/>
                  <p:cNvPicPr/>
                  <p:nvPr/>
                </p:nvPicPr>
                <p:blipFill>
                  <a:blip r:embed="rId25"/>
                  <a:stretch/>
                </p:blipFill>
                <p:spPr>
                  <a:xfrm>
                    <a:off x="2198880" y="6033240"/>
                    <a:ext cx="372960" cy="311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382" name="Straight Arrow Connector 120" descr=""/>
                  <p:cNvPicPr/>
                  <p:nvPr/>
                </p:nvPicPr>
                <p:blipFill>
                  <a:blip r:embed="rId26"/>
                  <a:stretch/>
                </p:blipFill>
                <p:spPr>
                  <a:xfrm>
                    <a:off x="2473560" y="6021720"/>
                    <a:ext cx="438840" cy="97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grpSp>
              <p:nvGrpSpPr>
                <p:cNvPr id="383" name="Freeform 92"/>
                <p:cNvGrpSpPr/>
                <p:nvPr/>
              </p:nvGrpSpPr>
              <p:grpSpPr>
                <a:xfrm>
                  <a:off x="3761280" y="7126560"/>
                  <a:ext cx="279000" cy="438480"/>
                  <a:chOff x="3761280" y="7126560"/>
                  <a:chExt cx="279000" cy="438480"/>
                </a:xfrm>
              </p:grpSpPr>
              <p:pic>
                <p:nvPicPr>
                  <p:cNvPr id="384" name="Freeform 92" descr=""/>
                  <p:cNvPicPr/>
                  <p:nvPr/>
                </p:nvPicPr>
                <p:blipFill>
                  <a:blip r:embed="rId27"/>
                  <a:stretch/>
                </p:blipFill>
                <p:spPr>
                  <a:xfrm>
                    <a:off x="3761280" y="7171920"/>
                    <a:ext cx="243720" cy="393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385" name=""/>
                  <p:cNvSpPr/>
                  <p:nvPr/>
                </p:nvSpPr>
                <p:spPr>
                  <a:xfrm rot="3904800">
                    <a:off x="3737880" y="7242480"/>
                    <a:ext cx="340920" cy="132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86" name="Freeform 93"/>
                <p:cNvGrpSpPr/>
                <p:nvPr/>
              </p:nvGrpSpPr>
              <p:grpSpPr>
                <a:xfrm>
                  <a:off x="2315160" y="7796880"/>
                  <a:ext cx="592200" cy="213120"/>
                  <a:chOff x="2315160" y="7796880"/>
                  <a:chExt cx="592200" cy="213120"/>
                </a:xfrm>
              </p:grpSpPr>
              <p:pic>
                <p:nvPicPr>
                  <p:cNvPr id="387" name="Freeform 93" descr=""/>
                  <p:cNvPicPr/>
                  <p:nvPr/>
                </p:nvPicPr>
                <p:blipFill>
                  <a:blip r:embed="rId28"/>
                  <a:stretch/>
                </p:blipFill>
                <p:spPr>
                  <a:xfrm>
                    <a:off x="2323080" y="7796880"/>
                    <a:ext cx="584280" cy="213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388" name=""/>
                  <p:cNvSpPr/>
                  <p:nvPr/>
                </p:nvSpPr>
                <p:spPr>
                  <a:xfrm rot="11623200">
                    <a:off x="2315880" y="7868520"/>
                    <a:ext cx="510840" cy="666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800" bIns="19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89" name="Freeform 94"/>
                <p:cNvGrpSpPr/>
                <p:nvPr/>
              </p:nvGrpSpPr>
              <p:grpSpPr>
                <a:xfrm>
                  <a:off x="3426120" y="7620120"/>
                  <a:ext cx="480960" cy="333720"/>
                  <a:chOff x="3426120" y="7620120"/>
                  <a:chExt cx="480960" cy="333720"/>
                </a:xfrm>
              </p:grpSpPr>
              <p:pic>
                <p:nvPicPr>
                  <p:cNvPr id="390" name="Freeform 94" descr=""/>
                  <p:cNvPicPr/>
                  <p:nvPr/>
                </p:nvPicPr>
                <p:blipFill>
                  <a:blip r:embed="rId29"/>
                  <a:stretch/>
                </p:blipFill>
                <p:spPr>
                  <a:xfrm>
                    <a:off x="3426120" y="7620120"/>
                    <a:ext cx="480960" cy="280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391" name=""/>
                  <p:cNvSpPr/>
                  <p:nvPr/>
                </p:nvSpPr>
                <p:spPr>
                  <a:xfrm rot="9249600">
                    <a:off x="3425760" y="7792560"/>
                    <a:ext cx="438480" cy="687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960" bIns="2196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92" name="Group 29"/>
                <p:cNvGrpSpPr/>
                <p:nvPr/>
              </p:nvGrpSpPr>
              <p:grpSpPr>
                <a:xfrm>
                  <a:off x="4178880" y="7208280"/>
                  <a:ext cx="721440" cy="230400"/>
                  <a:chOff x="4178880" y="7208280"/>
                  <a:chExt cx="721440" cy="230400"/>
                </a:xfrm>
              </p:grpSpPr>
              <p:grpSp>
                <p:nvGrpSpPr>
                  <p:cNvPr id="393" name="Oval 116"/>
                  <p:cNvGrpSpPr/>
                  <p:nvPr/>
                </p:nvGrpSpPr>
                <p:grpSpPr>
                  <a:xfrm>
                    <a:off x="4181760" y="7208280"/>
                    <a:ext cx="640440" cy="230400"/>
                    <a:chOff x="4181760" y="7208280"/>
                    <a:chExt cx="640440" cy="230400"/>
                  </a:xfrm>
                </p:grpSpPr>
                <p:pic>
                  <p:nvPicPr>
                    <p:cNvPr id="394" name="Oval 116" descr=""/>
                    <p:cNvPicPr/>
                    <p:nvPr/>
                  </p:nvPicPr>
                  <p:blipFill>
                    <a:blip r:embed="rId30"/>
                    <a:stretch/>
                  </p:blipFill>
                  <p:spPr>
                    <a:xfrm>
                      <a:off x="4181760" y="7208280"/>
                      <a:ext cx="640440" cy="230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395" name=""/>
                    <p:cNvSpPr/>
                    <p:nvPr/>
                  </p:nvSpPr>
                  <p:spPr>
                    <a:xfrm>
                      <a:off x="4275000" y="7243560"/>
                      <a:ext cx="446400" cy="1580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396" name="TextBox 107"/>
                  <p:cNvSpPr/>
                  <p:nvPr/>
                </p:nvSpPr>
                <p:spPr>
                  <a:xfrm>
                    <a:off x="4178880" y="7211880"/>
                    <a:ext cx="72144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003300"/>
                        </a:solidFill>
                        <a:latin typeface="Times New Roman"/>
                        <a:ea typeface="Times New Roman"/>
                      </a:rPr>
                      <a:t>SREBP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pic>
              <p:nvPicPr>
                <p:cNvPr id="397" name="Straight Arrow Connector 96" descr=""/>
                <p:cNvPicPr/>
                <p:nvPr/>
              </p:nvPicPr>
              <p:blipFill>
                <a:blip r:embed="rId31"/>
                <a:stretch/>
              </p:blipFill>
              <p:spPr>
                <a:xfrm>
                  <a:off x="3200040" y="7540920"/>
                  <a:ext cx="572760" cy="56088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398" name="Freeform 97"/>
                <p:cNvGrpSpPr/>
                <p:nvPr/>
              </p:nvGrpSpPr>
              <p:grpSpPr>
                <a:xfrm>
                  <a:off x="3957120" y="6937920"/>
                  <a:ext cx="523440" cy="352800"/>
                  <a:chOff x="3957120" y="6937920"/>
                  <a:chExt cx="523440" cy="352800"/>
                </a:xfrm>
              </p:grpSpPr>
              <p:pic>
                <p:nvPicPr>
                  <p:cNvPr id="399" name="Freeform 97" descr=""/>
                  <p:cNvPicPr/>
                  <p:nvPr/>
                </p:nvPicPr>
                <p:blipFill>
                  <a:blip r:embed="rId32"/>
                  <a:stretch/>
                </p:blipFill>
                <p:spPr>
                  <a:xfrm>
                    <a:off x="3957120" y="6980040"/>
                    <a:ext cx="523440" cy="310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400" name=""/>
                  <p:cNvSpPr/>
                  <p:nvPr/>
                </p:nvSpPr>
                <p:spPr>
                  <a:xfrm rot="1605600">
                    <a:off x="3956400" y="7043040"/>
                    <a:ext cx="482040" cy="59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2600" bIns="126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401" name="Group 29"/>
                <p:cNvGrpSpPr/>
                <p:nvPr/>
              </p:nvGrpSpPr>
              <p:grpSpPr>
                <a:xfrm>
                  <a:off x="3286080" y="8049600"/>
                  <a:ext cx="928440" cy="230400"/>
                  <a:chOff x="3286080" y="8049600"/>
                  <a:chExt cx="928440" cy="230400"/>
                </a:xfrm>
              </p:grpSpPr>
              <p:grpSp>
                <p:nvGrpSpPr>
                  <p:cNvPr id="402" name="Oval 114"/>
                  <p:cNvGrpSpPr/>
                  <p:nvPr/>
                </p:nvGrpSpPr>
                <p:grpSpPr>
                  <a:xfrm>
                    <a:off x="3425400" y="8049600"/>
                    <a:ext cx="640080" cy="230400"/>
                    <a:chOff x="3425400" y="8049600"/>
                    <a:chExt cx="640080" cy="230400"/>
                  </a:xfrm>
                </p:grpSpPr>
                <p:pic>
                  <p:nvPicPr>
                    <p:cNvPr id="403" name="Oval 114" descr=""/>
                    <p:cNvPicPr/>
                    <p:nvPr/>
                  </p:nvPicPr>
                  <p:blipFill>
                    <a:blip r:embed="rId33"/>
                    <a:stretch/>
                  </p:blipFill>
                  <p:spPr>
                    <a:xfrm>
                      <a:off x="3425400" y="8049600"/>
                      <a:ext cx="640080" cy="230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404" name=""/>
                    <p:cNvSpPr/>
                    <p:nvPr/>
                  </p:nvSpPr>
                  <p:spPr>
                    <a:xfrm>
                      <a:off x="3520080" y="8084880"/>
                      <a:ext cx="446040" cy="1580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405" name="TextBox 107"/>
                  <p:cNvSpPr/>
                  <p:nvPr/>
                </p:nvSpPr>
                <p:spPr>
                  <a:xfrm>
                    <a:off x="3286080" y="8060040"/>
                    <a:ext cx="92844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003300"/>
                        </a:solidFill>
                        <a:latin typeface="Times New Roman"/>
                        <a:ea typeface="Times New Roman"/>
                      </a:rPr>
                      <a:t>SREBP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pic>
              <p:nvPicPr>
                <p:cNvPr id="406" name="Straight Arrow Connector 99" descr=""/>
                <p:cNvPicPr/>
                <p:nvPr/>
              </p:nvPicPr>
              <p:blipFill>
                <a:blip r:embed="rId34"/>
                <a:stretch/>
              </p:blipFill>
              <p:spPr>
                <a:xfrm>
                  <a:off x="3980520" y="7351920"/>
                  <a:ext cx="670320" cy="3535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07" name="Straight Arrow Connector 100" descr=""/>
                <p:cNvPicPr/>
                <p:nvPr/>
              </p:nvPicPr>
              <p:blipFill>
                <a:blip r:embed="rId35"/>
                <a:stretch/>
              </p:blipFill>
              <p:spPr>
                <a:xfrm>
                  <a:off x="4687920" y="7485840"/>
                  <a:ext cx="298440" cy="67644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408" name="Group 29"/>
                <p:cNvGrpSpPr/>
                <p:nvPr/>
              </p:nvGrpSpPr>
              <p:grpSpPr>
                <a:xfrm>
                  <a:off x="3873600" y="8467560"/>
                  <a:ext cx="630720" cy="230400"/>
                  <a:chOff x="3873600" y="8467560"/>
                  <a:chExt cx="630720" cy="230400"/>
                </a:xfrm>
              </p:grpSpPr>
              <p:grpSp>
                <p:nvGrpSpPr>
                  <p:cNvPr id="409" name="Oval 112"/>
                  <p:cNvGrpSpPr/>
                  <p:nvPr/>
                </p:nvGrpSpPr>
                <p:grpSpPr>
                  <a:xfrm>
                    <a:off x="3873600" y="8467560"/>
                    <a:ext cx="630720" cy="230400"/>
                    <a:chOff x="3873600" y="8467560"/>
                    <a:chExt cx="630720" cy="230400"/>
                  </a:xfrm>
                </p:grpSpPr>
                <p:pic>
                  <p:nvPicPr>
                    <p:cNvPr id="410" name="Oval 112" descr=""/>
                    <p:cNvPicPr/>
                    <p:nvPr/>
                  </p:nvPicPr>
                  <p:blipFill>
                    <a:blip r:embed="rId36"/>
                    <a:stretch/>
                  </p:blipFill>
                  <p:spPr>
                    <a:xfrm>
                      <a:off x="3873600" y="8467560"/>
                      <a:ext cx="630720" cy="230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411" name=""/>
                    <p:cNvSpPr/>
                    <p:nvPr/>
                  </p:nvSpPr>
                  <p:spPr>
                    <a:xfrm>
                      <a:off x="3967200" y="8499960"/>
                      <a:ext cx="439560" cy="1580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412" name="TextBox 107"/>
                  <p:cNvSpPr/>
                  <p:nvPr/>
                </p:nvSpPr>
                <p:spPr>
                  <a:xfrm>
                    <a:off x="3952440" y="8481600"/>
                    <a:ext cx="466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403152"/>
                        </a:solidFill>
                        <a:latin typeface="Times New Roman"/>
                        <a:ea typeface="Times New Roman"/>
                      </a:rPr>
                      <a:t>STAR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pic>
              <p:nvPicPr>
                <p:cNvPr id="413" name="Straight Arrow Connector 102" descr=""/>
                <p:cNvPicPr/>
                <p:nvPr/>
              </p:nvPicPr>
              <p:blipFill>
                <a:blip r:embed="rId37"/>
                <a:stretch/>
              </p:blipFill>
              <p:spPr>
                <a:xfrm>
                  <a:off x="4632840" y="7693200"/>
                  <a:ext cx="274320" cy="40212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414" name="Group 29"/>
                <p:cNvGrpSpPr/>
                <p:nvPr/>
              </p:nvGrpSpPr>
              <p:grpSpPr>
                <a:xfrm>
                  <a:off x="4514760" y="8096760"/>
                  <a:ext cx="785880" cy="230400"/>
                  <a:chOff x="4514760" y="8096760"/>
                  <a:chExt cx="785880" cy="230400"/>
                </a:xfrm>
              </p:grpSpPr>
              <p:grpSp>
                <p:nvGrpSpPr>
                  <p:cNvPr id="415" name="Oval 110"/>
                  <p:cNvGrpSpPr/>
                  <p:nvPr/>
                </p:nvGrpSpPr>
                <p:grpSpPr>
                  <a:xfrm>
                    <a:off x="4571640" y="8096760"/>
                    <a:ext cx="640080" cy="230400"/>
                    <a:chOff x="4571640" y="8096760"/>
                    <a:chExt cx="640080" cy="230400"/>
                  </a:xfrm>
                </p:grpSpPr>
                <p:pic>
                  <p:nvPicPr>
                    <p:cNvPr id="416" name="Oval 110" descr=""/>
                    <p:cNvPicPr/>
                    <p:nvPr/>
                  </p:nvPicPr>
                  <p:blipFill>
                    <a:blip r:embed="rId38"/>
                    <a:stretch/>
                  </p:blipFill>
                  <p:spPr>
                    <a:xfrm>
                      <a:off x="4571640" y="8096760"/>
                      <a:ext cx="640080" cy="230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417" name=""/>
                    <p:cNvSpPr/>
                    <p:nvPr/>
                  </p:nvSpPr>
                  <p:spPr>
                    <a:xfrm>
                      <a:off x="4666320" y="8130600"/>
                      <a:ext cx="446040" cy="1580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418" name="TextBox 107"/>
                  <p:cNvSpPr/>
                  <p:nvPr/>
                </p:nvSpPr>
                <p:spPr>
                  <a:xfrm>
                    <a:off x="4514760" y="8104320"/>
                    <a:ext cx="78588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003300"/>
                        </a:solidFill>
                        <a:latin typeface="Times New Roman"/>
                        <a:ea typeface="Times New Roman"/>
                      </a:rPr>
                      <a:t>SRB-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419" name="Freeform 104"/>
                <p:cNvGrpSpPr/>
                <p:nvPr/>
              </p:nvGrpSpPr>
              <p:grpSpPr>
                <a:xfrm>
                  <a:off x="3640320" y="8279280"/>
                  <a:ext cx="303840" cy="334440"/>
                  <a:chOff x="3640320" y="8279280"/>
                  <a:chExt cx="303840" cy="334440"/>
                </a:xfrm>
              </p:grpSpPr>
              <p:pic>
                <p:nvPicPr>
                  <p:cNvPr id="420" name="Freeform 104" descr=""/>
                  <p:cNvPicPr/>
                  <p:nvPr/>
                </p:nvPicPr>
                <p:blipFill>
                  <a:blip r:embed="rId39"/>
                  <a:stretch/>
                </p:blipFill>
                <p:spPr>
                  <a:xfrm>
                    <a:off x="3663720" y="8279280"/>
                    <a:ext cx="280440" cy="334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421" name=""/>
                  <p:cNvSpPr/>
                  <p:nvPr/>
                </p:nvSpPr>
                <p:spPr>
                  <a:xfrm rot="14023200">
                    <a:off x="3595680" y="8403120"/>
                    <a:ext cx="308520" cy="457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080" bIns="-108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422" name="Freeform 105"/>
                <p:cNvGrpSpPr/>
                <p:nvPr/>
              </p:nvGrpSpPr>
              <p:grpSpPr>
                <a:xfrm>
                  <a:off x="3870720" y="8003160"/>
                  <a:ext cx="780120" cy="238680"/>
                  <a:chOff x="3870720" y="8003160"/>
                  <a:chExt cx="780120" cy="238680"/>
                </a:xfrm>
              </p:grpSpPr>
              <p:pic>
                <p:nvPicPr>
                  <p:cNvPr id="423" name="Freeform 105" descr=""/>
                  <p:cNvPicPr/>
                  <p:nvPr/>
                </p:nvPicPr>
                <p:blipFill>
                  <a:blip r:embed="rId40"/>
                  <a:stretch/>
                </p:blipFill>
                <p:spPr>
                  <a:xfrm>
                    <a:off x="3870720" y="8034840"/>
                    <a:ext cx="780120" cy="207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424" name=""/>
                  <p:cNvSpPr/>
                  <p:nvPr/>
                </p:nvSpPr>
                <p:spPr>
                  <a:xfrm rot="450600">
                    <a:off x="3878640" y="8048520"/>
                    <a:ext cx="702360" cy="70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3400" bIns="234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425" name="Freeform 106"/>
                <p:cNvGrpSpPr/>
                <p:nvPr/>
              </p:nvGrpSpPr>
              <p:grpSpPr>
                <a:xfrm>
                  <a:off x="3133080" y="8148960"/>
                  <a:ext cx="355320" cy="354960"/>
                  <a:chOff x="3133080" y="8148960"/>
                  <a:chExt cx="355320" cy="354960"/>
                </a:xfrm>
              </p:grpSpPr>
              <p:pic>
                <p:nvPicPr>
                  <p:cNvPr id="426" name="Freeform 106" descr=""/>
                  <p:cNvPicPr/>
                  <p:nvPr/>
                </p:nvPicPr>
                <p:blipFill>
                  <a:blip r:embed="rId41"/>
                  <a:stretch/>
                </p:blipFill>
                <p:spPr>
                  <a:xfrm>
                    <a:off x="3133080" y="8199360"/>
                    <a:ext cx="355320" cy="30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427" name=""/>
                  <p:cNvSpPr/>
                  <p:nvPr/>
                </p:nvSpPr>
                <p:spPr>
                  <a:xfrm rot="19276800">
                    <a:off x="3150360" y="8247600"/>
                    <a:ext cx="342360" cy="759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9160" bIns="2916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428" name="Group 29"/>
                <p:cNvGrpSpPr/>
                <p:nvPr/>
              </p:nvGrpSpPr>
              <p:grpSpPr>
                <a:xfrm>
                  <a:off x="2667240" y="8424720"/>
                  <a:ext cx="793440" cy="230400"/>
                  <a:chOff x="2667240" y="8424720"/>
                  <a:chExt cx="793440" cy="230400"/>
                </a:xfrm>
              </p:grpSpPr>
              <p:grpSp>
                <p:nvGrpSpPr>
                  <p:cNvPr id="429" name="Oval 108"/>
                  <p:cNvGrpSpPr/>
                  <p:nvPr/>
                </p:nvGrpSpPr>
                <p:grpSpPr>
                  <a:xfrm>
                    <a:off x="2682000" y="8424720"/>
                    <a:ext cx="749880" cy="230400"/>
                    <a:chOff x="2682000" y="8424720"/>
                    <a:chExt cx="749880" cy="230400"/>
                  </a:xfrm>
                </p:grpSpPr>
                <p:pic>
                  <p:nvPicPr>
                    <p:cNvPr id="430" name="Oval 108" descr=""/>
                    <p:cNvPicPr/>
                    <p:nvPr/>
                  </p:nvPicPr>
                  <p:blipFill>
                    <a:blip r:embed="rId42"/>
                    <a:stretch/>
                  </p:blipFill>
                  <p:spPr>
                    <a:xfrm>
                      <a:off x="2682000" y="8424720"/>
                      <a:ext cx="749880" cy="230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431" name=""/>
                    <p:cNvSpPr/>
                    <p:nvPr/>
                  </p:nvSpPr>
                  <p:spPr>
                    <a:xfrm>
                      <a:off x="2792880" y="8457120"/>
                      <a:ext cx="526320" cy="1580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432" name="TextBox 107"/>
                  <p:cNvSpPr/>
                  <p:nvPr/>
                </p:nvSpPr>
                <p:spPr>
                  <a:xfrm>
                    <a:off x="2667240" y="8429760"/>
                    <a:ext cx="79344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ff0000"/>
                        </a:solidFill>
                        <a:latin typeface="Times New Roman"/>
                        <a:ea typeface="Times New Roman"/>
                      </a:rPr>
                      <a:t>HMGCoAR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sp>
            <p:nvSpPr>
              <p:cNvPr id="433" name="TextBox 107"/>
              <p:cNvSpPr/>
              <p:nvPr/>
            </p:nvSpPr>
            <p:spPr>
              <a:xfrm>
                <a:off x="2287080" y="8919000"/>
                <a:ext cx="1793880" cy="215640"/>
              </a:xfrm>
              <a:prstGeom prst="rect">
                <a:avLst/>
              </a:prstGeom>
              <a:solidFill>
                <a:srgbClr val="e6e0ec"/>
              </a:solidFill>
              <a:ln w="9360">
                <a:solidFill>
                  <a:srgbClr val="403152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800" spc="-1" strike="noStrike">
                    <a:solidFill>
                      <a:srgbClr val="403152"/>
                    </a:solidFill>
                    <a:latin typeface="Times New Roman"/>
                    <a:ea typeface="Times New Roman"/>
                  </a:rPr>
                  <a:t>High Cholesterol Biosynthesi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434" name="Straight Arrow Connector 72"/>
              <p:cNvCxnSpPr/>
              <p:nvPr/>
            </p:nvCxnSpPr>
            <p:spPr>
              <a:xfrm flipV="1">
                <a:off x="3060000" y="8695800"/>
                <a:ext cx="1080" cy="222840"/>
              </a:xfrm>
              <a:prstGeom prst="straightConnector1">
                <a:avLst/>
              </a:prstGeom>
              <a:ln cap="rnd" w="12600">
                <a:solidFill>
                  <a:srgbClr val="c0504d"/>
                </a:solidFill>
                <a:custDash>
                  <a:ds d="300000" sp="1000"/>
                </a:custDash>
                <a:miter/>
                <a:headEnd len="med" type="stealth" w="med"/>
              </a:ln>
            </p:spPr>
          </p:cxnSp>
        </p:grpSp>
        <p:sp>
          <p:nvSpPr>
            <p:cNvPr id="435" name="TextBox 40"/>
            <p:cNvSpPr/>
            <p:nvPr/>
          </p:nvSpPr>
          <p:spPr>
            <a:xfrm>
              <a:off x="520560" y="5527800"/>
              <a:ext cx="32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6" name="Group 6"/>
          <p:cNvGrpSpPr/>
          <p:nvPr/>
        </p:nvGrpSpPr>
        <p:grpSpPr>
          <a:xfrm>
            <a:off x="450720" y="5008680"/>
            <a:ext cx="6772320" cy="4314600"/>
            <a:chOff x="450720" y="5008680"/>
            <a:chExt cx="6772320" cy="4314600"/>
          </a:xfrm>
        </p:grpSpPr>
        <p:grpSp>
          <p:nvGrpSpPr>
            <p:cNvPr id="437" name="Group 4"/>
            <p:cNvGrpSpPr/>
            <p:nvPr/>
          </p:nvGrpSpPr>
          <p:grpSpPr>
            <a:xfrm>
              <a:off x="450720" y="5008680"/>
              <a:ext cx="4687560" cy="4314600"/>
              <a:chOff x="450720" y="5008680"/>
              <a:chExt cx="4687560" cy="4314600"/>
            </a:xfrm>
          </p:grpSpPr>
          <p:sp>
            <p:nvSpPr>
              <p:cNvPr id="438" name="Rectangle 302"/>
              <p:cNvSpPr/>
              <p:nvPr/>
            </p:nvSpPr>
            <p:spPr>
              <a:xfrm>
                <a:off x="450720" y="5008680"/>
                <a:ext cx="245880" cy="180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439" name="Group 2"/>
              <p:cNvGrpSpPr/>
              <p:nvPr/>
            </p:nvGrpSpPr>
            <p:grpSpPr>
              <a:xfrm>
                <a:off x="1149120" y="5023440"/>
                <a:ext cx="1280880" cy="215640"/>
                <a:chOff x="1149120" y="5023440"/>
                <a:chExt cx="1280880" cy="215640"/>
              </a:xfrm>
            </p:grpSpPr>
            <p:sp>
              <p:nvSpPr>
                <p:cNvPr id="440" name="TextBox 145"/>
                <p:cNvSpPr/>
                <p:nvPr/>
              </p:nvSpPr>
              <p:spPr>
                <a:xfrm>
                  <a:off x="1149120" y="5023440"/>
                  <a:ext cx="1280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6260"/>
                      </a:solidFill>
                      <a:latin typeface="Times New Roman"/>
                      <a:ea typeface="Times New Roman"/>
                    </a:rPr>
                    <a:t>Gating Pattern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1" name="Straight Connector 304"/>
                <p:cNvSpPr/>
                <p:nvPr/>
              </p:nvSpPr>
              <p:spPr>
                <a:xfrm>
                  <a:off x="2199960" y="5128920"/>
                  <a:ext cx="215640" cy="0"/>
                </a:xfrm>
                <a:prstGeom prst="line">
                  <a:avLst/>
                </a:prstGeom>
                <a:ln w="12600">
                  <a:solidFill>
                    <a:srgbClr val="660033"/>
                  </a:solidFill>
                  <a:miter/>
                  <a:tailEnd len="med" type="stealth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442" name="Group 11"/>
              <p:cNvGrpSpPr/>
              <p:nvPr/>
            </p:nvGrpSpPr>
            <p:grpSpPr>
              <a:xfrm>
                <a:off x="755280" y="5391720"/>
                <a:ext cx="4383000" cy="3931560"/>
                <a:chOff x="755280" y="5391720"/>
                <a:chExt cx="4383000" cy="3931560"/>
              </a:xfrm>
            </p:grpSpPr>
            <p:grpSp>
              <p:nvGrpSpPr>
                <p:cNvPr id="443" name="Group 9"/>
                <p:cNvGrpSpPr/>
                <p:nvPr/>
              </p:nvGrpSpPr>
              <p:grpSpPr>
                <a:xfrm>
                  <a:off x="755280" y="5391720"/>
                  <a:ext cx="4383000" cy="3931560"/>
                  <a:chOff x="755280" y="5391720"/>
                  <a:chExt cx="4383000" cy="3931560"/>
                </a:xfrm>
              </p:grpSpPr>
              <p:grpSp>
                <p:nvGrpSpPr>
                  <p:cNvPr id="444" name="Group 4"/>
                  <p:cNvGrpSpPr/>
                  <p:nvPr/>
                </p:nvGrpSpPr>
                <p:grpSpPr>
                  <a:xfrm>
                    <a:off x="1068480" y="5391720"/>
                    <a:ext cx="3220560" cy="1440000"/>
                    <a:chOff x="1068480" y="5391720"/>
                    <a:chExt cx="3220560" cy="1440000"/>
                  </a:xfrm>
                </p:grpSpPr>
                <p:pic>
                  <p:nvPicPr>
                    <p:cNvPr id="445" name="Picture 12" descr=""/>
                    <p:cNvPicPr/>
                    <p:nvPr/>
                  </p:nvPicPr>
                  <p:blipFill>
                    <a:blip r:embed="rId1"/>
                    <a:srcRect l="0" t="7919" r="0" b="0"/>
                    <a:stretch/>
                  </p:blipFill>
                  <p:spPr>
                    <a:xfrm>
                      <a:off x="1068480" y="5420160"/>
                      <a:ext cx="1713240" cy="1411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446" name="Picture 307" descr=""/>
                    <p:cNvPicPr/>
                    <p:nvPr/>
                  </p:nvPicPr>
                  <p:blipFill>
                    <a:blip r:embed="rId2"/>
                    <a:srcRect l="25031" t="3245" r="51871" b="71203"/>
                    <a:stretch/>
                  </p:blipFill>
                  <p:spPr>
                    <a:xfrm>
                      <a:off x="2682000" y="5391720"/>
                      <a:ext cx="1607040" cy="1396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grpSp>
              <p:grpSp>
                <p:nvGrpSpPr>
                  <p:cNvPr id="447" name="Group 6"/>
                  <p:cNvGrpSpPr/>
                  <p:nvPr/>
                </p:nvGrpSpPr>
                <p:grpSpPr>
                  <a:xfrm>
                    <a:off x="820080" y="6892920"/>
                    <a:ext cx="4027320" cy="1130400"/>
                    <a:chOff x="820080" y="6892920"/>
                    <a:chExt cx="4027320" cy="1130400"/>
                  </a:xfrm>
                </p:grpSpPr>
                <p:pic>
                  <p:nvPicPr>
                    <p:cNvPr id="448" name="Picture 2" descr=""/>
                    <p:cNvPicPr/>
                    <p:nvPr/>
                  </p:nvPicPr>
                  <p:blipFill>
                    <a:blip r:embed="rId3"/>
                    <a:srcRect l="25268" t="33499" r="49904" b="36571"/>
                    <a:stretch/>
                  </p:blipFill>
                  <p:spPr>
                    <a:xfrm>
                      <a:off x="820080" y="6921360"/>
                      <a:ext cx="1271520" cy="10616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449" name="Picture 2" descr=""/>
                    <p:cNvPicPr/>
                    <p:nvPr/>
                  </p:nvPicPr>
                  <p:blipFill>
                    <a:blip r:embed="rId4"/>
                    <a:srcRect l="990" t="65993" r="74429" b="343"/>
                    <a:stretch/>
                  </p:blipFill>
                  <p:spPr>
                    <a:xfrm>
                      <a:off x="2234880" y="6892920"/>
                      <a:ext cx="1317600" cy="1130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450" name="Picture 2" descr=""/>
                    <p:cNvPicPr/>
                    <p:nvPr/>
                  </p:nvPicPr>
                  <p:blipFill>
                    <a:blip r:embed="rId5"/>
                    <a:srcRect l="25418" t="66807" r="49904" b="2427"/>
                    <a:stretch/>
                  </p:blipFill>
                  <p:spPr>
                    <a:xfrm>
                      <a:off x="3552480" y="6892920"/>
                      <a:ext cx="1294920" cy="1090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grpSp>
              <p:grpSp>
                <p:nvGrpSpPr>
                  <p:cNvPr id="451" name="Group 8"/>
                  <p:cNvGrpSpPr/>
                  <p:nvPr/>
                </p:nvGrpSpPr>
                <p:grpSpPr>
                  <a:xfrm>
                    <a:off x="755280" y="8065800"/>
                    <a:ext cx="4383000" cy="1257480"/>
                    <a:chOff x="755280" y="8065800"/>
                    <a:chExt cx="4383000" cy="1257480"/>
                  </a:xfrm>
                </p:grpSpPr>
                <p:pic>
                  <p:nvPicPr>
                    <p:cNvPr id="452" name="Picture 2" descr=""/>
                    <p:cNvPicPr/>
                    <p:nvPr/>
                  </p:nvPicPr>
                  <p:blipFill>
                    <a:blip r:embed="rId6"/>
                    <a:srcRect l="0" t="33531" r="74952" b="37110"/>
                    <a:stretch/>
                  </p:blipFill>
                  <p:spPr>
                    <a:xfrm>
                      <a:off x="755280" y="8065800"/>
                      <a:ext cx="1405800" cy="1257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453" name="Picture 2" descr=""/>
                    <p:cNvPicPr/>
                    <p:nvPr/>
                  </p:nvPicPr>
                  <p:blipFill>
                    <a:blip r:embed="rId7"/>
                    <a:srcRect l="47840" t="2961" r="27116" b="70527"/>
                    <a:stretch/>
                  </p:blipFill>
                  <p:spPr>
                    <a:xfrm>
                      <a:off x="2193120" y="8065800"/>
                      <a:ext cx="1426320" cy="1257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454" name="Picture 2" descr=""/>
                    <p:cNvPicPr/>
                    <p:nvPr/>
                  </p:nvPicPr>
                  <p:blipFill>
                    <a:blip r:embed="rId8"/>
                    <a:srcRect l="73059" t="2961" r="1726" b="69499"/>
                    <a:stretch/>
                  </p:blipFill>
                  <p:spPr>
                    <a:xfrm>
                      <a:off x="3629160" y="8065800"/>
                      <a:ext cx="1509120" cy="1257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grpSp>
            </p:grpSp>
            <p:sp>
              <p:nvSpPr>
                <p:cNvPr id="455" name="TextBox 319"/>
                <p:cNvSpPr/>
                <p:nvPr/>
              </p:nvSpPr>
              <p:spPr>
                <a:xfrm>
                  <a:off x="4156200" y="8134560"/>
                  <a:ext cx="792000" cy="580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Double Stain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(APC+FITC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56" name="TextBox 320"/>
                <p:cNvSpPr/>
                <p:nvPr/>
              </p:nvSpPr>
              <p:spPr>
                <a:xfrm>
                  <a:off x="4104000" y="8915400"/>
                  <a:ext cx="939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ingle Stain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57" name="TextBox 321"/>
                <p:cNvSpPr/>
                <p:nvPr/>
              </p:nvSpPr>
              <p:spPr>
                <a:xfrm>
                  <a:off x="2619360" y="8929800"/>
                  <a:ext cx="939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ingle Stain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58" name="TextBox 322"/>
                <p:cNvSpPr/>
                <p:nvPr/>
              </p:nvSpPr>
              <p:spPr>
                <a:xfrm>
                  <a:off x="1157400" y="8937360"/>
                  <a:ext cx="939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ingle Stain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59" name="TextBox 323"/>
                <p:cNvSpPr/>
                <p:nvPr/>
              </p:nvSpPr>
              <p:spPr>
                <a:xfrm>
                  <a:off x="2632320" y="8134560"/>
                  <a:ext cx="824400" cy="459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Double Stain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(PE+FITC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0" name="TextBox 325"/>
                <p:cNvSpPr/>
                <p:nvPr/>
              </p:nvSpPr>
              <p:spPr>
                <a:xfrm>
                  <a:off x="1187640" y="8157600"/>
                  <a:ext cx="8071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Double Stain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(PE+APC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1" name="TextBox 326"/>
                <p:cNvSpPr/>
                <p:nvPr/>
              </p:nvSpPr>
              <p:spPr>
                <a:xfrm flipH="1" rot="16200000">
                  <a:off x="578160" y="8365680"/>
                  <a:ext cx="939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ingle Stain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2" name="TextBox 327"/>
                <p:cNvSpPr/>
                <p:nvPr/>
              </p:nvSpPr>
              <p:spPr>
                <a:xfrm flipH="1" rot="16200000">
                  <a:off x="2022840" y="8385120"/>
                  <a:ext cx="939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ingle Stain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3" name="TextBox 328"/>
                <p:cNvSpPr/>
                <p:nvPr/>
              </p:nvSpPr>
              <p:spPr>
                <a:xfrm flipH="1" rot="16200000">
                  <a:off x="3435480" y="8359560"/>
                  <a:ext cx="939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ingle Stain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grpSp>
          <p:nvGrpSpPr>
            <p:cNvPr id="464" name="Group 12"/>
            <p:cNvGrpSpPr/>
            <p:nvPr/>
          </p:nvGrpSpPr>
          <p:grpSpPr>
            <a:xfrm>
              <a:off x="5445360" y="6255000"/>
              <a:ext cx="1777680" cy="1282680"/>
              <a:chOff x="5445360" y="6255000"/>
              <a:chExt cx="1777680" cy="1282680"/>
            </a:xfrm>
          </p:grpSpPr>
          <p:sp>
            <p:nvSpPr>
              <p:cNvPr id="465" name="TextBox 145"/>
              <p:cNvSpPr/>
              <p:nvPr/>
            </p:nvSpPr>
            <p:spPr>
              <a:xfrm>
                <a:off x="5484600" y="6255000"/>
                <a:ext cx="1617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800" spc="-1" strike="noStrike" u="sng">
                    <a:solidFill>
                      <a:srgbClr val="006260"/>
                    </a:solidFill>
                    <a:uFillTx/>
                    <a:latin typeface="Times New Roman"/>
                    <a:ea typeface="Times New Roman"/>
                  </a:rPr>
                  <a:t>Fluorophores &amp; Antigen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6" name="TextBox 145"/>
              <p:cNvSpPr/>
              <p:nvPr/>
            </p:nvSpPr>
            <p:spPr>
              <a:xfrm>
                <a:off x="5445360" y="6470280"/>
                <a:ext cx="1777680" cy="10674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800" spc="-1" strike="noStrike">
                    <a:solidFill>
                      <a:srgbClr val="ff0000"/>
                    </a:solidFill>
                    <a:latin typeface="Times New Roman"/>
                    <a:ea typeface="Times New Roman"/>
                  </a:rPr>
                  <a:t>PE: pAkt</a:t>
                </a:r>
                <a:r>
                  <a:rPr b="1" lang="en-IN" sz="800" spc="-1" strike="noStrike" baseline="30000">
                    <a:solidFill>
                      <a:srgbClr val="ff0000"/>
                    </a:solidFill>
                    <a:latin typeface="Times New Roman"/>
                    <a:ea typeface="Times New Roman"/>
                  </a:rPr>
                  <a:t>Thr30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800" spc="-1" strike="noStrike">
                    <a:solidFill>
                      <a:srgbClr val="ff3399"/>
                    </a:solidFill>
                    <a:latin typeface="Times New Roman"/>
                    <a:ea typeface="Times New Roman"/>
                  </a:rPr>
                  <a:t>APC: SREBP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800" spc="-1" strike="noStrike">
                    <a:solidFill>
                      <a:srgbClr val="005800"/>
                    </a:solidFill>
                    <a:latin typeface="Times New Roman"/>
                    <a:ea typeface="Times New Roman"/>
                  </a:rPr>
                  <a:t>FITC:</a:t>
                </a:r>
                <a:r>
                  <a:rPr b="1" lang="en-IN" sz="800" spc="-1" strike="noStrike">
                    <a:solidFill>
                      <a:srgbClr val="70ac2e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en-IN" sz="800" spc="-1" strike="noStrike">
                    <a:solidFill>
                      <a:srgbClr val="005800"/>
                    </a:solidFill>
                    <a:latin typeface="Times New Roman"/>
                    <a:ea typeface="Times New Roman"/>
                  </a:rPr>
                  <a:t>Akt, mTOR, pmTOR</a:t>
                </a:r>
                <a:r>
                  <a:rPr b="1" lang="en-IN" sz="800" spc="-1" strike="noStrike" baseline="30000">
                    <a:solidFill>
                      <a:srgbClr val="005800"/>
                    </a:solidFill>
                    <a:latin typeface="Times New Roman"/>
                    <a:ea typeface="Times New Roman"/>
                  </a:rPr>
                  <a:t>Ser2448 </a:t>
                </a:r>
                <a:r>
                  <a:rPr b="1" lang="en-IN" sz="800" spc="-1" strike="noStrike">
                    <a:solidFill>
                      <a:srgbClr val="005800"/>
                    </a:solidFill>
                    <a:latin typeface="Times New Roman"/>
                    <a:ea typeface="Times New Roman"/>
                  </a:rPr>
                  <a:t>, P70S6K, P38MAPK, HIF-1</a:t>
                </a:r>
                <a:r>
                  <a:rPr b="1" lang="el-GR" sz="800" spc="-1" strike="noStrike">
                    <a:solidFill>
                      <a:srgbClr val="005800"/>
                    </a:solidFill>
                    <a:latin typeface="Times New Roman"/>
                    <a:ea typeface="Times New Roman"/>
                  </a:rPr>
                  <a:t>α</a:t>
                </a:r>
                <a:r>
                  <a:rPr b="1" lang="en-IN" sz="800" spc="-1" strike="noStrike">
                    <a:solidFill>
                      <a:srgbClr val="005800"/>
                    </a:solidFill>
                    <a:latin typeface="Times New Roman"/>
                    <a:ea typeface="Times New Roman"/>
                  </a:rPr>
                  <a:t>, VEGF, COX2, SREBP2, STAR, SRB-1.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467" name="TextBox 117"/>
          <p:cNvSpPr/>
          <p:nvPr/>
        </p:nvSpPr>
        <p:spPr>
          <a:xfrm>
            <a:off x="-9360" y="9718560"/>
            <a:ext cx="1436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68" name="Group 1"/>
          <p:cNvGrpSpPr/>
          <p:nvPr/>
        </p:nvGrpSpPr>
        <p:grpSpPr>
          <a:xfrm>
            <a:off x="387360" y="376200"/>
            <a:ext cx="7099200" cy="2551680"/>
            <a:chOff x="387360" y="376200"/>
            <a:chExt cx="7099200" cy="2551680"/>
          </a:xfrm>
        </p:grpSpPr>
        <p:grpSp>
          <p:nvGrpSpPr>
            <p:cNvPr id="469" name="Group 210"/>
            <p:cNvGrpSpPr/>
            <p:nvPr/>
          </p:nvGrpSpPr>
          <p:grpSpPr>
            <a:xfrm>
              <a:off x="387360" y="376200"/>
              <a:ext cx="7099200" cy="2551680"/>
              <a:chOff x="387360" y="376200"/>
              <a:chExt cx="7099200" cy="2551680"/>
            </a:xfrm>
          </p:grpSpPr>
          <p:grpSp>
            <p:nvGrpSpPr>
              <p:cNvPr id="470" name="Group 156"/>
              <p:cNvGrpSpPr/>
              <p:nvPr/>
            </p:nvGrpSpPr>
            <p:grpSpPr>
              <a:xfrm>
                <a:off x="442800" y="376200"/>
                <a:ext cx="7043760" cy="2551680"/>
                <a:chOff x="442800" y="376200"/>
                <a:chExt cx="7043760" cy="2551680"/>
              </a:xfrm>
            </p:grpSpPr>
            <p:sp>
              <p:nvSpPr>
                <p:cNvPr id="471" name="TextBox 180"/>
                <p:cNvSpPr/>
                <p:nvPr/>
              </p:nvSpPr>
              <p:spPr>
                <a:xfrm>
                  <a:off x="6118560" y="2365920"/>
                  <a:ext cx="1368000" cy="21564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580000"/>
                      </a:solidFill>
                      <a:latin typeface="Times New Roman"/>
                      <a:ea typeface="Times New Roman"/>
                    </a:rPr>
                    <a:t>Drug Response Studie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72" name="Rounded Rectangle 5"/>
                <p:cNvSpPr/>
                <p:nvPr/>
              </p:nvSpPr>
              <p:spPr>
                <a:xfrm>
                  <a:off x="442800" y="873000"/>
                  <a:ext cx="2290680" cy="20448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ffba75"/>
                </a:solidFill>
                <a:ln w="25560">
                  <a:solidFill>
                    <a:srgbClr val="ffba75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ffffff"/>
                      </a:solidFill>
                      <a:latin typeface="Times New Roman"/>
                      <a:ea typeface="Times New Roman"/>
                    </a:rPr>
                    <a:t>Primary Culture with Patient Sample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473" name="Group 162"/>
                <p:cNvGrpSpPr/>
                <p:nvPr/>
              </p:nvGrpSpPr>
              <p:grpSpPr>
                <a:xfrm>
                  <a:off x="983520" y="1900080"/>
                  <a:ext cx="1257480" cy="272160"/>
                  <a:chOff x="983520" y="1900080"/>
                  <a:chExt cx="1257480" cy="272160"/>
                </a:xfrm>
              </p:grpSpPr>
              <p:sp>
                <p:nvSpPr>
                  <p:cNvPr id="474" name="Straight Connector 208"/>
                  <p:cNvSpPr/>
                  <p:nvPr/>
                </p:nvSpPr>
                <p:spPr>
                  <a:xfrm>
                    <a:off x="983520" y="2036880"/>
                    <a:ext cx="1257480" cy="0"/>
                  </a:xfrm>
                  <a:prstGeom prst="line">
                    <a:avLst/>
                  </a:prstGeom>
                  <a:ln w="12600">
                    <a:solidFill>
                      <a:srgbClr val="66003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5" name="Straight Connector 209"/>
                  <p:cNvSpPr/>
                  <p:nvPr/>
                </p:nvSpPr>
                <p:spPr>
                  <a:xfrm>
                    <a:off x="2239560" y="1900080"/>
                    <a:ext cx="0" cy="272160"/>
                  </a:xfrm>
                  <a:prstGeom prst="line">
                    <a:avLst/>
                  </a:prstGeom>
                  <a:ln w="12600">
                    <a:solidFill>
                      <a:srgbClr val="660033"/>
                    </a:solidFill>
                    <a:miter/>
                    <a:tailEnd len="med" type="stealth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6" name="Straight Connector 210"/>
                  <p:cNvSpPr/>
                  <p:nvPr/>
                </p:nvSpPr>
                <p:spPr>
                  <a:xfrm>
                    <a:off x="983520" y="1900080"/>
                    <a:ext cx="0" cy="272160"/>
                  </a:xfrm>
                  <a:prstGeom prst="line">
                    <a:avLst/>
                  </a:prstGeom>
                  <a:ln w="12600">
                    <a:solidFill>
                      <a:srgbClr val="660033"/>
                    </a:solidFill>
                    <a:miter/>
                    <a:tailEnd len="med" type="stealth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477" name="Straight Connector 7"/>
                <p:cNvSpPr/>
                <p:nvPr/>
              </p:nvSpPr>
              <p:spPr>
                <a:xfrm>
                  <a:off x="1612800" y="2030400"/>
                  <a:ext cx="0" cy="142560"/>
                </a:xfrm>
                <a:prstGeom prst="line">
                  <a:avLst/>
                </a:prstGeom>
                <a:ln w="12600">
                  <a:solidFill>
                    <a:srgbClr val="660033"/>
                  </a:solidFill>
                  <a:miter/>
                  <a:tailEnd len="med" type="stealth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478" name="Group 169"/>
                <p:cNvGrpSpPr/>
                <p:nvPr/>
              </p:nvGrpSpPr>
              <p:grpSpPr>
                <a:xfrm>
                  <a:off x="655560" y="1081440"/>
                  <a:ext cx="2894760" cy="1006200"/>
                  <a:chOff x="655560" y="1081440"/>
                  <a:chExt cx="2894760" cy="1006200"/>
                </a:xfrm>
              </p:grpSpPr>
              <p:grpSp>
                <p:nvGrpSpPr>
                  <p:cNvPr id="479" name="Group 156"/>
                  <p:cNvGrpSpPr/>
                  <p:nvPr/>
                </p:nvGrpSpPr>
                <p:grpSpPr>
                  <a:xfrm>
                    <a:off x="655560" y="1081440"/>
                    <a:ext cx="1847520" cy="764280"/>
                    <a:chOff x="655560" y="1081440"/>
                    <a:chExt cx="1847520" cy="764280"/>
                  </a:xfrm>
                </p:grpSpPr>
                <p:grpSp>
                  <p:nvGrpSpPr>
                    <p:cNvPr id="480" name="Group 135"/>
                    <p:cNvGrpSpPr/>
                    <p:nvPr/>
                  </p:nvGrpSpPr>
                  <p:grpSpPr>
                    <a:xfrm>
                      <a:off x="655560" y="1081440"/>
                      <a:ext cx="1847520" cy="474480"/>
                      <a:chOff x="655560" y="1081440"/>
                      <a:chExt cx="1847520" cy="474480"/>
                    </a:xfrm>
                  </p:grpSpPr>
                  <p:grpSp>
                    <p:nvGrpSpPr>
                      <p:cNvPr id="481" name="Group 132"/>
                      <p:cNvGrpSpPr/>
                      <p:nvPr/>
                    </p:nvGrpSpPr>
                    <p:grpSpPr>
                      <a:xfrm>
                        <a:off x="655560" y="1081440"/>
                        <a:ext cx="632520" cy="474480"/>
                        <a:chOff x="655560" y="1081440"/>
                        <a:chExt cx="632520" cy="474480"/>
                      </a:xfrm>
                    </p:grpSpPr>
                    <p:pic>
                      <p:nvPicPr>
                        <p:cNvPr id="482" name="Picture 3" descr="C:\Users\ELIZABETH\Desktop\BIO-RENDER IMAGES\Untitled.png"/>
                        <p:cNvPicPr/>
                        <p:nvPr/>
                      </p:nvPicPr>
                      <p:blipFill>
                        <a:blip r:embed="rId9"/>
                        <a:srcRect l="42873" t="8533" r="39659" b="75546"/>
                        <a:stretch/>
                      </p:blipFill>
                      <p:spPr>
                        <a:xfrm>
                          <a:off x="740880" y="1256400"/>
                          <a:ext cx="459720" cy="29952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483" name="TextBox 21"/>
                        <p:cNvSpPr/>
                        <p:nvPr/>
                      </p:nvSpPr>
                      <p:spPr>
                        <a:xfrm>
                          <a:off x="655560" y="1081440"/>
                          <a:ext cx="632520" cy="21564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t">
                          <a:sp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r>
                            <a:rPr b="1" lang="en-IN" sz="800" spc="-1" strike="noStrike">
                              <a:solidFill>
                                <a:srgbClr val="008080"/>
                              </a:solidFill>
                              <a:latin typeface="Times New Roman"/>
                              <a:ea typeface="Times New Roman"/>
                            </a:rPr>
                            <a:t>Optimum</a:t>
                          </a:r>
                          <a:endParaRPr b="0" lang="en-US" sz="8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grpSp>
                    <p:nvGrpSpPr>
                      <p:cNvPr id="484" name="Group 133"/>
                      <p:cNvGrpSpPr/>
                      <p:nvPr/>
                    </p:nvGrpSpPr>
                    <p:grpSpPr>
                      <a:xfrm>
                        <a:off x="1194840" y="1089720"/>
                        <a:ext cx="827280" cy="466200"/>
                        <a:chOff x="1194840" y="1089720"/>
                        <a:chExt cx="827280" cy="466200"/>
                      </a:xfrm>
                    </p:grpSpPr>
                    <p:pic>
                      <p:nvPicPr>
                        <p:cNvPr id="485" name="Picture 3" descr="C:\Users\ELIZABETH\Desktop\BIO-RENDER IMAGES\Untitled.png"/>
                        <p:cNvPicPr/>
                        <p:nvPr/>
                      </p:nvPicPr>
                      <p:blipFill>
                        <a:blip r:embed="rId10"/>
                        <a:srcRect l="60696" t="8268" r="23385" b="76851"/>
                        <a:stretch/>
                      </p:blipFill>
                      <p:spPr>
                        <a:xfrm>
                          <a:off x="1377360" y="1256400"/>
                          <a:ext cx="416160" cy="29952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486" name="TextBox 22"/>
                        <p:cNvSpPr/>
                        <p:nvPr/>
                      </p:nvSpPr>
                      <p:spPr>
                        <a:xfrm>
                          <a:off x="1194840" y="1089720"/>
                          <a:ext cx="827280" cy="21564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t">
                          <a:sp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r>
                            <a:rPr b="1" lang="en-IN" sz="800" spc="-1" strike="noStrike">
                              <a:solidFill>
                                <a:srgbClr val="339933"/>
                              </a:solidFill>
                              <a:latin typeface="Times New Roman"/>
                              <a:ea typeface="Times New Roman"/>
                            </a:rPr>
                            <a:t>Borderline</a:t>
                          </a:r>
                          <a:endParaRPr b="0" lang="en-US" sz="8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grpSp>
                    <p:nvGrpSpPr>
                      <p:cNvPr id="487" name="Group 134"/>
                      <p:cNvGrpSpPr/>
                      <p:nvPr/>
                    </p:nvGrpSpPr>
                    <p:grpSpPr>
                      <a:xfrm>
                        <a:off x="1869840" y="1094040"/>
                        <a:ext cx="633240" cy="453240"/>
                        <a:chOff x="1869840" y="1094040"/>
                        <a:chExt cx="633240" cy="453240"/>
                      </a:xfrm>
                    </p:grpSpPr>
                    <p:sp>
                      <p:nvSpPr>
                        <p:cNvPr id="488" name="TextBox 29"/>
                        <p:cNvSpPr/>
                        <p:nvPr/>
                      </p:nvSpPr>
                      <p:spPr>
                        <a:xfrm>
                          <a:off x="1869840" y="1094040"/>
                          <a:ext cx="633240" cy="21564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t">
                          <a:sp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r>
                            <a:rPr b="1" lang="en-IN" sz="800" spc="-1" strike="noStrike">
                              <a:solidFill>
                                <a:srgbClr val="ff0000"/>
                              </a:solidFill>
                              <a:latin typeface="Times New Roman"/>
                              <a:ea typeface="Times New Roman"/>
                            </a:rPr>
                            <a:t>High</a:t>
                          </a:r>
                          <a:endParaRPr b="0" lang="en-US" sz="8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pic>
                      <p:nvPicPr>
                        <p:cNvPr id="489" name="Picture 3" descr="C:\Users\ELIZABETH\Desktop\BIO-RENDER IMAGES\Untitled.png"/>
                        <p:cNvPicPr/>
                        <p:nvPr/>
                      </p:nvPicPr>
                      <p:blipFill>
                        <a:blip r:embed="rId11"/>
                        <a:srcRect l="77095" t="7712" r="6056" b="77141"/>
                        <a:stretch/>
                      </p:blipFill>
                      <p:spPr>
                        <a:xfrm>
                          <a:off x="1962000" y="1260360"/>
                          <a:ext cx="463320" cy="28692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grpSp>
                </p:grpSp>
                <p:grpSp>
                  <p:nvGrpSpPr>
                    <p:cNvPr id="490" name="Group 149"/>
                    <p:cNvGrpSpPr/>
                    <p:nvPr/>
                  </p:nvGrpSpPr>
                  <p:grpSpPr>
                    <a:xfrm>
                      <a:off x="815760" y="1520640"/>
                      <a:ext cx="262800" cy="325080"/>
                      <a:chOff x="815760" y="1520640"/>
                      <a:chExt cx="262800" cy="325080"/>
                    </a:xfrm>
                  </p:grpSpPr>
                  <p:cxnSp>
                    <p:nvCxnSpPr>
                      <p:cNvPr id="491" name="Straight Arrow Connector 197"/>
                      <p:cNvCxnSpPr/>
                      <p:nvPr/>
                    </p:nvCxnSpPr>
                    <p:spPr>
                      <a:xfrm>
                        <a:off x="982440" y="1520640"/>
                        <a:ext cx="1080" cy="135720"/>
                      </a:xfrm>
                      <a:prstGeom prst="straightConnector1">
                        <a:avLst/>
                      </a:prstGeom>
                      <a:ln w="12600">
                        <a:solidFill>
                          <a:srgbClr val="660033"/>
                        </a:solidFill>
                        <a:miter/>
                        <a:tailEnd len="med" type="stealth" w="med"/>
                      </a:ln>
                    </p:spPr>
                  </p:cxnSp>
                  <p:grpSp>
                    <p:nvGrpSpPr>
                      <p:cNvPr id="492" name="Freeform 198"/>
                      <p:cNvGrpSpPr/>
                      <p:nvPr/>
                    </p:nvGrpSpPr>
                    <p:grpSpPr>
                      <a:xfrm>
                        <a:off x="815760" y="1679040"/>
                        <a:ext cx="262800" cy="166680"/>
                        <a:chOff x="815760" y="1679040"/>
                        <a:chExt cx="262800" cy="166680"/>
                      </a:xfrm>
                    </p:grpSpPr>
                    <p:pic>
                      <p:nvPicPr>
                        <p:cNvPr id="493" name="Freeform 198" descr=""/>
                        <p:cNvPicPr/>
                        <p:nvPr/>
                      </p:nvPicPr>
                      <p:blipFill>
                        <a:blip r:embed="rId12"/>
                        <a:stretch/>
                      </p:blipFill>
                      <p:spPr>
                        <a:xfrm>
                          <a:off x="816120" y="1679040"/>
                          <a:ext cx="262440" cy="16668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494" name=""/>
                        <p:cNvSpPr/>
                        <p:nvPr/>
                      </p:nvSpPr>
                      <p:spPr>
                        <a:xfrm>
                          <a:off x="815760" y="1679040"/>
                          <a:ext cx="257400" cy="15948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</p:grpSp>
                <p:grpSp>
                  <p:nvGrpSpPr>
                    <p:cNvPr id="495" name="Group 150"/>
                    <p:cNvGrpSpPr/>
                    <p:nvPr/>
                  </p:nvGrpSpPr>
                  <p:grpSpPr>
                    <a:xfrm>
                      <a:off x="1432440" y="1522800"/>
                      <a:ext cx="262800" cy="322920"/>
                      <a:chOff x="1432440" y="1522800"/>
                      <a:chExt cx="262800" cy="322920"/>
                    </a:xfrm>
                  </p:grpSpPr>
                  <p:cxnSp>
                    <p:nvCxnSpPr>
                      <p:cNvPr id="496" name="Straight Arrow Connector 195"/>
                      <p:cNvCxnSpPr/>
                      <p:nvPr/>
                    </p:nvCxnSpPr>
                    <p:spPr>
                      <a:xfrm>
                        <a:off x="1598040" y="1522800"/>
                        <a:ext cx="1080" cy="119520"/>
                      </a:xfrm>
                      <a:prstGeom prst="straightConnector1">
                        <a:avLst/>
                      </a:prstGeom>
                      <a:ln w="12600">
                        <a:solidFill>
                          <a:srgbClr val="660033"/>
                        </a:solidFill>
                        <a:miter/>
                        <a:tailEnd len="med" type="stealth" w="med"/>
                      </a:ln>
                    </p:spPr>
                  </p:cxnSp>
                  <p:grpSp>
                    <p:nvGrpSpPr>
                      <p:cNvPr id="497" name="Freeform 196"/>
                      <p:cNvGrpSpPr/>
                      <p:nvPr/>
                    </p:nvGrpSpPr>
                    <p:grpSpPr>
                      <a:xfrm>
                        <a:off x="1432440" y="1688040"/>
                        <a:ext cx="262800" cy="157680"/>
                        <a:chOff x="1432440" y="1688040"/>
                        <a:chExt cx="262800" cy="157680"/>
                      </a:xfrm>
                    </p:grpSpPr>
                    <p:pic>
                      <p:nvPicPr>
                        <p:cNvPr id="498" name="Freeform 196" descr=""/>
                        <p:cNvPicPr/>
                        <p:nvPr/>
                      </p:nvPicPr>
                      <p:blipFill>
                        <a:blip r:embed="rId13"/>
                        <a:stretch/>
                      </p:blipFill>
                      <p:spPr>
                        <a:xfrm>
                          <a:off x="1432440" y="1688040"/>
                          <a:ext cx="262800" cy="15768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499" name=""/>
                        <p:cNvSpPr/>
                        <p:nvPr/>
                      </p:nvSpPr>
                      <p:spPr>
                        <a:xfrm>
                          <a:off x="1432440" y="1689480"/>
                          <a:ext cx="257760" cy="14904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</p:grpSp>
                <p:grpSp>
                  <p:nvGrpSpPr>
                    <p:cNvPr id="500" name="Group 153"/>
                    <p:cNvGrpSpPr/>
                    <p:nvPr/>
                  </p:nvGrpSpPr>
                  <p:grpSpPr>
                    <a:xfrm>
                      <a:off x="2047680" y="1521000"/>
                      <a:ext cx="262800" cy="322920"/>
                      <a:chOff x="2047680" y="1521000"/>
                      <a:chExt cx="262800" cy="322920"/>
                    </a:xfrm>
                  </p:grpSpPr>
                  <p:cxnSp>
                    <p:nvCxnSpPr>
                      <p:cNvPr id="501" name="Straight Arrow Connector 193"/>
                      <p:cNvCxnSpPr/>
                      <p:nvPr/>
                    </p:nvCxnSpPr>
                    <p:spPr>
                      <a:xfrm>
                        <a:off x="2207160" y="1521000"/>
                        <a:ext cx="1080" cy="137520"/>
                      </a:xfrm>
                      <a:prstGeom prst="straightConnector1">
                        <a:avLst/>
                      </a:prstGeom>
                      <a:ln w="12600">
                        <a:solidFill>
                          <a:srgbClr val="660033"/>
                        </a:solidFill>
                        <a:miter/>
                        <a:tailEnd len="med" type="stealth" w="med"/>
                      </a:ln>
                    </p:spPr>
                  </p:cxnSp>
                  <p:grpSp>
                    <p:nvGrpSpPr>
                      <p:cNvPr id="502" name="Freeform 194"/>
                      <p:cNvGrpSpPr/>
                      <p:nvPr/>
                    </p:nvGrpSpPr>
                    <p:grpSpPr>
                      <a:xfrm>
                        <a:off x="2047680" y="1680840"/>
                        <a:ext cx="262800" cy="163080"/>
                        <a:chOff x="2047680" y="1680840"/>
                        <a:chExt cx="262800" cy="163080"/>
                      </a:xfrm>
                    </p:grpSpPr>
                    <p:pic>
                      <p:nvPicPr>
                        <p:cNvPr id="503" name="Freeform 194" descr=""/>
                        <p:cNvPicPr/>
                        <p:nvPr/>
                      </p:nvPicPr>
                      <p:blipFill>
                        <a:blip r:embed="rId14"/>
                        <a:stretch/>
                      </p:blipFill>
                      <p:spPr>
                        <a:xfrm>
                          <a:off x="2048040" y="1680840"/>
                          <a:ext cx="262440" cy="16308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504" name=""/>
                        <p:cNvSpPr/>
                        <p:nvPr/>
                      </p:nvSpPr>
                      <p:spPr>
                        <a:xfrm>
                          <a:off x="2047680" y="1680840"/>
                          <a:ext cx="257040" cy="15984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</p:grpSp>
              </p:grpSp>
              <p:sp>
                <p:nvSpPr>
                  <p:cNvPr id="505" name="TextBox 44"/>
                  <p:cNvSpPr/>
                  <p:nvPr/>
                </p:nvSpPr>
                <p:spPr>
                  <a:xfrm>
                    <a:off x="2253960" y="1506960"/>
                    <a:ext cx="1296360" cy="5806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006666"/>
                        </a:solidFill>
                        <a:latin typeface="Times New Roman"/>
                        <a:ea typeface="Times New Roman"/>
                      </a:rPr>
                      <a:t>Primarily 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006666"/>
                        </a:solidFill>
                        <a:latin typeface="Times New Roman"/>
                        <a:ea typeface="Times New Roman"/>
                      </a:rPr>
                      <a:t>Debulked 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006666"/>
                        </a:solidFill>
                        <a:latin typeface="Times New Roman"/>
                        <a:ea typeface="Times New Roman"/>
                      </a:rPr>
                      <a:t>Ovarian 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006666"/>
                        </a:solidFill>
                        <a:latin typeface="Times New Roman"/>
                        <a:ea typeface="Times New Roman"/>
                      </a:rPr>
                      <a:t>Tissues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506" name="Group 210"/>
                <p:cNvGrpSpPr/>
                <p:nvPr/>
              </p:nvGrpSpPr>
              <p:grpSpPr>
                <a:xfrm>
                  <a:off x="851760" y="2190960"/>
                  <a:ext cx="1557000" cy="348840"/>
                  <a:chOff x="851760" y="2190960"/>
                  <a:chExt cx="1557000" cy="348840"/>
                </a:xfrm>
              </p:grpSpPr>
              <p:grpSp>
                <p:nvGrpSpPr>
                  <p:cNvPr id="507" name="Group 183"/>
                  <p:cNvGrpSpPr/>
                  <p:nvPr/>
                </p:nvGrpSpPr>
                <p:grpSpPr>
                  <a:xfrm>
                    <a:off x="1425240" y="2190960"/>
                    <a:ext cx="332640" cy="348840"/>
                    <a:chOff x="1425240" y="2190960"/>
                    <a:chExt cx="332640" cy="348840"/>
                  </a:xfrm>
                </p:grpSpPr>
                <p:grpSp>
                  <p:nvGrpSpPr>
                    <p:cNvPr id="508" name="Freeform 175"/>
                    <p:cNvGrpSpPr/>
                    <p:nvPr/>
                  </p:nvGrpSpPr>
                  <p:grpSpPr>
                    <a:xfrm>
                      <a:off x="1645200" y="2377440"/>
                      <a:ext cx="79200" cy="79200"/>
                      <a:chOff x="1645200" y="2377440"/>
                      <a:chExt cx="79200" cy="79200"/>
                    </a:xfrm>
                  </p:grpSpPr>
                  <p:pic>
                    <p:nvPicPr>
                      <p:cNvPr id="509" name="Freeform 175" descr=""/>
                      <p:cNvPicPr/>
                      <p:nvPr/>
                    </p:nvPicPr>
                    <p:blipFill>
                      <a:blip r:embed="rId15"/>
                      <a:stretch/>
                    </p:blipFill>
                    <p:spPr>
                      <a:xfrm>
                        <a:off x="1645200" y="2377440"/>
                        <a:ext cx="79200" cy="792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  <p:sp>
                    <p:nvSpPr>
                      <p:cNvPr id="510" name=""/>
                      <p:cNvSpPr/>
                      <p:nvPr/>
                    </p:nvSpPr>
                    <p:spPr>
                      <a:xfrm>
                        <a:off x="1645200" y="2379600"/>
                        <a:ext cx="70920" cy="7308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26280" bIns="2628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grpSp>
                  <p:nvGrpSpPr>
                    <p:cNvPr id="511" name="Freeform 176"/>
                    <p:cNvGrpSpPr/>
                    <p:nvPr/>
                  </p:nvGrpSpPr>
                  <p:grpSpPr>
                    <a:xfrm>
                      <a:off x="1584000" y="2340720"/>
                      <a:ext cx="73080" cy="79200"/>
                      <a:chOff x="1584000" y="2340720"/>
                      <a:chExt cx="73080" cy="79200"/>
                    </a:xfrm>
                  </p:grpSpPr>
                  <p:pic>
                    <p:nvPicPr>
                      <p:cNvPr id="512" name="Freeform 176" descr=""/>
                      <p:cNvPicPr/>
                      <p:nvPr/>
                    </p:nvPicPr>
                    <p:blipFill>
                      <a:blip r:embed="rId16"/>
                      <a:stretch/>
                    </p:blipFill>
                    <p:spPr>
                      <a:xfrm>
                        <a:off x="1585800" y="2340720"/>
                        <a:ext cx="71280" cy="792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  <p:sp>
                    <p:nvSpPr>
                      <p:cNvPr id="513" name=""/>
                      <p:cNvSpPr/>
                      <p:nvPr/>
                    </p:nvSpPr>
                    <p:spPr>
                      <a:xfrm>
                        <a:off x="1584000" y="2342880"/>
                        <a:ext cx="69120" cy="7308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26280" bIns="2628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grpSp>
                  <p:nvGrpSpPr>
                    <p:cNvPr id="514" name="Freeform 177"/>
                    <p:cNvGrpSpPr/>
                    <p:nvPr/>
                  </p:nvGrpSpPr>
                  <p:grpSpPr>
                    <a:xfrm>
                      <a:off x="1510920" y="2371320"/>
                      <a:ext cx="79200" cy="79200"/>
                      <a:chOff x="1510920" y="2371320"/>
                      <a:chExt cx="79200" cy="79200"/>
                    </a:xfrm>
                  </p:grpSpPr>
                  <p:pic>
                    <p:nvPicPr>
                      <p:cNvPr id="515" name="Freeform 177" descr=""/>
                      <p:cNvPicPr/>
                      <p:nvPr/>
                    </p:nvPicPr>
                    <p:blipFill>
                      <a:blip r:embed="rId17"/>
                      <a:stretch/>
                    </p:blipFill>
                    <p:spPr>
                      <a:xfrm>
                        <a:off x="1510920" y="2371320"/>
                        <a:ext cx="79200" cy="792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  <p:sp>
                    <p:nvSpPr>
                      <p:cNvPr id="516" name=""/>
                      <p:cNvSpPr/>
                      <p:nvPr/>
                    </p:nvSpPr>
                    <p:spPr>
                      <a:xfrm>
                        <a:off x="1510920" y="2372400"/>
                        <a:ext cx="70920" cy="7308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26280" bIns="2628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grpSp>
                  <p:nvGrpSpPr>
                    <p:cNvPr id="517" name="Group 170"/>
                    <p:cNvGrpSpPr/>
                    <p:nvPr/>
                  </p:nvGrpSpPr>
                  <p:grpSpPr>
                    <a:xfrm>
                      <a:off x="1425240" y="2190960"/>
                      <a:ext cx="332640" cy="348840"/>
                      <a:chOff x="1425240" y="2190960"/>
                      <a:chExt cx="332640" cy="348840"/>
                    </a:xfrm>
                  </p:grpSpPr>
                  <p:grpSp>
                    <p:nvGrpSpPr>
                      <p:cNvPr id="518" name="Freeform 179"/>
                      <p:cNvGrpSpPr/>
                      <p:nvPr/>
                    </p:nvGrpSpPr>
                    <p:grpSpPr>
                      <a:xfrm>
                        <a:off x="1578240" y="2420280"/>
                        <a:ext cx="78840" cy="79200"/>
                        <a:chOff x="1578240" y="2420280"/>
                        <a:chExt cx="78840" cy="79200"/>
                      </a:xfrm>
                    </p:grpSpPr>
                    <p:pic>
                      <p:nvPicPr>
                        <p:cNvPr id="519" name="Freeform 179" descr=""/>
                        <p:cNvPicPr/>
                        <p:nvPr/>
                      </p:nvPicPr>
                      <p:blipFill>
                        <a:blip r:embed="rId18"/>
                        <a:stretch/>
                      </p:blipFill>
                      <p:spPr>
                        <a:xfrm>
                          <a:off x="1578600" y="2420280"/>
                          <a:ext cx="78480" cy="7920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520" name=""/>
                        <p:cNvSpPr/>
                        <p:nvPr/>
                      </p:nvSpPr>
                      <p:spPr>
                        <a:xfrm>
                          <a:off x="1578240" y="2422080"/>
                          <a:ext cx="70200" cy="7308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26280" bIns="2628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sp>
                    <p:nvSpPr>
                      <p:cNvPr id="521" name="Rounded Rectangle 180"/>
                      <p:cNvSpPr/>
                      <p:nvPr/>
                    </p:nvSpPr>
                    <p:spPr>
                      <a:xfrm>
                        <a:off x="1431360" y="2341440"/>
                        <a:ext cx="326520" cy="193320"/>
                      </a:xfrm>
                      <a:prstGeom prst="roundRect">
                        <a:avLst>
                          <a:gd name="adj" fmla="val 16667"/>
                        </a:avLst>
                      </a:prstGeom>
                      <a:gradFill rotWithShape="0">
                        <a:gsLst>
                          <a:gs pos="0">
                            <a:srgbClr val="9ab5e4"/>
                          </a:gs>
                          <a:gs pos="100000">
                            <a:srgbClr val="e1e8f5"/>
                          </a:gs>
                        </a:gsLst>
                        <a:lin ang="16200000"/>
                      </a:gra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22" name="Oval 181"/>
                      <p:cNvSpPr/>
                      <p:nvPr/>
                    </p:nvSpPr>
                    <p:spPr>
                      <a:xfrm>
                        <a:off x="1433160" y="2239920"/>
                        <a:ext cx="324720" cy="45720"/>
                      </a:xfrm>
                      <a:prstGeom prst="ellipse">
                        <a:avLst/>
                      </a:prstGeom>
                      <a:solidFill>
                        <a:srgbClr val="a9c1df"/>
                      </a:solidFill>
                      <a:ln w="12600">
                        <a:solidFill>
                          <a:srgbClr val="385d8a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4040" bIns="-1404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23" name="Straight Connector 182"/>
                      <p:cNvSpPr/>
                      <p:nvPr/>
                    </p:nvSpPr>
                    <p:spPr>
                      <a:xfrm>
                        <a:off x="1429920" y="2271600"/>
                        <a:ext cx="0" cy="268200"/>
                      </a:xfrm>
                      <a:prstGeom prst="line">
                        <a:avLst/>
                      </a:prstGeom>
                      <a:ln w="9360">
                        <a:solidFill>
                          <a:srgbClr val="10253f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24" name="Straight Connector 183"/>
                      <p:cNvSpPr/>
                      <p:nvPr/>
                    </p:nvSpPr>
                    <p:spPr>
                      <a:xfrm>
                        <a:off x="1757880" y="2262240"/>
                        <a:ext cx="0" cy="266400"/>
                      </a:xfrm>
                      <a:prstGeom prst="line">
                        <a:avLst/>
                      </a:prstGeom>
                      <a:ln w="9360">
                        <a:solidFill>
                          <a:srgbClr val="10253f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25" name="Straight Connector 184"/>
                      <p:cNvSpPr/>
                      <p:nvPr/>
                    </p:nvSpPr>
                    <p:spPr>
                      <a:xfrm>
                        <a:off x="1425240" y="2535120"/>
                        <a:ext cx="332640" cy="0"/>
                      </a:xfrm>
                      <a:prstGeom prst="line">
                        <a:avLst/>
                      </a:prstGeom>
                      <a:ln w="9360">
                        <a:solidFill>
                          <a:srgbClr val="10253f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800" bIns="-46800" anchor="t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26" name="Oval 185"/>
                      <p:cNvSpPr/>
                      <p:nvPr/>
                    </p:nvSpPr>
                    <p:spPr>
                      <a:xfrm>
                        <a:off x="1433160" y="2190960"/>
                        <a:ext cx="324720" cy="56880"/>
                      </a:xfrm>
                      <a:prstGeom prst="ellipse">
                        <a:avLst/>
                      </a:prstGeom>
                      <a:solidFill>
                        <a:srgbClr val="4f81bd"/>
                      </a:solidFill>
                      <a:ln w="12600">
                        <a:solidFill>
                          <a:srgbClr val="385d8a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6480" bIns="-648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27" name="Rectangle 186"/>
                      <p:cNvSpPr/>
                      <p:nvPr/>
                    </p:nvSpPr>
                    <p:spPr>
                      <a:xfrm>
                        <a:off x="1431360" y="2225520"/>
                        <a:ext cx="326520" cy="71280"/>
                      </a:xfrm>
                      <a:prstGeom prst="rect">
                        <a:avLst/>
                      </a:prstGeom>
                      <a:solidFill>
                        <a:srgbClr val="4f81bd"/>
                      </a:solidFill>
                      <a:ln w="12600">
                        <a:solidFill>
                          <a:srgbClr val="385d8a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24480" bIns="2448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</p:grpSp>
              <p:grpSp>
                <p:nvGrpSpPr>
                  <p:cNvPr id="528" name="Group 184"/>
                  <p:cNvGrpSpPr/>
                  <p:nvPr/>
                </p:nvGrpSpPr>
                <p:grpSpPr>
                  <a:xfrm>
                    <a:off x="851760" y="2193120"/>
                    <a:ext cx="283320" cy="341640"/>
                    <a:chOff x="851760" y="2193120"/>
                    <a:chExt cx="283320" cy="341640"/>
                  </a:xfrm>
                </p:grpSpPr>
                <p:grpSp>
                  <p:nvGrpSpPr>
                    <p:cNvPr id="529" name="Freeform 163"/>
                    <p:cNvGrpSpPr/>
                    <p:nvPr/>
                  </p:nvGrpSpPr>
                  <p:grpSpPr>
                    <a:xfrm>
                      <a:off x="1023840" y="2383200"/>
                      <a:ext cx="73080" cy="79200"/>
                      <a:chOff x="1023840" y="2383200"/>
                      <a:chExt cx="73080" cy="79200"/>
                    </a:xfrm>
                  </p:grpSpPr>
                  <p:pic>
                    <p:nvPicPr>
                      <p:cNvPr id="530" name="Freeform 163" descr=""/>
                      <p:cNvPicPr/>
                      <p:nvPr/>
                    </p:nvPicPr>
                    <p:blipFill>
                      <a:blip r:embed="rId19"/>
                      <a:stretch/>
                    </p:blipFill>
                    <p:spPr>
                      <a:xfrm>
                        <a:off x="1024920" y="2383920"/>
                        <a:ext cx="72000" cy="784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  <p:sp>
                    <p:nvSpPr>
                      <p:cNvPr id="531" name=""/>
                      <p:cNvSpPr/>
                      <p:nvPr/>
                    </p:nvSpPr>
                    <p:spPr>
                      <a:xfrm>
                        <a:off x="1023840" y="2383200"/>
                        <a:ext cx="69840" cy="7200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25200" bIns="2520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grpSp>
                  <p:nvGrpSpPr>
                    <p:cNvPr id="532" name="Freeform 164"/>
                    <p:cNvGrpSpPr/>
                    <p:nvPr/>
                  </p:nvGrpSpPr>
                  <p:grpSpPr>
                    <a:xfrm>
                      <a:off x="956520" y="2346480"/>
                      <a:ext cx="79200" cy="79200"/>
                      <a:chOff x="956520" y="2346480"/>
                      <a:chExt cx="79200" cy="79200"/>
                    </a:xfrm>
                  </p:grpSpPr>
                  <p:pic>
                    <p:nvPicPr>
                      <p:cNvPr id="533" name="Freeform 164" descr=""/>
                      <p:cNvPicPr/>
                      <p:nvPr/>
                    </p:nvPicPr>
                    <p:blipFill>
                      <a:blip r:embed="rId20"/>
                      <a:stretch/>
                    </p:blipFill>
                    <p:spPr>
                      <a:xfrm>
                        <a:off x="956520" y="2347200"/>
                        <a:ext cx="79200" cy="784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  <p:sp>
                    <p:nvSpPr>
                      <p:cNvPr id="534" name=""/>
                      <p:cNvSpPr/>
                      <p:nvPr/>
                    </p:nvSpPr>
                    <p:spPr>
                      <a:xfrm>
                        <a:off x="959040" y="2346480"/>
                        <a:ext cx="70920" cy="7236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25560" bIns="2556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grpSp>
                  <p:nvGrpSpPr>
                    <p:cNvPr id="535" name="Freeform 165"/>
                    <p:cNvGrpSpPr/>
                    <p:nvPr/>
                  </p:nvGrpSpPr>
                  <p:grpSpPr>
                    <a:xfrm>
                      <a:off x="889560" y="2377080"/>
                      <a:ext cx="73080" cy="79200"/>
                      <a:chOff x="889560" y="2377080"/>
                      <a:chExt cx="73080" cy="79200"/>
                    </a:xfrm>
                  </p:grpSpPr>
                  <p:pic>
                    <p:nvPicPr>
                      <p:cNvPr id="536" name="Freeform 165" descr=""/>
                      <p:cNvPicPr/>
                      <p:nvPr/>
                    </p:nvPicPr>
                    <p:blipFill>
                      <a:blip r:embed="rId21"/>
                      <a:stretch/>
                    </p:blipFill>
                    <p:spPr>
                      <a:xfrm>
                        <a:off x="890280" y="2378880"/>
                        <a:ext cx="72360" cy="774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  <p:sp>
                    <p:nvSpPr>
                      <p:cNvPr id="537" name=""/>
                      <p:cNvSpPr/>
                      <p:nvPr/>
                    </p:nvSpPr>
                    <p:spPr>
                      <a:xfrm>
                        <a:off x="889560" y="2377080"/>
                        <a:ext cx="69840" cy="7128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24480" bIns="2448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grpSp>
                  <p:nvGrpSpPr>
                    <p:cNvPr id="538" name="Group 188"/>
                    <p:cNvGrpSpPr/>
                    <p:nvPr/>
                  </p:nvGrpSpPr>
                  <p:grpSpPr>
                    <a:xfrm>
                      <a:off x="851760" y="2193120"/>
                      <a:ext cx="283320" cy="341640"/>
                      <a:chOff x="851760" y="2193120"/>
                      <a:chExt cx="283320" cy="341640"/>
                    </a:xfrm>
                  </p:grpSpPr>
                  <p:grpSp>
                    <p:nvGrpSpPr>
                      <p:cNvPr id="539" name="Freeform 167"/>
                      <p:cNvGrpSpPr/>
                      <p:nvPr/>
                    </p:nvGrpSpPr>
                    <p:grpSpPr>
                      <a:xfrm>
                        <a:off x="925920" y="2425680"/>
                        <a:ext cx="51840" cy="79200"/>
                        <a:chOff x="925920" y="2425680"/>
                        <a:chExt cx="51840" cy="79200"/>
                      </a:xfrm>
                    </p:grpSpPr>
                    <p:pic>
                      <p:nvPicPr>
                        <p:cNvPr id="540" name="Freeform 167" descr=""/>
                        <p:cNvPicPr/>
                        <p:nvPr/>
                      </p:nvPicPr>
                      <p:blipFill>
                        <a:blip r:embed="rId22"/>
                        <a:stretch/>
                      </p:blipFill>
                      <p:spPr>
                        <a:xfrm>
                          <a:off x="927000" y="2426760"/>
                          <a:ext cx="50760" cy="7812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541" name=""/>
                        <p:cNvSpPr/>
                        <p:nvPr/>
                      </p:nvSpPr>
                      <p:spPr>
                        <a:xfrm>
                          <a:off x="925920" y="2425680"/>
                          <a:ext cx="48960" cy="7164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24840" bIns="2484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sp>
                    <p:nvSpPr>
                      <p:cNvPr id="542" name="Rounded Rectangle 168"/>
                      <p:cNvSpPr/>
                      <p:nvPr/>
                    </p:nvSpPr>
                    <p:spPr>
                      <a:xfrm>
                        <a:off x="851760" y="2343960"/>
                        <a:ext cx="283320" cy="190800"/>
                      </a:xfrm>
                      <a:prstGeom prst="roundRect">
                        <a:avLst>
                          <a:gd name="adj" fmla="val 16667"/>
                        </a:avLst>
                      </a:prstGeom>
                      <a:gradFill rotWithShape="0">
                        <a:gsLst>
                          <a:gs pos="0">
                            <a:srgbClr val="9ab5e4"/>
                          </a:gs>
                          <a:gs pos="100000">
                            <a:srgbClr val="e1e8f5"/>
                          </a:gs>
                        </a:gsLst>
                        <a:lin ang="16200000"/>
                      </a:gra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43" name="Oval 169"/>
                      <p:cNvSpPr/>
                      <p:nvPr/>
                    </p:nvSpPr>
                    <p:spPr>
                      <a:xfrm>
                        <a:off x="851760" y="2242080"/>
                        <a:ext cx="283320" cy="39600"/>
                      </a:xfrm>
                      <a:prstGeom prst="ellipse">
                        <a:avLst/>
                      </a:prstGeom>
                      <a:solidFill>
                        <a:srgbClr val="a9c1df"/>
                      </a:solidFill>
                      <a:ln w="12600">
                        <a:solidFill>
                          <a:srgbClr val="385d8a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8720" bIns="-1872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44" name="Straight Connector 170"/>
                      <p:cNvSpPr/>
                      <p:nvPr/>
                    </p:nvSpPr>
                    <p:spPr>
                      <a:xfrm>
                        <a:off x="851760" y="2262960"/>
                        <a:ext cx="0" cy="268560"/>
                      </a:xfrm>
                      <a:prstGeom prst="line">
                        <a:avLst/>
                      </a:prstGeom>
                      <a:ln w="9360">
                        <a:solidFill>
                          <a:srgbClr val="10253f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45" name="Straight Connector 171"/>
                      <p:cNvSpPr/>
                      <p:nvPr/>
                    </p:nvSpPr>
                    <p:spPr>
                      <a:xfrm>
                        <a:off x="1135080" y="2266200"/>
                        <a:ext cx="0" cy="265320"/>
                      </a:xfrm>
                      <a:prstGeom prst="line">
                        <a:avLst/>
                      </a:prstGeom>
                      <a:ln w="9360">
                        <a:solidFill>
                          <a:srgbClr val="10253f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46" name="Straight Connector 172"/>
                      <p:cNvSpPr/>
                      <p:nvPr/>
                    </p:nvSpPr>
                    <p:spPr>
                      <a:xfrm>
                        <a:off x="851760" y="2534760"/>
                        <a:ext cx="283320" cy="0"/>
                      </a:xfrm>
                      <a:prstGeom prst="line">
                        <a:avLst/>
                      </a:prstGeom>
                      <a:ln w="9360">
                        <a:solidFill>
                          <a:srgbClr val="10253f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800" bIns="-46800" anchor="t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47" name="Oval 173"/>
                      <p:cNvSpPr/>
                      <p:nvPr/>
                    </p:nvSpPr>
                    <p:spPr>
                      <a:xfrm>
                        <a:off x="851760" y="2193120"/>
                        <a:ext cx="283320" cy="54000"/>
                      </a:xfrm>
                      <a:prstGeom prst="ellipse">
                        <a:avLst/>
                      </a:prstGeom>
                      <a:solidFill>
                        <a:srgbClr val="4f81bd"/>
                      </a:solidFill>
                      <a:ln w="12600">
                        <a:solidFill>
                          <a:srgbClr val="385d8a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8640" bIns="-864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48" name="Rectangle 174"/>
                      <p:cNvSpPr/>
                      <p:nvPr/>
                    </p:nvSpPr>
                    <p:spPr>
                      <a:xfrm>
                        <a:off x="851760" y="2228040"/>
                        <a:ext cx="283320" cy="61920"/>
                      </a:xfrm>
                      <a:prstGeom prst="rect">
                        <a:avLst/>
                      </a:prstGeom>
                      <a:solidFill>
                        <a:srgbClr val="4f81bd"/>
                      </a:solidFill>
                      <a:ln w="12600">
                        <a:solidFill>
                          <a:srgbClr val="385d8a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15120" bIns="1512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</p:grpSp>
              <p:grpSp>
                <p:nvGrpSpPr>
                  <p:cNvPr id="549" name="Group 197"/>
                  <p:cNvGrpSpPr/>
                  <p:nvPr/>
                </p:nvGrpSpPr>
                <p:grpSpPr>
                  <a:xfrm>
                    <a:off x="2125440" y="2193480"/>
                    <a:ext cx="283320" cy="341280"/>
                    <a:chOff x="2125440" y="2193480"/>
                    <a:chExt cx="283320" cy="341280"/>
                  </a:xfrm>
                </p:grpSpPr>
                <p:grpSp>
                  <p:nvGrpSpPr>
                    <p:cNvPr id="550" name="Freeform 151"/>
                    <p:cNvGrpSpPr/>
                    <p:nvPr/>
                  </p:nvGrpSpPr>
                  <p:grpSpPr>
                    <a:xfrm>
                      <a:off x="2297520" y="2383200"/>
                      <a:ext cx="73080" cy="79200"/>
                      <a:chOff x="2297520" y="2383200"/>
                      <a:chExt cx="73080" cy="79200"/>
                    </a:xfrm>
                  </p:grpSpPr>
                  <p:pic>
                    <p:nvPicPr>
                      <p:cNvPr id="551" name="Freeform 151" descr=""/>
                      <p:cNvPicPr/>
                      <p:nvPr/>
                    </p:nvPicPr>
                    <p:blipFill>
                      <a:blip r:embed="rId23"/>
                      <a:stretch/>
                    </p:blipFill>
                    <p:spPr>
                      <a:xfrm>
                        <a:off x="2298600" y="2383560"/>
                        <a:ext cx="72000" cy="788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  <p:sp>
                    <p:nvSpPr>
                      <p:cNvPr id="552" name=""/>
                      <p:cNvSpPr/>
                      <p:nvPr/>
                    </p:nvSpPr>
                    <p:spPr>
                      <a:xfrm>
                        <a:off x="2297520" y="2383200"/>
                        <a:ext cx="69480" cy="7236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25560" bIns="2556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grpSp>
                  <p:nvGrpSpPr>
                    <p:cNvPr id="553" name="Freeform 152"/>
                    <p:cNvGrpSpPr/>
                    <p:nvPr/>
                  </p:nvGrpSpPr>
                  <p:grpSpPr>
                    <a:xfrm>
                      <a:off x="2230560" y="2346480"/>
                      <a:ext cx="79200" cy="79200"/>
                      <a:chOff x="2230560" y="2346480"/>
                      <a:chExt cx="79200" cy="79200"/>
                    </a:xfrm>
                  </p:grpSpPr>
                  <p:pic>
                    <p:nvPicPr>
                      <p:cNvPr id="554" name="Freeform 152" descr=""/>
                      <p:cNvPicPr/>
                      <p:nvPr/>
                    </p:nvPicPr>
                    <p:blipFill>
                      <a:blip r:embed="rId24"/>
                      <a:stretch/>
                    </p:blipFill>
                    <p:spPr>
                      <a:xfrm>
                        <a:off x="2230560" y="2346840"/>
                        <a:ext cx="79200" cy="788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  <p:sp>
                    <p:nvSpPr>
                      <p:cNvPr id="555" name=""/>
                      <p:cNvSpPr/>
                      <p:nvPr/>
                    </p:nvSpPr>
                    <p:spPr>
                      <a:xfrm>
                        <a:off x="2232720" y="2346480"/>
                        <a:ext cx="70920" cy="7272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25920" bIns="2592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grpSp>
                  <p:nvGrpSpPr>
                    <p:cNvPr id="556" name="Freeform 153"/>
                    <p:cNvGrpSpPr/>
                    <p:nvPr/>
                  </p:nvGrpSpPr>
                  <p:grpSpPr>
                    <a:xfrm>
                      <a:off x="2163240" y="2377080"/>
                      <a:ext cx="73080" cy="79200"/>
                      <a:chOff x="2163240" y="2377080"/>
                      <a:chExt cx="73080" cy="79200"/>
                    </a:xfrm>
                  </p:grpSpPr>
                  <p:pic>
                    <p:nvPicPr>
                      <p:cNvPr id="557" name="Freeform 153" descr=""/>
                      <p:cNvPicPr/>
                      <p:nvPr/>
                    </p:nvPicPr>
                    <p:blipFill>
                      <a:blip r:embed="rId25"/>
                      <a:stretch/>
                    </p:blipFill>
                    <p:spPr>
                      <a:xfrm>
                        <a:off x="2164320" y="2378160"/>
                        <a:ext cx="72000" cy="781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  <p:sp>
                    <p:nvSpPr>
                      <p:cNvPr id="558" name=""/>
                      <p:cNvSpPr/>
                      <p:nvPr/>
                    </p:nvSpPr>
                    <p:spPr>
                      <a:xfrm>
                        <a:off x="2163240" y="2377080"/>
                        <a:ext cx="69840" cy="716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24840" bIns="2484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grpSp>
                  <p:nvGrpSpPr>
                    <p:cNvPr id="559" name="Group 201"/>
                    <p:cNvGrpSpPr/>
                    <p:nvPr/>
                  </p:nvGrpSpPr>
                  <p:grpSpPr>
                    <a:xfrm>
                      <a:off x="2125440" y="2193480"/>
                      <a:ext cx="283320" cy="341280"/>
                      <a:chOff x="2125440" y="2193480"/>
                      <a:chExt cx="283320" cy="341280"/>
                    </a:xfrm>
                  </p:grpSpPr>
                  <p:grpSp>
                    <p:nvGrpSpPr>
                      <p:cNvPr id="560" name="Freeform 155"/>
                      <p:cNvGrpSpPr/>
                      <p:nvPr/>
                    </p:nvGrpSpPr>
                    <p:grpSpPr>
                      <a:xfrm>
                        <a:off x="2233440" y="2425680"/>
                        <a:ext cx="71640" cy="79200"/>
                        <a:chOff x="2233440" y="2425680"/>
                        <a:chExt cx="71640" cy="79200"/>
                      </a:xfrm>
                    </p:grpSpPr>
                    <p:pic>
                      <p:nvPicPr>
                        <p:cNvPr id="561" name="Freeform 155" descr=""/>
                        <p:cNvPicPr/>
                        <p:nvPr/>
                      </p:nvPicPr>
                      <p:blipFill>
                        <a:blip r:embed="rId26"/>
                        <a:stretch/>
                      </p:blipFill>
                      <p:spPr>
                        <a:xfrm>
                          <a:off x="2235240" y="2426400"/>
                          <a:ext cx="69840" cy="7848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562" name=""/>
                        <p:cNvSpPr/>
                        <p:nvPr/>
                      </p:nvSpPr>
                      <p:spPr>
                        <a:xfrm>
                          <a:off x="2233440" y="2425680"/>
                          <a:ext cx="67680" cy="7200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25200" bIns="2520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sp>
                    <p:nvSpPr>
                      <p:cNvPr id="563" name="Rounded Rectangle 156"/>
                      <p:cNvSpPr/>
                      <p:nvPr/>
                    </p:nvSpPr>
                    <p:spPr>
                      <a:xfrm>
                        <a:off x="2125440" y="2344320"/>
                        <a:ext cx="283320" cy="190440"/>
                      </a:xfrm>
                      <a:prstGeom prst="roundRect">
                        <a:avLst>
                          <a:gd name="adj" fmla="val 16667"/>
                        </a:avLst>
                      </a:prstGeom>
                      <a:gradFill rotWithShape="0">
                        <a:gsLst>
                          <a:gs pos="0">
                            <a:srgbClr val="9ab5e4"/>
                          </a:gs>
                          <a:gs pos="100000">
                            <a:srgbClr val="e1e8f5"/>
                          </a:gs>
                        </a:gsLst>
                        <a:lin ang="16200000"/>
                      </a:gra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64" name="Oval 157"/>
                      <p:cNvSpPr/>
                      <p:nvPr/>
                    </p:nvSpPr>
                    <p:spPr>
                      <a:xfrm>
                        <a:off x="2125440" y="2242440"/>
                        <a:ext cx="283320" cy="39600"/>
                      </a:xfrm>
                      <a:prstGeom prst="ellipse">
                        <a:avLst/>
                      </a:prstGeom>
                      <a:solidFill>
                        <a:srgbClr val="a9c1df"/>
                      </a:solidFill>
                      <a:ln w="12600">
                        <a:solidFill>
                          <a:srgbClr val="385d8a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8720" bIns="-1872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65" name="Straight Connector 158"/>
                      <p:cNvSpPr/>
                      <p:nvPr/>
                    </p:nvSpPr>
                    <p:spPr>
                      <a:xfrm>
                        <a:off x="2125440" y="2261520"/>
                        <a:ext cx="0" cy="270000"/>
                      </a:xfrm>
                      <a:prstGeom prst="line">
                        <a:avLst/>
                      </a:prstGeom>
                      <a:ln w="9360">
                        <a:solidFill>
                          <a:srgbClr val="10253f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66" name="Straight Connector 159"/>
                      <p:cNvSpPr/>
                      <p:nvPr/>
                    </p:nvSpPr>
                    <p:spPr>
                      <a:xfrm>
                        <a:off x="2408760" y="2264760"/>
                        <a:ext cx="0" cy="266760"/>
                      </a:xfrm>
                      <a:prstGeom prst="line">
                        <a:avLst/>
                      </a:prstGeom>
                      <a:ln w="9360">
                        <a:solidFill>
                          <a:srgbClr val="10253f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67" name="Straight Connector 160"/>
                      <p:cNvSpPr/>
                      <p:nvPr/>
                    </p:nvSpPr>
                    <p:spPr>
                      <a:xfrm>
                        <a:off x="2125440" y="2534760"/>
                        <a:ext cx="283320" cy="0"/>
                      </a:xfrm>
                      <a:prstGeom prst="line">
                        <a:avLst/>
                      </a:prstGeom>
                      <a:ln w="9360">
                        <a:solidFill>
                          <a:srgbClr val="10253f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800" bIns="-46800" anchor="t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68" name="Oval 161"/>
                      <p:cNvSpPr/>
                      <p:nvPr/>
                    </p:nvSpPr>
                    <p:spPr>
                      <a:xfrm>
                        <a:off x="2125440" y="2193480"/>
                        <a:ext cx="283320" cy="54000"/>
                      </a:xfrm>
                      <a:prstGeom prst="ellipse">
                        <a:avLst/>
                      </a:prstGeom>
                      <a:solidFill>
                        <a:srgbClr val="4f81bd"/>
                      </a:solidFill>
                      <a:ln w="12600">
                        <a:solidFill>
                          <a:srgbClr val="385d8a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8640" bIns="-864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69" name="Rectangle 162"/>
                      <p:cNvSpPr/>
                      <p:nvPr/>
                    </p:nvSpPr>
                    <p:spPr>
                      <a:xfrm>
                        <a:off x="2125440" y="2228400"/>
                        <a:ext cx="283320" cy="60120"/>
                      </a:xfrm>
                      <a:prstGeom prst="rect">
                        <a:avLst/>
                      </a:prstGeom>
                      <a:solidFill>
                        <a:srgbClr val="4f81bd"/>
                      </a:solidFill>
                      <a:ln w="12600">
                        <a:solidFill>
                          <a:srgbClr val="385d8a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13320" bIns="1332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</p:grpSp>
            </p:grpSp>
            <p:sp>
              <p:nvSpPr>
                <p:cNvPr id="570" name="TextBox 44"/>
                <p:cNvSpPr/>
                <p:nvPr/>
              </p:nvSpPr>
              <p:spPr>
                <a:xfrm>
                  <a:off x="808920" y="2568600"/>
                  <a:ext cx="165060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6260"/>
                      </a:solidFill>
                      <a:latin typeface="Times New Roman"/>
                      <a:ea typeface="Times New Roman"/>
                    </a:rPr>
                    <a:t>Freshly Collected Tissues 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6260"/>
                      </a:solidFill>
                      <a:latin typeface="Times New Roman"/>
                      <a:ea typeface="Times New Roman"/>
                    </a:rPr>
                    <a:t>in Chilled PBS(pH-7.4) 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571" name="Group 219"/>
                <p:cNvGrpSpPr/>
                <p:nvPr/>
              </p:nvGrpSpPr>
              <p:grpSpPr>
                <a:xfrm>
                  <a:off x="2495160" y="1239840"/>
                  <a:ext cx="412560" cy="1161000"/>
                  <a:chOff x="2495160" y="1239840"/>
                  <a:chExt cx="412560" cy="1161000"/>
                </a:xfrm>
              </p:grpSpPr>
              <p:sp>
                <p:nvSpPr>
                  <p:cNvPr id="572" name="Straight Connector 146"/>
                  <p:cNvSpPr/>
                  <p:nvPr/>
                </p:nvSpPr>
                <p:spPr>
                  <a:xfrm>
                    <a:off x="2495160" y="2399400"/>
                    <a:ext cx="412560" cy="0"/>
                  </a:xfrm>
                  <a:prstGeom prst="line">
                    <a:avLst/>
                  </a:prstGeom>
                  <a:ln w="12600">
                    <a:solidFill>
                      <a:srgbClr val="66003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3" name="Straight Connector 147"/>
                  <p:cNvSpPr/>
                  <p:nvPr/>
                </p:nvSpPr>
                <p:spPr>
                  <a:xfrm>
                    <a:off x="2907720" y="1239840"/>
                    <a:ext cx="0" cy="1161000"/>
                  </a:xfrm>
                  <a:prstGeom prst="line">
                    <a:avLst/>
                  </a:prstGeom>
                  <a:ln w="12600">
                    <a:solidFill>
                      <a:srgbClr val="66003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574" name="Group 2"/>
                <p:cNvGrpSpPr/>
                <p:nvPr/>
              </p:nvGrpSpPr>
              <p:grpSpPr>
                <a:xfrm>
                  <a:off x="3943080" y="394920"/>
                  <a:ext cx="1078200" cy="969480"/>
                  <a:chOff x="3943080" y="394920"/>
                  <a:chExt cx="1078200" cy="969480"/>
                </a:xfrm>
              </p:grpSpPr>
              <p:grpSp>
                <p:nvGrpSpPr>
                  <p:cNvPr id="575" name="Group 1"/>
                  <p:cNvGrpSpPr/>
                  <p:nvPr/>
                </p:nvGrpSpPr>
                <p:grpSpPr>
                  <a:xfrm>
                    <a:off x="4190760" y="394920"/>
                    <a:ext cx="815040" cy="664200"/>
                    <a:chOff x="4190760" y="394920"/>
                    <a:chExt cx="815040" cy="664200"/>
                  </a:xfrm>
                </p:grpSpPr>
                <p:grpSp>
                  <p:nvGrpSpPr>
                    <p:cNvPr id="576" name="Group 245"/>
                    <p:cNvGrpSpPr/>
                    <p:nvPr/>
                  </p:nvGrpSpPr>
                  <p:grpSpPr>
                    <a:xfrm>
                      <a:off x="4190760" y="831960"/>
                      <a:ext cx="595080" cy="227160"/>
                      <a:chOff x="4190760" y="831960"/>
                      <a:chExt cx="595080" cy="227160"/>
                    </a:xfrm>
                  </p:grpSpPr>
                  <p:sp>
                    <p:nvSpPr>
                      <p:cNvPr id="577" name="Freeform 126"/>
                      <p:cNvSpPr/>
                      <p:nvPr/>
                    </p:nvSpPr>
                    <p:spPr>
                      <a:xfrm>
                        <a:off x="4500360" y="876240"/>
                        <a:ext cx="91800" cy="65160"/>
                      </a:xfrm>
                      <a:custGeom>
                        <a:avLst/>
                        <a:gdLst/>
                        <a:ahLst/>
                        <a:rect l="l" t="t" r="r" b="b"/>
                        <a:pathLst>
                          <a:path w="100035" h="39868">
                            <a:moveTo>
                              <a:pt x="0" y="0"/>
                            </a:moveTo>
                            <a:cubicBezTo>
                              <a:pt x="0" y="0"/>
                              <a:pt x="92187" y="40280"/>
                              <a:pt x="99662" y="39865"/>
                            </a:cubicBezTo>
                            <a:cubicBezTo>
                              <a:pt x="107137" y="39450"/>
                              <a:pt x="0" y="0"/>
                              <a:pt x="0" y="0"/>
                            </a:cubicBezTo>
                            <a:close/>
                          </a:path>
                        </a:pathLst>
                      </a:custGeom>
                      <a:solidFill>
                        <a:srgbClr val="c68c52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18360" bIns="18360" anchor="ctr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78" name="Freeform 127"/>
                      <p:cNvSpPr/>
                      <p:nvPr/>
                    </p:nvSpPr>
                    <p:spPr>
                      <a:xfrm>
                        <a:off x="4608360" y="887400"/>
                        <a:ext cx="71280" cy="46080"/>
                      </a:xfrm>
                      <a:custGeom>
                        <a:avLst/>
                        <a:gdLst/>
                        <a:ahLst/>
                        <a:rect l="l" t="t" r="r" b="b"/>
                        <a:pathLst>
                          <a:path w="74661" h="48701">
                            <a:moveTo>
                              <a:pt x="117" y="40389"/>
                            </a:moveTo>
                            <a:cubicBezTo>
                              <a:pt x="3024" y="47864"/>
                              <a:pt x="63236" y="52017"/>
                              <a:pt x="72372" y="45373"/>
                            </a:cubicBezTo>
                            <a:cubicBezTo>
                              <a:pt x="81508" y="38729"/>
                              <a:pt x="60745" y="5923"/>
                              <a:pt x="54931" y="525"/>
                            </a:cubicBezTo>
                            <a:cubicBezTo>
                              <a:pt x="49117" y="-4874"/>
                              <a:pt x="-2790" y="32914"/>
                              <a:pt x="117" y="40389"/>
                            </a:cubicBezTo>
                            <a:close/>
                          </a:path>
                        </a:pathLst>
                      </a:custGeom>
                      <a:solidFill>
                        <a:srgbClr val="c68c52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720" bIns="-720" anchor="ctr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79" name="Freeform 128"/>
                      <p:cNvSpPr/>
                      <p:nvPr/>
                    </p:nvSpPr>
                    <p:spPr>
                      <a:xfrm>
                        <a:off x="4403520" y="863280"/>
                        <a:ext cx="96840" cy="79200"/>
                      </a:xfrm>
                      <a:custGeom>
                        <a:avLst/>
                        <a:gdLst/>
                        <a:ahLst/>
                        <a:rect l="l" t="t" r="r" b="b"/>
                        <a:pathLst>
                          <a:path w="107757" h="83701">
                            <a:moveTo>
                              <a:pt x="3271" y="83653"/>
                            </a:moveTo>
                            <a:cubicBezTo>
                              <a:pt x="-1297" y="81992"/>
                              <a:pt x="-881" y="40051"/>
                              <a:pt x="3271" y="26348"/>
                            </a:cubicBezTo>
                            <a:cubicBezTo>
                              <a:pt x="7423" y="12645"/>
                              <a:pt x="11576" y="5169"/>
                              <a:pt x="28186" y="1432"/>
                            </a:cubicBezTo>
                            <a:cubicBezTo>
                              <a:pt x="44796" y="-2305"/>
                              <a:pt x="91721" y="2263"/>
                              <a:pt x="102933" y="3924"/>
                            </a:cubicBezTo>
                            <a:cubicBezTo>
                              <a:pt x="114145" y="5585"/>
                              <a:pt x="103348" y="10152"/>
                              <a:pt x="95458" y="11398"/>
                            </a:cubicBezTo>
                            <a:cubicBezTo>
                              <a:pt x="87568" y="12644"/>
                              <a:pt x="66390" y="7245"/>
                              <a:pt x="55593" y="11398"/>
                            </a:cubicBezTo>
                            <a:cubicBezTo>
                              <a:pt x="44796" y="15551"/>
                              <a:pt x="36076" y="28424"/>
                              <a:pt x="30678" y="36314"/>
                            </a:cubicBezTo>
                            <a:cubicBezTo>
                              <a:pt x="25280" y="44204"/>
                              <a:pt x="7839" y="85314"/>
                              <a:pt x="3271" y="83653"/>
                            </a:cubicBezTo>
                            <a:close/>
                          </a:path>
                        </a:pathLst>
                      </a:custGeom>
                      <a:solidFill>
                        <a:srgbClr val="c68c52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32400" bIns="32400" anchor="ctr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80" name="Freeform 129"/>
                      <p:cNvSpPr/>
                      <p:nvPr/>
                    </p:nvSpPr>
                    <p:spPr>
                      <a:xfrm>
                        <a:off x="4311360" y="885600"/>
                        <a:ext cx="61920" cy="65160"/>
                      </a:xfrm>
                      <a:custGeom>
                        <a:avLst/>
                        <a:gdLst/>
                        <a:ahLst/>
                        <a:rect l="l" t="t" r="r" b="b"/>
                        <a:pathLst>
                          <a:path w="66233" h="68100">
                            <a:moveTo>
                              <a:pt x="65795" y="67290"/>
                            </a:moveTo>
                            <a:cubicBezTo>
                              <a:pt x="61227" y="73104"/>
                              <a:pt x="7244" y="46112"/>
                              <a:pt x="1015" y="34900"/>
                            </a:cubicBezTo>
                            <a:cubicBezTo>
                              <a:pt x="-5214" y="23688"/>
                              <a:pt x="18871" y="1264"/>
                              <a:pt x="28422" y="18"/>
                            </a:cubicBezTo>
                            <a:cubicBezTo>
                              <a:pt x="37973" y="-1228"/>
                              <a:pt x="70363" y="61476"/>
                              <a:pt x="65795" y="67290"/>
                            </a:cubicBezTo>
                            <a:close/>
                          </a:path>
                        </a:pathLst>
                      </a:custGeom>
                      <a:solidFill>
                        <a:srgbClr val="c68c52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18360" bIns="18360" anchor="ctr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81" name="Freeform 130"/>
                      <p:cNvSpPr/>
                      <p:nvPr/>
                    </p:nvSpPr>
                    <p:spPr>
                      <a:xfrm rot="1518000">
                        <a:off x="4461840" y="902880"/>
                        <a:ext cx="71280" cy="63360"/>
                      </a:xfrm>
                      <a:custGeom>
                        <a:avLst/>
                        <a:gdLst/>
                        <a:ahLst/>
                        <a:rect l="l" t="t" r="r" b="b"/>
                        <a:pathLst>
                          <a:path w="107757" h="83701">
                            <a:moveTo>
                              <a:pt x="3271" y="83653"/>
                            </a:moveTo>
                            <a:cubicBezTo>
                              <a:pt x="-1297" y="81992"/>
                              <a:pt x="-881" y="40051"/>
                              <a:pt x="3271" y="26348"/>
                            </a:cubicBezTo>
                            <a:cubicBezTo>
                              <a:pt x="7423" y="12645"/>
                              <a:pt x="11576" y="5169"/>
                              <a:pt x="28186" y="1432"/>
                            </a:cubicBezTo>
                            <a:cubicBezTo>
                              <a:pt x="44796" y="-2305"/>
                              <a:pt x="91721" y="2263"/>
                              <a:pt x="102933" y="3924"/>
                            </a:cubicBezTo>
                            <a:cubicBezTo>
                              <a:pt x="114145" y="5585"/>
                              <a:pt x="103348" y="10152"/>
                              <a:pt x="95458" y="11398"/>
                            </a:cubicBezTo>
                            <a:cubicBezTo>
                              <a:pt x="87568" y="12644"/>
                              <a:pt x="66390" y="7245"/>
                              <a:pt x="55593" y="11398"/>
                            </a:cubicBezTo>
                            <a:cubicBezTo>
                              <a:pt x="44796" y="15551"/>
                              <a:pt x="36076" y="28424"/>
                              <a:pt x="30678" y="36314"/>
                            </a:cubicBezTo>
                            <a:cubicBezTo>
                              <a:pt x="25280" y="44204"/>
                              <a:pt x="7839" y="85314"/>
                              <a:pt x="3271" y="83653"/>
                            </a:cubicBezTo>
                            <a:close/>
                          </a:path>
                        </a:pathLst>
                      </a:custGeom>
                      <a:solidFill>
                        <a:srgbClr val="c68c52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16560" bIns="16560" anchor="ctr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82" name="Freeform 131"/>
                      <p:cNvSpPr/>
                      <p:nvPr/>
                    </p:nvSpPr>
                    <p:spPr>
                      <a:xfrm>
                        <a:off x="4581360" y="914400"/>
                        <a:ext cx="72720" cy="46080"/>
                      </a:xfrm>
                      <a:custGeom>
                        <a:avLst/>
                        <a:gdLst/>
                        <a:ahLst/>
                        <a:rect l="l" t="t" r="r" b="b"/>
                        <a:pathLst>
                          <a:path w="74661" h="48701">
                            <a:moveTo>
                              <a:pt x="117" y="40389"/>
                            </a:moveTo>
                            <a:cubicBezTo>
                              <a:pt x="3024" y="47864"/>
                              <a:pt x="63236" y="52017"/>
                              <a:pt x="72372" y="45373"/>
                            </a:cubicBezTo>
                            <a:cubicBezTo>
                              <a:pt x="81508" y="38729"/>
                              <a:pt x="60745" y="5923"/>
                              <a:pt x="54931" y="525"/>
                            </a:cubicBezTo>
                            <a:cubicBezTo>
                              <a:pt x="49117" y="-4874"/>
                              <a:pt x="-2790" y="32914"/>
                              <a:pt x="117" y="40389"/>
                            </a:cubicBezTo>
                            <a:close/>
                          </a:path>
                        </a:pathLst>
                      </a:custGeom>
                      <a:solidFill>
                        <a:srgbClr val="c68c52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720" bIns="-720" anchor="ctr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83" name="Freeform 132"/>
                      <p:cNvSpPr/>
                      <p:nvPr/>
                    </p:nvSpPr>
                    <p:spPr>
                      <a:xfrm>
                        <a:off x="4479480" y="877680"/>
                        <a:ext cx="85680" cy="81000"/>
                      </a:xfrm>
                      <a:custGeom>
                        <a:avLst/>
                        <a:gdLst/>
                        <a:ahLst/>
                        <a:rect l="l" t="t" r="r" b="b"/>
                        <a:pathLst>
                          <a:path w="107757" h="83701">
                            <a:moveTo>
                              <a:pt x="3271" y="83653"/>
                            </a:moveTo>
                            <a:cubicBezTo>
                              <a:pt x="-1297" y="81992"/>
                              <a:pt x="-881" y="40051"/>
                              <a:pt x="3271" y="26348"/>
                            </a:cubicBezTo>
                            <a:cubicBezTo>
                              <a:pt x="7423" y="12645"/>
                              <a:pt x="11576" y="5169"/>
                              <a:pt x="28186" y="1432"/>
                            </a:cubicBezTo>
                            <a:cubicBezTo>
                              <a:pt x="44796" y="-2305"/>
                              <a:pt x="91721" y="2263"/>
                              <a:pt x="102933" y="3924"/>
                            </a:cubicBezTo>
                            <a:cubicBezTo>
                              <a:pt x="114145" y="5585"/>
                              <a:pt x="103348" y="10152"/>
                              <a:pt x="95458" y="11398"/>
                            </a:cubicBezTo>
                            <a:cubicBezTo>
                              <a:pt x="87568" y="12644"/>
                              <a:pt x="66390" y="7245"/>
                              <a:pt x="55593" y="11398"/>
                            </a:cubicBezTo>
                            <a:cubicBezTo>
                              <a:pt x="44796" y="15551"/>
                              <a:pt x="36076" y="28424"/>
                              <a:pt x="30678" y="36314"/>
                            </a:cubicBezTo>
                            <a:cubicBezTo>
                              <a:pt x="25280" y="44204"/>
                              <a:pt x="7839" y="85314"/>
                              <a:pt x="3271" y="83653"/>
                            </a:cubicBezTo>
                            <a:close/>
                          </a:path>
                        </a:pathLst>
                      </a:custGeom>
                      <a:solidFill>
                        <a:srgbClr val="c68c52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34200" bIns="34200" anchor="ctr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84" name="Freeform 133"/>
                      <p:cNvSpPr/>
                      <p:nvPr/>
                    </p:nvSpPr>
                    <p:spPr>
                      <a:xfrm>
                        <a:off x="4385880" y="901440"/>
                        <a:ext cx="63360" cy="63360"/>
                      </a:xfrm>
                      <a:custGeom>
                        <a:avLst/>
                        <a:gdLst/>
                        <a:ahLst/>
                        <a:rect l="l" t="t" r="r" b="b"/>
                        <a:pathLst>
                          <a:path w="66233" h="68100">
                            <a:moveTo>
                              <a:pt x="65795" y="67290"/>
                            </a:moveTo>
                            <a:cubicBezTo>
                              <a:pt x="61227" y="73104"/>
                              <a:pt x="7244" y="46112"/>
                              <a:pt x="1015" y="34900"/>
                            </a:cubicBezTo>
                            <a:cubicBezTo>
                              <a:pt x="-5214" y="23688"/>
                              <a:pt x="18871" y="1264"/>
                              <a:pt x="28422" y="18"/>
                            </a:cubicBezTo>
                            <a:cubicBezTo>
                              <a:pt x="37973" y="-1228"/>
                              <a:pt x="70363" y="61476"/>
                              <a:pt x="65795" y="67290"/>
                            </a:cubicBezTo>
                            <a:close/>
                          </a:path>
                        </a:pathLst>
                      </a:custGeom>
                      <a:solidFill>
                        <a:srgbClr val="c68c52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16560" bIns="16560" anchor="ctr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85" name="Freeform 134"/>
                      <p:cNvSpPr/>
                      <p:nvPr/>
                    </p:nvSpPr>
                    <p:spPr>
                      <a:xfrm rot="1518000">
                        <a:off x="4520520" y="917640"/>
                        <a:ext cx="88920" cy="65160"/>
                      </a:xfrm>
                      <a:custGeom>
                        <a:avLst/>
                        <a:gdLst/>
                        <a:ahLst/>
                        <a:rect l="l" t="t" r="r" b="b"/>
                        <a:pathLst>
                          <a:path w="107757" h="83701">
                            <a:moveTo>
                              <a:pt x="3271" y="83653"/>
                            </a:moveTo>
                            <a:cubicBezTo>
                              <a:pt x="-1297" y="81992"/>
                              <a:pt x="-881" y="40051"/>
                              <a:pt x="3271" y="26348"/>
                            </a:cubicBezTo>
                            <a:cubicBezTo>
                              <a:pt x="7423" y="12645"/>
                              <a:pt x="11576" y="5169"/>
                              <a:pt x="28186" y="1432"/>
                            </a:cubicBezTo>
                            <a:cubicBezTo>
                              <a:pt x="44796" y="-2305"/>
                              <a:pt x="91721" y="2263"/>
                              <a:pt x="102933" y="3924"/>
                            </a:cubicBezTo>
                            <a:cubicBezTo>
                              <a:pt x="114145" y="5585"/>
                              <a:pt x="103348" y="10152"/>
                              <a:pt x="95458" y="11398"/>
                            </a:cubicBezTo>
                            <a:cubicBezTo>
                              <a:pt x="87568" y="12644"/>
                              <a:pt x="66390" y="7245"/>
                              <a:pt x="55593" y="11398"/>
                            </a:cubicBezTo>
                            <a:cubicBezTo>
                              <a:pt x="44796" y="15551"/>
                              <a:pt x="36076" y="28424"/>
                              <a:pt x="30678" y="36314"/>
                            </a:cubicBezTo>
                            <a:cubicBezTo>
                              <a:pt x="25280" y="44204"/>
                              <a:pt x="7839" y="85314"/>
                              <a:pt x="3271" y="83653"/>
                            </a:cubicBezTo>
                            <a:close/>
                          </a:path>
                        </a:pathLst>
                      </a:custGeom>
                      <a:solidFill>
                        <a:srgbClr val="c68c52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18360" bIns="18360" anchor="ctr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grpSp>
                    <p:nvGrpSpPr>
                      <p:cNvPr id="586" name="Group 236"/>
                      <p:cNvGrpSpPr/>
                      <p:nvPr/>
                    </p:nvGrpSpPr>
                    <p:grpSpPr>
                      <a:xfrm>
                        <a:off x="4190760" y="831960"/>
                        <a:ext cx="595080" cy="227160"/>
                        <a:chOff x="4190760" y="831960"/>
                        <a:chExt cx="595080" cy="227160"/>
                      </a:xfrm>
                    </p:grpSpPr>
                    <p:sp>
                      <p:nvSpPr>
                        <p:cNvPr id="587" name="Rectangle 140"/>
                        <p:cNvSpPr/>
                        <p:nvPr/>
                      </p:nvSpPr>
                      <p:spPr>
                        <a:xfrm>
                          <a:off x="4195080" y="915840"/>
                          <a:ext cx="570240" cy="139680"/>
                        </a:xfrm>
                        <a:prstGeom prst="rect">
                          <a:avLst/>
                        </a:prstGeom>
                        <a:gradFill rotWithShape="0">
                          <a:gsLst>
                            <a:gs pos="0">
                              <a:srgbClr val="9ab5e4"/>
                            </a:gs>
                            <a:gs pos="100000">
                              <a:srgbClr val="e1e8f5">
                                <a:alpha val="60000"/>
                              </a:srgbClr>
                            </a:gs>
                          </a:gsLst>
                          <a:lin ang="18900000"/>
                        </a:gradFill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grpSp>
                      <p:nvGrpSpPr>
                        <p:cNvPr id="588" name="Group 230"/>
                        <p:cNvGrpSpPr/>
                        <p:nvPr/>
                      </p:nvGrpSpPr>
                      <p:grpSpPr>
                        <a:xfrm>
                          <a:off x="4190760" y="831960"/>
                          <a:ext cx="595080" cy="227160"/>
                          <a:chOff x="4190760" y="831960"/>
                          <a:chExt cx="595080" cy="227160"/>
                        </a:xfrm>
                      </p:grpSpPr>
                      <p:sp>
                        <p:nvSpPr>
                          <p:cNvPr id="589" name="Straight Connector 142"/>
                          <p:cNvSpPr/>
                          <p:nvPr/>
                        </p:nvSpPr>
                        <p:spPr>
                          <a:xfrm>
                            <a:off x="4195440" y="903240"/>
                            <a:ext cx="0" cy="149400"/>
                          </a:xfrm>
                          <a:prstGeom prst="line">
                            <a:avLst/>
                          </a:prstGeom>
                          <a:ln w="12600">
                            <a:solidFill>
                              <a:srgbClr val="006666"/>
                            </a:solidFill>
                            <a:miter/>
                          </a:ln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lIns="90000" rIns="90000" tIns="46800" bIns="46800" anchor="t">
                            <a:noAutofit/>
                          </a:bodyPr>
                          <a:p>
                            <a:endParaRPr b="0" lang="en-US" sz="2000" spc="-1" strike="noStrike">
                              <a:solidFill>
                                <a:srgbClr val="000000"/>
                              </a:solidFill>
                              <a:latin typeface="Calibri"/>
                            </a:endParaRPr>
                          </a:p>
                        </p:txBody>
                      </p:sp>
                      <p:sp>
                        <p:nvSpPr>
                          <p:cNvPr id="590" name="Straight Connector 143"/>
                          <p:cNvSpPr/>
                          <p:nvPr/>
                        </p:nvSpPr>
                        <p:spPr>
                          <a:xfrm>
                            <a:off x="4784400" y="912960"/>
                            <a:ext cx="0" cy="146160"/>
                          </a:xfrm>
                          <a:prstGeom prst="line">
                            <a:avLst/>
                          </a:prstGeom>
                          <a:ln w="12600">
                            <a:solidFill>
                              <a:srgbClr val="006666"/>
                            </a:solidFill>
                            <a:miter/>
                          </a:ln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lIns="90000" rIns="90000" tIns="46800" bIns="46800" anchor="t">
                            <a:noAutofit/>
                          </a:bodyPr>
                          <a:p>
                            <a:endParaRPr b="0" lang="en-US" sz="2000" spc="-1" strike="noStrike">
                              <a:solidFill>
                                <a:srgbClr val="000000"/>
                              </a:solidFill>
                              <a:latin typeface="Calibri"/>
                            </a:endParaRPr>
                          </a:p>
                        </p:txBody>
                      </p:sp>
                      <p:sp>
                        <p:nvSpPr>
                          <p:cNvPr id="591" name="Straight Connector 144"/>
                          <p:cNvSpPr/>
                          <p:nvPr/>
                        </p:nvSpPr>
                        <p:spPr>
                          <a:xfrm>
                            <a:off x="4190760" y="1053000"/>
                            <a:ext cx="593640" cy="0"/>
                          </a:xfrm>
                          <a:prstGeom prst="line">
                            <a:avLst/>
                          </a:prstGeom>
                          <a:ln w="12600">
                            <a:solidFill>
                              <a:srgbClr val="006666"/>
                            </a:solidFill>
                            <a:miter/>
                          </a:ln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lIns="90000" rIns="90000" tIns="-46800" bIns="-46800" anchor="t">
                            <a:noAutofit/>
                          </a:bodyPr>
                          <a:p>
                            <a:endParaRPr b="0" lang="en-US" sz="2000" spc="-1" strike="noStrike">
                              <a:solidFill>
                                <a:srgbClr val="000000"/>
                              </a:solidFill>
                              <a:latin typeface="Calibri"/>
                            </a:endParaRPr>
                          </a:p>
                        </p:txBody>
                      </p:sp>
                      <p:sp>
                        <p:nvSpPr>
                          <p:cNvPr id="592" name="Oval 145"/>
                          <p:cNvSpPr/>
                          <p:nvPr/>
                        </p:nvSpPr>
                        <p:spPr>
                          <a:xfrm>
                            <a:off x="4195440" y="831960"/>
                            <a:ext cx="590400" cy="163800"/>
                          </a:xfrm>
                          <a:prstGeom prst="ellipse">
                            <a:avLst/>
                          </a:prstGeom>
                          <a:gradFill rotWithShape="0">
                            <a:gsLst>
                              <a:gs pos="0">
                                <a:srgbClr val="9ab5e4"/>
                              </a:gs>
                              <a:gs pos="100000">
                                <a:srgbClr val="e1e8f5">
                                  <a:alpha val="60000"/>
                                </a:srgbClr>
                              </a:gs>
                            </a:gsLst>
                            <a:lin ang="5400000"/>
                          </a:gradFill>
                          <a:ln w="12600">
                            <a:solidFill>
                              <a:srgbClr val="006666"/>
                            </a:solidFill>
                            <a:miter/>
                          </a:ln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lIns="90000" rIns="90000" tIns="46800" bIns="46800" anchor="ctr">
                            <a:noAutofit/>
                          </a:bodyPr>
                          <a:p>
                            <a:pPr algn="ctr">
                              <a:lnSpc>
                                <a:spcPct val="100000"/>
                              </a:lnSpc>
                              <a:tabLst>
                                <a:tab algn="l" pos="0"/>
                                <a:tab algn="l" pos="1017720"/>
                                <a:tab algn="l" pos="2035080"/>
                                <a:tab algn="l" pos="3052800"/>
                                <a:tab algn="l" pos="4070520"/>
                                <a:tab algn="l" pos="5087880"/>
                                <a:tab algn="l" pos="6105600"/>
                                <a:tab algn="l" pos="7122960"/>
                                <a:tab algn="l" pos="8140680"/>
                                <a:tab algn="l" pos="9158400"/>
                                <a:tab algn="l" pos="10175760"/>
                              </a:tabLst>
                            </a:pPr>
                            <a:endParaRPr b="0" lang="en-US" sz="2000" spc="-1" strike="noStrike">
                              <a:solidFill>
                                <a:srgbClr val="000000"/>
                              </a:solidFill>
                              <a:latin typeface="Calibri"/>
                            </a:endParaRPr>
                          </a:p>
                        </p:txBody>
                      </p:sp>
                    </p:grpSp>
                  </p:grpSp>
                  <p:sp>
                    <p:nvSpPr>
                      <p:cNvPr id="593" name="Freeform 136"/>
                      <p:cNvSpPr/>
                      <p:nvPr/>
                    </p:nvSpPr>
                    <p:spPr>
                      <a:xfrm>
                        <a:off x="4628880" y="912600"/>
                        <a:ext cx="72720" cy="46080"/>
                      </a:xfrm>
                      <a:custGeom>
                        <a:avLst/>
                        <a:gdLst/>
                        <a:ahLst/>
                        <a:rect l="l" t="t" r="r" b="b"/>
                        <a:pathLst>
                          <a:path w="74661" h="48701">
                            <a:moveTo>
                              <a:pt x="117" y="40389"/>
                            </a:moveTo>
                            <a:cubicBezTo>
                              <a:pt x="3024" y="47864"/>
                              <a:pt x="63236" y="52017"/>
                              <a:pt x="72372" y="45373"/>
                            </a:cubicBezTo>
                            <a:cubicBezTo>
                              <a:pt x="81508" y="38729"/>
                              <a:pt x="60745" y="5923"/>
                              <a:pt x="54931" y="525"/>
                            </a:cubicBezTo>
                            <a:cubicBezTo>
                              <a:pt x="49117" y="-4874"/>
                              <a:pt x="-2790" y="32914"/>
                              <a:pt x="117" y="40389"/>
                            </a:cubicBezTo>
                            <a:close/>
                          </a:path>
                        </a:pathLst>
                      </a:custGeom>
                      <a:solidFill>
                        <a:srgbClr val="c68c52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720" bIns="-720" anchor="ctr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94" name="Freeform 137"/>
                      <p:cNvSpPr/>
                      <p:nvPr/>
                    </p:nvSpPr>
                    <p:spPr>
                      <a:xfrm>
                        <a:off x="4424040" y="888840"/>
                        <a:ext cx="85680" cy="79200"/>
                      </a:xfrm>
                      <a:custGeom>
                        <a:avLst/>
                        <a:gdLst/>
                        <a:ahLst/>
                        <a:rect l="l" t="t" r="r" b="b"/>
                        <a:pathLst>
                          <a:path w="107757" h="83701">
                            <a:moveTo>
                              <a:pt x="3271" y="83653"/>
                            </a:moveTo>
                            <a:cubicBezTo>
                              <a:pt x="-1297" y="81992"/>
                              <a:pt x="-881" y="40051"/>
                              <a:pt x="3271" y="26348"/>
                            </a:cubicBezTo>
                            <a:cubicBezTo>
                              <a:pt x="7423" y="12645"/>
                              <a:pt x="11576" y="5169"/>
                              <a:pt x="28186" y="1432"/>
                            </a:cubicBezTo>
                            <a:cubicBezTo>
                              <a:pt x="44796" y="-2305"/>
                              <a:pt x="91721" y="2263"/>
                              <a:pt x="102933" y="3924"/>
                            </a:cubicBezTo>
                            <a:cubicBezTo>
                              <a:pt x="114145" y="5585"/>
                              <a:pt x="103348" y="10152"/>
                              <a:pt x="95458" y="11398"/>
                            </a:cubicBezTo>
                            <a:cubicBezTo>
                              <a:pt x="87568" y="12644"/>
                              <a:pt x="66390" y="7245"/>
                              <a:pt x="55593" y="11398"/>
                            </a:cubicBezTo>
                            <a:cubicBezTo>
                              <a:pt x="44796" y="15551"/>
                              <a:pt x="36076" y="28424"/>
                              <a:pt x="30678" y="36314"/>
                            </a:cubicBezTo>
                            <a:cubicBezTo>
                              <a:pt x="25280" y="44204"/>
                              <a:pt x="7839" y="85314"/>
                              <a:pt x="3271" y="83653"/>
                            </a:cubicBezTo>
                            <a:close/>
                          </a:path>
                        </a:pathLst>
                      </a:custGeom>
                      <a:solidFill>
                        <a:srgbClr val="c68c52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32400" bIns="32400" anchor="ctr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95" name="Freeform 138"/>
                      <p:cNvSpPr/>
                      <p:nvPr/>
                    </p:nvSpPr>
                    <p:spPr>
                      <a:xfrm>
                        <a:off x="4330440" y="911160"/>
                        <a:ext cx="63360" cy="65160"/>
                      </a:xfrm>
                      <a:custGeom>
                        <a:avLst/>
                        <a:gdLst/>
                        <a:ahLst/>
                        <a:rect l="l" t="t" r="r" b="b"/>
                        <a:pathLst>
                          <a:path w="66233" h="68100">
                            <a:moveTo>
                              <a:pt x="65795" y="67290"/>
                            </a:moveTo>
                            <a:cubicBezTo>
                              <a:pt x="61227" y="73104"/>
                              <a:pt x="7244" y="46112"/>
                              <a:pt x="1015" y="34900"/>
                            </a:cubicBezTo>
                            <a:cubicBezTo>
                              <a:pt x="-5214" y="23688"/>
                              <a:pt x="18871" y="1264"/>
                              <a:pt x="28422" y="18"/>
                            </a:cubicBezTo>
                            <a:cubicBezTo>
                              <a:pt x="37973" y="-1228"/>
                              <a:pt x="70363" y="61476"/>
                              <a:pt x="65795" y="67290"/>
                            </a:cubicBezTo>
                            <a:close/>
                          </a:path>
                        </a:pathLst>
                      </a:custGeom>
                      <a:solidFill>
                        <a:srgbClr val="c68c52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18360" bIns="18360" anchor="ctr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596" name="Freeform 139"/>
                      <p:cNvSpPr/>
                      <p:nvPr/>
                    </p:nvSpPr>
                    <p:spPr>
                      <a:xfrm rot="1518000">
                        <a:off x="4482360" y="928080"/>
                        <a:ext cx="71280" cy="63360"/>
                      </a:xfrm>
                      <a:custGeom>
                        <a:avLst/>
                        <a:gdLst/>
                        <a:ahLst/>
                        <a:rect l="l" t="t" r="r" b="b"/>
                        <a:pathLst>
                          <a:path w="107757" h="83701">
                            <a:moveTo>
                              <a:pt x="3271" y="83653"/>
                            </a:moveTo>
                            <a:cubicBezTo>
                              <a:pt x="-1297" y="81992"/>
                              <a:pt x="-881" y="40051"/>
                              <a:pt x="3271" y="26348"/>
                            </a:cubicBezTo>
                            <a:cubicBezTo>
                              <a:pt x="7423" y="12645"/>
                              <a:pt x="11576" y="5169"/>
                              <a:pt x="28186" y="1432"/>
                            </a:cubicBezTo>
                            <a:cubicBezTo>
                              <a:pt x="44796" y="-2305"/>
                              <a:pt x="91721" y="2263"/>
                              <a:pt x="102933" y="3924"/>
                            </a:cubicBezTo>
                            <a:cubicBezTo>
                              <a:pt x="114145" y="5585"/>
                              <a:pt x="103348" y="10152"/>
                              <a:pt x="95458" y="11398"/>
                            </a:cubicBezTo>
                            <a:cubicBezTo>
                              <a:pt x="87568" y="12644"/>
                              <a:pt x="66390" y="7245"/>
                              <a:pt x="55593" y="11398"/>
                            </a:cubicBezTo>
                            <a:cubicBezTo>
                              <a:pt x="44796" y="15551"/>
                              <a:pt x="36076" y="28424"/>
                              <a:pt x="30678" y="36314"/>
                            </a:cubicBezTo>
                            <a:cubicBezTo>
                              <a:pt x="25280" y="44204"/>
                              <a:pt x="7839" y="85314"/>
                              <a:pt x="3271" y="83653"/>
                            </a:cubicBezTo>
                            <a:close/>
                          </a:path>
                        </a:pathLst>
                      </a:custGeom>
                      <a:solidFill>
                        <a:srgbClr val="c68c52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16560" bIns="16560" anchor="ctr">
                        <a:noAutofit/>
                      </a:bodyPr>
                      <a:p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pic>
                  <p:nvPicPr>
                    <p:cNvPr id="597" name="Picture 225" descr="C:\Users\ELIZABETH\Desktop\BIO-RENDER IMAGES\Untitled (1).jpg"/>
                    <p:cNvPicPr/>
                    <p:nvPr/>
                  </p:nvPicPr>
                  <p:blipFill>
                    <a:blip r:embed="rId27"/>
                    <a:srcRect l="37149" t="27259" r="30678" b="43495"/>
                    <a:stretch/>
                  </p:blipFill>
                  <p:spPr>
                    <a:xfrm rot="20327400">
                      <a:off x="4519800" y="466560"/>
                      <a:ext cx="450000" cy="281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grpSp>
              <p:sp>
                <p:nvSpPr>
                  <p:cNvPr id="598" name="TextBox 108"/>
                  <p:cNvSpPr/>
                  <p:nvPr/>
                </p:nvSpPr>
                <p:spPr>
                  <a:xfrm>
                    <a:off x="3943080" y="1027080"/>
                    <a:ext cx="107820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006666"/>
                        </a:solidFill>
                        <a:latin typeface="Times New Roman"/>
                        <a:ea typeface="Times New Roman"/>
                      </a:rPr>
                      <a:t>Minced Tissues in Chilled PBS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599" name="Straight Connector 13"/>
                <p:cNvSpPr/>
                <p:nvPr/>
              </p:nvSpPr>
              <p:spPr>
                <a:xfrm flipH="1">
                  <a:off x="3676680" y="1317600"/>
                  <a:ext cx="636480" cy="642960"/>
                </a:xfrm>
                <a:prstGeom prst="line">
                  <a:avLst/>
                </a:prstGeom>
                <a:ln w="12600">
                  <a:solidFill>
                    <a:srgbClr val="660033"/>
                  </a:solidFill>
                  <a:miter/>
                  <a:tailEnd len="med" type="stealth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600" name="Group 4"/>
                <p:cNvGrpSpPr/>
                <p:nvPr/>
              </p:nvGrpSpPr>
              <p:grpSpPr>
                <a:xfrm>
                  <a:off x="3000960" y="1940760"/>
                  <a:ext cx="1066320" cy="863280"/>
                  <a:chOff x="3000960" y="1940760"/>
                  <a:chExt cx="1066320" cy="863280"/>
                </a:xfrm>
              </p:grpSpPr>
              <p:pic>
                <p:nvPicPr>
                  <p:cNvPr id="601" name="Picture 2" descr=""/>
                  <p:cNvPicPr/>
                  <p:nvPr/>
                </p:nvPicPr>
                <p:blipFill>
                  <a:blip r:embed="rId28"/>
                  <a:srcRect l="3889" t="6621" r="18111" b="11696"/>
                  <a:stretch/>
                </p:blipFill>
                <p:spPr>
                  <a:xfrm>
                    <a:off x="3432240" y="1940760"/>
                    <a:ext cx="243000" cy="448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602" name="TextBox 114"/>
                  <p:cNvSpPr/>
                  <p:nvPr/>
                </p:nvSpPr>
                <p:spPr>
                  <a:xfrm>
                    <a:off x="3000960" y="2345040"/>
                    <a:ext cx="1066320" cy="4590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006666"/>
                        </a:solidFill>
                        <a:latin typeface="Times New Roman"/>
                        <a:ea typeface="Times New Roman"/>
                      </a:rPr>
                      <a:t>Collagenase Digestion 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006666"/>
                        </a:solidFill>
                        <a:latin typeface="Times New Roman"/>
                        <a:ea typeface="Times New Roman"/>
                      </a:rPr>
                      <a:t>for 6hrs at 37</a:t>
                    </a:r>
                    <a:r>
                      <a:rPr b="1" lang="en-IN" sz="800" spc="-1" strike="noStrike" baseline="30000">
                        <a:solidFill>
                          <a:srgbClr val="006666"/>
                        </a:solidFill>
                        <a:latin typeface="Times New Roman"/>
                        <a:ea typeface="Times New Roman"/>
                      </a:rPr>
                      <a:t>0</a:t>
                    </a:r>
                    <a:r>
                      <a:rPr b="1" lang="en-IN" sz="800" spc="-1" strike="noStrike">
                        <a:solidFill>
                          <a:srgbClr val="006666"/>
                        </a:solidFill>
                        <a:latin typeface="Times New Roman"/>
                        <a:ea typeface="Times New Roman"/>
                      </a:rPr>
                      <a:t>C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603" name="Group 25"/>
                <p:cNvGrpSpPr/>
                <p:nvPr/>
              </p:nvGrpSpPr>
              <p:grpSpPr>
                <a:xfrm>
                  <a:off x="4004640" y="1697040"/>
                  <a:ext cx="1048680" cy="1137600"/>
                  <a:chOff x="4004640" y="1697040"/>
                  <a:chExt cx="1048680" cy="1137600"/>
                </a:xfrm>
              </p:grpSpPr>
              <p:sp>
                <p:nvSpPr>
                  <p:cNvPr id="604" name="Oval 97"/>
                  <p:cNvSpPr/>
                  <p:nvPr/>
                </p:nvSpPr>
                <p:spPr>
                  <a:xfrm>
                    <a:off x="4478040" y="1984320"/>
                    <a:ext cx="25200" cy="21960"/>
                  </a:xfrm>
                  <a:prstGeom prst="ellipse">
                    <a:avLst/>
                  </a:prstGeom>
                  <a:solidFill>
                    <a:srgbClr val="c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1320" bIns="-3132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5" name="Oval 98"/>
                  <p:cNvSpPr/>
                  <p:nvPr/>
                </p:nvSpPr>
                <p:spPr>
                  <a:xfrm>
                    <a:off x="4500360" y="1979280"/>
                    <a:ext cx="26640" cy="23760"/>
                  </a:xfrm>
                  <a:prstGeom prst="ellipse">
                    <a:avLst/>
                  </a:prstGeom>
                  <a:solidFill>
                    <a:srgbClr val="c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520" bIns="-2952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6" name="Oval 99"/>
                  <p:cNvSpPr/>
                  <p:nvPr/>
                </p:nvSpPr>
                <p:spPr>
                  <a:xfrm>
                    <a:off x="4524120" y="1985760"/>
                    <a:ext cx="25200" cy="20520"/>
                  </a:xfrm>
                  <a:prstGeom prst="ellipse">
                    <a:avLst/>
                  </a:prstGeom>
                  <a:solidFill>
                    <a:srgbClr val="c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040" bIns="-3204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7" name="Oval 100"/>
                  <p:cNvSpPr/>
                  <p:nvPr/>
                </p:nvSpPr>
                <p:spPr>
                  <a:xfrm>
                    <a:off x="4552920" y="1984320"/>
                    <a:ext cx="23760" cy="20520"/>
                  </a:xfrm>
                  <a:prstGeom prst="ellipse">
                    <a:avLst/>
                  </a:prstGeom>
                  <a:solidFill>
                    <a:srgbClr val="c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040" bIns="-3204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grpSp>
                <p:nvGrpSpPr>
                  <p:cNvPr id="608" name="Group 7"/>
                  <p:cNvGrpSpPr/>
                  <p:nvPr/>
                </p:nvGrpSpPr>
                <p:grpSpPr>
                  <a:xfrm>
                    <a:off x="4004640" y="1697040"/>
                    <a:ext cx="1048680" cy="1137600"/>
                    <a:chOff x="4004640" y="1697040"/>
                    <a:chExt cx="1048680" cy="1137600"/>
                  </a:xfrm>
                </p:grpSpPr>
                <p:sp>
                  <p:nvSpPr>
                    <p:cNvPr id="609" name="TextBox 145"/>
                    <p:cNvSpPr/>
                    <p:nvPr/>
                  </p:nvSpPr>
                  <p:spPr>
                    <a:xfrm>
                      <a:off x="4004640" y="2375640"/>
                      <a:ext cx="1048680" cy="4590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800" spc="-1" strike="noStrike">
                          <a:solidFill>
                            <a:srgbClr val="006260"/>
                          </a:solidFill>
                          <a:latin typeface="Times New Roman"/>
                          <a:ea typeface="Times New Roman"/>
                        </a:rPr>
                        <a:t>Straining of cells from collagenase digested tissue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grpSp>
                  <p:nvGrpSpPr>
                    <p:cNvPr id="610" name="Group 23561"/>
                    <p:cNvGrpSpPr/>
                    <p:nvPr/>
                  </p:nvGrpSpPr>
                  <p:grpSpPr>
                    <a:xfrm>
                      <a:off x="4415040" y="1697040"/>
                      <a:ext cx="213120" cy="676080"/>
                      <a:chOff x="4415040" y="1697040"/>
                      <a:chExt cx="213120" cy="676080"/>
                    </a:xfrm>
                  </p:grpSpPr>
                  <p:grpSp>
                    <p:nvGrpSpPr>
                      <p:cNvPr id="611" name="Group 125"/>
                      <p:cNvGrpSpPr/>
                      <p:nvPr/>
                    </p:nvGrpSpPr>
                    <p:grpSpPr>
                      <a:xfrm>
                        <a:off x="4415400" y="1882800"/>
                        <a:ext cx="206280" cy="142920"/>
                        <a:chOff x="4415400" y="1882800"/>
                        <a:chExt cx="206280" cy="142920"/>
                      </a:xfrm>
                    </p:grpSpPr>
                    <p:sp>
                      <p:nvSpPr>
                        <p:cNvPr id="612" name="Rectangle 117"/>
                        <p:cNvSpPr/>
                        <p:nvPr/>
                      </p:nvSpPr>
                      <p:spPr>
                        <a:xfrm>
                          <a:off x="4415400" y="1913040"/>
                          <a:ext cx="204840" cy="92160"/>
                        </a:xfrm>
                        <a:prstGeom prst="rect">
                          <a:avLst/>
                        </a:prstGeom>
                        <a:solidFill>
                          <a:srgbClr val="fac090">
                            <a:alpha val="20000"/>
                          </a:srgbClr>
                        </a:solidFill>
                        <a:ln w="12600">
                          <a:solidFill>
                            <a:srgbClr val="000000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5360" bIns="4536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613" name="Oval 118"/>
                        <p:cNvSpPr/>
                        <p:nvPr/>
                      </p:nvSpPr>
                      <p:spPr>
                        <a:xfrm>
                          <a:off x="4415400" y="1882800"/>
                          <a:ext cx="203400" cy="50760"/>
                        </a:xfrm>
                        <a:prstGeom prst="ellipse">
                          <a:avLst/>
                        </a:prstGeom>
                        <a:solidFill>
                          <a:srgbClr val="ffcfb7"/>
                        </a:solidFill>
                        <a:ln w="12600">
                          <a:solidFill>
                            <a:srgbClr val="262626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-10440" bIns="-1044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614" name="Rectangle 119"/>
                        <p:cNvSpPr/>
                        <p:nvPr/>
                      </p:nvSpPr>
                      <p:spPr>
                        <a:xfrm>
                          <a:off x="4418280" y="1967040"/>
                          <a:ext cx="203400" cy="58680"/>
                        </a:xfrm>
                        <a:prstGeom prst="rect">
                          <a:avLst/>
                        </a:prstGeom>
                        <a:noFill/>
                        <a:ln w="12600">
                          <a:solidFill>
                            <a:srgbClr val="385d8a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11880" bIns="1188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grpSp>
                    <p:nvGrpSpPr>
                      <p:cNvPr id="615" name="Group 23557"/>
                      <p:cNvGrpSpPr/>
                      <p:nvPr/>
                    </p:nvGrpSpPr>
                    <p:grpSpPr>
                      <a:xfrm>
                        <a:off x="4468320" y="1697040"/>
                        <a:ext cx="79560" cy="279720"/>
                        <a:chOff x="4468320" y="1697040"/>
                        <a:chExt cx="79560" cy="279720"/>
                      </a:xfrm>
                    </p:grpSpPr>
                    <p:sp>
                      <p:nvSpPr>
                        <p:cNvPr id="616" name="Rectangle 114"/>
                        <p:cNvSpPr/>
                        <p:nvPr/>
                      </p:nvSpPr>
                      <p:spPr>
                        <a:xfrm>
                          <a:off x="4507560" y="1698480"/>
                          <a:ext cx="15480" cy="246240"/>
                        </a:xfrm>
                        <a:prstGeom prst="rect">
                          <a:avLst/>
                        </a:prstGeom>
                        <a:noFill/>
                        <a:ln w="12600">
                          <a:solidFill>
                            <a:srgbClr val="000000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617" name="Rounded Rectangle 115"/>
                        <p:cNvSpPr/>
                        <p:nvPr/>
                      </p:nvSpPr>
                      <p:spPr>
                        <a:xfrm>
                          <a:off x="4485240" y="1923840"/>
                          <a:ext cx="49680" cy="52920"/>
                        </a:xfrm>
                        <a:custGeom>
                          <a:avLst/>
                          <a:gdLst>
                            <a:gd name="textAreaLeft" fmla="*/ 2160 w 49680"/>
                            <a:gd name="textAreaRight" fmla="*/ 47520 w 49680"/>
                            <a:gd name="textAreaTop" fmla="*/ 2160 h 52920"/>
                            <a:gd name="textAreaBottom" fmla="*/ 50760 h 52920"/>
                          </a:gdLst>
                          <a:ahLst/>
                          <a:rect l="textAreaLeft" t="textAreaTop" r="textAreaRight" b="textAreaBottom"/>
                          <a:pathLst>
                            <a:path w="21600" h="22999">
                              <a:moveTo>
                                <a:pt x="3600" y="0"/>
                              </a:moveTo>
                              <a:arcTo wR="3600" hR="3600" stAng="16200000" swAng="-5400000"/>
                              <a:lnTo>
                                <a:pt x="0" y="19399"/>
                              </a:lnTo>
                              <a:arcTo wR="3600" hR="3600" stAng="10800000" swAng="-5400000"/>
                              <a:lnTo>
                                <a:pt x="18000" y="22999"/>
                              </a:lnTo>
                              <a:arcTo wR="3600" hR="3600" stAng="5400000" swAng="-5400000"/>
                              <a:lnTo>
                                <a:pt x="21600" y="3600"/>
                              </a:lnTo>
                              <a:arcTo wR="3600" hR="3600" stAng="0" swAng="-5400000"/>
                              <a:close/>
                            </a:path>
                          </a:pathLst>
                        </a:custGeom>
                        <a:solidFill>
                          <a:srgbClr val="000000"/>
                        </a:solidFill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1800" bIns="180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618" name="Straight Connector 116"/>
                        <p:cNvSpPr/>
                        <p:nvPr/>
                      </p:nvSpPr>
                      <p:spPr>
                        <a:xfrm>
                          <a:off x="4468320" y="1697040"/>
                          <a:ext cx="79560" cy="0"/>
                        </a:xfrm>
                        <a:prstGeom prst="line">
                          <a:avLst/>
                        </a:prstGeom>
                        <a:ln w="9360">
                          <a:solidFill>
                            <a:srgbClr val="000000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-46800" bIns="-46800" anchor="t">
                          <a:noAutofit/>
                        </a:bodyPr>
                        <a:p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grpSp>
                    <p:nvGrpSpPr>
                      <p:cNvPr id="619" name="Group 23560"/>
                      <p:cNvGrpSpPr/>
                      <p:nvPr/>
                    </p:nvGrpSpPr>
                    <p:grpSpPr>
                      <a:xfrm>
                        <a:off x="4415040" y="1940760"/>
                        <a:ext cx="213120" cy="432360"/>
                        <a:chOff x="4415040" y="1940760"/>
                        <a:chExt cx="213120" cy="432360"/>
                      </a:xfrm>
                    </p:grpSpPr>
                    <p:pic>
                      <p:nvPicPr>
                        <p:cNvPr id="620" name="Group 107" descr=""/>
                        <p:cNvPicPr/>
                        <p:nvPr/>
                      </p:nvPicPr>
                      <p:blipFill>
                        <a:blip r:embed="rId29"/>
                        <a:stretch/>
                      </p:blipFill>
                      <p:spPr>
                        <a:xfrm>
                          <a:off x="4415040" y="1940760"/>
                          <a:ext cx="213120" cy="43236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grpSp>
                      <p:nvGrpSpPr>
                        <p:cNvPr id="621" name="Group 23559"/>
                        <p:cNvGrpSpPr/>
                        <p:nvPr/>
                      </p:nvGrpSpPr>
                      <p:grpSpPr>
                        <a:xfrm>
                          <a:off x="4476960" y="2046240"/>
                          <a:ext cx="68760" cy="99360"/>
                          <a:chOff x="4476960" y="2046240"/>
                          <a:chExt cx="68760" cy="99360"/>
                        </a:xfrm>
                      </p:grpSpPr>
                      <p:sp>
                        <p:nvSpPr>
                          <p:cNvPr id="622" name="Freeform 109"/>
                          <p:cNvSpPr/>
                          <p:nvPr/>
                        </p:nvSpPr>
                        <p:spPr>
                          <a:xfrm>
                            <a:off x="4489920" y="2046240"/>
                            <a:ext cx="37440" cy="71640"/>
                          </a:xfrm>
                          <a:custGeom>
                            <a:avLst/>
                            <a:gdLst/>
                            <a:ahLst/>
                            <a:rect l="l" t="t" r="r" b="b"/>
                            <a:pathLst>
                              <a:path w="112426" h="246540">
                                <a:moveTo>
                                  <a:pt x="42085" y="2553"/>
                                </a:moveTo>
                                <a:cubicBezTo>
                                  <a:pt x="26099" y="-16630"/>
                                  <a:pt x="23434" y="77687"/>
                                  <a:pt x="16507" y="104863"/>
                                </a:cubicBezTo>
                                <a:cubicBezTo>
                                  <a:pt x="9580" y="132039"/>
                                  <a:pt x="-2676" y="143762"/>
                                  <a:pt x="521" y="165610"/>
                                </a:cubicBezTo>
                                <a:cubicBezTo>
                                  <a:pt x="3718" y="187458"/>
                                  <a:pt x="17040" y="226890"/>
                                  <a:pt x="35690" y="235949"/>
                                </a:cubicBezTo>
                                <a:cubicBezTo>
                                  <a:pt x="54340" y="245008"/>
                                  <a:pt x="111890" y="260461"/>
                                  <a:pt x="112423" y="219963"/>
                                </a:cubicBezTo>
                                <a:cubicBezTo>
                                  <a:pt x="112956" y="179465"/>
                                  <a:pt x="58071" y="21736"/>
                                  <a:pt x="42085" y="2553"/>
                                </a:cubicBezTo>
                                <a:close/>
                              </a:path>
                            </a:pathLst>
                          </a:custGeom>
                          <a:gradFill rotWithShape="0">
                            <a:gsLst>
                              <a:gs pos="0">
                                <a:srgbClr val="9c5633"/>
                              </a:gs>
                              <a:gs pos="100000">
                                <a:srgbClr val="ff975e"/>
                              </a:gs>
                            </a:gsLst>
                            <a:lin ang="5400000"/>
                          </a:gradFill>
                          <a:ln w="0">
                            <a:noFill/>
                          </a:ln>
                          <a:effectLst>
                            <a:outerShdw dist="38183" dir="2700000" blurRad="0" rotWithShape="0">
                              <a:srgbClr val="000000">
                                <a:alpha val="40000"/>
                              </a:srgbClr>
                            </a:outerShdw>
                          </a:effectLst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lIns="90000" rIns="90000" tIns="24840" bIns="24840" anchor="ctr">
                            <a:noAutofit/>
                          </a:bodyPr>
                          <a:p>
                            <a:endParaRPr b="0" lang="en-US" sz="2000" spc="-1" strike="noStrike">
                              <a:solidFill>
                                <a:srgbClr val="000000"/>
                              </a:solidFill>
                              <a:latin typeface="Calibri"/>
                            </a:endParaRPr>
                          </a:p>
                        </p:txBody>
                      </p:sp>
                      <p:sp>
                        <p:nvSpPr>
                          <p:cNvPr id="623" name="Freeform 110"/>
                          <p:cNvSpPr/>
                          <p:nvPr/>
                        </p:nvSpPr>
                        <p:spPr>
                          <a:xfrm>
                            <a:off x="4527720" y="2064600"/>
                            <a:ext cx="18000" cy="69840"/>
                          </a:xfrm>
                          <a:custGeom>
                            <a:avLst/>
                            <a:gdLst/>
                            <a:ahLst/>
                            <a:rect l="l" t="t" r="r" b="b"/>
                            <a:pathLst>
                              <a:path w="112426" h="246540">
                                <a:moveTo>
                                  <a:pt x="42085" y="2553"/>
                                </a:moveTo>
                                <a:cubicBezTo>
                                  <a:pt x="26099" y="-16630"/>
                                  <a:pt x="23434" y="77687"/>
                                  <a:pt x="16507" y="104863"/>
                                </a:cubicBezTo>
                                <a:cubicBezTo>
                                  <a:pt x="9580" y="132039"/>
                                  <a:pt x="-2676" y="143762"/>
                                  <a:pt x="521" y="165610"/>
                                </a:cubicBezTo>
                                <a:cubicBezTo>
                                  <a:pt x="3718" y="187458"/>
                                  <a:pt x="17040" y="226890"/>
                                  <a:pt x="35690" y="235949"/>
                                </a:cubicBezTo>
                                <a:cubicBezTo>
                                  <a:pt x="54340" y="245008"/>
                                  <a:pt x="111890" y="260461"/>
                                  <a:pt x="112423" y="219963"/>
                                </a:cubicBezTo>
                                <a:cubicBezTo>
                                  <a:pt x="112956" y="179465"/>
                                  <a:pt x="58071" y="21736"/>
                                  <a:pt x="42085" y="2553"/>
                                </a:cubicBezTo>
                                <a:close/>
                              </a:path>
                            </a:pathLst>
                          </a:custGeom>
                          <a:gradFill rotWithShape="0">
                            <a:gsLst>
                              <a:gs pos="0">
                                <a:srgbClr val="9c5633"/>
                              </a:gs>
                              <a:gs pos="100000">
                                <a:srgbClr val="ff975e"/>
                              </a:gs>
                            </a:gsLst>
                            <a:lin ang="5400000"/>
                          </a:gradFill>
                          <a:ln w="0">
                            <a:noFill/>
                          </a:ln>
                          <a:effectLst>
                            <a:outerShdw dist="38183" dir="2700000" blurRad="0" rotWithShape="0">
                              <a:srgbClr val="000000">
                                <a:alpha val="40000"/>
                              </a:srgbClr>
                            </a:outerShdw>
                          </a:effectLst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lIns="90000" rIns="90000" tIns="23040" bIns="23040" anchor="ctr">
                            <a:noAutofit/>
                          </a:bodyPr>
                          <a:p>
                            <a:endParaRPr b="0" lang="en-US" sz="2000" spc="-1" strike="noStrike">
                              <a:solidFill>
                                <a:srgbClr val="000000"/>
                              </a:solidFill>
                              <a:latin typeface="Calibri"/>
                            </a:endParaRPr>
                          </a:p>
                        </p:txBody>
                      </p:sp>
                      <p:sp>
                        <p:nvSpPr>
                          <p:cNvPr id="624" name="Freeform 111"/>
                          <p:cNvSpPr/>
                          <p:nvPr/>
                        </p:nvSpPr>
                        <p:spPr>
                          <a:xfrm>
                            <a:off x="4476960" y="2073960"/>
                            <a:ext cx="16200" cy="71640"/>
                          </a:xfrm>
                          <a:custGeom>
                            <a:avLst/>
                            <a:gdLst/>
                            <a:ahLst/>
                            <a:rect l="l" t="t" r="r" b="b"/>
                            <a:pathLst>
                              <a:path w="112426" h="246540">
                                <a:moveTo>
                                  <a:pt x="42085" y="2553"/>
                                </a:moveTo>
                                <a:cubicBezTo>
                                  <a:pt x="26099" y="-16630"/>
                                  <a:pt x="23434" y="77687"/>
                                  <a:pt x="16507" y="104863"/>
                                </a:cubicBezTo>
                                <a:cubicBezTo>
                                  <a:pt x="9580" y="132039"/>
                                  <a:pt x="-2676" y="143762"/>
                                  <a:pt x="521" y="165610"/>
                                </a:cubicBezTo>
                                <a:cubicBezTo>
                                  <a:pt x="3718" y="187458"/>
                                  <a:pt x="17040" y="226890"/>
                                  <a:pt x="35690" y="235949"/>
                                </a:cubicBezTo>
                                <a:cubicBezTo>
                                  <a:pt x="54340" y="245008"/>
                                  <a:pt x="111890" y="260461"/>
                                  <a:pt x="112423" y="219963"/>
                                </a:cubicBezTo>
                                <a:cubicBezTo>
                                  <a:pt x="112956" y="179465"/>
                                  <a:pt x="58071" y="21736"/>
                                  <a:pt x="42085" y="2553"/>
                                </a:cubicBezTo>
                                <a:close/>
                              </a:path>
                            </a:pathLst>
                          </a:custGeom>
                          <a:gradFill rotWithShape="0">
                            <a:gsLst>
                              <a:gs pos="0">
                                <a:srgbClr val="9c5633"/>
                              </a:gs>
                              <a:gs pos="100000">
                                <a:srgbClr val="ff975e"/>
                              </a:gs>
                            </a:gsLst>
                            <a:lin ang="5400000"/>
                          </a:gradFill>
                          <a:ln w="0">
                            <a:noFill/>
                          </a:ln>
                          <a:effectLst>
                            <a:outerShdw dist="38183" dir="2700000" blurRad="0" rotWithShape="0">
                              <a:srgbClr val="000000">
                                <a:alpha val="40000"/>
                              </a:srgbClr>
                            </a:outerShdw>
                          </a:effectLst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lIns="90000" rIns="90000" tIns="24840" bIns="24840" anchor="ctr">
                            <a:noAutofit/>
                          </a:bodyPr>
                          <a:p>
                            <a:endParaRPr b="0" lang="en-US" sz="2000" spc="-1" strike="noStrike">
                              <a:solidFill>
                                <a:srgbClr val="000000"/>
                              </a:solidFill>
                              <a:latin typeface="Calibri"/>
                            </a:endParaRPr>
                          </a:p>
                        </p:txBody>
                      </p:sp>
                    </p:grpSp>
                  </p:grpSp>
                </p:grpSp>
              </p:grpSp>
            </p:grpSp>
            <p:sp>
              <p:nvSpPr>
                <p:cNvPr id="625" name="Straight Connector 16"/>
                <p:cNvSpPr/>
                <p:nvPr/>
              </p:nvSpPr>
              <p:spPr>
                <a:xfrm>
                  <a:off x="3811320" y="2149560"/>
                  <a:ext cx="485640" cy="0"/>
                </a:xfrm>
                <a:prstGeom prst="line">
                  <a:avLst/>
                </a:prstGeom>
                <a:ln w="12600">
                  <a:solidFill>
                    <a:srgbClr val="660033"/>
                  </a:solidFill>
                  <a:miter/>
                  <a:tailEnd len="med" type="stealth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6" name="Straight Connector 17"/>
                <p:cNvSpPr/>
                <p:nvPr/>
              </p:nvSpPr>
              <p:spPr>
                <a:xfrm>
                  <a:off x="4761000" y="2146320"/>
                  <a:ext cx="312480" cy="0"/>
                </a:xfrm>
                <a:prstGeom prst="line">
                  <a:avLst/>
                </a:prstGeom>
                <a:ln w="12600">
                  <a:solidFill>
                    <a:srgbClr val="660033"/>
                  </a:solidFill>
                  <a:miter/>
                  <a:tailEnd len="med" type="stealth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627" name="Group 27"/>
                <p:cNvGrpSpPr/>
                <p:nvPr/>
              </p:nvGrpSpPr>
              <p:grpSpPr>
                <a:xfrm>
                  <a:off x="4943880" y="1614240"/>
                  <a:ext cx="1281240" cy="1313640"/>
                  <a:chOff x="4943880" y="1614240"/>
                  <a:chExt cx="1281240" cy="1313640"/>
                </a:xfrm>
              </p:grpSpPr>
              <p:pic>
                <p:nvPicPr>
                  <p:cNvPr id="628" name="Picture 3" descr="C:\Users\ELIZABETH\Desktop\BIO-RENDER IMAGES\Untitled (1).png"/>
                  <p:cNvPicPr/>
                  <p:nvPr/>
                </p:nvPicPr>
                <p:blipFill>
                  <a:blip r:embed="rId30"/>
                  <a:stretch/>
                </p:blipFill>
                <p:spPr>
                  <a:xfrm>
                    <a:off x="5073480" y="1614240"/>
                    <a:ext cx="749160" cy="717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629" name="TextBox 145"/>
                  <p:cNvSpPr/>
                  <p:nvPr/>
                </p:nvSpPr>
                <p:spPr>
                  <a:xfrm>
                    <a:off x="4943880" y="2347200"/>
                    <a:ext cx="1281240" cy="5806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006260"/>
                        </a:solidFill>
                        <a:latin typeface="Times New Roman"/>
                        <a:ea typeface="Times New Roman"/>
                      </a:rPr>
                      <a:t>Centrifugation of strained tissue exudates  at 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006260"/>
                        </a:solidFill>
                        <a:latin typeface="Times New Roman"/>
                        <a:ea typeface="Times New Roman"/>
                      </a:rPr>
                      <a:t>3000 rpm for 4-5 min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630" name="Group 32"/>
                <p:cNvGrpSpPr/>
                <p:nvPr/>
              </p:nvGrpSpPr>
              <p:grpSpPr>
                <a:xfrm>
                  <a:off x="4902480" y="562320"/>
                  <a:ext cx="2026080" cy="705240"/>
                  <a:chOff x="4902480" y="562320"/>
                  <a:chExt cx="2026080" cy="705240"/>
                </a:xfrm>
              </p:grpSpPr>
              <p:grpSp>
                <p:nvGrpSpPr>
                  <p:cNvPr id="631" name="Group 30"/>
                  <p:cNvGrpSpPr/>
                  <p:nvPr/>
                </p:nvGrpSpPr>
                <p:grpSpPr>
                  <a:xfrm>
                    <a:off x="4902480" y="562320"/>
                    <a:ext cx="1091160" cy="556920"/>
                    <a:chOff x="4902480" y="562320"/>
                    <a:chExt cx="1091160" cy="556920"/>
                  </a:xfrm>
                </p:grpSpPr>
                <p:pic>
                  <p:nvPicPr>
                    <p:cNvPr id="632" name="Picture 2" descr=""/>
                    <p:cNvPicPr/>
                    <p:nvPr/>
                  </p:nvPicPr>
                  <p:blipFill>
                    <a:blip r:embed="rId31"/>
                    <a:srcRect l="3937" t="6556" r="18110" b="11667"/>
                    <a:stretch/>
                  </p:blipFill>
                  <p:spPr>
                    <a:xfrm>
                      <a:off x="5329440" y="562320"/>
                      <a:ext cx="177480" cy="2599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grpSp>
                  <p:nvGrpSpPr>
                    <p:cNvPr id="633" name="Group 282"/>
                    <p:cNvGrpSpPr/>
                    <p:nvPr/>
                  </p:nvGrpSpPr>
                  <p:grpSpPr>
                    <a:xfrm>
                      <a:off x="5506920" y="824400"/>
                      <a:ext cx="486720" cy="294840"/>
                      <a:chOff x="5506920" y="824400"/>
                      <a:chExt cx="486720" cy="294840"/>
                    </a:xfrm>
                  </p:grpSpPr>
                  <p:sp>
                    <p:nvSpPr>
                      <p:cNvPr id="634" name="Rectangle 77"/>
                      <p:cNvSpPr/>
                      <p:nvPr/>
                    </p:nvSpPr>
                    <p:spPr>
                      <a:xfrm>
                        <a:off x="5609880" y="963360"/>
                        <a:ext cx="383760" cy="127080"/>
                      </a:xfrm>
                      <a:prstGeom prst="rect">
                        <a:avLst/>
                      </a:prstGeom>
                      <a:gradFill rotWithShape="0">
                        <a:gsLst>
                          <a:gs pos="0">
                            <a:srgbClr val="ff85ac"/>
                          </a:gs>
                          <a:gs pos="100000">
                            <a:srgbClr val="ffdbe5"/>
                          </a:gs>
                        </a:gsLst>
                        <a:lin ang="16200000"/>
                      </a:gra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grpSp>
                    <p:nvGrpSpPr>
                      <p:cNvPr id="635" name="Group 366"/>
                      <p:cNvGrpSpPr/>
                      <p:nvPr/>
                    </p:nvGrpSpPr>
                    <p:grpSpPr>
                      <a:xfrm>
                        <a:off x="5506920" y="824400"/>
                        <a:ext cx="486000" cy="294840"/>
                        <a:chOff x="5506920" y="824400"/>
                        <a:chExt cx="486000" cy="294840"/>
                      </a:xfrm>
                    </p:grpSpPr>
                    <p:sp>
                      <p:nvSpPr>
                        <p:cNvPr id="636" name="Oval 89"/>
                        <p:cNvSpPr/>
                        <p:nvPr/>
                      </p:nvSpPr>
                      <p:spPr>
                        <a:xfrm>
                          <a:off x="5506920" y="824400"/>
                          <a:ext cx="486000" cy="131760"/>
                        </a:xfrm>
                        <a:prstGeom prst="ellipse">
                          <a:avLst/>
                        </a:prstGeom>
                        <a:solidFill>
                          <a:srgbClr val="b7dee8"/>
                        </a:solidFill>
                        <a:ln w="12600">
                          <a:solidFill>
                            <a:srgbClr val="10253f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637" name="Straight Connector 90"/>
                        <p:cNvSpPr/>
                        <p:nvPr/>
                      </p:nvSpPr>
                      <p:spPr>
                        <a:xfrm>
                          <a:off x="5506920" y="889200"/>
                          <a:ext cx="0" cy="230040"/>
                        </a:xfrm>
                        <a:prstGeom prst="line">
                          <a:avLst/>
                        </a:prstGeom>
                        <a:ln w="12600">
                          <a:solidFill>
                            <a:srgbClr val="10253f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t">
                          <a:noAutofit/>
                        </a:bodyPr>
                        <a:p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638" name="Straight Connector 91"/>
                        <p:cNvSpPr/>
                        <p:nvPr/>
                      </p:nvSpPr>
                      <p:spPr>
                        <a:xfrm>
                          <a:off x="5992920" y="889200"/>
                          <a:ext cx="0" cy="230040"/>
                        </a:xfrm>
                        <a:prstGeom prst="line">
                          <a:avLst/>
                        </a:prstGeom>
                        <a:ln w="12600">
                          <a:solidFill>
                            <a:srgbClr val="10253f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t">
                          <a:noAutofit/>
                        </a:bodyPr>
                        <a:p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639" name="Straight Connector 92"/>
                        <p:cNvSpPr/>
                        <p:nvPr/>
                      </p:nvSpPr>
                      <p:spPr>
                        <a:xfrm>
                          <a:off x="5506920" y="1116000"/>
                          <a:ext cx="486000" cy="0"/>
                        </a:xfrm>
                        <a:prstGeom prst="line">
                          <a:avLst/>
                        </a:prstGeom>
                        <a:ln w="12600">
                          <a:solidFill>
                            <a:srgbClr val="10253f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-46800" bIns="-46800" anchor="t">
                          <a:noAutofit/>
                        </a:bodyPr>
                        <a:p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</p:grpSp>
                <p:sp>
                  <p:nvSpPr>
                    <p:cNvPr id="640" name="TextBox 118"/>
                    <p:cNvSpPr/>
                    <p:nvPr/>
                  </p:nvSpPr>
                  <p:spPr>
                    <a:xfrm>
                      <a:off x="4902480" y="596160"/>
                      <a:ext cx="512640" cy="3373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800" spc="-1" strike="noStrike">
                          <a:solidFill>
                            <a:srgbClr val="006260"/>
                          </a:solidFill>
                          <a:latin typeface="Times New Roman"/>
                          <a:ea typeface="Times New Roman"/>
                        </a:rPr>
                        <a:t>Cell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800" spc="-1" strike="noStrike">
                          <a:solidFill>
                            <a:srgbClr val="006260"/>
                          </a:solidFill>
                          <a:latin typeface="Times New Roman"/>
                          <a:ea typeface="Times New Roman"/>
                        </a:rPr>
                        <a:t>pellets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641" name="Freeform 76"/>
                    <p:cNvSpPr/>
                    <p:nvPr/>
                  </p:nvSpPr>
                  <p:spPr>
                    <a:xfrm rot="1939200">
                      <a:off x="5521320" y="762840"/>
                      <a:ext cx="285840" cy="72720"/>
                    </a:xfrm>
                    <a:custGeom>
                      <a:avLst/>
                      <a:gdLst/>
                      <a:ahLst/>
                      <a:rect l="l" t="t" r="r" b="b"/>
                      <a:pathLst>
                        <a:path w="442032" h="121709">
                          <a:moveTo>
                            <a:pt x="0" y="121709"/>
                          </a:moveTo>
                          <a:cubicBezTo>
                            <a:pt x="80172" y="63566"/>
                            <a:pt x="160345" y="5423"/>
                            <a:pt x="234017" y="367"/>
                          </a:cubicBezTo>
                          <a:cubicBezTo>
                            <a:pt x="307689" y="-4689"/>
                            <a:pt x="374860" y="43342"/>
                            <a:pt x="442032" y="91373"/>
                          </a:cubicBezTo>
                        </a:path>
                      </a:pathLst>
                    </a:custGeom>
                    <a:noFill/>
                    <a:ln w="12600">
                      <a:solidFill>
                        <a:srgbClr val="660033"/>
                      </a:solidFill>
                      <a:round/>
                      <a:tailEnd len="med" type="stealth" w="med"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5920" bIns="25920" anchor="ctr">
                      <a:noAutofit/>
                    </a:bodyPr>
                    <a:p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642" name="TextBox 155"/>
                  <p:cNvSpPr/>
                  <p:nvPr/>
                </p:nvSpPr>
                <p:spPr>
                  <a:xfrm>
                    <a:off x="5957280" y="565200"/>
                    <a:ext cx="971280" cy="702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006260"/>
                        </a:solidFill>
                        <a:latin typeface="Times New Roman"/>
                        <a:ea typeface="Times New Roman"/>
                      </a:rPr>
                      <a:t>Plating of cells in DMEM 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006260"/>
                        </a:solidFill>
                        <a:latin typeface="Times New Roman"/>
                        <a:ea typeface="Times New Roman"/>
                      </a:rPr>
                      <a:t>F-12 medium supplemented with 20% FBS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643" name="Group 302"/>
                <p:cNvGrpSpPr/>
                <p:nvPr/>
              </p:nvGrpSpPr>
              <p:grpSpPr>
                <a:xfrm>
                  <a:off x="6456960" y="1525320"/>
                  <a:ext cx="689040" cy="284400"/>
                  <a:chOff x="6456960" y="1525320"/>
                  <a:chExt cx="689040" cy="284400"/>
                </a:xfrm>
              </p:grpSpPr>
              <p:sp>
                <p:nvSpPr>
                  <p:cNvPr id="644" name="Rectangle 55"/>
                  <p:cNvSpPr/>
                  <p:nvPr/>
                </p:nvSpPr>
                <p:spPr>
                  <a:xfrm>
                    <a:off x="6456960" y="1658880"/>
                    <a:ext cx="689040" cy="150840"/>
                  </a:xfrm>
                  <a:prstGeom prst="rect">
                    <a:avLst/>
                  </a:prstGeom>
                  <a:gradFill rotWithShape="0">
                    <a:gsLst>
                      <a:gs pos="0">
                        <a:srgbClr val="ff85ac"/>
                      </a:gs>
                      <a:gs pos="100000">
                        <a:srgbClr val="ffdbe5"/>
                      </a:gs>
                    </a:gsLst>
                    <a:lin ang="16200000"/>
                  </a:gra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grpSp>
                <p:nvGrpSpPr>
                  <p:cNvPr id="645" name="Group 366"/>
                  <p:cNvGrpSpPr/>
                  <p:nvPr/>
                </p:nvGrpSpPr>
                <p:grpSpPr>
                  <a:xfrm>
                    <a:off x="6457320" y="1525320"/>
                    <a:ext cx="687960" cy="278280"/>
                    <a:chOff x="6457320" y="1525320"/>
                    <a:chExt cx="687960" cy="278280"/>
                  </a:xfrm>
                </p:grpSpPr>
                <p:sp>
                  <p:nvSpPr>
                    <p:cNvPr id="646" name="Oval 67"/>
                    <p:cNvSpPr/>
                    <p:nvPr/>
                  </p:nvSpPr>
                  <p:spPr>
                    <a:xfrm>
                      <a:off x="6457320" y="1525320"/>
                      <a:ext cx="687960" cy="111240"/>
                    </a:xfrm>
                    <a:prstGeom prst="ellipse">
                      <a:avLst/>
                    </a:prstGeom>
                    <a:solidFill>
                      <a:srgbClr val="b7dee8"/>
                    </a:solidFill>
                    <a:ln w="12600">
                      <a:solidFill>
                        <a:srgbClr val="10253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2040" bIns="3204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647" name="Straight Connector 68"/>
                    <p:cNvSpPr/>
                    <p:nvPr/>
                  </p:nvSpPr>
                  <p:spPr>
                    <a:xfrm>
                      <a:off x="6457320" y="1580760"/>
                      <a:ext cx="0" cy="222840"/>
                    </a:xfrm>
                    <a:prstGeom prst="line">
                      <a:avLst/>
                    </a:prstGeom>
                    <a:ln w="12600">
                      <a:solidFill>
                        <a:srgbClr val="10253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648" name="Straight Connector 69"/>
                    <p:cNvSpPr/>
                    <p:nvPr/>
                  </p:nvSpPr>
                  <p:spPr>
                    <a:xfrm>
                      <a:off x="7145280" y="1580760"/>
                      <a:ext cx="0" cy="222840"/>
                    </a:xfrm>
                    <a:prstGeom prst="line">
                      <a:avLst/>
                    </a:prstGeom>
                    <a:ln w="12600">
                      <a:solidFill>
                        <a:srgbClr val="10253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649" name="Straight Connector 70"/>
                    <p:cNvSpPr/>
                    <p:nvPr/>
                  </p:nvSpPr>
                  <p:spPr>
                    <a:xfrm>
                      <a:off x="6457320" y="1803600"/>
                      <a:ext cx="687960" cy="0"/>
                    </a:xfrm>
                    <a:prstGeom prst="line">
                      <a:avLst/>
                    </a:prstGeom>
                    <a:ln w="12600">
                      <a:solidFill>
                        <a:srgbClr val="10253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</p:grpSp>
            <p:sp>
              <p:nvSpPr>
                <p:cNvPr id="650" name="TextBox 178"/>
                <p:cNvSpPr/>
                <p:nvPr/>
              </p:nvSpPr>
              <p:spPr>
                <a:xfrm>
                  <a:off x="6103080" y="1771200"/>
                  <a:ext cx="138096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6260"/>
                      </a:solidFill>
                      <a:latin typeface="Times New Roman"/>
                      <a:ea typeface="Times New Roman"/>
                    </a:rPr>
                    <a:t>Bulk culture of cells 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6260"/>
                      </a:solidFill>
                      <a:latin typeface="Times New Roman"/>
                      <a:ea typeface="Times New Roman"/>
                    </a:rPr>
                    <a:t>over 2 passage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1" name="Straight Connector 22"/>
                <p:cNvSpPr/>
                <p:nvPr/>
              </p:nvSpPr>
              <p:spPr>
                <a:xfrm>
                  <a:off x="6734160" y="2144880"/>
                  <a:ext cx="0" cy="215640"/>
                </a:xfrm>
                <a:prstGeom prst="line">
                  <a:avLst/>
                </a:prstGeom>
                <a:ln w="12600">
                  <a:solidFill>
                    <a:srgbClr val="660033"/>
                  </a:solidFill>
                  <a:miter/>
                  <a:tailEnd len="med" type="stealth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652" name="Group 97"/>
                <p:cNvGrpSpPr/>
                <p:nvPr/>
              </p:nvGrpSpPr>
              <p:grpSpPr>
                <a:xfrm>
                  <a:off x="2902320" y="376200"/>
                  <a:ext cx="1040760" cy="1199880"/>
                  <a:chOff x="2902320" y="376200"/>
                  <a:chExt cx="1040760" cy="1199880"/>
                </a:xfrm>
              </p:grpSpPr>
              <p:pic>
                <p:nvPicPr>
                  <p:cNvPr id="653" name="Picture 226" descr="C:\Users\ELIZABETH\Desktop\BIO-RENDER IMAGES\Untitled (2).jpg"/>
                  <p:cNvPicPr/>
                  <p:nvPr/>
                </p:nvPicPr>
                <p:blipFill>
                  <a:blip r:embed="rId32"/>
                  <a:srcRect l="43448" t="13841" r="35011" b="53136"/>
                  <a:stretch/>
                </p:blipFill>
                <p:spPr>
                  <a:xfrm rot="20998800">
                    <a:off x="3563640" y="986760"/>
                    <a:ext cx="279000" cy="294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grpSp>
                <p:nvGrpSpPr>
                  <p:cNvPr id="654" name="Group 431"/>
                  <p:cNvGrpSpPr/>
                  <p:nvPr/>
                </p:nvGrpSpPr>
                <p:grpSpPr>
                  <a:xfrm>
                    <a:off x="2902320" y="376200"/>
                    <a:ext cx="1040760" cy="1199880"/>
                    <a:chOff x="2902320" y="376200"/>
                    <a:chExt cx="1040760" cy="1199880"/>
                  </a:xfrm>
                </p:grpSpPr>
                <p:pic>
                  <p:nvPicPr>
                    <p:cNvPr id="655" name="Picture 226" descr="C:\Users\ELIZABETH\Desktop\BIO-RENDER IMAGES\Untitled (2).jpg"/>
                    <p:cNvPicPr/>
                    <p:nvPr/>
                  </p:nvPicPr>
                  <p:blipFill>
                    <a:blip r:embed="rId33"/>
                    <a:srcRect l="15338" t="13849" r="55477" b="53133"/>
                    <a:stretch/>
                  </p:blipFill>
                  <p:spPr>
                    <a:xfrm>
                      <a:off x="2917440" y="731160"/>
                      <a:ext cx="578520" cy="450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656" name="TextBox 108"/>
                    <p:cNvSpPr/>
                    <p:nvPr/>
                  </p:nvSpPr>
                  <p:spPr>
                    <a:xfrm>
                      <a:off x="2902320" y="376200"/>
                      <a:ext cx="1040760" cy="4590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800" spc="-1" strike="noStrike">
                          <a:solidFill>
                            <a:srgbClr val="006666"/>
                          </a:solidFill>
                          <a:latin typeface="Times New Roman"/>
                          <a:ea typeface="Times New Roman"/>
                        </a:rPr>
                        <a:t>Tissues Washing and Processing in Chilled PB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grpSp>
                  <p:nvGrpSpPr>
                    <p:cNvPr id="657" name="Group 434"/>
                    <p:cNvGrpSpPr/>
                    <p:nvPr/>
                  </p:nvGrpSpPr>
                  <p:grpSpPr>
                    <a:xfrm>
                      <a:off x="3238560" y="1298160"/>
                      <a:ext cx="590400" cy="277920"/>
                      <a:chOff x="3238560" y="1298160"/>
                      <a:chExt cx="590400" cy="277920"/>
                    </a:xfrm>
                  </p:grpSpPr>
                  <p:grpSp>
                    <p:nvGrpSpPr>
                      <p:cNvPr id="658" name="Freeform 41"/>
                      <p:cNvGrpSpPr/>
                      <p:nvPr/>
                    </p:nvGrpSpPr>
                    <p:grpSpPr>
                      <a:xfrm>
                        <a:off x="3498840" y="1371600"/>
                        <a:ext cx="109440" cy="79200"/>
                        <a:chOff x="3498840" y="1371600"/>
                        <a:chExt cx="109440" cy="79200"/>
                      </a:xfrm>
                    </p:grpSpPr>
                    <p:pic>
                      <p:nvPicPr>
                        <p:cNvPr id="659" name="Freeform 41" descr=""/>
                        <p:cNvPicPr/>
                        <p:nvPr/>
                      </p:nvPicPr>
                      <p:blipFill>
                        <a:blip r:embed="rId34"/>
                        <a:stretch/>
                      </p:blipFill>
                      <p:spPr>
                        <a:xfrm>
                          <a:off x="3501360" y="1371960"/>
                          <a:ext cx="106920" cy="7812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660" name=""/>
                        <p:cNvSpPr/>
                        <p:nvPr/>
                      </p:nvSpPr>
                      <p:spPr>
                        <a:xfrm>
                          <a:off x="3498840" y="1371600"/>
                          <a:ext cx="107280" cy="7920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32400" bIns="3240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grpSp>
                    <p:nvGrpSpPr>
                      <p:cNvPr id="661" name="Group 444"/>
                      <p:cNvGrpSpPr/>
                      <p:nvPr/>
                    </p:nvGrpSpPr>
                    <p:grpSpPr>
                      <a:xfrm>
                        <a:off x="3238560" y="1298160"/>
                        <a:ext cx="590400" cy="277920"/>
                        <a:chOff x="3238560" y="1298160"/>
                        <a:chExt cx="590400" cy="277920"/>
                      </a:xfrm>
                    </p:grpSpPr>
                    <p:grpSp>
                      <p:nvGrpSpPr>
                        <p:cNvPr id="662" name="Freeform 43"/>
                        <p:cNvGrpSpPr/>
                        <p:nvPr/>
                      </p:nvGrpSpPr>
                      <p:grpSpPr>
                        <a:xfrm>
                          <a:off x="3334320" y="1371600"/>
                          <a:ext cx="438840" cy="170640"/>
                          <a:chOff x="3334320" y="1371600"/>
                          <a:chExt cx="438840" cy="170640"/>
                        </a:xfrm>
                      </p:grpSpPr>
                      <p:pic>
                        <p:nvPicPr>
                          <p:cNvPr id="663" name="Freeform 43" descr=""/>
                          <p:cNvPicPr/>
                          <p:nvPr/>
                        </p:nvPicPr>
                        <p:blipFill>
                          <a:blip r:embed="rId35"/>
                          <a:stretch/>
                        </p:blipFill>
                        <p:spPr>
                          <a:xfrm>
                            <a:off x="3337200" y="1373400"/>
                            <a:ext cx="435960" cy="168840"/>
                          </a:xfrm>
                          <a:prstGeom prst="rect">
                            <a:avLst/>
                          </a:prstGeom>
                          <a:ln w="0">
                            <a:noFill/>
                          </a:ln>
                        </p:spPr>
                      </p:pic>
                      <p:sp>
                        <p:nvSpPr>
                          <p:cNvPr id="664" name=""/>
                          <p:cNvSpPr/>
                          <p:nvPr/>
                        </p:nvSpPr>
                        <p:spPr>
                          <a:xfrm>
                            <a:off x="3334320" y="1371600"/>
                            <a:ext cx="436680" cy="168840"/>
                          </a:xfrm>
                          <a:prstGeom prst="rect">
                            <a:avLst/>
                          </a:prstGeom>
                          <a:noFill/>
                          <a:ln w="0">
                            <a:noFill/>
                          </a:ln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lIns="90000" rIns="90000" tIns="46800" bIns="46800" anchor="ctr">
                            <a:noAutofit/>
                          </a:bodyPr>
                          <a:p>
                            <a:pPr algn="ctr">
                              <a:lnSpc>
                                <a:spcPct val="100000"/>
                              </a:lnSpc>
                              <a:tabLst>
                                <a:tab algn="l" pos="0"/>
                                <a:tab algn="l" pos="1017720"/>
                                <a:tab algn="l" pos="2035080"/>
                                <a:tab algn="l" pos="3052800"/>
                                <a:tab algn="l" pos="4070520"/>
                                <a:tab algn="l" pos="5087880"/>
                                <a:tab algn="l" pos="6105600"/>
                                <a:tab algn="l" pos="7122960"/>
                                <a:tab algn="l" pos="8140680"/>
                                <a:tab algn="l" pos="9158400"/>
                                <a:tab algn="l" pos="10175760"/>
                              </a:tabLst>
                            </a:pPr>
                            <a:endParaRPr b="0" lang="en-US" sz="2000" spc="-1" strike="noStrike">
                              <a:solidFill>
                                <a:srgbClr val="000000"/>
                              </a:solidFill>
                              <a:latin typeface="Calibri"/>
                            </a:endParaRPr>
                          </a:p>
                        </p:txBody>
                      </p:sp>
                    </p:grpSp>
                    <p:grpSp>
                      <p:nvGrpSpPr>
                        <p:cNvPr id="665" name="Group 446"/>
                        <p:cNvGrpSpPr/>
                        <p:nvPr/>
                      </p:nvGrpSpPr>
                      <p:grpSpPr>
                        <a:xfrm>
                          <a:off x="3238560" y="1298160"/>
                          <a:ext cx="590400" cy="277920"/>
                          <a:chOff x="3238560" y="1298160"/>
                          <a:chExt cx="590400" cy="277920"/>
                        </a:xfrm>
                      </p:grpSpPr>
                      <p:sp>
                        <p:nvSpPr>
                          <p:cNvPr id="666" name="Straight Connector 45"/>
                          <p:cNvSpPr/>
                          <p:nvPr/>
                        </p:nvSpPr>
                        <p:spPr>
                          <a:xfrm>
                            <a:off x="3238560" y="1380600"/>
                            <a:ext cx="0" cy="149400"/>
                          </a:xfrm>
                          <a:prstGeom prst="line">
                            <a:avLst/>
                          </a:prstGeom>
                          <a:ln w="12600">
                            <a:solidFill>
                              <a:srgbClr val="006666"/>
                            </a:solidFill>
                            <a:miter/>
                          </a:ln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lIns="90000" rIns="90000" tIns="46800" bIns="46800" anchor="t">
                            <a:noAutofit/>
                          </a:bodyPr>
                          <a:p>
                            <a:endParaRPr b="0" lang="en-US" sz="2000" spc="-1" strike="noStrike">
                              <a:solidFill>
                                <a:srgbClr val="000000"/>
                              </a:solidFill>
                              <a:latin typeface="Calibri"/>
                            </a:endParaRPr>
                          </a:p>
                        </p:txBody>
                      </p:sp>
                      <p:sp>
                        <p:nvSpPr>
                          <p:cNvPr id="667" name="Oval 46"/>
                          <p:cNvSpPr/>
                          <p:nvPr/>
                        </p:nvSpPr>
                        <p:spPr>
                          <a:xfrm>
                            <a:off x="3238560" y="1298160"/>
                            <a:ext cx="590400" cy="163440"/>
                          </a:xfrm>
                          <a:prstGeom prst="ellipse">
                            <a:avLst/>
                          </a:prstGeom>
                          <a:gradFill rotWithShape="0">
                            <a:gsLst>
                              <a:gs pos="0">
                                <a:srgbClr val="9ab5e4"/>
                              </a:gs>
                              <a:gs pos="100000">
                                <a:srgbClr val="e1e8f5">
                                  <a:alpha val="60000"/>
                                </a:srgbClr>
                              </a:gs>
                            </a:gsLst>
                            <a:lin ang="5400000"/>
                          </a:gradFill>
                          <a:ln w="12600">
                            <a:solidFill>
                              <a:srgbClr val="006666"/>
                            </a:solidFill>
                            <a:miter/>
                          </a:ln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lIns="90000" rIns="90000" tIns="46800" bIns="46800" anchor="ctr">
                            <a:noAutofit/>
                          </a:bodyPr>
                          <a:p>
                            <a:pPr algn="ctr">
                              <a:lnSpc>
                                <a:spcPct val="100000"/>
                              </a:lnSpc>
                              <a:tabLst>
                                <a:tab algn="l" pos="0"/>
                                <a:tab algn="l" pos="1017720"/>
                                <a:tab algn="l" pos="2035080"/>
                                <a:tab algn="l" pos="3052800"/>
                                <a:tab algn="l" pos="4070520"/>
                                <a:tab algn="l" pos="5087880"/>
                                <a:tab algn="l" pos="6105600"/>
                                <a:tab algn="l" pos="7122960"/>
                                <a:tab algn="l" pos="8140680"/>
                                <a:tab algn="l" pos="9158400"/>
                                <a:tab algn="l" pos="10175760"/>
                              </a:tabLst>
                            </a:pPr>
                            <a:endParaRPr b="0" lang="en-US" sz="2000" spc="-1" strike="noStrike">
                              <a:solidFill>
                                <a:srgbClr val="000000"/>
                              </a:solidFill>
                              <a:latin typeface="Calibri"/>
                            </a:endParaRPr>
                          </a:p>
                        </p:txBody>
                      </p:sp>
                      <p:sp>
                        <p:nvSpPr>
                          <p:cNvPr id="668" name="Straight Connector 47"/>
                          <p:cNvSpPr/>
                          <p:nvPr/>
                        </p:nvSpPr>
                        <p:spPr>
                          <a:xfrm>
                            <a:off x="3828960" y="1380600"/>
                            <a:ext cx="0" cy="149400"/>
                          </a:xfrm>
                          <a:prstGeom prst="line">
                            <a:avLst/>
                          </a:prstGeom>
                          <a:ln w="12600">
                            <a:solidFill>
                              <a:srgbClr val="006666"/>
                            </a:solidFill>
                            <a:miter/>
                          </a:ln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lIns="90000" rIns="90000" tIns="46800" bIns="46800" anchor="t">
                            <a:noAutofit/>
                          </a:bodyPr>
                          <a:p>
                            <a:endParaRPr b="0" lang="en-US" sz="2000" spc="-1" strike="noStrike">
                              <a:solidFill>
                                <a:srgbClr val="000000"/>
                              </a:solidFill>
                              <a:latin typeface="Calibri"/>
                            </a:endParaRPr>
                          </a:p>
                        </p:txBody>
                      </p:sp>
                      <p:sp>
                        <p:nvSpPr>
                          <p:cNvPr id="669" name="Freeform 48"/>
                          <p:cNvSpPr/>
                          <p:nvPr/>
                        </p:nvSpPr>
                        <p:spPr>
                          <a:xfrm>
                            <a:off x="3240000" y="1525320"/>
                            <a:ext cx="588960" cy="50760"/>
                          </a:xfrm>
                          <a:custGeom>
                            <a:avLst/>
                            <a:gdLst/>
                            <a:ahLst/>
                            <a:rect l="l" t="t" r="r" b="b"/>
                            <a:pathLst>
                              <a:path w="611436" h="54369">
                                <a:moveTo>
                                  <a:pt x="0" y="0"/>
                                </a:moveTo>
                                <a:cubicBezTo>
                                  <a:pt x="63577" y="20886"/>
                                  <a:pt x="127154" y="41772"/>
                                  <a:pt x="195550" y="49575"/>
                                </a:cubicBezTo>
                                <a:cubicBezTo>
                                  <a:pt x="263946" y="57378"/>
                                  <a:pt x="341065" y="55084"/>
                                  <a:pt x="410379" y="46821"/>
                                </a:cubicBezTo>
                                <a:cubicBezTo>
                                  <a:pt x="479693" y="38559"/>
                                  <a:pt x="545564" y="19279"/>
                                  <a:pt x="611436" y="0"/>
                                </a:cubicBezTo>
                              </a:path>
                            </a:pathLst>
                          </a:custGeom>
                          <a:noFill/>
                          <a:ln w="12600">
                            <a:solidFill>
                              <a:srgbClr val="006666"/>
                            </a:solidFill>
                            <a:round/>
                          </a:ln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lIns="90000" rIns="90000" tIns="3960" bIns="3960" anchor="ctr">
                            <a:noAutofit/>
                          </a:bodyPr>
                          <a:p>
                            <a:endParaRPr b="0" lang="en-US" sz="2000" spc="-1" strike="noStrike">
                              <a:solidFill>
                                <a:srgbClr val="000000"/>
                              </a:solidFill>
                              <a:latin typeface="Calibri"/>
                            </a:endParaRPr>
                          </a:p>
                        </p:txBody>
                      </p:sp>
                    </p:grpSp>
                  </p:grpSp>
                </p:grpSp>
                <p:grpSp>
                  <p:nvGrpSpPr>
                    <p:cNvPr id="670" name="Group 435"/>
                    <p:cNvGrpSpPr/>
                    <p:nvPr/>
                  </p:nvGrpSpPr>
                  <p:grpSpPr>
                    <a:xfrm>
                      <a:off x="3408120" y="1216440"/>
                      <a:ext cx="256320" cy="213120"/>
                      <a:chOff x="3408120" y="1216440"/>
                      <a:chExt cx="256320" cy="213120"/>
                    </a:xfrm>
                  </p:grpSpPr>
                  <p:grpSp>
                    <p:nvGrpSpPr>
                      <p:cNvPr id="671" name="Teardrop 35"/>
                      <p:cNvGrpSpPr/>
                      <p:nvPr/>
                    </p:nvGrpSpPr>
                    <p:grpSpPr>
                      <a:xfrm>
                        <a:off x="3420000" y="1289160"/>
                        <a:ext cx="53640" cy="56520"/>
                        <a:chOff x="3420000" y="1289160"/>
                        <a:chExt cx="53640" cy="56520"/>
                      </a:xfrm>
                    </p:grpSpPr>
                    <p:pic>
                      <p:nvPicPr>
                        <p:cNvPr id="672" name="Teardrop 35" descr=""/>
                        <p:cNvPicPr/>
                        <p:nvPr/>
                      </p:nvPicPr>
                      <p:blipFill>
                        <a:blip r:embed="rId36"/>
                        <a:stretch/>
                      </p:blipFill>
                      <p:spPr>
                        <a:xfrm>
                          <a:off x="3420000" y="1289160"/>
                          <a:ext cx="53640" cy="5616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673" name=""/>
                        <p:cNvSpPr/>
                        <p:nvPr/>
                      </p:nvSpPr>
                      <p:spPr>
                        <a:xfrm rot="18795600">
                          <a:off x="3429000" y="1305360"/>
                          <a:ext cx="32040" cy="3348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-13320" bIns="-1332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grpSp>
                    <p:nvGrpSpPr>
                      <p:cNvPr id="674" name="Teardrop 36"/>
                      <p:cNvGrpSpPr/>
                      <p:nvPr/>
                    </p:nvGrpSpPr>
                    <p:grpSpPr>
                      <a:xfrm>
                        <a:off x="3408120" y="1368000"/>
                        <a:ext cx="53640" cy="61560"/>
                        <a:chOff x="3408120" y="1368000"/>
                        <a:chExt cx="53640" cy="61560"/>
                      </a:xfrm>
                    </p:grpSpPr>
                    <p:pic>
                      <p:nvPicPr>
                        <p:cNvPr id="675" name="Teardrop 36" descr=""/>
                        <p:cNvPicPr/>
                        <p:nvPr/>
                      </p:nvPicPr>
                      <p:blipFill>
                        <a:blip r:embed="rId37"/>
                        <a:stretch/>
                      </p:blipFill>
                      <p:spPr>
                        <a:xfrm>
                          <a:off x="3408120" y="1368000"/>
                          <a:ext cx="53640" cy="6156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676" name=""/>
                        <p:cNvSpPr/>
                        <p:nvPr/>
                      </p:nvSpPr>
                      <p:spPr>
                        <a:xfrm rot="18795600">
                          <a:off x="3416760" y="1386000"/>
                          <a:ext cx="33120" cy="3456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-12240" bIns="-1224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grpSp>
                    <p:nvGrpSpPr>
                      <p:cNvPr id="677" name="Teardrop 37"/>
                      <p:cNvGrpSpPr/>
                      <p:nvPr/>
                    </p:nvGrpSpPr>
                    <p:grpSpPr>
                      <a:xfrm>
                        <a:off x="3485520" y="1306080"/>
                        <a:ext cx="53640" cy="61560"/>
                        <a:chOff x="3485520" y="1306080"/>
                        <a:chExt cx="53640" cy="61560"/>
                      </a:xfrm>
                    </p:grpSpPr>
                    <p:pic>
                      <p:nvPicPr>
                        <p:cNvPr id="678" name="Teardrop 37" descr=""/>
                        <p:cNvPicPr/>
                        <p:nvPr/>
                      </p:nvPicPr>
                      <p:blipFill>
                        <a:blip r:embed="rId38"/>
                        <a:stretch/>
                      </p:blipFill>
                      <p:spPr>
                        <a:xfrm>
                          <a:off x="3485520" y="1306080"/>
                          <a:ext cx="53640" cy="6156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679" name=""/>
                        <p:cNvSpPr/>
                        <p:nvPr/>
                      </p:nvSpPr>
                      <p:spPr>
                        <a:xfrm rot="18795600">
                          <a:off x="3494520" y="1325160"/>
                          <a:ext cx="32040" cy="3348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-13320" bIns="-1332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grpSp>
                    <p:nvGrpSpPr>
                      <p:cNvPr id="680" name="Teardrop 38"/>
                      <p:cNvGrpSpPr/>
                      <p:nvPr/>
                    </p:nvGrpSpPr>
                    <p:grpSpPr>
                      <a:xfrm>
                        <a:off x="3545280" y="1306080"/>
                        <a:ext cx="53640" cy="61560"/>
                        <a:chOff x="3545280" y="1306080"/>
                        <a:chExt cx="53640" cy="61560"/>
                      </a:xfrm>
                    </p:grpSpPr>
                    <p:pic>
                      <p:nvPicPr>
                        <p:cNvPr id="681" name="Teardrop 38" descr=""/>
                        <p:cNvPicPr/>
                        <p:nvPr/>
                      </p:nvPicPr>
                      <p:blipFill>
                        <a:blip r:embed="rId39"/>
                        <a:stretch/>
                      </p:blipFill>
                      <p:spPr>
                        <a:xfrm>
                          <a:off x="3545280" y="1306080"/>
                          <a:ext cx="53640" cy="6156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682" name=""/>
                        <p:cNvSpPr/>
                        <p:nvPr/>
                      </p:nvSpPr>
                      <p:spPr>
                        <a:xfrm rot="18795600">
                          <a:off x="3555000" y="1325880"/>
                          <a:ext cx="32040" cy="3348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-13320" bIns="-1332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grpSp>
                    <p:nvGrpSpPr>
                      <p:cNvPr id="683" name="Teardrop 39"/>
                      <p:cNvGrpSpPr/>
                      <p:nvPr/>
                    </p:nvGrpSpPr>
                    <p:grpSpPr>
                      <a:xfrm>
                        <a:off x="3408120" y="1216440"/>
                        <a:ext cx="53640" cy="61560"/>
                        <a:chOff x="3408120" y="1216440"/>
                        <a:chExt cx="53640" cy="61560"/>
                      </a:xfrm>
                    </p:grpSpPr>
                    <p:pic>
                      <p:nvPicPr>
                        <p:cNvPr id="684" name="Teardrop 39" descr=""/>
                        <p:cNvPicPr/>
                        <p:nvPr/>
                      </p:nvPicPr>
                      <p:blipFill>
                        <a:blip r:embed="rId40"/>
                        <a:stretch/>
                      </p:blipFill>
                      <p:spPr>
                        <a:xfrm>
                          <a:off x="3408120" y="1216440"/>
                          <a:ext cx="53640" cy="6156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685" name=""/>
                        <p:cNvSpPr/>
                        <p:nvPr/>
                      </p:nvSpPr>
                      <p:spPr>
                        <a:xfrm rot="18795600">
                          <a:off x="3415680" y="1236240"/>
                          <a:ext cx="32040" cy="3348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-13320" bIns="-1332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grpSp>
                    <p:nvGrpSpPr>
                      <p:cNvPr id="686" name="Teardrop 40"/>
                      <p:cNvGrpSpPr/>
                      <p:nvPr/>
                    </p:nvGrpSpPr>
                    <p:grpSpPr>
                      <a:xfrm>
                        <a:off x="3610800" y="1334160"/>
                        <a:ext cx="53640" cy="61560"/>
                        <a:chOff x="3610800" y="1334160"/>
                        <a:chExt cx="53640" cy="61560"/>
                      </a:xfrm>
                    </p:grpSpPr>
                    <p:pic>
                      <p:nvPicPr>
                        <p:cNvPr id="687" name="Teardrop 40" descr=""/>
                        <p:cNvPicPr/>
                        <p:nvPr/>
                      </p:nvPicPr>
                      <p:blipFill>
                        <a:blip r:embed="rId41"/>
                        <a:stretch/>
                      </p:blipFill>
                      <p:spPr>
                        <a:xfrm>
                          <a:off x="3610800" y="1334160"/>
                          <a:ext cx="53640" cy="6156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688" name=""/>
                        <p:cNvSpPr/>
                        <p:nvPr/>
                      </p:nvSpPr>
                      <p:spPr>
                        <a:xfrm rot="18795600">
                          <a:off x="3619080" y="1353600"/>
                          <a:ext cx="32040" cy="3348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-13320" bIns="-13320" anchor="ctr">
                          <a:no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</p:grpSp>
                <p:grpSp>
                  <p:nvGrpSpPr>
                    <p:cNvPr id="689" name="Teardrop 34"/>
                    <p:cNvGrpSpPr/>
                    <p:nvPr/>
                  </p:nvGrpSpPr>
                  <p:grpSpPr>
                    <a:xfrm>
                      <a:off x="3364920" y="1127520"/>
                      <a:ext cx="54720" cy="66960"/>
                      <a:chOff x="3364920" y="1127520"/>
                      <a:chExt cx="54720" cy="66960"/>
                    </a:xfrm>
                  </p:grpSpPr>
                  <p:pic>
                    <p:nvPicPr>
                      <p:cNvPr id="690" name="Teardrop 34" descr=""/>
                      <p:cNvPicPr/>
                      <p:nvPr/>
                    </p:nvPicPr>
                    <p:blipFill>
                      <a:blip r:embed="rId42"/>
                      <a:stretch/>
                    </p:blipFill>
                    <p:spPr>
                      <a:xfrm>
                        <a:off x="3364920" y="1127520"/>
                        <a:ext cx="54720" cy="669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  <p:sp>
                    <p:nvSpPr>
                      <p:cNvPr id="691" name=""/>
                      <p:cNvSpPr/>
                      <p:nvPr/>
                    </p:nvSpPr>
                    <p:spPr>
                      <a:xfrm rot="18795600">
                        <a:off x="3374640" y="1149840"/>
                        <a:ext cx="34920" cy="3420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2600" bIns="-1260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</p:grpSp>
            </p:grpSp>
            <p:sp>
              <p:nvSpPr>
                <p:cNvPr id="692" name="Freeform 24"/>
                <p:cNvSpPr/>
                <p:nvPr/>
              </p:nvSpPr>
              <p:spPr>
                <a:xfrm rot="1494000">
                  <a:off x="3990600" y="623880"/>
                  <a:ext cx="471240" cy="158760"/>
                </a:xfrm>
                <a:custGeom>
                  <a:avLst/>
                  <a:gdLst/>
                  <a:ahLst/>
                  <a:rect l="l" t="t" r="r" b="b"/>
                  <a:pathLst>
                    <a:path w="442032" h="121709">
                      <a:moveTo>
                        <a:pt x="0" y="121709"/>
                      </a:moveTo>
                      <a:cubicBezTo>
                        <a:pt x="80172" y="63566"/>
                        <a:pt x="160345" y="5423"/>
                        <a:pt x="234017" y="367"/>
                      </a:cubicBezTo>
                      <a:cubicBezTo>
                        <a:pt x="307689" y="-4689"/>
                        <a:pt x="374860" y="43342"/>
                        <a:pt x="442032" y="91373"/>
                      </a:cubicBezTo>
                    </a:path>
                  </a:pathLst>
                </a:custGeom>
                <a:noFill/>
                <a:ln w="12600">
                  <a:solidFill>
                    <a:srgbClr val="660033"/>
                  </a:solidFill>
                  <a:round/>
                  <a:tailEnd len="med" type="stealth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93" name="Straight Connector 25"/>
                <p:cNvSpPr/>
                <p:nvPr/>
              </p:nvSpPr>
              <p:spPr>
                <a:xfrm flipV="1">
                  <a:off x="5576760" y="1203120"/>
                  <a:ext cx="122040" cy="365040"/>
                </a:xfrm>
                <a:prstGeom prst="line">
                  <a:avLst/>
                </a:prstGeom>
                <a:ln w="12600">
                  <a:solidFill>
                    <a:srgbClr val="660033"/>
                  </a:solidFill>
                  <a:miter/>
                  <a:tailEnd len="med" type="stealth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cxnSp>
              <p:nvCxnSpPr>
                <p:cNvPr id="694" name="Straight Arrow Connector 26"/>
                <p:cNvCxnSpPr/>
                <p:nvPr/>
              </p:nvCxnSpPr>
              <p:spPr>
                <a:xfrm flipV="1">
                  <a:off x="2903400" y="1090440"/>
                  <a:ext cx="173520" cy="155880"/>
                </a:xfrm>
                <a:prstGeom prst="straightConnector1">
                  <a:avLst/>
                </a:prstGeom>
                <a:ln w="12600">
                  <a:solidFill>
                    <a:srgbClr val="660033"/>
                  </a:solidFill>
                  <a:miter/>
                  <a:tailEnd len="med" type="stealth" w="med"/>
                </a:ln>
              </p:spPr>
            </p:cxnSp>
            <p:sp>
              <p:nvSpPr>
                <p:cNvPr id="695" name="Straight Connector 27"/>
                <p:cNvSpPr/>
                <p:nvPr/>
              </p:nvSpPr>
              <p:spPr>
                <a:xfrm>
                  <a:off x="6485040" y="1217520"/>
                  <a:ext cx="172800" cy="290520"/>
                </a:xfrm>
                <a:prstGeom prst="line">
                  <a:avLst/>
                </a:prstGeom>
                <a:ln w="12600">
                  <a:solidFill>
                    <a:srgbClr val="660033"/>
                  </a:solidFill>
                  <a:miter/>
                  <a:tailEnd len="med" type="stealth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696" name="Rectangle 3"/>
              <p:cNvSpPr/>
              <p:nvPr/>
            </p:nvSpPr>
            <p:spPr>
              <a:xfrm>
                <a:off x="387360" y="606240"/>
                <a:ext cx="245880" cy="180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97" name="Group 2"/>
            <p:cNvGrpSpPr/>
            <p:nvPr/>
          </p:nvGrpSpPr>
          <p:grpSpPr>
            <a:xfrm>
              <a:off x="5621400" y="965160"/>
              <a:ext cx="322200" cy="104760"/>
              <a:chOff x="5621400" y="965160"/>
              <a:chExt cx="322200" cy="104760"/>
            </a:xfrm>
          </p:grpSpPr>
          <p:sp>
            <p:nvSpPr>
              <p:cNvPr id="698" name="Oval 245"/>
              <p:cNvSpPr/>
              <p:nvPr/>
            </p:nvSpPr>
            <p:spPr>
              <a:xfrm>
                <a:off x="5664240" y="996840"/>
                <a:ext cx="109440" cy="73080"/>
              </a:xfrm>
              <a:prstGeom prst="ellipse">
                <a:avLst/>
              </a:prstGeom>
              <a:gradFill rotWithShape="0">
                <a:gsLst>
                  <a:gs pos="0">
                    <a:srgbClr val="ffc000"/>
                  </a:gs>
                  <a:gs pos="100000">
                    <a:srgbClr val="f2f2f2"/>
                  </a:gs>
                </a:gsLst>
                <a:lin ang="5400000"/>
              </a:gradFill>
              <a:ln cap="rnd" w="1800">
                <a:solidFill>
                  <a:srgbClr val="000000"/>
                </a:solidFill>
                <a:custDash>
                  <a:ds d="3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9" name="Oval 246"/>
              <p:cNvSpPr/>
              <p:nvPr/>
            </p:nvSpPr>
            <p:spPr>
              <a:xfrm>
                <a:off x="5697360" y="1011240"/>
                <a:ext cx="45720" cy="44280"/>
              </a:xfrm>
              <a:prstGeom prst="ellipse">
                <a:avLst/>
              </a:prstGeom>
              <a:gradFill rotWithShape="0">
                <a:gsLst>
                  <a:gs pos="0">
                    <a:srgbClr val="5d2500"/>
                  </a:gs>
                  <a:gs pos="100000">
                    <a:srgbClr val="a34700"/>
                  </a:gs>
                </a:gsLst>
                <a:lin ang="27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0" name="Oval 247"/>
              <p:cNvSpPr/>
              <p:nvPr/>
            </p:nvSpPr>
            <p:spPr>
              <a:xfrm>
                <a:off x="5762520" y="995400"/>
                <a:ext cx="109440" cy="71640"/>
              </a:xfrm>
              <a:prstGeom prst="ellipse">
                <a:avLst/>
              </a:prstGeom>
              <a:gradFill rotWithShape="0">
                <a:gsLst>
                  <a:gs pos="0">
                    <a:srgbClr val="ffc000"/>
                  </a:gs>
                  <a:gs pos="100000">
                    <a:srgbClr val="f2f2f2"/>
                  </a:gs>
                </a:gsLst>
                <a:lin ang="5400000"/>
              </a:gradFill>
              <a:ln cap="rnd" w="1800">
                <a:solidFill>
                  <a:srgbClr val="000000"/>
                </a:solidFill>
                <a:custDash>
                  <a:ds d="3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1" name="Oval 248"/>
              <p:cNvSpPr/>
              <p:nvPr/>
            </p:nvSpPr>
            <p:spPr>
              <a:xfrm>
                <a:off x="5794560" y="1008000"/>
                <a:ext cx="46080" cy="46080"/>
              </a:xfrm>
              <a:prstGeom prst="ellipse">
                <a:avLst/>
              </a:prstGeom>
              <a:gradFill rotWithShape="0">
                <a:gsLst>
                  <a:gs pos="0">
                    <a:srgbClr val="5d2500"/>
                  </a:gs>
                  <a:gs pos="100000">
                    <a:srgbClr val="a34700"/>
                  </a:gs>
                </a:gsLst>
                <a:lin ang="27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2" name="Oval 249"/>
              <p:cNvSpPr/>
              <p:nvPr/>
            </p:nvSpPr>
            <p:spPr>
              <a:xfrm>
                <a:off x="5832720" y="995400"/>
                <a:ext cx="109440" cy="71640"/>
              </a:xfrm>
              <a:prstGeom prst="ellipse">
                <a:avLst/>
              </a:prstGeom>
              <a:gradFill rotWithShape="0">
                <a:gsLst>
                  <a:gs pos="0">
                    <a:srgbClr val="ffc000"/>
                  </a:gs>
                  <a:gs pos="100000">
                    <a:srgbClr val="f2f2f2"/>
                  </a:gs>
                </a:gsLst>
                <a:lin ang="5400000"/>
              </a:gradFill>
              <a:ln cap="rnd" w="1800">
                <a:solidFill>
                  <a:srgbClr val="000000"/>
                </a:solidFill>
                <a:custDash>
                  <a:ds d="3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3" name="Oval 250"/>
              <p:cNvSpPr/>
              <p:nvPr/>
            </p:nvSpPr>
            <p:spPr>
              <a:xfrm>
                <a:off x="5865840" y="1008000"/>
                <a:ext cx="44280" cy="46080"/>
              </a:xfrm>
              <a:prstGeom prst="ellipse">
                <a:avLst/>
              </a:prstGeom>
              <a:gradFill rotWithShape="0">
                <a:gsLst>
                  <a:gs pos="0">
                    <a:srgbClr val="5d2500"/>
                  </a:gs>
                  <a:gs pos="100000">
                    <a:srgbClr val="a34700"/>
                  </a:gs>
                </a:gsLst>
                <a:lin ang="27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4" name="Oval 251"/>
              <p:cNvSpPr/>
              <p:nvPr/>
            </p:nvSpPr>
            <p:spPr>
              <a:xfrm>
                <a:off x="5621400" y="969840"/>
                <a:ext cx="109440" cy="73080"/>
              </a:xfrm>
              <a:prstGeom prst="ellipse">
                <a:avLst/>
              </a:prstGeom>
              <a:gradFill rotWithShape="0">
                <a:gsLst>
                  <a:gs pos="0">
                    <a:srgbClr val="ffc000"/>
                  </a:gs>
                  <a:gs pos="100000">
                    <a:srgbClr val="f2f2f2"/>
                  </a:gs>
                </a:gsLst>
                <a:lin ang="5400000"/>
              </a:gradFill>
              <a:ln cap="rnd" w="1800">
                <a:solidFill>
                  <a:srgbClr val="000000"/>
                </a:solidFill>
                <a:custDash>
                  <a:ds d="3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5" name="Oval 252"/>
              <p:cNvSpPr/>
              <p:nvPr/>
            </p:nvSpPr>
            <p:spPr>
              <a:xfrm>
                <a:off x="5654520" y="984240"/>
                <a:ext cx="46080" cy="44280"/>
              </a:xfrm>
              <a:prstGeom prst="ellipse">
                <a:avLst/>
              </a:prstGeom>
              <a:gradFill rotWithShape="0">
                <a:gsLst>
                  <a:gs pos="0">
                    <a:srgbClr val="5d2500"/>
                  </a:gs>
                  <a:gs pos="100000">
                    <a:srgbClr val="a34700"/>
                  </a:gs>
                </a:gsLst>
                <a:lin ang="27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6" name="Oval 253"/>
              <p:cNvSpPr/>
              <p:nvPr/>
            </p:nvSpPr>
            <p:spPr>
              <a:xfrm>
                <a:off x="5732280" y="965160"/>
                <a:ext cx="109440" cy="73080"/>
              </a:xfrm>
              <a:prstGeom prst="ellipse">
                <a:avLst/>
              </a:prstGeom>
              <a:gradFill rotWithShape="0">
                <a:gsLst>
                  <a:gs pos="0">
                    <a:srgbClr val="ffc000"/>
                  </a:gs>
                  <a:gs pos="100000">
                    <a:srgbClr val="f2f2f2"/>
                  </a:gs>
                </a:gsLst>
                <a:lin ang="5400000"/>
              </a:gradFill>
              <a:ln cap="rnd" w="1800">
                <a:solidFill>
                  <a:srgbClr val="000000"/>
                </a:solidFill>
                <a:custDash>
                  <a:ds d="3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7" name="Oval 254"/>
              <p:cNvSpPr/>
              <p:nvPr/>
            </p:nvSpPr>
            <p:spPr>
              <a:xfrm>
                <a:off x="5765760" y="977760"/>
                <a:ext cx="44280" cy="46080"/>
              </a:xfrm>
              <a:prstGeom prst="ellipse">
                <a:avLst/>
              </a:prstGeom>
              <a:gradFill rotWithShape="0">
                <a:gsLst>
                  <a:gs pos="0">
                    <a:srgbClr val="5d2500"/>
                  </a:gs>
                  <a:gs pos="100000">
                    <a:srgbClr val="a34700"/>
                  </a:gs>
                </a:gsLst>
                <a:lin ang="27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8" name="Oval 255"/>
              <p:cNvSpPr/>
              <p:nvPr/>
            </p:nvSpPr>
            <p:spPr>
              <a:xfrm>
                <a:off x="5834160" y="969840"/>
                <a:ext cx="109440" cy="73080"/>
              </a:xfrm>
              <a:prstGeom prst="ellipse">
                <a:avLst/>
              </a:prstGeom>
              <a:gradFill rotWithShape="0">
                <a:gsLst>
                  <a:gs pos="0">
                    <a:srgbClr val="ffc000"/>
                  </a:gs>
                  <a:gs pos="100000">
                    <a:srgbClr val="f2f2f2"/>
                  </a:gs>
                </a:gsLst>
                <a:lin ang="5400000"/>
              </a:gradFill>
              <a:ln cap="rnd" w="1800">
                <a:solidFill>
                  <a:srgbClr val="000000"/>
                </a:solidFill>
                <a:custDash>
                  <a:ds d="3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9" name="Oval 256"/>
              <p:cNvSpPr/>
              <p:nvPr/>
            </p:nvSpPr>
            <p:spPr>
              <a:xfrm>
                <a:off x="5867640" y="984240"/>
                <a:ext cx="44280" cy="44280"/>
              </a:xfrm>
              <a:prstGeom prst="ellipse">
                <a:avLst/>
              </a:prstGeom>
              <a:gradFill rotWithShape="0">
                <a:gsLst>
                  <a:gs pos="0">
                    <a:srgbClr val="5d2500"/>
                  </a:gs>
                  <a:gs pos="100000">
                    <a:srgbClr val="a34700"/>
                  </a:gs>
                </a:gsLst>
                <a:lin ang="27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10" name="Group 1"/>
            <p:cNvGrpSpPr/>
            <p:nvPr/>
          </p:nvGrpSpPr>
          <p:grpSpPr>
            <a:xfrm>
              <a:off x="6512040" y="1650600"/>
              <a:ext cx="583920" cy="134640"/>
              <a:chOff x="6512040" y="1650600"/>
              <a:chExt cx="583920" cy="134640"/>
            </a:xfrm>
          </p:grpSpPr>
          <p:sp>
            <p:nvSpPr>
              <p:cNvPr id="711" name="Oval 258"/>
              <p:cNvSpPr/>
              <p:nvPr/>
            </p:nvSpPr>
            <p:spPr>
              <a:xfrm>
                <a:off x="6564240" y="1688400"/>
                <a:ext cx="106200" cy="90360"/>
              </a:xfrm>
              <a:prstGeom prst="ellipse">
                <a:avLst/>
              </a:prstGeom>
              <a:gradFill rotWithShape="0">
                <a:gsLst>
                  <a:gs pos="0">
                    <a:srgbClr val="984807"/>
                  </a:gs>
                  <a:gs pos="100000">
                    <a:srgbClr val="fcd5b5"/>
                  </a:gs>
                </a:gsLst>
                <a:lin ang="8100000"/>
              </a:gradFill>
              <a:ln cap="rnd" w="1800">
                <a:solidFill>
                  <a:srgbClr val="984807"/>
                </a:solidFill>
                <a:custDash>
                  <a:ds d="3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2" name="Oval 259"/>
              <p:cNvSpPr/>
              <p:nvPr/>
            </p:nvSpPr>
            <p:spPr>
              <a:xfrm>
                <a:off x="6594480" y="1713960"/>
                <a:ext cx="45720" cy="45720"/>
              </a:xfrm>
              <a:prstGeom prst="ellipse">
                <a:avLst/>
              </a:prstGeom>
              <a:solidFill>
                <a:srgbClr val="ffc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3" name="Oval 260"/>
              <p:cNvSpPr/>
              <p:nvPr/>
            </p:nvSpPr>
            <p:spPr>
              <a:xfrm>
                <a:off x="6670800" y="1691640"/>
                <a:ext cx="104760" cy="90360"/>
              </a:xfrm>
              <a:prstGeom prst="ellipse">
                <a:avLst/>
              </a:prstGeom>
              <a:gradFill rotWithShape="0">
                <a:gsLst>
                  <a:gs pos="0">
                    <a:srgbClr val="984807"/>
                  </a:gs>
                  <a:gs pos="100000">
                    <a:srgbClr val="fcd5b5"/>
                  </a:gs>
                </a:gsLst>
                <a:lin ang="8100000"/>
              </a:gradFill>
              <a:ln cap="rnd" w="1800">
                <a:solidFill>
                  <a:srgbClr val="984807"/>
                </a:solidFill>
                <a:custDash>
                  <a:ds d="3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4" name="Oval 261"/>
              <p:cNvSpPr/>
              <p:nvPr/>
            </p:nvSpPr>
            <p:spPr>
              <a:xfrm>
                <a:off x="6699240" y="1717200"/>
                <a:ext cx="45720" cy="44280"/>
              </a:xfrm>
              <a:prstGeom prst="ellipse">
                <a:avLst/>
              </a:prstGeom>
              <a:solidFill>
                <a:srgbClr val="ffc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5" name="Oval 262"/>
              <p:cNvSpPr/>
              <p:nvPr/>
            </p:nvSpPr>
            <p:spPr>
              <a:xfrm>
                <a:off x="6778440" y="1694880"/>
                <a:ext cx="104760" cy="90360"/>
              </a:xfrm>
              <a:prstGeom prst="ellipse">
                <a:avLst/>
              </a:prstGeom>
              <a:gradFill rotWithShape="0">
                <a:gsLst>
                  <a:gs pos="0">
                    <a:srgbClr val="984807"/>
                  </a:gs>
                  <a:gs pos="100000">
                    <a:srgbClr val="fcd5b5"/>
                  </a:gs>
                </a:gsLst>
                <a:lin ang="8100000"/>
              </a:gradFill>
              <a:ln cap="rnd" w="1800">
                <a:solidFill>
                  <a:srgbClr val="984807"/>
                </a:solidFill>
                <a:custDash>
                  <a:ds d="3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6" name="Oval 263"/>
              <p:cNvSpPr/>
              <p:nvPr/>
            </p:nvSpPr>
            <p:spPr>
              <a:xfrm>
                <a:off x="6807240" y="1720440"/>
                <a:ext cx="45720" cy="44280"/>
              </a:xfrm>
              <a:prstGeom prst="ellipse">
                <a:avLst/>
              </a:prstGeom>
              <a:solidFill>
                <a:srgbClr val="ffc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7" name="Oval 264"/>
              <p:cNvSpPr/>
              <p:nvPr/>
            </p:nvSpPr>
            <p:spPr>
              <a:xfrm>
                <a:off x="6886440" y="1688400"/>
                <a:ext cx="104760" cy="91800"/>
              </a:xfrm>
              <a:prstGeom prst="ellipse">
                <a:avLst/>
              </a:prstGeom>
              <a:gradFill rotWithShape="0">
                <a:gsLst>
                  <a:gs pos="0">
                    <a:srgbClr val="984807"/>
                  </a:gs>
                  <a:gs pos="100000">
                    <a:srgbClr val="fcd5b5"/>
                  </a:gs>
                </a:gsLst>
                <a:lin ang="8100000"/>
              </a:gradFill>
              <a:ln cap="rnd" w="1800">
                <a:solidFill>
                  <a:srgbClr val="984807"/>
                </a:solidFill>
                <a:custDash>
                  <a:ds d="3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8" name="Oval 265"/>
              <p:cNvSpPr/>
              <p:nvPr/>
            </p:nvSpPr>
            <p:spPr>
              <a:xfrm>
                <a:off x="6915240" y="1715400"/>
                <a:ext cx="45720" cy="44280"/>
              </a:xfrm>
              <a:prstGeom prst="ellipse">
                <a:avLst/>
              </a:prstGeom>
              <a:solidFill>
                <a:srgbClr val="ffc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9" name="Oval 266"/>
              <p:cNvSpPr/>
              <p:nvPr/>
            </p:nvSpPr>
            <p:spPr>
              <a:xfrm>
                <a:off x="6991200" y="1686960"/>
                <a:ext cx="104760" cy="90360"/>
              </a:xfrm>
              <a:prstGeom prst="ellipse">
                <a:avLst/>
              </a:prstGeom>
              <a:gradFill rotWithShape="0">
                <a:gsLst>
                  <a:gs pos="0">
                    <a:srgbClr val="984807"/>
                  </a:gs>
                  <a:gs pos="100000">
                    <a:srgbClr val="fcd5b5"/>
                  </a:gs>
                </a:gsLst>
                <a:lin ang="8100000"/>
              </a:gradFill>
              <a:ln cap="rnd" w="1800">
                <a:solidFill>
                  <a:srgbClr val="984807"/>
                </a:solidFill>
                <a:custDash>
                  <a:ds d="3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0" name="Oval 267"/>
              <p:cNvSpPr/>
              <p:nvPr/>
            </p:nvSpPr>
            <p:spPr>
              <a:xfrm>
                <a:off x="7020000" y="1712520"/>
                <a:ext cx="45720" cy="45720"/>
              </a:xfrm>
              <a:prstGeom prst="ellipse">
                <a:avLst/>
              </a:prstGeom>
              <a:solidFill>
                <a:srgbClr val="ffc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1" name="Oval 268"/>
              <p:cNvSpPr/>
              <p:nvPr/>
            </p:nvSpPr>
            <p:spPr>
              <a:xfrm>
                <a:off x="6512040" y="1674360"/>
                <a:ext cx="104760" cy="91800"/>
              </a:xfrm>
              <a:prstGeom prst="ellipse">
                <a:avLst/>
              </a:prstGeom>
              <a:gradFill rotWithShape="0">
                <a:gsLst>
                  <a:gs pos="0">
                    <a:srgbClr val="984807"/>
                  </a:gs>
                  <a:gs pos="100000">
                    <a:srgbClr val="fcd5b5"/>
                  </a:gs>
                </a:gsLst>
                <a:lin ang="8100000"/>
              </a:gradFill>
              <a:ln cap="rnd" w="1800">
                <a:solidFill>
                  <a:srgbClr val="984807"/>
                </a:solidFill>
                <a:custDash>
                  <a:ds d="3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2" name="Oval 269"/>
              <p:cNvSpPr/>
              <p:nvPr/>
            </p:nvSpPr>
            <p:spPr>
              <a:xfrm>
                <a:off x="6541920" y="1699560"/>
                <a:ext cx="45720" cy="45720"/>
              </a:xfrm>
              <a:prstGeom prst="ellipse">
                <a:avLst/>
              </a:prstGeom>
              <a:solidFill>
                <a:srgbClr val="ffc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3" name="Oval 270"/>
              <p:cNvSpPr/>
              <p:nvPr/>
            </p:nvSpPr>
            <p:spPr>
              <a:xfrm>
                <a:off x="6618240" y="1663200"/>
                <a:ext cx="104760" cy="90360"/>
              </a:xfrm>
              <a:prstGeom prst="ellipse">
                <a:avLst/>
              </a:prstGeom>
              <a:gradFill rotWithShape="0">
                <a:gsLst>
                  <a:gs pos="0">
                    <a:srgbClr val="984807"/>
                  </a:gs>
                  <a:gs pos="100000">
                    <a:srgbClr val="fcd5b5"/>
                  </a:gs>
                </a:gsLst>
                <a:lin ang="8100000"/>
              </a:gradFill>
              <a:ln cap="rnd" w="1800">
                <a:solidFill>
                  <a:srgbClr val="984807"/>
                </a:solidFill>
                <a:custDash>
                  <a:ds d="3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4" name="Oval 271"/>
              <p:cNvSpPr/>
              <p:nvPr/>
            </p:nvSpPr>
            <p:spPr>
              <a:xfrm>
                <a:off x="6648480" y="1688400"/>
                <a:ext cx="45720" cy="45720"/>
              </a:xfrm>
              <a:prstGeom prst="ellipse">
                <a:avLst/>
              </a:prstGeom>
              <a:solidFill>
                <a:srgbClr val="ffc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5" name="Oval 272"/>
              <p:cNvSpPr/>
              <p:nvPr/>
            </p:nvSpPr>
            <p:spPr>
              <a:xfrm>
                <a:off x="6746760" y="1663200"/>
                <a:ext cx="104760" cy="90360"/>
              </a:xfrm>
              <a:prstGeom prst="ellipse">
                <a:avLst/>
              </a:prstGeom>
              <a:gradFill rotWithShape="0">
                <a:gsLst>
                  <a:gs pos="0">
                    <a:srgbClr val="984807"/>
                  </a:gs>
                  <a:gs pos="100000">
                    <a:srgbClr val="fcd5b5"/>
                  </a:gs>
                </a:gsLst>
                <a:lin ang="8100000"/>
              </a:gradFill>
              <a:ln cap="rnd" w="1800">
                <a:solidFill>
                  <a:srgbClr val="984807"/>
                </a:solidFill>
                <a:custDash>
                  <a:ds d="3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6" name="Oval 273"/>
              <p:cNvSpPr/>
              <p:nvPr/>
            </p:nvSpPr>
            <p:spPr>
              <a:xfrm>
                <a:off x="6777000" y="1688400"/>
                <a:ext cx="45720" cy="45720"/>
              </a:xfrm>
              <a:prstGeom prst="ellipse">
                <a:avLst/>
              </a:prstGeom>
              <a:solidFill>
                <a:srgbClr val="ffc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7" name="Oval 274"/>
              <p:cNvSpPr/>
              <p:nvPr/>
            </p:nvSpPr>
            <p:spPr>
              <a:xfrm>
                <a:off x="6861240" y="1653480"/>
                <a:ext cx="104760" cy="91800"/>
              </a:xfrm>
              <a:prstGeom prst="ellipse">
                <a:avLst/>
              </a:prstGeom>
              <a:gradFill rotWithShape="0">
                <a:gsLst>
                  <a:gs pos="0">
                    <a:srgbClr val="984807"/>
                  </a:gs>
                  <a:gs pos="100000">
                    <a:srgbClr val="fcd5b5"/>
                  </a:gs>
                </a:gsLst>
                <a:lin ang="8100000"/>
              </a:gradFill>
              <a:ln cap="rnd" w="1800">
                <a:solidFill>
                  <a:srgbClr val="984807"/>
                </a:solidFill>
                <a:custDash>
                  <a:ds d="3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8" name="Oval 275"/>
              <p:cNvSpPr/>
              <p:nvPr/>
            </p:nvSpPr>
            <p:spPr>
              <a:xfrm>
                <a:off x="6891480" y="1679040"/>
                <a:ext cx="44280" cy="45720"/>
              </a:xfrm>
              <a:prstGeom prst="ellipse">
                <a:avLst/>
              </a:prstGeom>
              <a:solidFill>
                <a:srgbClr val="ffc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9" name="Oval 276"/>
              <p:cNvSpPr/>
              <p:nvPr/>
            </p:nvSpPr>
            <p:spPr>
              <a:xfrm>
                <a:off x="6962760" y="1650600"/>
                <a:ext cx="104760" cy="90360"/>
              </a:xfrm>
              <a:prstGeom prst="ellipse">
                <a:avLst/>
              </a:prstGeom>
              <a:gradFill rotWithShape="0">
                <a:gsLst>
                  <a:gs pos="0">
                    <a:srgbClr val="984807"/>
                  </a:gs>
                  <a:gs pos="100000">
                    <a:srgbClr val="fcd5b5"/>
                  </a:gs>
                </a:gsLst>
                <a:lin ang="8100000"/>
              </a:gradFill>
              <a:ln cap="rnd" w="1800">
                <a:solidFill>
                  <a:srgbClr val="984807"/>
                </a:solidFill>
                <a:custDash>
                  <a:ds d="3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0" name="Oval 277"/>
              <p:cNvSpPr/>
              <p:nvPr/>
            </p:nvSpPr>
            <p:spPr>
              <a:xfrm>
                <a:off x="6991200" y="1675800"/>
                <a:ext cx="45720" cy="45720"/>
              </a:xfrm>
              <a:prstGeom prst="ellipse">
                <a:avLst/>
              </a:prstGeom>
              <a:solidFill>
                <a:srgbClr val="ffc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aphicFrame>
        <p:nvGraphicFramePr>
          <p:cNvPr id="731" name=""/>
          <p:cNvGraphicFramePr/>
          <p:nvPr/>
        </p:nvGraphicFramePr>
        <p:xfrm>
          <a:off x="1681200" y="3121200"/>
          <a:ext cx="3959280" cy="1726920"/>
        </p:xfrm>
        <a:graphic>
          <a:graphicData uri="http://schemas.openxmlformats.org/drawingml/2006/table">
            <a:tbl>
              <a:tblPr/>
              <a:tblGrid>
                <a:gridCol w="1197000"/>
                <a:gridCol w="1295280"/>
                <a:gridCol w="1467000"/>
              </a:tblGrid>
              <a:tr h="446040"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1000" spc="-1" strike="noStrike">
                          <a:solidFill>
                            <a:srgbClr val="002200"/>
                          </a:solidFill>
                          <a:latin typeface="Times New Roman"/>
                          <a:ea typeface="Times New Roman"/>
                        </a:rPr>
                        <a:t>Cohort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gradFill rotWithShape="0">
                      <a:gsLst>
                        <a:gs pos="0">
                          <a:srgbClr val="4f6228"/>
                        </a:gs>
                        <a:gs pos="100000">
                          <a:srgbClr val="ffffff"/>
                        </a:gs>
                      </a:gsLst>
                      <a:lin ang="18900000"/>
                    </a:gra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1000" spc="-1" strike="noStrike">
                          <a:solidFill>
                            <a:srgbClr val="0022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IN" sz="1000" spc="-1" strike="noStrike">
                          <a:solidFill>
                            <a:srgbClr val="002200"/>
                          </a:solidFill>
                          <a:latin typeface="Times New Roman"/>
                          <a:ea typeface="Times New Roman"/>
                        </a:rPr>
                        <a:t>IC</a:t>
                      </a:r>
                      <a:r>
                        <a:rPr b="1" lang="en-IN" sz="1000" spc="-1" strike="noStrike" baseline="-25000">
                          <a:solidFill>
                            <a:srgbClr val="002200"/>
                          </a:solidFill>
                          <a:latin typeface="Times New Roman"/>
                          <a:ea typeface="Times New Roman"/>
                        </a:rPr>
                        <a:t>50</a:t>
                      </a:r>
                      <a:r>
                        <a:rPr b="1" lang="en-IN" sz="1000" spc="-1" strike="noStrike">
                          <a:solidFill>
                            <a:srgbClr val="002200"/>
                          </a:solidFill>
                          <a:latin typeface="Times New Roman"/>
                          <a:ea typeface="Times New Roman"/>
                        </a:rPr>
                        <a:t> Value Ran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gradFill rotWithShape="0">
                      <a:gsLst>
                        <a:gs pos="0">
                          <a:srgbClr val="4f6228"/>
                        </a:gs>
                        <a:gs pos="100000">
                          <a:srgbClr val="ffffff"/>
                        </a:gs>
                      </a:gsLst>
                      <a:lin ang="18900000"/>
                    </a:gra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1000" spc="-1" strike="noStrike">
                          <a:solidFill>
                            <a:srgbClr val="002200"/>
                          </a:solidFill>
                          <a:latin typeface="Times New Roman"/>
                          <a:ea typeface="Times New Roman"/>
                        </a:rPr>
                        <a:t>Response Statu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gradFill rotWithShape="0">
                      <a:gsLst>
                        <a:gs pos="0">
                          <a:srgbClr val="4f6228"/>
                        </a:gs>
                        <a:gs pos="100000">
                          <a:srgbClr val="ffffff"/>
                        </a:gs>
                      </a:gsLst>
                      <a:lin ang="18900000"/>
                    </a:gradFill>
                  </a:tcPr>
                </a:tc>
              </a:tr>
              <a:tr h="417240"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ptimu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-1.9µ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spond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46400"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orderli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-3.5µ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ermediate Respond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17240"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ig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5-6µ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n-Respond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732" name="Rectangle 293"/>
          <p:cNvSpPr/>
          <p:nvPr/>
        </p:nvSpPr>
        <p:spPr>
          <a:xfrm>
            <a:off x="419040" y="3105000"/>
            <a:ext cx="24624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1" lang="en-IN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3" name="TextBox 117"/>
          <p:cNvSpPr/>
          <p:nvPr/>
        </p:nvSpPr>
        <p:spPr>
          <a:xfrm>
            <a:off x="-9360" y="9813960"/>
            <a:ext cx="1436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34" name="Group 9"/>
          <p:cNvGrpSpPr/>
          <p:nvPr/>
        </p:nvGrpSpPr>
        <p:grpSpPr>
          <a:xfrm>
            <a:off x="947880" y="515880"/>
            <a:ext cx="6535440" cy="3078360"/>
            <a:chOff x="947880" y="515880"/>
            <a:chExt cx="6535440" cy="3078360"/>
          </a:xfrm>
        </p:grpSpPr>
        <p:sp>
          <p:nvSpPr>
            <p:cNvPr id="735" name="Rectangle 18"/>
            <p:cNvSpPr/>
            <p:nvPr/>
          </p:nvSpPr>
          <p:spPr>
            <a:xfrm>
              <a:off x="947880" y="515880"/>
              <a:ext cx="2216160" cy="390240"/>
            </a:xfrm>
            <a:prstGeom prst="rect">
              <a:avLst/>
            </a:prstGeom>
            <a:solidFill>
              <a:srgbClr val="cc0099">
                <a:alpha val="30000"/>
              </a:srgbClr>
            </a:solidFill>
            <a:ln cap="rnd" w="2520">
              <a:solidFill>
                <a:srgbClr val="cc0099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1000" spc="-1" strike="noStrike">
                  <a:solidFill>
                    <a:srgbClr val="632523"/>
                  </a:solidFill>
                  <a:latin typeface="Times New Roman"/>
                  <a:ea typeface="Times New Roman"/>
                </a:rPr>
                <a:t>First-priority reference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736" name="Group 8"/>
            <p:cNvGrpSpPr/>
            <p:nvPr/>
          </p:nvGrpSpPr>
          <p:grpSpPr>
            <a:xfrm>
              <a:off x="1101960" y="756360"/>
              <a:ext cx="6381360" cy="2837880"/>
              <a:chOff x="1101960" y="756360"/>
              <a:chExt cx="6381360" cy="2837880"/>
            </a:xfrm>
          </p:grpSpPr>
          <p:grpSp>
            <p:nvGrpSpPr>
              <p:cNvPr id="737" name="Group 11"/>
              <p:cNvGrpSpPr/>
              <p:nvPr/>
            </p:nvGrpSpPr>
            <p:grpSpPr>
              <a:xfrm>
                <a:off x="1101960" y="1081800"/>
                <a:ext cx="6244920" cy="2512440"/>
                <a:chOff x="1101960" y="1081800"/>
                <a:chExt cx="6244920" cy="2512440"/>
              </a:xfrm>
            </p:grpSpPr>
            <p:grpSp>
              <p:nvGrpSpPr>
                <p:cNvPr id="738" name="Group 4"/>
                <p:cNvGrpSpPr/>
                <p:nvPr/>
              </p:nvGrpSpPr>
              <p:grpSpPr>
                <a:xfrm>
                  <a:off x="1101960" y="1081800"/>
                  <a:ext cx="3078360" cy="2148120"/>
                  <a:chOff x="1101960" y="1081800"/>
                  <a:chExt cx="3078360" cy="2148120"/>
                </a:xfrm>
              </p:grpSpPr>
              <p:pic>
                <p:nvPicPr>
                  <p:cNvPr id="739" name="Picture 2" descr="C:\Users\ELIZABETH\Desktop\FIRST PRIORITY SINGLE STAINS.jpg"/>
                  <p:cNvPicPr/>
                  <p:nvPr/>
                </p:nvPicPr>
                <p:blipFill>
                  <a:blip r:embed="rId1"/>
                  <a:srcRect l="9151" t="21254" r="21699" b="32249"/>
                  <a:stretch/>
                </p:blipFill>
                <p:spPr>
                  <a:xfrm>
                    <a:off x="1182960" y="1081800"/>
                    <a:ext cx="2997360" cy="2148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740" name="TextBox 2"/>
                  <p:cNvSpPr/>
                  <p:nvPr/>
                </p:nvSpPr>
                <p:spPr>
                  <a:xfrm flipV="1" rot="5400000">
                    <a:off x="600120" y="1857600"/>
                    <a:ext cx="12193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632523"/>
                        </a:solidFill>
                        <a:latin typeface="Times New Roman"/>
                        <a:ea typeface="Times New Roman"/>
                      </a:rPr>
                      <a:t>Positive Cells(%)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741" name="Group 3"/>
                <p:cNvGrpSpPr/>
                <p:nvPr/>
              </p:nvGrpSpPr>
              <p:grpSpPr>
                <a:xfrm>
                  <a:off x="4432680" y="1081800"/>
                  <a:ext cx="2914200" cy="2512440"/>
                  <a:chOff x="4432680" y="1081800"/>
                  <a:chExt cx="2914200" cy="2512440"/>
                </a:xfrm>
              </p:grpSpPr>
              <p:pic>
                <p:nvPicPr>
                  <p:cNvPr id="742" name="Picture 3" descr="C:\Users\ELIZABETH\Desktop\FIRST PRIORITY DOUBLE STAINS.jpg"/>
                  <p:cNvPicPr/>
                  <p:nvPr/>
                </p:nvPicPr>
                <p:blipFill>
                  <a:blip r:embed="rId2"/>
                  <a:srcRect l="12205" t="23526" r="18460" b="25562"/>
                  <a:stretch/>
                </p:blipFill>
                <p:spPr>
                  <a:xfrm>
                    <a:off x="4649040" y="1081800"/>
                    <a:ext cx="2697840" cy="2512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743" name="TextBox 5"/>
                  <p:cNvSpPr/>
                  <p:nvPr/>
                </p:nvSpPr>
                <p:spPr>
                  <a:xfrm flipV="1" rot="5400000">
                    <a:off x="3930840" y="1852920"/>
                    <a:ext cx="12193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632523"/>
                        </a:solidFill>
                        <a:latin typeface="Times New Roman"/>
                        <a:ea typeface="Times New Roman"/>
                      </a:rPr>
                      <a:t>Positive Cells(%)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pic>
            <p:nvPicPr>
              <p:cNvPr id="744" name="Picture 32" descr="C:\Users\ELIZABETH\Desktop\SECOND PRIORITY SINGLE STAINS.jpg"/>
              <p:cNvPicPr/>
              <p:nvPr/>
            </p:nvPicPr>
            <p:blipFill>
              <a:blip r:embed="rId3"/>
              <a:srcRect l="71377" t="5908" r="0" b="80266"/>
              <a:stretch/>
            </p:blipFill>
            <p:spPr>
              <a:xfrm>
                <a:off x="3439440" y="756360"/>
                <a:ext cx="909720" cy="569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45" name="Picture 33" descr="C:\Users\ELIZABETH\Desktop\SECOND PRIORITY SINGLE STAINS.jpg"/>
              <p:cNvPicPr/>
              <p:nvPr/>
            </p:nvPicPr>
            <p:blipFill>
              <a:blip r:embed="rId4"/>
              <a:srcRect l="71377" t="5908" r="0" b="80266"/>
              <a:stretch/>
            </p:blipFill>
            <p:spPr>
              <a:xfrm>
                <a:off x="6573600" y="787680"/>
                <a:ext cx="909720" cy="56916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grpSp>
        <p:nvGrpSpPr>
          <p:cNvPr id="746" name="Group 12"/>
          <p:cNvGrpSpPr/>
          <p:nvPr/>
        </p:nvGrpSpPr>
        <p:grpSpPr>
          <a:xfrm>
            <a:off x="947880" y="6438960"/>
            <a:ext cx="5722920" cy="3603600"/>
            <a:chOff x="947880" y="6438960"/>
            <a:chExt cx="5722920" cy="3603600"/>
          </a:xfrm>
        </p:grpSpPr>
        <p:grpSp>
          <p:nvGrpSpPr>
            <p:cNvPr id="747" name="Group 7"/>
            <p:cNvGrpSpPr/>
            <p:nvPr/>
          </p:nvGrpSpPr>
          <p:grpSpPr>
            <a:xfrm>
              <a:off x="1482840" y="6958080"/>
              <a:ext cx="5187960" cy="3084480"/>
              <a:chOff x="1482840" y="6958080"/>
              <a:chExt cx="5187960" cy="3084480"/>
            </a:xfrm>
          </p:grpSpPr>
          <p:grpSp>
            <p:nvGrpSpPr>
              <p:cNvPr id="748" name="Group 6"/>
              <p:cNvGrpSpPr/>
              <p:nvPr/>
            </p:nvGrpSpPr>
            <p:grpSpPr>
              <a:xfrm>
                <a:off x="1482840" y="6958080"/>
                <a:ext cx="4564080" cy="3084480"/>
                <a:chOff x="1482840" y="6958080"/>
                <a:chExt cx="4564080" cy="3084480"/>
              </a:xfrm>
            </p:grpSpPr>
            <p:grpSp>
              <p:nvGrpSpPr>
                <p:cNvPr id="749" name="Group 12"/>
                <p:cNvGrpSpPr/>
                <p:nvPr/>
              </p:nvGrpSpPr>
              <p:grpSpPr>
                <a:xfrm>
                  <a:off x="1482840" y="7083360"/>
                  <a:ext cx="4441320" cy="2959200"/>
                  <a:chOff x="1482840" y="7083360"/>
                  <a:chExt cx="4441320" cy="2959200"/>
                </a:xfrm>
              </p:grpSpPr>
              <p:pic>
                <p:nvPicPr>
                  <p:cNvPr id="750" name="Picture 6" descr="C:\Users\ELIZABETH\Desktop\THIRD PRIORITY SINGLE STAINS.jpg"/>
                  <p:cNvPicPr/>
                  <p:nvPr/>
                </p:nvPicPr>
                <p:blipFill>
                  <a:blip r:embed="rId5"/>
                  <a:srcRect l="17588" t="21822" r="11581" b="27246"/>
                  <a:stretch/>
                </p:blipFill>
                <p:spPr>
                  <a:xfrm>
                    <a:off x="1796760" y="7083360"/>
                    <a:ext cx="4127400" cy="2959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751" name="TextBox 21"/>
                  <p:cNvSpPr/>
                  <p:nvPr/>
                </p:nvSpPr>
                <p:spPr>
                  <a:xfrm flipV="1" rot="5400000">
                    <a:off x="656280" y="7934760"/>
                    <a:ext cx="18684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632523"/>
                        </a:solidFill>
                        <a:latin typeface="Times New Roman"/>
                        <a:ea typeface="Times New Roman"/>
                      </a:rPr>
                      <a:t>Positive Cells(%)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752" name="Rectangle 4"/>
                <p:cNvSpPr/>
                <p:nvPr/>
              </p:nvSpPr>
              <p:spPr>
                <a:xfrm>
                  <a:off x="4569120" y="6958080"/>
                  <a:ext cx="1477800" cy="5158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753" name="Picture 30" descr="C:\Users\ELIZABETH\Desktop\SECOND PRIORITY SINGLE STAINS.jpg"/>
              <p:cNvPicPr/>
              <p:nvPr/>
            </p:nvPicPr>
            <p:blipFill>
              <a:blip r:embed="rId6"/>
              <a:srcRect l="71373" t="5911" r="0" b="80265"/>
              <a:stretch/>
            </p:blipFill>
            <p:spPr>
              <a:xfrm>
                <a:off x="5176800" y="6964200"/>
                <a:ext cx="1494000" cy="93420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754" name="Rectangle 20"/>
            <p:cNvSpPr/>
            <p:nvPr/>
          </p:nvSpPr>
          <p:spPr>
            <a:xfrm flipV="1" rot="10800000">
              <a:off x="947880" y="6438960"/>
              <a:ext cx="2216160" cy="390240"/>
            </a:xfrm>
            <a:prstGeom prst="rect">
              <a:avLst/>
            </a:prstGeom>
            <a:solidFill>
              <a:srgbClr val="993300">
                <a:alpha val="20000"/>
              </a:srgbClr>
            </a:solidFill>
            <a:ln cap="rnd" w="2520">
              <a:solidFill>
                <a:srgbClr val="993300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1000" spc="-1" strike="noStrike">
                  <a:solidFill>
                    <a:srgbClr val="632523"/>
                  </a:solidFill>
                  <a:latin typeface="Times New Roman"/>
                  <a:ea typeface="Times New Roman"/>
                </a:rPr>
                <a:t>Third-priority reference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55" name="Group 11"/>
          <p:cNvGrpSpPr/>
          <p:nvPr/>
        </p:nvGrpSpPr>
        <p:grpSpPr>
          <a:xfrm>
            <a:off x="934920" y="3303000"/>
            <a:ext cx="6383520" cy="3381840"/>
            <a:chOff x="934920" y="3303000"/>
            <a:chExt cx="6383520" cy="3381840"/>
          </a:xfrm>
        </p:grpSpPr>
        <p:grpSp>
          <p:nvGrpSpPr>
            <p:cNvPr id="756" name="Group 3"/>
            <p:cNvGrpSpPr/>
            <p:nvPr/>
          </p:nvGrpSpPr>
          <p:grpSpPr>
            <a:xfrm>
              <a:off x="1111320" y="3657240"/>
              <a:ext cx="6207120" cy="3027600"/>
              <a:chOff x="1111320" y="3657240"/>
              <a:chExt cx="6207120" cy="3027600"/>
            </a:xfrm>
          </p:grpSpPr>
          <p:grpSp>
            <p:nvGrpSpPr>
              <p:cNvPr id="757" name="Group 1"/>
              <p:cNvGrpSpPr/>
              <p:nvPr/>
            </p:nvGrpSpPr>
            <p:grpSpPr>
              <a:xfrm>
                <a:off x="1111320" y="3657240"/>
                <a:ext cx="3547800" cy="2565360"/>
                <a:chOff x="1111320" y="3657240"/>
                <a:chExt cx="3547800" cy="2565360"/>
              </a:xfrm>
            </p:grpSpPr>
            <p:pic>
              <p:nvPicPr>
                <p:cNvPr id="758" name="Picture 4" descr="C:\Users\ELIZABETH\Desktop\SECOND PRIORITY SINGLE STAINS.jpg"/>
                <p:cNvPicPr/>
                <p:nvPr/>
              </p:nvPicPr>
              <p:blipFill>
                <a:blip r:embed="rId7"/>
                <a:srcRect l="10263" t="18229" r="17996" b="36392"/>
                <a:stretch/>
              </p:blipFill>
              <p:spPr>
                <a:xfrm>
                  <a:off x="1173960" y="4259520"/>
                  <a:ext cx="2533320" cy="196308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759" name="Group 9"/>
                <p:cNvGrpSpPr/>
                <p:nvPr/>
              </p:nvGrpSpPr>
              <p:grpSpPr>
                <a:xfrm>
                  <a:off x="1111320" y="4342680"/>
                  <a:ext cx="3547800" cy="1357200"/>
                  <a:chOff x="1111320" y="4342680"/>
                  <a:chExt cx="3547800" cy="1357200"/>
                </a:xfrm>
              </p:grpSpPr>
              <p:sp>
                <p:nvSpPr>
                  <p:cNvPr id="760" name="TextBox 10"/>
                  <p:cNvSpPr/>
                  <p:nvPr/>
                </p:nvSpPr>
                <p:spPr>
                  <a:xfrm flipV="1" rot="5400000">
                    <a:off x="609480" y="4844160"/>
                    <a:ext cx="12193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632523"/>
                        </a:solidFill>
                        <a:latin typeface="Times New Roman"/>
                        <a:ea typeface="Times New Roman"/>
                      </a:rPr>
                      <a:t>Positive Cells(%)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1" name="TextBox 13"/>
                  <p:cNvSpPr/>
                  <p:nvPr/>
                </p:nvSpPr>
                <p:spPr>
                  <a:xfrm flipV="1" rot="5400000">
                    <a:off x="3941640" y="4982040"/>
                    <a:ext cx="12193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800" spc="-1" strike="noStrike">
                        <a:solidFill>
                          <a:srgbClr val="632523"/>
                        </a:solidFill>
                        <a:latin typeface="Times New Roman"/>
                        <a:ea typeface="Times New Roman"/>
                      </a:rPr>
                      <a:t>Positive Cells(%)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pic>
              <p:nvPicPr>
                <p:cNvPr id="762" name="Picture 23" descr="C:\Users\ELIZABETH\Desktop\SECOND PRIORITY SINGLE STAINS.jpg"/>
                <p:cNvPicPr/>
                <p:nvPr/>
              </p:nvPicPr>
              <p:blipFill>
                <a:blip r:embed="rId8"/>
                <a:srcRect l="71377" t="5908" r="0" b="80266"/>
                <a:stretch/>
              </p:blipFill>
              <p:spPr>
                <a:xfrm>
                  <a:off x="2984760" y="3657240"/>
                  <a:ext cx="910080" cy="5688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pic>
            <p:nvPicPr>
              <p:cNvPr id="763" name="Picture 5" descr="C:\Users\ELIZABETH\Desktop\SECOND PRIORITY DOUBLE STAINS.jpg"/>
              <p:cNvPicPr/>
              <p:nvPr/>
            </p:nvPicPr>
            <p:blipFill>
              <a:blip r:embed="rId9"/>
              <a:srcRect l="10262" t="21718" r="11210" b="25660"/>
              <a:stretch/>
            </p:blipFill>
            <p:spPr>
              <a:xfrm>
                <a:off x="4631040" y="4226040"/>
                <a:ext cx="2561040" cy="2458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64" name="Picture 26" descr="C:\Users\ELIZABETH\Desktop\SECOND PRIORITY SINGLE STAINS.jpg"/>
              <p:cNvPicPr/>
              <p:nvPr/>
            </p:nvPicPr>
            <p:blipFill>
              <a:blip r:embed="rId10"/>
              <a:srcRect l="71377" t="5908" r="0" b="80266"/>
              <a:stretch/>
            </p:blipFill>
            <p:spPr>
              <a:xfrm>
                <a:off x="6408360" y="3663720"/>
                <a:ext cx="910080" cy="56880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765" name="Rectangle 19"/>
            <p:cNvSpPr/>
            <p:nvPr/>
          </p:nvSpPr>
          <p:spPr>
            <a:xfrm flipV="1" rot="10800000">
              <a:off x="934920" y="3302640"/>
              <a:ext cx="2216160" cy="360360"/>
            </a:xfrm>
            <a:prstGeom prst="rect">
              <a:avLst/>
            </a:prstGeom>
            <a:solidFill>
              <a:srgbClr val="006666">
                <a:alpha val="30000"/>
              </a:srgbClr>
            </a:solidFill>
            <a:ln cap="rnd" w="2520">
              <a:solidFill>
                <a:srgbClr val="006666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1000" spc="-1" strike="noStrike">
                  <a:solidFill>
                    <a:srgbClr val="632523"/>
                  </a:solidFill>
                  <a:latin typeface="Times New Roman"/>
                  <a:ea typeface="Times New Roman"/>
                </a:rPr>
                <a:t>Second-priority reference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66" name="Group 116"/>
          <p:cNvGrpSpPr/>
          <p:nvPr/>
        </p:nvGrpSpPr>
        <p:grpSpPr>
          <a:xfrm>
            <a:off x="438120" y="538200"/>
            <a:ext cx="2954520" cy="1823040"/>
            <a:chOff x="438120" y="538200"/>
            <a:chExt cx="2954520" cy="1823040"/>
          </a:xfrm>
        </p:grpSpPr>
        <p:grpSp>
          <p:nvGrpSpPr>
            <p:cNvPr id="767" name="Group 68"/>
            <p:cNvGrpSpPr/>
            <p:nvPr/>
          </p:nvGrpSpPr>
          <p:grpSpPr>
            <a:xfrm>
              <a:off x="438120" y="538200"/>
              <a:ext cx="2378520" cy="1329480"/>
              <a:chOff x="438120" y="538200"/>
              <a:chExt cx="2378520" cy="1329480"/>
            </a:xfrm>
          </p:grpSpPr>
          <p:grpSp>
            <p:nvGrpSpPr>
              <p:cNvPr id="768" name="Group 250"/>
              <p:cNvGrpSpPr/>
              <p:nvPr/>
            </p:nvGrpSpPr>
            <p:grpSpPr>
              <a:xfrm>
                <a:off x="861840" y="558720"/>
                <a:ext cx="1954800" cy="1308960"/>
                <a:chOff x="861840" y="558720"/>
                <a:chExt cx="1954800" cy="1308960"/>
              </a:xfrm>
            </p:grpSpPr>
            <p:grpSp>
              <p:nvGrpSpPr>
                <p:cNvPr id="769" name="Group 7196"/>
                <p:cNvGrpSpPr/>
                <p:nvPr/>
              </p:nvGrpSpPr>
              <p:grpSpPr>
                <a:xfrm>
                  <a:off x="863280" y="558720"/>
                  <a:ext cx="1953360" cy="1308960"/>
                  <a:chOff x="863280" y="558720"/>
                  <a:chExt cx="1953360" cy="1308960"/>
                </a:xfrm>
              </p:grpSpPr>
              <p:pic>
                <p:nvPicPr>
                  <p:cNvPr id="770" name="Straight Arrow Connector 17" descr=""/>
                  <p:cNvPicPr/>
                  <p:nvPr/>
                </p:nvPicPr>
                <p:blipFill>
                  <a:blip r:embed="rId1"/>
                  <a:stretch/>
                </p:blipFill>
                <p:spPr>
                  <a:xfrm>
                    <a:off x="1756080" y="822600"/>
                    <a:ext cx="163440" cy="322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771" name="Straight Arrow Connector 18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210760" y="828720"/>
                    <a:ext cx="357480" cy="268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772" name="Straight Arrow Connector 19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1077120" y="828720"/>
                    <a:ext cx="351360" cy="262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773" name="Straight Arrow Connector 20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749960" y="1578960"/>
                    <a:ext cx="157320" cy="255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774" name="TextBox 532"/>
                  <p:cNvSpPr/>
                  <p:nvPr/>
                </p:nvSpPr>
                <p:spPr>
                  <a:xfrm>
                    <a:off x="1234080" y="558720"/>
                    <a:ext cx="1216800" cy="276840"/>
                  </a:xfrm>
                  <a:prstGeom prst="rect">
                    <a:avLst/>
                  </a:prstGeom>
                  <a:noFill/>
                  <a:ln w="9360">
                    <a:solidFill>
                      <a:srgbClr val="de006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600" spc="-1" strike="noStrike">
                        <a:solidFill>
                          <a:srgbClr val="de006f"/>
                        </a:solidFill>
                        <a:latin typeface="Arial"/>
                        <a:ea typeface="Arial"/>
                      </a:rPr>
                      <a:t>Median Effective Dose of Carboplatin (2 µM)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5" name="TextBox 180"/>
                  <p:cNvSpPr/>
                  <p:nvPr/>
                </p:nvSpPr>
                <p:spPr>
                  <a:xfrm>
                    <a:off x="1033920" y="1682280"/>
                    <a:ext cx="168588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600" spc="-1" strike="noStrike">
                        <a:solidFill>
                          <a:srgbClr val="800080"/>
                        </a:solidFill>
                        <a:latin typeface="Arial"/>
                        <a:ea typeface="Arial"/>
                      </a:rPr>
                      <a:t>Drug Response Assessment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grpSp>
                <p:nvGrpSpPr>
                  <p:cNvPr id="776" name="Group 19"/>
                  <p:cNvGrpSpPr/>
                  <p:nvPr/>
                </p:nvGrpSpPr>
                <p:grpSpPr>
                  <a:xfrm>
                    <a:off x="863280" y="1058760"/>
                    <a:ext cx="1941480" cy="277920"/>
                    <a:chOff x="863280" y="1058760"/>
                    <a:chExt cx="1941480" cy="277920"/>
                  </a:xfrm>
                </p:grpSpPr>
                <p:grpSp>
                  <p:nvGrpSpPr>
                    <p:cNvPr id="777" name="Group 543"/>
                    <p:cNvGrpSpPr/>
                    <p:nvPr/>
                  </p:nvGrpSpPr>
                  <p:grpSpPr>
                    <a:xfrm>
                      <a:off x="863280" y="1058760"/>
                      <a:ext cx="593640" cy="277920"/>
                      <a:chOff x="863280" y="1058760"/>
                      <a:chExt cx="593640" cy="277920"/>
                    </a:xfrm>
                  </p:grpSpPr>
                  <p:grpSp>
                    <p:nvGrpSpPr>
                      <p:cNvPr id="778" name="Rectangle 65"/>
                      <p:cNvGrpSpPr/>
                      <p:nvPr/>
                    </p:nvGrpSpPr>
                    <p:grpSpPr>
                      <a:xfrm>
                        <a:off x="865080" y="1177200"/>
                        <a:ext cx="591840" cy="159480"/>
                        <a:chOff x="865080" y="1177200"/>
                        <a:chExt cx="591840" cy="159480"/>
                      </a:xfrm>
                    </p:grpSpPr>
                    <p:pic>
                      <p:nvPicPr>
                        <p:cNvPr id="779" name="Rectangle 65" descr=""/>
                        <p:cNvPicPr/>
                        <p:nvPr/>
                      </p:nvPicPr>
                      <p:blipFill>
                        <a:blip r:embed="rId5"/>
                        <a:stretch/>
                      </p:blipFill>
                      <p:spPr>
                        <a:xfrm>
                          <a:off x="866520" y="1177200"/>
                          <a:ext cx="590400" cy="15804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780" name=""/>
                        <p:cNvSpPr/>
                        <p:nvPr/>
                      </p:nvSpPr>
                      <p:spPr>
                        <a:xfrm>
                          <a:off x="865080" y="1179360"/>
                          <a:ext cx="589680" cy="15732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grpSp>
                    <p:nvGrpSpPr>
                      <p:cNvPr id="781" name="Group 366"/>
                      <p:cNvGrpSpPr/>
                      <p:nvPr/>
                    </p:nvGrpSpPr>
                    <p:grpSpPr>
                      <a:xfrm>
                        <a:off x="863280" y="1058760"/>
                        <a:ext cx="591480" cy="277920"/>
                        <a:chOff x="863280" y="1058760"/>
                        <a:chExt cx="591480" cy="277920"/>
                      </a:xfrm>
                    </p:grpSpPr>
                    <p:sp>
                      <p:nvSpPr>
                        <p:cNvPr id="782" name="Oval 77"/>
                        <p:cNvSpPr/>
                        <p:nvPr/>
                      </p:nvSpPr>
                      <p:spPr>
                        <a:xfrm>
                          <a:off x="863280" y="1058760"/>
                          <a:ext cx="588600" cy="94320"/>
                        </a:xfrm>
                        <a:prstGeom prst="ellipse">
                          <a:avLst/>
                        </a:prstGeom>
                        <a:gradFill rotWithShape="0">
                          <a:gsLst>
                            <a:gs pos="0">
                              <a:srgbClr val="93cddd">
                                <a:alpha val="10196"/>
                              </a:srgbClr>
                            </a:gs>
                            <a:gs pos="100000">
                              <a:srgbClr val="b7dee8"/>
                            </a:gs>
                          </a:gsLst>
                          <a:lin ang="5400000"/>
                        </a:gradFill>
                        <a:ln w="12600">
                          <a:solidFill>
                            <a:srgbClr val="10253f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20160" bIns="2016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783" name="Straight Connector 78"/>
                        <p:cNvSpPr/>
                        <p:nvPr/>
                      </p:nvSpPr>
                      <p:spPr>
                        <a:xfrm>
                          <a:off x="863280" y="1106640"/>
                          <a:ext cx="0" cy="228600"/>
                        </a:xfrm>
                        <a:prstGeom prst="line">
                          <a:avLst/>
                        </a:prstGeom>
                        <a:ln w="12600">
                          <a:solidFill>
                            <a:srgbClr val="10253f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t">
                          <a:noAutofit/>
                        </a:bodyPr>
                        <a:p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784" name="Straight Connector 79"/>
                        <p:cNvSpPr/>
                        <p:nvPr/>
                      </p:nvSpPr>
                      <p:spPr>
                        <a:xfrm>
                          <a:off x="1454760" y="1114560"/>
                          <a:ext cx="0" cy="222120"/>
                        </a:xfrm>
                        <a:prstGeom prst="line">
                          <a:avLst/>
                        </a:prstGeom>
                        <a:ln w="12600">
                          <a:solidFill>
                            <a:srgbClr val="10253f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t">
                          <a:noAutofit/>
                        </a:bodyPr>
                        <a:p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sp>
                    <p:nvSpPr>
                      <p:cNvPr id="785" name="Oval 67"/>
                      <p:cNvSpPr/>
                      <p:nvPr/>
                    </p:nvSpPr>
                    <p:spPr>
                      <a:xfrm>
                        <a:off x="951120" y="1202400"/>
                        <a:ext cx="132120" cy="94320"/>
                      </a:xfrm>
                      <a:prstGeom prst="ellipse">
                        <a:avLst/>
                      </a:prstGeom>
                      <a:gradFill rotWithShape="0">
                        <a:gsLst>
                          <a:gs pos="0">
                            <a:srgbClr val="215968">
                              <a:alpha val="20000"/>
                            </a:srgbClr>
                          </a:gs>
                          <a:gs pos="100000">
                            <a:srgbClr val="d9d9d9"/>
                          </a:gs>
                        </a:gsLst>
                        <a:lin ang="5400000"/>
                      </a:gradFill>
                      <a:ln w="3240">
                        <a:solidFill>
                          <a:srgbClr val="1f497d"/>
                        </a:solidFill>
                        <a:prstDash val="sysDot"/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20160" bIns="2016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786" name="Oval 68"/>
                      <p:cNvSpPr/>
                      <p:nvPr/>
                    </p:nvSpPr>
                    <p:spPr>
                      <a:xfrm>
                        <a:off x="981000" y="1226520"/>
                        <a:ext cx="69120" cy="46080"/>
                      </a:xfrm>
                      <a:prstGeom prst="ellipse">
                        <a:avLst/>
                      </a:prstGeom>
                      <a:solidFill>
                        <a:srgbClr val="14374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3680" bIns="-1368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787" name="Oval 69"/>
                      <p:cNvSpPr/>
                      <p:nvPr/>
                    </p:nvSpPr>
                    <p:spPr>
                      <a:xfrm>
                        <a:off x="1105200" y="1202400"/>
                        <a:ext cx="109800" cy="94320"/>
                      </a:xfrm>
                      <a:prstGeom prst="ellipse">
                        <a:avLst/>
                      </a:prstGeom>
                      <a:gradFill rotWithShape="0">
                        <a:gsLst>
                          <a:gs pos="0">
                            <a:srgbClr val="215968">
                              <a:alpha val="20000"/>
                            </a:srgbClr>
                          </a:gs>
                          <a:gs pos="100000">
                            <a:srgbClr val="d9d9d9"/>
                          </a:gs>
                        </a:gsLst>
                        <a:lin ang="5400000"/>
                      </a:gradFill>
                      <a:ln w="3240">
                        <a:solidFill>
                          <a:srgbClr val="1f497d"/>
                        </a:solidFill>
                        <a:prstDash val="sysDot"/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20160" bIns="2016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788" name="Oval 70"/>
                      <p:cNvSpPr/>
                      <p:nvPr/>
                    </p:nvSpPr>
                    <p:spPr>
                      <a:xfrm>
                        <a:off x="1128960" y="1226520"/>
                        <a:ext cx="56520" cy="46080"/>
                      </a:xfrm>
                      <a:prstGeom prst="ellipse">
                        <a:avLst/>
                      </a:prstGeom>
                      <a:solidFill>
                        <a:srgbClr val="14374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3680" bIns="-1368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789" name="Oval 71"/>
                      <p:cNvSpPr/>
                      <p:nvPr/>
                    </p:nvSpPr>
                    <p:spPr>
                      <a:xfrm>
                        <a:off x="1237320" y="1194480"/>
                        <a:ext cx="128880" cy="100440"/>
                      </a:xfrm>
                      <a:prstGeom prst="ellipse">
                        <a:avLst/>
                      </a:prstGeom>
                      <a:gradFill rotWithShape="0">
                        <a:gsLst>
                          <a:gs pos="0">
                            <a:srgbClr val="215968">
                              <a:alpha val="20000"/>
                            </a:srgbClr>
                          </a:gs>
                          <a:gs pos="100000">
                            <a:srgbClr val="d9d9d9"/>
                          </a:gs>
                        </a:gsLst>
                        <a:lin ang="5400000"/>
                      </a:gradFill>
                      <a:ln w="3240">
                        <a:solidFill>
                          <a:srgbClr val="1f497d"/>
                        </a:solidFill>
                        <a:prstDash val="sysDot"/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24120" bIns="2412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790" name="Oval 72"/>
                      <p:cNvSpPr/>
                      <p:nvPr/>
                    </p:nvSpPr>
                    <p:spPr>
                      <a:xfrm>
                        <a:off x="1270440" y="1220040"/>
                        <a:ext cx="64440" cy="51120"/>
                      </a:xfrm>
                      <a:prstGeom prst="ellipse">
                        <a:avLst/>
                      </a:prstGeom>
                      <a:solidFill>
                        <a:srgbClr val="14374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0080" bIns="-1008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791" name="Oval 73"/>
                      <p:cNvSpPr/>
                      <p:nvPr/>
                    </p:nvSpPr>
                    <p:spPr>
                      <a:xfrm>
                        <a:off x="1172880" y="1189800"/>
                        <a:ext cx="127080" cy="92520"/>
                      </a:xfrm>
                      <a:prstGeom prst="ellipse">
                        <a:avLst/>
                      </a:prstGeom>
                      <a:gradFill rotWithShape="0">
                        <a:gsLst>
                          <a:gs pos="0">
                            <a:srgbClr val="215968">
                              <a:alpha val="20000"/>
                            </a:srgbClr>
                          </a:gs>
                          <a:gs pos="100000">
                            <a:srgbClr val="d9d9d9"/>
                          </a:gs>
                        </a:gsLst>
                        <a:lin ang="5400000"/>
                      </a:gradFill>
                      <a:ln w="3240">
                        <a:solidFill>
                          <a:srgbClr val="1f497d"/>
                        </a:solidFill>
                        <a:prstDash val="sysDot"/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19080" bIns="1908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792" name="Oval 74"/>
                      <p:cNvSpPr/>
                      <p:nvPr/>
                    </p:nvSpPr>
                    <p:spPr>
                      <a:xfrm>
                        <a:off x="1206000" y="1212120"/>
                        <a:ext cx="61200" cy="47880"/>
                      </a:xfrm>
                      <a:prstGeom prst="ellipse">
                        <a:avLst/>
                      </a:prstGeom>
                      <a:solidFill>
                        <a:srgbClr val="14374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2600" bIns="-1260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793" name="Oval 75"/>
                      <p:cNvSpPr/>
                      <p:nvPr/>
                    </p:nvSpPr>
                    <p:spPr>
                      <a:xfrm>
                        <a:off x="1020240" y="1188000"/>
                        <a:ext cx="109800" cy="89280"/>
                      </a:xfrm>
                      <a:prstGeom prst="ellipse">
                        <a:avLst/>
                      </a:prstGeom>
                      <a:gradFill rotWithShape="0">
                        <a:gsLst>
                          <a:gs pos="0">
                            <a:srgbClr val="215968">
                              <a:alpha val="20000"/>
                            </a:srgbClr>
                          </a:gs>
                          <a:gs pos="100000">
                            <a:srgbClr val="d9d9d9"/>
                          </a:gs>
                        </a:gsLst>
                        <a:lin ang="5400000"/>
                      </a:gradFill>
                      <a:ln w="3240">
                        <a:solidFill>
                          <a:srgbClr val="1f497d"/>
                        </a:solidFill>
                        <a:prstDash val="sysDot"/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16560" bIns="1656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794" name="Oval 76"/>
                      <p:cNvSpPr/>
                      <p:nvPr/>
                    </p:nvSpPr>
                    <p:spPr>
                      <a:xfrm>
                        <a:off x="1051920" y="1210680"/>
                        <a:ext cx="64440" cy="47880"/>
                      </a:xfrm>
                      <a:prstGeom prst="ellipse">
                        <a:avLst/>
                      </a:prstGeom>
                      <a:solidFill>
                        <a:srgbClr val="14374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2600" bIns="-1260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grpSp>
                  <p:nvGrpSpPr>
                    <p:cNvPr id="795" name="Group 543"/>
                    <p:cNvGrpSpPr/>
                    <p:nvPr/>
                  </p:nvGrpSpPr>
                  <p:grpSpPr>
                    <a:xfrm>
                      <a:off x="1521360" y="1060920"/>
                      <a:ext cx="616320" cy="263160"/>
                      <a:chOff x="1521360" y="1060920"/>
                      <a:chExt cx="616320" cy="263160"/>
                    </a:xfrm>
                  </p:grpSpPr>
                  <p:grpSp>
                    <p:nvGrpSpPr>
                      <p:cNvPr id="796" name="Rectangle 49"/>
                      <p:cNvGrpSpPr/>
                      <p:nvPr/>
                    </p:nvGrpSpPr>
                    <p:grpSpPr>
                      <a:xfrm>
                        <a:off x="1521360" y="1182600"/>
                        <a:ext cx="616320" cy="140400"/>
                        <a:chOff x="1521360" y="1182600"/>
                        <a:chExt cx="616320" cy="140400"/>
                      </a:xfrm>
                    </p:grpSpPr>
                    <p:pic>
                      <p:nvPicPr>
                        <p:cNvPr id="797" name="Rectangle 49" descr=""/>
                        <p:cNvPicPr/>
                        <p:nvPr/>
                      </p:nvPicPr>
                      <p:blipFill>
                        <a:blip r:embed="rId6"/>
                        <a:stretch/>
                      </p:blipFill>
                      <p:spPr>
                        <a:xfrm>
                          <a:off x="1521360" y="1182600"/>
                          <a:ext cx="616320" cy="13968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798" name=""/>
                        <p:cNvSpPr/>
                        <p:nvPr/>
                      </p:nvSpPr>
                      <p:spPr>
                        <a:xfrm>
                          <a:off x="1522800" y="1183680"/>
                          <a:ext cx="614520" cy="13932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grpSp>
                    <p:nvGrpSpPr>
                      <p:cNvPr id="799" name="Group 366"/>
                      <p:cNvGrpSpPr/>
                      <p:nvPr/>
                    </p:nvGrpSpPr>
                    <p:grpSpPr>
                      <a:xfrm>
                        <a:off x="1535040" y="1060920"/>
                        <a:ext cx="602280" cy="263160"/>
                        <a:chOff x="1535040" y="1060920"/>
                        <a:chExt cx="602280" cy="263160"/>
                      </a:xfrm>
                    </p:grpSpPr>
                    <p:sp>
                      <p:nvSpPr>
                        <p:cNvPr id="800" name="Oval 61"/>
                        <p:cNvSpPr/>
                        <p:nvPr/>
                      </p:nvSpPr>
                      <p:spPr>
                        <a:xfrm>
                          <a:off x="1535040" y="1060920"/>
                          <a:ext cx="602280" cy="99720"/>
                        </a:xfrm>
                        <a:prstGeom prst="ellipse">
                          <a:avLst/>
                        </a:prstGeom>
                        <a:gradFill rotWithShape="0">
                          <a:gsLst>
                            <a:gs pos="0">
                              <a:srgbClr val="93cddd">
                                <a:alpha val="10196"/>
                              </a:srgbClr>
                            </a:gs>
                            <a:gs pos="100000">
                              <a:srgbClr val="b7dee8"/>
                            </a:gs>
                          </a:gsLst>
                          <a:lin ang="5400000"/>
                        </a:gradFill>
                        <a:ln w="12600">
                          <a:solidFill>
                            <a:srgbClr val="10253f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24120" bIns="2412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801" name="Straight Connector 62"/>
                        <p:cNvSpPr/>
                        <p:nvPr/>
                      </p:nvSpPr>
                      <p:spPr>
                        <a:xfrm>
                          <a:off x="1535040" y="1109880"/>
                          <a:ext cx="0" cy="210960"/>
                        </a:xfrm>
                        <a:prstGeom prst="line">
                          <a:avLst/>
                        </a:prstGeom>
                        <a:ln w="12600">
                          <a:solidFill>
                            <a:srgbClr val="10253f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t">
                          <a:noAutofit/>
                        </a:bodyPr>
                        <a:p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802" name="Straight Connector 63"/>
                        <p:cNvSpPr/>
                        <p:nvPr/>
                      </p:nvSpPr>
                      <p:spPr>
                        <a:xfrm>
                          <a:off x="2137320" y="1109880"/>
                          <a:ext cx="0" cy="210960"/>
                        </a:xfrm>
                        <a:prstGeom prst="line">
                          <a:avLst/>
                        </a:prstGeom>
                        <a:ln w="12600">
                          <a:solidFill>
                            <a:srgbClr val="10253f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t">
                          <a:noAutofit/>
                        </a:bodyPr>
                        <a:p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803" name="Straight Connector 64"/>
                        <p:cNvSpPr/>
                        <p:nvPr/>
                      </p:nvSpPr>
                      <p:spPr>
                        <a:xfrm>
                          <a:off x="1535040" y="1324080"/>
                          <a:ext cx="602280" cy="0"/>
                        </a:xfrm>
                        <a:prstGeom prst="line">
                          <a:avLst/>
                        </a:prstGeom>
                        <a:ln w="12600">
                          <a:solidFill>
                            <a:srgbClr val="10253f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-46800" bIns="-46800" anchor="t">
                          <a:noAutofit/>
                        </a:bodyPr>
                        <a:p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grpSp>
                    <p:nvGrpSpPr>
                      <p:cNvPr id="804" name="Oval 51"/>
                      <p:cNvGrpSpPr/>
                      <p:nvPr/>
                    </p:nvGrpSpPr>
                    <p:grpSpPr>
                      <a:xfrm>
                        <a:off x="1623960" y="1207080"/>
                        <a:ext cx="132840" cy="97560"/>
                        <a:chOff x="1623960" y="1207080"/>
                        <a:chExt cx="132840" cy="97560"/>
                      </a:xfrm>
                    </p:grpSpPr>
                    <p:pic>
                      <p:nvPicPr>
                        <p:cNvPr id="805" name="Oval 51" descr=""/>
                        <p:cNvPicPr/>
                        <p:nvPr/>
                      </p:nvPicPr>
                      <p:blipFill>
                        <a:blip r:embed="rId7"/>
                        <a:stretch/>
                      </p:blipFill>
                      <p:spPr>
                        <a:xfrm>
                          <a:off x="1623960" y="1207080"/>
                          <a:ext cx="132840" cy="9756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806" name=""/>
                        <p:cNvSpPr/>
                        <p:nvPr/>
                      </p:nvSpPr>
                      <p:spPr>
                        <a:xfrm>
                          <a:off x="1640520" y="1220400"/>
                          <a:ext cx="91800" cy="6516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18360" bIns="1836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sp>
                    <p:nvSpPr>
                      <p:cNvPr id="807" name="Oval 52"/>
                      <p:cNvSpPr/>
                      <p:nvPr/>
                    </p:nvSpPr>
                    <p:spPr>
                      <a:xfrm>
                        <a:off x="1636200" y="1233720"/>
                        <a:ext cx="64440" cy="46080"/>
                      </a:xfrm>
                      <a:prstGeom prst="ellipse">
                        <a:avLst/>
                      </a:prstGeom>
                      <a:solidFill>
                        <a:srgbClr val="00b05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3680" bIns="-1368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grpSp>
                    <p:nvGrpSpPr>
                      <p:cNvPr id="808" name="Oval 53"/>
                      <p:cNvGrpSpPr/>
                      <p:nvPr/>
                    </p:nvGrpSpPr>
                    <p:grpSpPr>
                      <a:xfrm>
                        <a:off x="1769040" y="1207080"/>
                        <a:ext cx="138960" cy="97560"/>
                        <a:chOff x="1769040" y="1207080"/>
                        <a:chExt cx="138960" cy="97560"/>
                      </a:xfrm>
                    </p:grpSpPr>
                    <p:pic>
                      <p:nvPicPr>
                        <p:cNvPr id="809" name="Oval 53" descr=""/>
                        <p:cNvPicPr/>
                        <p:nvPr/>
                      </p:nvPicPr>
                      <p:blipFill>
                        <a:blip r:embed="rId8"/>
                        <a:stretch/>
                      </p:blipFill>
                      <p:spPr>
                        <a:xfrm>
                          <a:off x="1769040" y="1207080"/>
                          <a:ext cx="138960" cy="9756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810" name=""/>
                        <p:cNvSpPr/>
                        <p:nvPr/>
                      </p:nvSpPr>
                      <p:spPr>
                        <a:xfrm>
                          <a:off x="1790640" y="1220400"/>
                          <a:ext cx="90720" cy="6516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18360" bIns="1836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sp>
                    <p:nvSpPr>
                      <p:cNvPr id="811" name="Oval 54"/>
                      <p:cNvSpPr/>
                      <p:nvPr/>
                    </p:nvSpPr>
                    <p:spPr>
                      <a:xfrm>
                        <a:off x="1787400" y="1233720"/>
                        <a:ext cx="64440" cy="46080"/>
                      </a:xfrm>
                      <a:prstGeom prst="ellipse">
                        <a:avLst/>
                      </a:prstGeom>
                      <a:solidFill>
                        <a:srgbClr val="00b05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3680" bIns="-1368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grpSp>
                    <p:nvGrpSpPr>
                      <p:cNvPr id="812" name="Oval 55"/>
                      <p:cNvGrpSpPr/>
                      <p:nvPr/>
                    </p:nvGrpSpPr>
                    <p:grpSpPr>
                      <a:xfrm>
                        <a:off x="1920240" y="1200960"/>
                        <a:ext cx="138960" cy="103680"/>
                        <a:chOff x="1920240" y="1200960"/>
                        <a:chExt cx="138960" cy="103680"/>
                      </a:xfrm>
                    </p:grpSpPr>
                    <p:pic>
                      <p:nvPicPr>
                        <p:cNvPr id="813" name="Oval 55" descr=""/>
                        <p:cNvPicPr/>
                        <p:nvPr/>
                      </p:nvPicPr>
                      <p:blipFill>
                        <a:blip r:embed="rId9"/>
                        <a:stretch/>
                      </p:blipFill>
                      <p:spPr>
                        <a:xfrm>
                          <a:off x="1920240" y="1200960"/>
                          <a:ext cx="138960" cy="10368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814" name=""/>
                        <p:cNvSpPr/>
                        <p:nvPr/>
                      </p:nvSpPr>
                      <p:spPr>
                        <a:xfrm>
                          <a:off x="1941480" y="1212840"/>
                          <a:ext cx="91800" cy="6984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23040" bIns="2304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sp>
                    <p:nvSpPr>
                      <p:cNvPr id="815" name="Oval 56"/>
                      <p:cNvSpPr/>
                      <p:nvPr/>
                    </p:nvSpPr>
                    <p:spPr>
                      <a:xfrm>
                        <a:off x="1938240" y="1225800"/>
                        <a:ext cx="62640" cy="52200"/>
                      </a:xfrm>
                      <a:prstGeom prst="ellipse">
                        <a:avLst/>
                      </a:prstGeom>
                      <a:solidFill>
                        <a:srgbClr val="00b05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9720" bIns="-972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grpSp>
                    <p:nvGrpSpPr>
                      <p:cNvPr id="816" name="Oval 57"/>
                      <p:cNvGrpSpPr/>
                      <p:nvPr/>
                    </p:nvGrpSpPr>
                    <p:grpSpPr>
                      <a:xfrm>
                        <a:off x="1859760" y="1194840"/>
                        <a:ext cx="132840" cy="97560"/>
                        <a:chOff x="1859760" y="1194840"/>
                        <a:chExt cx="132840" cy="97560"/>
                      </a:xfrm>
                    </p:grpSpPr>
                    <p:pic>
                      <p:nvPicPr>
                        <p:cNvPr id="817" name="Oval 57" descr=""/>
                        <p:cNvPicPr/>
                        <p:nvPr/>
                      </p:nvPicPr>
                      <p:blipFill>
                        <a:blip r:embed="rId10"/>
                        <a:stretch/>
                      </p:blipFill>
                      <p:spPr>
                        <a:xfrm>
                          <a:off x="1859760" y="1194840"/>
                          <a:ext cx="132840" cy="9756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818" name=""/>
                        <p:cNvSpPr/>
                        <p:nvPr/>
                      </p:nvSpPr>
                      <p:spPr>
                        <a:xfrm>
                          <a:off x="1875600" y="1207800"/>
                          <a:ext cx="91800" cy="6516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18360" bIns="1836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sp>
                    <p:nvSpPr>
                      <p:cNvPr id="819" name="Oval 58"/>
                      <p:cNvSpPr/>
                      <p:nvPr/>
                    </p:nvSpPr>
                    <p:spPr>
                      <a:xfrm>
                        <a:off x="1872360" y="1219320"/>
                        <a:ext cx="62640" cy="47520"/>
                      </a:xfrm>
                      <a:prstGeom prst="ellipse">
                        <a:avLst/>
                      </a:prstGeom>
                      <a:solidFill>
                        <a:srgbClr val="00b05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2960" bIns="-1296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grpSp>
                    <p:nvGrpSpPr>
                      <p:cNvPr id="820" name="Oval 59"/>
                      <p:cNvGrpSpPr/>
                      <p:nvPr/>
                    </p:nvGrpSpPr>
                    <p:grpSpPr>
                      <a:xfrm>
                        <a:off x="1684440" y="1194840"/>
                        <a:ext cx="138960" cy="91440"/>
                        <a:chOff x="1684440" y="1194840"/>
                        <a:chExt cx="138960" cy="91440"/>
                      </a:xfrm>
                    </p:grpSpPr>
                    <p:pic>
                      <p:nvPicPr>
                        <p:cNvPr id="821" name="Oval 59" descr=""/>
                        <p:cNvPicPr/>
                        <p:nvPr/>
                      </p:nvPicPr>
                      <p:blipFill>
                        <a:blip r:embed="rId11"/>
                        <a:stretch/>
                      </p:blipFill>
                      <p:spPr>
                        <a:xfrm>
                          <a:off x="1684440" y="1194840"/>
                          <a:ext cx="138960" cy="9144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822" name=""/>
                        <p:cNvSpPr/>
                        <p:nvPr/>
                      </p:nvSpPr>
                      <p:spPr>
                        <a:xfrm>
                          <a:off x="1705680" y="1206000"/>
                          <a:ext cx="90000" cy="6300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16200" bIns="1620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sp>
                    <p:nvSpPr>
                      <p:cNvPr id="823" name="Oval 60"/>
                      <p:cNvSpPr/>
                      <p:nvPr/>
                    </p:nvSpPr>
                    <p:spPr>
                      <a:xfrm>
                        <a:off x="1702080" y="1217880"/>
                        <a:ext cx="64440" cy="47520"/>
                      </a:xfrm>
                      <a:prstGeom prst="ellipse">
                        <a:avLst/>
                      </a:prstGeom>
                      <a:solidFill>
                        <a:srgbClr val="00b05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2960" bIns="-1296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grpSp>
                  <p:nvGrpSpPr>
                    <p:cNvPr id="824" name="Group 543"/>
                    <p:cNvGrpSpPr/>
                    <p:nvPr/>
                  </p:nvGrpSpPr>
                  <p:grpSpPr>
                    <a:xfrm>
                      <a:off x="2201760" y="1059840"/>
                      <a:ext cx="603000" cy="266760"/>
                      <a:chOff x="2201760" y="1059840"/>
                      <a:chExt cx="603000" cy="266760"/>
                    </a:xfrm>
                  </p:grpSpPr>
                  <p:grpSp>
                    <p:nvGrpSpPr>
                      <p:cNvPr id="825" name="Rectangle 33"/>
                      <p:cNvGrpSpPr/>
                      <p:nvPr/>
                    </p:nvGrpSpPr>
                    <p:grpSpPr>
                      <a:xfrm>
                        <a:off x="2204280" y="1187280"/>
                        <a:ext cx="600480" cy="139320"/>
                        <a:chOff x="2204280" y="1187280"/>
                        <a:chExt cx="600480" cy="139320"/>
                      </a:xfrm>
                    </p:grpSpPr>
                    <p:pic>
                      <p:nvPicPr>
                        <p:cNvPr id="826" name="Rectangle 33" descr=""/>
                        <p:cNvPicPr/>
                        <p:nvPr/>
                      </p:nvPicPr>
                      <p:blipFill>
                        <a:blip r:embed="rId12"/>
                        <a:stretch/>
                      </p:blipFill>
                      <p:spPr>
                        <a:xfrm>
                          <a:off x="2206800" y="1187280"/>
                          <a:ext cx="597600" cy="13932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827" name=""/>
                        <p:cNvSpPr/>
                        <p:nvPr/>
                      </p:nvSpPr>
                      <p:spPr>
                        <a:xfrm>
                          <a:off x="2204280" y="1187640"/>
                          <a:ext cx="600480" cy="13716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grpSp>
                    <p:nvGrpSpPr>
                      <p:cNvPr id="828" name="Group 366"/>
                      <p:cNvGrpSpPr/>
                      <p:nvPr/>
                    </p:nvGrpSpPr>
                    <p:grpSpPr>
                      <a:xfrm>
                        <a:off x="2201760" y="1059840"/>
                        <a:ext cx="603000" cy="264960"/>
                        <a:chOff x="2201760" y="1059840"/>
                        <a:chExt cx="603000" cy="264960"/>
                      </a:xfrm>
                    </p:grpSpPr>
                    <p:sp>
                      <p:nvSpPr>
                        <p:cNvPr id="829" name="Oval 45"/>
                        <p:cNvSpPr/>
                        <p:nvPr/>
                      </p:nvSpPr>
                      <p:spPr>
                        <a:xfrm>
                          <a:off x="2201760" y="1059840"/>
                          <a:ext cx="603000" cy="91440"/>
                        </a:xfrm>
                        <a:prstGeom prst="ellipse">
                          <a:avLst/>
                        </a:prstGeom>
                        <a:gradFill rotWithShape="0">
                          <a:gsLst>
                            <a:gs pos="0">
                              <a:srgbClr val="93cddd">
                                <a:alpha val="10196"/>
                              </a:srgbClr>
                            </a:gs>
                            <a:gs pos="100000">
                              <a:srgbClr val="b7dee8"/>
                            </a:gs>
                          </a:gsLst>
                          <a:lin ang="5400000"/>
                        </a:gradFill>
                        <a:ln w="12600">
                          <a:solidFill>
                            <a:srgbClr val="10253f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18000" bIns="1800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830" name="Straight Connector 46"/>
                        <p:cNvSpPr/>
                        <p:nvPr/>
                      </p:nvSpPr>
                      <p:spPr>
                        <a:xfrm>
                          <a:off x="2201760" y="1105560"/>
                          <a:ext cx="0" cy="219240"/>
                        </a:xfrm>
                        <a:prstGeom prst="line">
                          <a:avLst/>
                        </a:prstGeom>
                        <a:ln w="12600">
                          <a:solidFill>
                            <a:srgbClr val="10253f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t">
                          <a:noAutofit/>
                        </a:bodyPr>
                        <a:p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831" name="Straight Connector 47"/>
                        <p:cNvSpPr/>
                        <p:nvPr/>
                      </p:nvSpPr>
                      <p:spPr>
                        <a:xfrm>
                          <a:off x="2804760" y="1105560"/>
                          <a:ext cx="0" cy="219240"/>
                        </a:xfrm>
                        <a:prstGeom prst="line">
                          <a:avLst/>
                        </a:prstGeom>
                        <a:ln w="12600">
                          <a:solidFill>
                            <a:srgbClr val="10253f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t">
                          <a:noAutofit/>
                        </a:bodyPr>
                        <a:p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832" name="Straight Connector 48"/>
                        <p:cNvSpPr/>
                        <p:nvPr/>
                      </p:nvSpPr>
                      <p:spPr>
                        <a:xfrm>
                          <a:off x="2201760" y="1323360"/>
                          <a:ext cx="603000" cy="0"/>
                        </a:xfrm>
                        <a:prstGeom prst="line">
                          <a:avLst/>
                        </a:prstGeom>
                        <a:ln w="12600">
                          <a:solidFill>
                            <a:srgbClr val="10253f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-46800" bIns="-46800" anchor="t">
                          <a:noAutofit/>
                        </a:bodyPr>
                        <a:p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grpSp>
                    <p:nvGrpSpPr>
                      <p:cNvPr id="833" name="Oval 35"/>
                      <p:cNvGrpSpPr/>
                      <p:nvPr/>
                    </p:nvGrpSpPr>
                    <p:grpSpPr>
                      <a:xfrm>
                        <a:off x="2289240" y="1211760"/>
                        <a:ext cx="133200" cy="96840"/>
                        <a:chOff x="2289240" y="1211760"/>
                        <a:chExt cx="133200" cy="96840"/>
                      </a:xfrm>
                    </p:grpSpPr>
                    <p:pic>
                      <p:nvPicPr>
                        <p:cNvPr id="834" name="Oval 35" descr=""/>
                        <p:cNvPicPr/>
                        <p:nvPr/>
                      </p:nvPicPr>
                      <p:blipFill>
                        <a:blip r:embed="rId13"/>
                        <a:stretch/>
                      </p:blipFill>
                      <p:spPr>
                        <a:xfrm>
                          <a:off x="2289240" y="1211760"/>
                          <a:ext cx="133200" cy="9684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835" name=""/>
                        <p:cNvSpPr/>
                        <p:nvPr/>
                      </p:nvSpPr>
                      <p:spPr>
                        <a:xfrm>
                          <a:off x="2306880" y="1223640"/>
                          <a:ext cx="92160" cy="6444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17640" bIns="1764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sp>
                    <p:nvSpPr>
                      <p:cNvPr id="836" name="Oval 36"/>
                      <p:cNvSpPr/>
                      <p:nvPr/>
                    </p:nvSpPr>
                    <p:spPr>
                      <a:xfrm>
                        <a:off x="2319840" y="1231920"/>
                        <a:ext cx="63000" cy="45720"/>
                      </a:xfrm>
                      <a:prstGeom prst="ellipse">
                        <a:avLst/>
                      </a:prstGeom>
                      <a:solidFill>
                        <a:srgbClr val="ff000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4040" bIns="-1404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grpSp>
                    <p:nvGrpSpPr>
                      <p:cNvPr id="837" name="Oval 37"/>
                      <p:cNvGrpSpPr/>
                      <p:nvPr/>
                    </p:nvGrpSpPr>
                    <p:grpSpPr>
                      <a:xfrm>
                        <a:off x="2440800" y="1211760"/>
                        <a:ext cx="133200" cy="96840"/>
                        <a:chOff x="2440800" y="1211760"/>
                        <a:chExt cx="133200" cy="96840"/>
                      </a:xfrm>
                    </p:grpSpPr>
                    <p:pic>
                      <p:nvPicPr>
                        <p:cNvPr id="838" name="Oval 37" descr=""/>
                        <p:cNvPicPr/>
                        <p:nvPr/>
                      </p:nvPicPr>
                      <p:blipFill>
                        <a:blip r:embed="rId14"/>
                        <a:stretch/>
                      </p:blipFill>
                      <p:spPr>
                        <a:xfrm>
                          <a:off x="2440800" y="1211760"/>
                          <a:ext cx="133200" cy="9684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839" name=""/>
                        <p:cNvSpPr/>
                        <p:nvPr/>
                      </p:nvSpPr>
                      <p:spPr>
                        <a:xfrm>
                          <a:off x="2457360" y="1223640"/>
                          <a:ext cx="91080" cy="6444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17640" bIns="1764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sp>
                    <p:nvSpPr>
                      <p:cNvPr id="840" name="Oval 38"/>
                      <p:cNvSpPr/>
                      <p:nvPr/>
                    </p:nvSpPr>
                    <p:spPr>
                      <a:xfrm>
                        <a:off x="2469600" y="1231920"/>
                        <a:ext cx="66240" cy="45720"/>
                      </a:xfrm>
                      <a:prstGeom prst="ellipse">
                        <a:avLst/>
                      </a:prstGeom>
                      <a:solidFill>
                        <a:srgbClr val="ff000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4040" bIns="-1404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grpSp>
                    <p:nvGrpSpPr>
                      <p:cNvPr id="841" name="Oval 39"/>
                      <p:cNvGrpSpPr/>
                      <p:nvPr/>
                    </p:nvGrpSpPr>
                    <p:grpSpPr>
                      <a:xfrm>
                        <a:off x="2592360" y="1199520"/>
                        <a:ext cx="133200" cy="109080"/>
                        <a:chOff x="2592360" y="1199520"/>
                        <a:chExt cx="133200" cy="109080"/>
                      </a:xfrm>
                    </p:grpSpPr>
                    <p:pic>
                      <p:nvPicPr>
                        <p:cNvPr id="842" name="Oval 39" descr=""/>
                        <p:cNvPicPr/>
                        <p:nvPr/>
                      </p:nvPicPr>
                      <p:blipFill>
                        <a:blip r:embed="rId15"/>
                        <a:stretch/>
                      </p:blipFill>
                      <p:spPr>
                        <a:xfrm>
                          <a:off x="2592360" y="1199520"/>
                          <a:ext cx="133200" cy="10908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843" name=""/>
                        <p:cNvSpPr/>
                        <p:nvPr/>
                      </p:nvSpPr>
                      <p:spPr>
                        <a:xfrm>
                          <a:off x="2608560" y="1216080"/>
                          <a:ext cx="92160" cy="6948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22680" bIns="2268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sp>
                    <p:nvSpPr>
                      <p:cNvPr id="844" name="Oval 40"/>
                      <p:cNvSpPr/>
                      <p:nvPr/>
                    </p:nvSpPr>
                    <p:spPr>
                      <a:xfrm>
                        <a:off x="2622960" y="1220760"/>
                        <a:ext cx="63000" cy="55080"/>
                      </a:xfrm>
                      <a:prstGeom prst="ellipse">
                        <a:avLst/>
                      </a:prstGeom>
                      <a:solidFill>
                        <a:srgbClr val="ff000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7560" bIns="-756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grpSp>
                    <p:nvGrpSpPr>
                      <p:cNvPr id="845" name="Oval 41"/>
                      <p:cNvGrpSpPr/>
                      <p:nvPr/>
                    </p:nvGrpSpPr>
                    <p:grpSpPr>
                      <a:xfrm>
                        <a:off x="2525760" y="1199520"/>
                        <a:ext cx="133200" cy="96840"/>
                        <a:chOff x="2525760" y="1199520"/>
                        <a:chExt cx="133200" cy="96840"/>
                      </a:xfrm>
                    </p:grpSpPr>
                    <p:pic>
                      <p:nvPicPr>
                        <p:cNvPr id="846" name="Oval 41" descr=""/>
                        <p:cNvPicPr/>
                        <p:nvPr/>
                      </p:nvPicPr>
                      <p:blipFill>
                        <a:blip r:embed="rId16"/>
                        <a:stretch/>
                      </p:blipFill>
                      <p:spPr>
                        <a:xfrm>
                          <a:off x="2525760" y="1199520"/>
                          <a:ext cx="133200" cy="9684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847" name=""/>
                        <p:cNvSpPr/>
                        <p:nvPr/>
                      </p:nvSpPr>
                      <p:spPr>
                        <a:xfrm>
                          <a:off x="2542680" y="1211040"/>
                          <a:ext cx="92160" cy="6444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17640" bIns="1764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sp>
                    <p:nvSpPr>
                      <p:cNvPr id="848" name="Oval 42"/>
                      <p:cNvSpPr/>
                      <p:nvPr/>
                    </p:nvSpPr>
                    <p:spPr>
                      <a:xfrm>
                        <a:off x="2556720" y="1214640"/>
                        <a:ext cx="63000" cy="50400"/>
                      </a:xfrm>
                      <a:prstGeom prst="ellipse">
                        <a:avLst/>
                      </a:prstGeom>
                      <a:solidFill>
                        <a:srgbClr val="ff000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0800" bIns="-1080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grpSp>
                    <p:nvGrpSpPr>
                      <p:cNvPr id="849" name="Oval 43"/>
                      <p:cNvGrpSpPr/>
                      <p:nvPr/>
                    </p:nvGrpSpPr>
                    <p:grpSpPr>
                      <a:xfrm>
                        <a:off x="2355840" y="1193400"/>
                        <a:ext cx="133200" cy="96840"/>
                        <a:chOff x="2355840" y="1193400"/>
                        <a:chExt cx="133200" cy="96840"/>
                      </a:xfrm>
                    </p:grpSpPr>
                    <p:pic>
                      <p:nvPicPr>
                        <p:cNvPr id="850" name="Oval 43" descr=""/>
                        <p:cNvPicPr/>
                        <p:nvPr/>
                      </p:nvPicPr>
                      <p:blipFill>
                        <a:blip r:embed="rId17"/>
                        <a:stretch/>
                      </p:blipFill>
                      <p:spPr>
                        <a:xfrm>
                          <a:off x="2355840" y="1193400"/>
                          <a:ext cx="133200" cy="9684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851" name=""/>
                        <p:cNvSpPr/>
                        <p:nvPr/>
                      </p:nvSpPr>
                      <p:spPr>
                        <a:xfrm>
                          <a:off x="2372040" y="1209240"/>
                          <a:ext cx="90000" cy="6264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15840" bIns="1584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017720"/>
                              <a:tab algn="l" pos="2035080"/>
                              <a:tab algn="l" pos="3052800"/>
                              <a:tab algn="l" pos="4070520"/>
                              <a:tab algn="l" pos="5087880"/>
                              <a:tab algn="l" pos="6105600"/>
                              <a:tab algn="l" pos="7122960"/>
                              <a:tab algn="l" pos="8140680"/>
                              <a:tab algn="l" pos="9158400"/>
                              <a:tab algn="l" pos="10175760"/>
                            </a:tabLst>
                          </a:pPr>
                          <a:endParaRPr b="0" lang="en-US" sz="20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sp>
                    <p:nvSpPr>
                      <p:cNvPr id="852" name="Oval 44"/>
                      <p:cNvSpPr/>
                      <p:nvPr/>
                    </p:nvSpPr>
                    <p:spPr>
                      <a:xfrm>
                        <a:off x="2384280" y="1212840"/>
                        <a:ext cx="64440" cy="50400"/>
                      </a:xfrm>
                      <a:prstGeom prst="ellipse">
                        <a:avLst/>
                      </a:prstGeom>
                      <a:solidFill>
                        <a:srgbClr val="ff000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0800" bIns="-1080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1017720"/>
                            <a:tab algn="l" pos="2035080"/>
                            <a:tab algn="l" pos="3052800"/>
                            <a:tab algn="l" pos="4070520"/>
                            <a:tab algn="l" pos="5087880"/>
                            <a:tab algn="l" pos="6105600"/>
                            <a:tab algn="l" pos="7122960"/>
                            <a:tab algn="l" pos="8140680"/>
                            <a:tab algn="l" pos="9158400"/>
                            <a:tab algn="l" pos="10175760"/>
                          </a:tabLst>
                        </a:pPr>
                        <a:endPara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</p:grpSp>
              <p:grpSp>
                <p:nvGrpSpPr>
                  <p:cNvPr id="853" name="TextBox 532"/>
                  <p:cNvGrpSpPr/>
                  <p:nvPr/>
                </p:nvGrpSpPr>
                <p:grpSpPr>
                  <a:xfrm>
                    <a:off x="1368360" y="1420560"/>
                    <a:ext cx="890640" cy="195120"/>
                    <a:chOff x="1368360" y="1420560"/>
                    <a:chExt cx="890640" cy="195120"/>
                  </a:xfrm>
                </p:grpSpPr>
                <p:pic>
                  <p:nvPicPr>
                    <p:cNvPr id="854" name="TextBox 532" descr=""/>
                    <p:cNvPicPr/>
                    <p:nvPr/>
                  </p:nvPicPr>
                  <p:blipFill>
                    <a:blip r:embed="rId18"/>
                    <a:stretch/>
                  </p:blipFill>
                  <p:spPr>
                    <a:xfrm>
                      <a:off x="1368360" y="1420560"/>
                      <a:ext cx="890640" cy="195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855" name=""/>
                    <p:cNvSpPr/>
                    <p:nvPr/>
                  </p:nvSpPr>
                  <p:spPr>
                    <a:xfrm>
                      <a:off x="1372680" y="1426680"/>
                      <a:ext cx="883440" cy="1854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de006f"/>
                          </a:solidFill>
                          <a:latin typeface="Arial"/>
                        </a:rPr>
                        <a:t>24hrs treatment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pic>
                <p:nvPicPr>
                  <p:cNvPr id="856" name="Straight Arrow Connector 25" descr=""/>
                  <p:cNvPicPr/>
                  <p:nvPr/>
                </p:nvPicPr>
                <p:blipFill>
                  <a:blip r:embed="rId19"/>
                  <a:stretch/>
                </p:blipFill>
                <p:spPr>
                  <a:xfrm>
                    <a:off x="871200" y="1316880"/>
                    <a:ext cx="502920" cy="243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857" name="Straight Arrow Connector 26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2253240" y="1316880"/>
                    <a:ext cx="563400" cy="249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858" name="TextBox 302"/>
                  <p:cNvSpPr/>
                  <p:nvPr/>
                </p:nvSpPr>
                <p:spPr>
                  <a:xfrm>
                    <a:off x="875880" y="1014840"/>
                    <a:ext cx="59076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600" spc="-1" strike="noStrike">
                        <a:solidFill>
                          <a:srgbClr val="008080"/>
                        </a:solidFill>
                        <a:latin typeface="Arial"/>
                        <a:ea typeface="Arial"/>
                      </a:rPr>
                      <a:t>Optimum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59" name="TextBox 303"/>
                  <p:cNvSpPr/>
                  <p:nvPr/>
                </p:nvSpPr>
                <p:spPr>
                  <a:xfrm>
                    <a:off x="1547640" y="1020960"/>
                    <a:ext cx="60876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600" spc="-1" strike="noStrike">
                        <a:solidFill>
                          <a:srgbClr val="006600"/>
                        </a:solidFill>
                        <a:latin typeface="Arial"/>
                        <a:ea typeface="Arial"/>
                      </a:rPr>
                      <a:t>Borderline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60" name="TextBox 304"/>
                  <p:cNvSpPr/>
                  <p:nvPr/>
                </p:nvSpPr>
                <p:spPr>
                  <a:xfrm>
                    <a:off x="2174760" y="1018800"/>
                    <a:ext cx="62640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600" spc="-1" strike="noStrike">
                        <a:solidFill>
                          <a:srgbClr val="ff0000"/>
                        </a:solidFill>
                        <a:latin typeface="Arial"/>
                        <a:ea typeface="Arial"/>
                      </a:rPr>
                      <a:t>High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861" name="Straight Connector 16"/>
                <p:cNvSpPr/>
                <p:nvPr/>
              </p:nvSpPr>
              <p:spPr>
                <a:xfrm>
                  <a:off x="861840" y="1332000"/>
                  <a:ext cx="606600" cy="0"/>
                </a:xfrm>
                <a:prstGeom prst="line">
                  <a:avLst/>
                </a:prstGeom>
                <a:ln w="12600">
                  <a:solidFill>
                    <a:srgbClr val="10253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862" name="Rectangle 14"/>
              <p:cNvSpPr/>
              <p:nvPr/>
            </p:nvSpPr>
            <p:spPr>
              <a:xfrm>
                <a:off x="438120" y="538200"/>
                <a:ext cx="296640" cy="15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863" name="Straight Arrow Connector 3" descr=""/>
            <p:cNvPicPr/>
            <p:nvPr/>
          </p:nvPicPr>
          <p:blipFill>
            <a:blip r:embed="rId21"/>
            <a:stretch/>
          </p:blipFill>
          <p:spPr>
            <a:xfrm>
              <a:off x="1029960" y="1780200"/>
              <a:ext cx="335160" cy="158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4" name="TextBox 532"/>
            <p:cNvSpPr/>
            <p:nvPr/>
          </p:nvSpPr>
          <p:spPr>
            <a:xfrm>
              <a:off x="622800" y="1810080"/>
              <a:ext cx="497160" cy="276840"/>
            </a:xfrm>
            <a:prstGeom prst="rect">
              <a:avLst/>
            </a:prstGeom>
            <a:noFill/>
            <a:ln w="9360">
              <a:solidFill>
                <a:srgbClr val="de006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600" spc="-1" strike="noStrike">
                  <a:solidFill>
                    <a:srgbClr val="de006f"/>
                  </a:solidFill>
                  <a:latin typeface="Arial"/>
                  <a:ea typeface="Arial"/>
                </a:rPr>
                <a:t>DNA  Damage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5" name="TextBox 532"/>
            <p:cNvSpPr/>
            <p:nvPr/>
          </p:nvSpPr>
          <p:spPr>
            <a:xfrm>
              <a:off x="1168560" y="1992960"/>
              <a:ext cx="554040" cy="368280"/>
            </a:xfrm>
            <a:prstGeom prst="rect">
              <a:avLst/>
            </a:prstGeom>
            <a:noFill/>
            <a:ln w="9360">
              <a:solidFill>
                <a:srgbClr val="de006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600" spc="-1" strike="noStrike">
                  <a:solidFill>
                    <a:srgbClr val="de006f"/>
                  </a:solidFill>
                  <a:latin typeface="Arial"/>
                  <a:ea typeface="Arial"/>
                </a:rPr>
                <a:t>DNA-Pt adduct 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600" spc="-1" strike="noStrike">
                  <a:solidFill>
                    <a:srgbClr val="de006f"/>
                  </a:solidFill>
                  <a:latin typeface="Arial"/>
                  <a:ea typeface="Arial"/>
                </a:rPr>
                <a:t>Retention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66" name="Straight Arrow Connector 6" descr=""/>
            <p:cNvPicPr/>
            <p:nvPr/>
          </p:nvPicPr>
          <p:blipFill>
            <a:blip r:embed="rId22"/>
            <a:stretch/>
          </p:blipFill>
          <p:spPr>
            <a:xfrm>
              <a:off x="1359360" y="1798560"/>
              <a:ext cx="158400" cy="25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67" name="Straight Arrow Connector 7" descr=""/>
            <p:cNvPicPr/>
            <p:nvPr/>
          </p:nvPicPr>
          <p:blipFill>
            <a:blip r:embed="rId23"/>
            <a:stretch/>
          </p:blipFill>
          <p:spPr>
            <a:xfrm>
              <a:off x="1847160" y="1786320"/>
              <a:ext cx="158400" cy="255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8" name="TextBox 532"/>
            <p:cNvSpPr/>
            <p:nvPr/>
          </p:nvSpPr>
          <p:spPr>
            <a:xfrm>
              <a:off x="1768320" y="1991520"/>
              <a:ext cx="451440" cy="276840"/>
            </a:xfrm>
            <a:prstGeom prst="rect">
              <a:avLst/>
            </a:prstGeom>
            <a:noFill/>
            <a:ln w="9360">
              <a:solidFill>
                <a:srgbClr val="de006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600" spc="-1" strike="noStrike">
                  <a:solidFill>
                    <a:srgbClr val="de006f"/>
                  </a:solidFill>
                  <a:latin typeface="Arial"/>
                  <a:ea typeface="Arial"/>
                </a:rPr>
                <a:t>ROS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600" spc="-1" strike="noStrike">
                  <a:solidFill>
                    <a:srgbClr val="de006f"/>
                  </a:solidFill>
                  <a:latin typeface="Arial"/>
                  <a:ea typeface="Arial"/>
                </a:rPr>
                <a:t>Levels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69" name="Straight Arrow Connector 9" descr=""/>
            <p:cNvPicPr/>
            <p:nvPr/>
          </p:nvPicPr>
          <p:blipFill>
            <a:blip r:embed="rId24"/>
            <a:stretch/>
          </p:blipFill>
          <p:spPr>
            <a:xfrm>
              <a:off x="2389680" y="1670400"/>
              <a:ext cx="469440" cy="15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70" name="Straight Arrow Connector 10" descr=""/>
            <p:cNvPicPr/>
            <p:nvPr/>
          </p:nvPicPr>
          <p:blipFill>
            <a:blip r:embed="rId25"/>
            <a:stretch/>
          </p:blipFill>
          <p:spPr>
            <a:xfrm>
              <a:off x="2292120" y="1804680"/>
              <a:ext cx="231480" cy="237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71" name="TextBox 532"/>
            <p:cNvSpPr/>
            <p:nvPr/>
          </p:nvSpPr>
          <p:spPr>
            <a:xfrm>
              <a:off x="2267280" y="1992240"/>
              <a:ext cx="735840" cy="368280"/>
            </a:xfrm>
            <a:prstGeom prst="rect">
              <a:avLst/>
            </a:prstGeom>
            <a:noFill/>
            <a:ln w="9360">
              <a:solidFill>
                <a:srgbClr val="de006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600" spc="-1" strike="noStrike">
                  <a:solidFill>
                    <a:srgbClr val="de006f"/>
                  </a:solidFill>
                  <a:latin typeface="Arial"/>
                  <a:ea typeface="Arial"/>
                </a:rPr>
                <a:t>Mitochondrial Membrane Depolarization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2" name="TextBox 532"/>
            <p:cNvSpPr/>
            <p:nvPr/>
          </p:nvSpPr>
          <p:spPr>
            <a:xfrm>
              <a:off x="2778120" y="1497600"/>
              <a:ext cx="614520" cy="368280"/>
            </a:xfrm>
            <a:prstGeom prst="rect">
              <a:avLst/>
            </a:prstGeom>
            <a:noFill/>
            <a:ln w="9360">
              <a:solidFill>
                <a:srgbClr val="de006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600" spc="-1" strike="noStrike">
                  <a:solidFill>
                    <a:srgbClr val="de006f"/>
                  </a:solidFill>
                  <a:latin typeface="Arial"/>
                  <a:ea typeface="Arial"/>
                </a:rPr>
                <a:t>Membrane Cholesterol Enrichment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73" name="Group 131"/>
          <p:cNvGrpSpPr/>
          <p:nvPr/>
        </p:nvGrpSpPr>
        <p:grpSpPr>
          <a:xfrm>
            <a:off x="3328920" y="561960"/>
            <a:ext cx="1692360" cy="1343160"/>
            <a:chOff x="3328920" y="561960"/>
            <a:chExt cx="1692360" cy="1343160"/>
          </a:xfrm>
        </p:grpSpPr>
        <p:grpSp>
          <p:nvGrpSpPr>
            <p:cNvPr id="874" name="Group 107"/>
            <p:cNvGrpSpPr/>
            <p:nvPr/>
          </p:nvGrpSpPr>
          <p:grpSpPr>
            <a:xfrm>
              <a:off x="3524760" y="634320"/>
              <a:ext cx="1496520" cy="1270800"/>
              <a:chOff x="3524760" y="634320"/>
              <a:chExt cx="1496520" cy="1270800"/>
            </a:xfrm>
          </p:grpSpPr>
          <p:grpSp>
            <p:nvGrpSpPr>
              <p:cNvPr id="875" name="Group 11271"/>
              <p:cNvGrpSpPr/>
              <p:nvPr/>
            </p:nvGrpSpPr>
            <p:grpSpPr>
              <a:xfrm>
                <a:off x="3524760" y="634320"/>
                <a:ext cx="1496520" cy="1270800"/>
                <a:chOff x="3524760" y="634320"/>
                <a:chExt cx="1496520" cy="1270800"/>
              </a:xfrm>
            </p:grpSpPr>
            <p:pic>
              <p:nvPicPr>
                <p:cNvPr id="876" name="Picture 5" descr="C:\Users\ELIZABETH\Desktop\OVARIAN CANCER COMPLETE FOLDER\Canvas Final Images\COMET TAIL LENGTH.jpg"/>
                <p:cNvPicPr/>
                <p:nvPr/>
              </p:nvPicPr>
              <p:blipFill>
                <a:blip r:embed="rId26"/>
                <a:srcRect l="18999" t="14277" r="20905" b="39709"/>
                <a:stretch/>
              </p:blipFill>
              <p:spPr>
                <a:xfrm>
                  <a:off x="3709440" y="645120"/>
                  <a:ext cx="1311840" cy="12600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877" name="TextBox 1"/>
                <p:cNvSpPr/>
                <p:nvPr/>
              </p:nvSpPr>
              <p:spPr>
                <a:xfrm rot="16200000">
                  <a:off x="3105360" y="1053360"/>
                  <a:ext cx="102384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omet Tail Length(µm)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878" name="Group 79"/>
              <p:cNvGrpSpPr/>
              <p:nvPr/>
            </p:nvGrpSpPr>
            <p:grpSpPr>
              <a:xfrm>
                <a:off x="3843720" y="634320"/>
                <a:ext cx="434520" cy="185400"/>
                <a:chOff x="3843720" y="634320"/>
                <a:chExt cx="434520" cy="185400"/>
              </a:xfrm>
            </p:grpSpPr>
            <p:sp>
              <p:nvSpPr>
                <p:cNvPr id="879" name="TextBox 365"/>
                <p:cNvSpPr/>
                <p:nvPr/>
              </p:nvSpPr>
              <p:spPr>
                <a:xfrm>
                  <a:off x="3843720" y="634320"/>
                  <a:ext cx="43452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***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0" name="Straight Connector 92"/>
                <p:cNvSpPr/>
                <p:nvPr/>
              </p:nvSpPr>
              <p:spPr>
                <a:xfrm>
                  <a:off x="4017600" y="770040"/>
                  <a:ext cx="18396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881" name="Group 80"/>
              <p:cNvGrpSpPr/>
              <p:nvPr/>
            </p:nvGrpSpPr>
            <p:grpSpPr>
              <a:xfrm>
                <a:off x="4147920" y="780480"/>
                <a:ext cx="534240" cy="185400"/>
                <a:chOff x="4147920" y="780480"/>
                <a:chExt cx="534240" cy="185400"/>
              </a:xfrm>
            </p:grpSpPr>
            <p:sp>
              <p:nvSpPr>
                <p:cNvPr id="882" name="TextBox 365"/>
                <p:cNvSpPr/>
                <p:nvPr/>
              </p:nvSpPr>
              <p:spPr>
                <a:xfrm>
                  <a:off x="4147920" y="780480"/>
                  <a:ext cx="53424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***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3" name="Straight Connector 90"/>
                <p:cNvSpPr/>
                <p:nvPr/>
              </p:nvSpPr>
              <p:spPr>
                <a:xfrm>
                  <a:off x="4316400" y="922320"/>
                  <a:ext cx="1872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884" name="Group 81"/>
              <p:cNvGrpSpPr/>
              <p:nvPr/>
            </p:nvGrpSpPr>
            <p:grpSpPr>
              <a:xfrm>
                <a:off x="4638240" y="832680"/>
                <a:ext cx="284760" cy="185400"/>
                <a:chOff x="4638240" y="832680"/>
                <a:chExt cx="284760" cy="185400"/>
              </a:xfrm>
            </p:grpSpPr>
            <p:sp>
              <p:nvSpPr>
                <p:cNvPr id="885" name="TextBox 365"/>
                <p:cNvSpPr/>
                <p:nvPr/>
              </p:nvSpPr>
              <p:spPr>
                <a:xfrm>
                  <a:off x="4638240" y="832680"/>
                  <a:ext cx="2847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*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6" name="Straight Connector 88"/>
                <p:cNvSpPr/>
                <p:nvPr/>
              </p:nvSpPr>
              <p:spPr>
                <a:xfrm>
                  <a:off x="4682880" y="971280"/>
                  <a:ext cx="19044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887" name="Rectangle 82"/>
            <p:cNvSpPr/>
            <p:nvPr/>
          </p:nvSpPr>
          <p:spPr>
            <a:xfrm>
              <a:off x="3328920" y="561960"/>
              <a:ext cx="296640" cy="15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88" name="Group 130"/>
          <p:cNvGrpSpPr/>
          <p:nvPr/>
        </p:nvGrpSpPr>
        <p:grpSpPr>
          <a:xfrm>
            <a:off x="5129280" y="550800"/>
            <a:ext cx="2106720" cy="1454040"/>
            <a:chOff x="5129280" y="550800"/>
            <a:chExt cx="2106720" cy="1454040"/>
          </a:xfrm>
        </p:grpSpPr>
        <p:grpSp>
          <p:nvGrpSpPr>
            <p:cNvPr id="889" name="Group 129"/>
            <p:cNvGrpSpPr/>
            <p:nvPr/>
          </p:nvGrpSpPr>
          <p:grpSpPr>
            <a:xfrm>
              <a:off x="5358960" y="633600"/>
              <a:ext cx="1877040" cy="1371240"/>
              <a:chOff x="5358960" y="633600"/>
              <a:chExt cx="1877040" cy="1371240"/>
            </a:xfrm>
          </p:grpSpPr>
          <p:grpSp>
            <p:nvGrpSpPr>
              <p:cNvPr id="890" name="Group 19"/>
              <p:cNvGrpSpPr/>
              <p:nvPr/>
            </p:nvGrpSpPr>
            <p:grpSpPr>
              <a:xfrm>
                <a:off x="5543640" y="633600"/>
                <a:ext cx="1692360" cy="1371240"/>
                <a:chOff x="5543640" y="633600"/>
                <a:chExt cx="1692360" cy="1371240"/>
              </a:xfrm>
            </p:grpSpPr>
            <p:pic>
              <p:nvPicPr>
                <p:cNvPr id="891" name="Picture 3" descr="C:\Users\ELIZABETH\Desktop\OVARIAN CANCER COMPLETE FOLDER\Canvas Final Images\ROS (DCF% POSITIVE CELLS).jpg"/>
                <p:cNvPicPr/>
                <p:nvPr/>
              </p:nvPicPr>
              <p:blipFill>
                <a:blip r:embed="rId27"/>
                <a:srcRect l="14922" t="29716" r="7896" b="13947"/>
                <a:stretch/>
              </p:blipFill>
              <p:spPr>
                <a:xfrm>
                  <a:off x="5543640" y="633600"/>
                  <a:ext cx="1594800" cy="13712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892" name="TextBox 365"/>
                <p:cNvSpPr/>
                <p:nvPr/>
              </p:nvSpPr>
              <p:spPr>
                <a:xfrm>
                  <a:off x="5543640" y="813240"/>
                  <a:ext cx="87732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***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3" name="Straight Connector 102"/>
                <p:cNvSpPr/>
                <p:nvPr/>
              </p:nvSpPr>
              <p:spPr>
                <a:xfrm>
                  <a:off x="5851440" y="944280"/>
                  <a:ext cx="25236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4" name="TextBox 365"/>
                <p:cNvSpPr/>
                <p:nvPr/>
              </p:nvSpPr>
              <p:spPr>
                <a:xfrm>
                  <a:off x="5972760" y="976320"/>
                  <a:ext cx="87732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***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5" name="Straight Connector 104"/>
                <p:cNvSpPr/>
                <p:nvPr/>
              </p:nvSpPr>
              <p:spPr>
                <a:xfrm>
                  <a:off x="6280200" y="1106280"/>
                  <a:ext cx="25236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896" name="Group 18"/>
                <p:cNvGrpSpPr/>
                <p:nvPr/>
              </p:nvGrpSpPr>
              <p:grpSpPr>
                <a:xfrm>
                  <a:off x="6358680" y="839160"/>
                  <a:ext cx="877320" cy="185400"/>
                  <a:chOff x="6358680" y="839160"/>
                  <a:chExt cx="877320" cy="185400"/>
                </a:xfrm>
              </p:grpSpPr>
              <p:sp>
                <p:nvSpPr>
                  <p:cNvPr id="897" name="TextBox 365"/>
                  <p:cNvSpPr/>
                  <p:nvPr/>
                </p:nvSpPr>
                <p:spPr>
                  <a:xfrm>
                    <a:off x="6358680" y="839160"/>
                    <a:ext cx="87732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ns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98" name="Straight Connector 107"/>
                  <p:cNvSpPr/>
                  <p:nvPr/>
                </p:nvSpPr>
                <p:spPr>
                  <a:xfrm>
                    <a:off x="6664320" y="969480"/>
                    <a:ext cx="25380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sp>
            <p:nvSpPr>
              <p:cNvPr id="899" name="TextBox 1"/>
              <p:cNvSpPr/>
              <p:nvPr/>
            </p:nvSpPr>
            <p:spPr>
              <a:xfrm rot="16200000">
                <a:off x="4939920" y="1065240"/>
                <a:ext cx="102312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OS Positive Cells(%)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00" name="Rectangle 97"/>
            <p:cNvSpPr/>
            <p:nvPr/>
          </p:nvSpPr>
          <p:spPr>
            <a:xfrm>
              <a:off x="5129280" y="550800"/>
              <a:ext cx="296640" cy="15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01" name="Group 147"/>
          <p:cNvGrpSpPr/>
          <p:nvPr/>
        </p:nvGrpSpPr>
        <p:grpSpPr>
          <a:xfrm>
            <a:off x="409680" y="2523960"/>
            <a:ext cx="2468520" cy="1795680"/>
            <a:chOff x="409680" y="2523960"/>
            <a:chExt cx="2468520" cy="1795680"/>
          </a:xfrm>
        </p:grpSpPr>
        <p:grpSp>
          <p:nvGrpSpPr>
            <p:cNvPr id="902" name="Group 14"/>
            <p:cNvGrpSpPr/>
            <p:nvPr/>
          </p:nvGrpSpPr>
          <p:grpSpPr>
            <a:xfrm>
              <a:off x="630720" y="2583720"/>
              <a:ext cx="2247480" cy="1735920"/>
              <a:chOff x="630720" y="2583720"/>
              <a:chExt cx="2247480" cy="1735920"/>
            </a:xfrm>
          </p:grpSpPr>
          <p:grpSp>
            <p:nvGrpSpPr>
              <p:cNvPr id="903" name="Group 1"/>
              <p:cNvGrpSpPr/>
              <p:nvPr/>
            </p:nvGrpSpPr>
            <p:grpSpPr>
              <a:xfrm>
                <a:off x="630720" y="2627280"/>
                <a:ext cx="2083680" cy="1692360"/>
                <a:chOff x="630720" y="2627280"/>
                <a:chExt cx="2083680" cy="1692360"/>
              </a:xfrm>
            </p:grpSpPr>
            <p:pic>
              <p:nvPicPr>
                <p:cNvPr id="904" name="Picture 2" descr="C:\Users\ELIZABETH\Desktop\OVARIAN CANCER COMPLETE FOLDER\Canvas Final Images\JC-1 RED+GREEN RATIO.jpg"/>
                <p:cNvPicPr/>
                <p:nvPr/>
              </p:nvPicPr>
              <p:blipFill>
                <a:blip r:embed="rId28"/>
                <a:srcRect l="13137" t="32327" r="6872" b="12917"/>
                <a:stretch/>
              </p:blipFill>
              <p:spPr>
                <a:xfrm>
                  <a:off x="806760" y="2627280"/>
                  <a:ext cx="1907640" cy="16923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905" name="TextBox 1"/>
                <p:cNvSpPr/>
                <p:nvPr/>
              </p:nvSpPr>
              <p:spPr>
                <a:xfrm rot="16200000">
                  <a:off x="116640" y="3191400"/>
                  <a:ext cx="121320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JC-1 Red/Green Ratio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906" name="Group 5"/>
              <p:cNvGrpSpPr/>
              <p:nvPr/>
            </p:nvGrpSpPr>
            <p:grpSpPr>
              <a:xfrm>
                <a:off x="878400" y="2583720"/>
                <a:ext cx="913680" cy="185400"/>
                <a:chOff x="878400" y="2583720"/>
                <a:chExt cx="913680" cy="185400"/>
              </a:xfrm>
            </p:grpSpPr>
            <p:sp>
              <p:nvSpPr>
                <p:cNvPr id="907" name="TextBox 365"/>
                <p:cNvSpPr/>
                <p:nvPr/>
              </p:nvSpPr>
              <p:spPr>
                <a:xfrm>
                  <a:off x="878400" y="2583720"/>
                  <a:ext cx="9136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***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08" name="Straight Connector 120"/>
                <p:cNvSpPr/>
                <p:nvPr/>
              </p:nvSpPr>
              <p:spPr>
                <a:xfrm>
                  <a:off x="1198440" y="2741760"/>
                  <a:ext cx="26496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909" name="Group 8"/>
              <p:cNvGrpSpPr/>
              <p:nvPr/>
            </p:nvGrpSpPr>
            <p:grpSpPr>
              <a:xfrm>
                <a:off x="1395360" y="3083400"/>
                <a:ext cx="994680" cy="185400"/>
                <a:chOff x="1395360" y="3083400"/>
                <a:chExt cx="994680" cy="185400"/>
              </a:xfrm>
            </p:grpSpPr>
            <p:sp>
              <p:nvSpPr>
                <p:cNvPr id="910" name="TextBox 365"/>
                <p:cNvSpPr/>
                <p:nvPr/>
              </p:nvSpPr>
              <p:spPr>
                <a:xfrm>
                  <a:off x="1395360" y="3083400"/>
                  <a:ext cx="9946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***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1" name="Straight Connector 118"/>
                <p:cNvSpPr/>
                <p:nvPr/>
              </p:nvSpPr>
              <p:spPr>
                <a:xfrm>
                  <a:off x="1743120" y="3241800"/>
                  <a:ext cx="2872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912" name="Group 11"/>
              <p:cNvGrpSpPr/>
              <p:nvPr/>
            </p:nvGrpSpPr>
            <p:grpSpPr>
              <a:xfrm>
                <a:off x="1883520" y="3508200"/>
                <a:ext cx="994680" cy="185400"/>
                <a:chOff x="1883520" y="3508200"/>
                <a:chExt cx="994680" cy="185400"/>
              </a:xfrm>
            </p:grpSpPr>
            <p:sp>
              <p:nvSpPr>
                <p:cNvPr id="913" name="TextBox 365"/>
                <p:cNvSpPr/>
                <p:nvPr/>
              </p:nvSpPr>
              <p:spPr>
                <a:xfrm>
                  <a:off x="1883520" y="3508200"/>
                  <a:ext cx="9946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ns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4" name="Straight Connector 116"/>
                <p:cNvSpPr/>
                <p:nvPr/>
              </p:nvSpPr>
              <p:spPr>
                <a:xfrm>
                  <a:off x="2230560" y="3667320"/>
                  <a:ext cx="2872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915" name="Rectangle 110"/>
            <p:cNvSpPr/>
            <p:nvPr/>
          </p:nvSpPr>
          <p:spPr>
            <a:xfrm>
              <a:off x="409680" y="2523960"/>
              <a:ext cx="296640" cy="15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16" name="TextBox 117"/>
          <p:cNvSpPr/>
          <p:nvPr/>
        </p:nvSpPr>
        <p:spPr>
          <a:xfrm>
            <a:off x="-9360" y="9813960"/>
            <a:ext cx="1436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17" name="Group 15"/>
          <p:cNvGrpSpPr/>
          <p:nvPr/>
        </p:nvGrpSpPr>
        <p:grpSpPr>
          <a:xfrm>
            <a:off x="3095640" y="2440080"/>
            <a:ext cx="4289400" cy="2662200"/>
            <a:chOff x="3095640" y="2440080"/>
            <a:chExt cx="4289400" cy="2662200"/>
          </a:xfrm>
        </p:grpSpPr>
        <p:sp>
          <p:nvSpPr>
            <p:cNvPr id="918" name="Rectangle 141"/>
            <p:cNvSpPr/>
            <p:nvPr/>
          </p:nvSpPr>
          <p:spPr>
            <a:xfrm>
              <a:off x="3095640" y="2573280"/>
              <a:ext cx="296640" cy="15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919" name="Group 13"/>
            <p:cNvGrpSpPr/>
            <p:nvPr/>
          </p:nvGrpSpPr>
          <p:grpSpPr>
            <a:xfrm>
              <a:off x="3390840" y="2440080"/>
              <a:ext cx="3994200" cy="2662200"/>
              <a:chOff x="3390840" y="2440080"/>
              <a:chExt cx="3994200" cy="2662200"/>
            </a:xfrm>
          </p:grpSpPr>
          <p:grpSp>
            <p:nvGrpSpPr>
              <p:cNvPr id="920" name="Group 12"/>
              <p:cNvGrpSpPr/>
              <p:nvPr/>
            </p:nvGrpSpPr>
            <p:grpSpPr>
              <a:xfrm>
                <a:off x="3390840" y="2440080"/>
                <a:ext cx="3994200" cy="2662200"/>
                <a:chOff x="3390840" y="2440080"/>
                <a:chExt cx="3994200" cy="2662200"/>
              </a:xfrm>
            </p:grpSpPr>
            <p:grpSp>
              <p:nvGrpSpPr>
                <p:cNvPr id="921" name="Group 11"/>
                <p:cNvGrpSpPr/>
                <p:nvPr/>
              </p:nvGrpSpPr>
              <p:grpSpPr>
                <a:xfrm>
                  <a:off x="3390840" y="2440080"/>
                  <a:ext cx="3994200" cy="2662200"/>
                  <a:chOff x="3390840" y="2440080"/>
                  <a:chExt cx="3994200" cy="2662200"/>
                </a:xfrm>
              </p:grpSpPr>
              <p:grpSp>
                <p:nvGrpSpPr>
                  <p:cNvPr id="922" name="Group 1"/>
                  <p:cNvGrpSpPr/>
                  <p:nvPr/>
                </p:nvGrpSpPr>
                <p:grpSpPr>
                  <a:xfrm>
                    <a:off x="3390840" y="2861640"/>
                    <a:ext cx="3849480" cy="2240640"/>
                    <a:chOff x="3390840" y="2861640"/>
                    <a:chExt cx="3849480" cy="2240640"/>
                  </a:xfrm>
                </p:grpSpPr>
                <p:pic>
                  <p:nvPicPr>
                    <p:cNvPr id="923" name="Picture 2" descr=""/>
                    <p:cNvPicPr/>
                    <p:nvPr/>
                  </p:nvPicPr>
                  <p:blipFill>
                    <a:blip r:embed="rId29"/>
                    <a:srcRect l="2022" t="3701" r="20656" b="65409"/>
                    <a:stretch/>
                  </p:blipFill>
                  <p:spPr>
                    <a:xfrm>
                      <a:off x="3390840" y="2861640"/>
                      <a:ext cx="3849480" cy="11732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924" name="Picture 2" descr=""/>
                    <p:cNvPicPr/>
                    <p:nvPr/>
                  </p:nvPicPr>
                  <p:blipFill>
                    <a:blip r:embed="rId30"/>
                    <a:srcRect l="2022" t="38233" r="59322" b="30831"/>
                    <a:stretch/>
                  </p:blipFill>
                  <p:spPr>
                    <a:xfrm>
                      <a:off x="4537440" y="4106520"/>
                      <a:ext cx="1631160" cy="9957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grpSp>
              <p:sp>
                <p:nvSpPr>
                  <p:cNvPr id="925" name="TextBox 1"/>
                  <p:cNvSpPr/>
                  <p:nvPr/>
                </p:nvSpPr>
                <p:spPr>
                  <a:xfrm>
                    <a:off x="6513480" y="2440080"/>
                    <a:ext cx="871560" cy="4597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600" spc="-1" strike="noStrike">
                        <a:solidFill>
                          <a:srgbClr val="10253f"/>
                        </a:solidFill>
                        <a:latin typeface="Arial"/>
                        <a:ea typeface="Arial"/>
                      </a:rPr>
                      <a:t>Cells positively stained with antibody against Pt modified DNA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cxnSp>
              <p:nvCxnSpPr>
                <p:cNvPr id="926" name="Straight Arrow Connector 4"/>
                <p:cNvCxnSpPr/>
                <p:nvPr/>
              </p:nvCxnSpPr>
              <p:spPr>
                <a:xfrm flipV="1">
                  <a:off x="6654600" y="2920680"/>
                  <a:ext cx="1080" cy="144720"/>
                </a:xfrm>
                <a:prstGeom prst="straightConnector1">
                  <a:avLst/>
                </a:prstGeom>
                <a:ln cap="rnd" w="12600">
                  <a:solidFill>
                    <a:srgbClr val="1f497d"/>
                  </a:solidFill>
                  <a:miter/>
                  <a:tailEnd len="med" type="stealth" w="med"/>
                </a:ln>
              </p:spPr>
            </p:cxnSp>
            <p:cxnSp>
              <p:nvCxnSpPr>
                <p:cNvPr id="927" name="Straight Arrow Connector 134"/>
                <p:cNvCxnSpPr/>
                <p:nvPr/>
              </p:nvCxnSpPr>
              <p:spPr>
                <a:xfrm>
                  <a:off x="5239800" y="4447080"/>
                  <a:ext cx="144720" cy="1080"/>
                </a:xfrm>
                <a:prstGeom prst="straightConnector1">
                  <a:avLst/>
                </a:prstGeom>
                <a:ln cap="rnd" w="12600">
                  <a:solidFill>
                    <a:srgbClr val="1f497d"/>
                  </a:solidFill>
                  <a:miter/>
                  <a:tailEnd len="med" type="stealth" w="med"/>
                </a:ln>
              </p:spPr>
            </p:cxnSp>
            <p:sp>
              <p:nvSpPr>
                <p:cNvPr id="928" name="TextBox 1"/>
                <p:cNvSpPr/>
                <p:nvPr/>
              </p:nvSpPr>
              <p:spPr>
                <a:xfrm>
                  <a:off x="5305320" y="4311720"/>
                  <a:ext cx="869760" cy="2768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10253f"/>
                      </a:solidFill>
                      <a:latin typeface="Arial"/>
                      <a:ea typeface="Arial"/>
                    </a:rPr>
                    <a:t>Cells with Pt-DNA conjugates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9" name="TextBox 1"/>
                <p:cNvSpPr/>
                <p:nvPr/>
              </p:nvSpPr>
              <p:spPr>
                <a:xfrm rot="16200000">
                  <a:off x="4403160" y="4260960"/>
                  <a:ext cx="871560" cy="2768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>
                      <a:solidFill>
                        <a:srgbClr val="10253f"/>
                      </a:solidFill>
                      <a:latin typeface="Arial"/>
                      <a:ea typeface="Arial"/>
                    </a:rPr>
                    <a:t>Cells without Pt-DNA conjugates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cxnSp>
              <p:nvCxnSpPr>
                <p:cNvPr id="930" name="Straight Arrow Connector 139"/>
                <p:cNvCxnSpPr/>
                <p:nvPr/>
              </p:nvCxnSpPr>
              <p:spPr>
                <a:xfrm flipV="1">
                  <a:off x="4833360" y="4717800"/>
                  <a:ext cx="1080" cy="144720"/>
                </a:xfrm>
                <a:prstGeom prst="straightConnector1">
                  <a:avLst/>
                </a:prstGeom>
                <a:ln cap="rnd" w="12600">
                  <a:solidFill>
                    <a:srgbClr val="1f497d"/>
                  </a:solidFill>
                  <a:miter/>
                  <a:tailEnd len="med" type="stealth" w="med"/>
                </a:ln>
              </p:spPr>
            </p:cxnSp>
          </p:grpSp>
          <p:grpSp>
            <p:nvGrpSpPr>
              <p:cNvPr id="931" name="TextBox 142"/>
              <p:cNvGrpSpPr/>
              <p:nvPr/>
            </p:nvGrpSpPr>
            <p:grpSpPr>
              <a:xfrm>
                <a:off x="3529440" y="2560320"/>
                <a:ext cx="2401920" cy="188640"/>
                <a:chOff x="3529440" y="2560320"/>
                <a:chExt cx="2401920" cy="188640"/>
              </a:xfrm>
            </p:grpSpPr>
            <p:pic>
              <p:nvPicPr>
                <p:cNvPr id="932" name="TextBox 142" descr=""/>
                <p:cNvPicPr/>
                <p:nvPr/>
              </p:nvPicPr>
              <p:blipFill>
                <a:blip r:embed="rId31"/>
                <a:stretch/>
              </p:blipFill>
              <p:spPr>
                <a:xfrm>
                  <a:off x="3529440" y="2560320"/>
                  <a:ext cx="2401920" cy="1886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933" name=""/>
                <p:cNvSpPr/>
                <p:nvPr/>
              </p:nvSpPr>
              <p:spPr>
                <a:xfrm>
                  <a:off x="3529440" y="2560680"/>
                  <a:ext cx="23950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 u="sng">
                      <a:solidFill>
                        <a:srgbClr val="540054"/>
                      </a:solidFill>
                      <a:uFillTx/>
                      <a:latin typeface="Arial"/>
                    </a:rPr>
                    <a:t>Figure4A:</a:t>
                  </a:r>
                  <a:r>
                    <a:rPr b="1" lang="en-IN" sz="600" spc="-1" strike="noStrike">
                      <a:solidFill>
                        <a:srgbClr val="540054"/>
                      </a:solidFill>
                      <a:latin typeface="Arial"/>
                    </a:rPr>
                    <a:t>Gating Pattern(Pt-DNA adduct accumulation)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</p:grpSp>
      <p:grpSp>
        <p:nvGrpSpPr>
          <p:cNvPr id="934" name="Group 23"/>
          <p:cNvGrpSpPr/>
          <p:nvPr/>
        </p:nvGrpSpPr>
        <p:grpSpPr>
          <a:xfrm>
            <a:off x="3786120" y="5361120"/>
            <a:ext cx="3546360" cy="2813040"/>
            <a:chOff x="3786120" y="5361120"/>
            <a:chExt cx="3546360" cy="2813040"/>
          </a:xfrm>
        </p:grpSpPr>
        <p:grpSp>
          <p:nvGrpSpPr>
            <p:cNvPr id="935" name="Group 21"/>
            <p:cNvGrpSpPr/>
            <p:nvPr/>
          </p:nvGrpSpPr>
          <p:grpSpPr>
            <a:xfrm>
              <a:off x="3786120" y="5361120"/>
              <a:ext cx="3224160" cy="2813040"/>
              <a:chOff x="3786120" y="5361120"/>
              <a:chExt cx="3224160" cy="2813040"/>
            </a:xfrm>
          </p:grpSpPr>
          <p:grpSp>
            <p:nvGrpSpPr>
              <p:cNvPr id="936" name="Group 94"/>
              <p:cNvGrpSpPr/>
              <p:nvPr/>
            </p:nvGrpSpPr>
            <p:grpSpPr>
              <a:xfrm>
                <a:off x="3786120" y="5368320"/>
                <a:ext cx="3224160" cy="2805840"/>
                <a:chOff x="3786120" y="5368320"/>
                <a:chExt cx="3224160" cy="2805840"/>
              </a:xfrm>
            </p:grpSpPr>
            <p:grpSp>
              <p:nvGrpSpPr>
                <p:cNvPr id="937" name="Group 93"/>
                <p:cNvGrpSpPr/>
                <p:nvPr/>
              </p:nvGrpSpPr>
              <p:grpSpPr>
                <a:xfrm>
                  <a:off x="3924720" y="5706360"/>
                  <a:ext cx="3085560" cy="2467800"/>
                  <a:chOff x="3924720" y="5706360"/>
                  <a:chExt cx="3085560" cy="2467800"/>
                </a:xfrm>
              </p:grpSpPr>
              <p:grpSp>
                <p:nvGrpSpPr>
                  <p:cNvPr id="938" name="Group 87"/>
                  <p:cNvGrpSpPr/>
                  <p:nvPr/>
                </p:nvGrpSpPr>
                <p:grpSpPr>
                  <a:xfrm>
                    <a:off x="3924720" y="5706360"/>
                    <a:ext cx="2599560" cy="2467800"/>
                    <a:chOff x="3924720" y="5706360"/>
                    <a:chExt cx="2599560" cy="2467800"/>
                  </a:xfrm>
                </p:grpSpPr>
                <p:pic>
                  <p:nvPicPr>
                    <p:cNvPr id="939" name="Picture 3" descr=""/>
                    <p:cNvPicPr/>
                    <p:nvPr/>
                  </p:nvPicPr>
                  <p:blipFill>
                    <a:blip r:embed="rId32"/>
                    <a:srcRect l="53391" t="2742" r="21764" b="65975"/>
                    <a:stretch/>
                  </p:blipFill>
                  <p:spPr>
                    <a:xfrm>
                      <a:off x="4646880" y="6977520"/>
                      <a:ext cx="1245960" cy="11966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940" name="Picture 3" descr=""/>
                    <p:cNvPicPr/>
                    <p:nvPr/>
                  </p:nvPicPr>
                  <p:blipFill>
                    <a:blip r:embed="rId33"/>
                    <a:srcRect l="1231" t="3217" r="73383" b="66071"/>
                    <a:stretch/>
                  </p:blipFill>
                  <p:spPr>
                    <a:xfrm>
                      <a:off x="3924720" y="5706360"/>
                      <a:ext cx="1334880" cy="1231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941" name="Picture 3" descr=""/>
                    <p:cNvPicPr/>
                    <p:nvPr/>
                  </p:nvPicPr>
                  <p:blipFill>
                    <a:blip r:embed="rId34"/>
                    <a:srcRect l="27119" t="3222" r="48098" b="66021"/>
                    <a:stretch/>
                  </p:blipFill>
                  <p:spPr>
                    <a:xfrm>
                      <a:off x="5247720" y="5719320"/>
                      <a:ext cx="1276560" cy="12186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grpSp>
              <p:sp>
                <p:nvSpPr>
                  <p:cNvPr id="942" name="Oval 151"/>
                  <p:cNvSpPr/>
                  <p:nvPr/>
                </p:nvSpPr>
                <p:spPr>
                  <a:xfrm>
                    <a:off x="5369040" y="7141680"/>
                    <a:ext cx="307800" cy="28692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43" name="Freeform 152"/>
                  <p:cNvSpPr/>
                  <p:nvPr/>
                </p:nvSpPr>
                <p:spPr>
                  <a:xfrm>
                    <a:off x="5675400" y="7147800"/>
                    <a:ext cx="444600" cy="90360"/>
                  </a:xfrm>
                  <a:custGeom>
                    <a:avLst/>
                    <a:gdLst/>
                    <a:ahLst/>
                    <a:rect l="l" t="t" r="r" b="b"/>
                    <a:pathLst>
                      <a:path w="443831" h="91035">
                        <a:moveTo>
                          <a:pt x="0" y="91035"/>
                        </a:moveTo>
                        <a:cubicBezTo>
                          <a:pt x="72635" y="46919"/>
                          <a:pt x="145270" y="2804"/>
                          <a:pt x="219242" y="130"/>
                        </a:cubicBezTo>
                        <a:cubicBezTo>
                          <a:pt x="293214" y="-2544"/>
                          <a:pt x="368522" y="36224"/>
                          <a:pt x="443831" y="74993"/>
                        </a:cubicBez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  <a:tailEnd len="med" type="stealth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560" bIns="43560" anchor="ctr">
                    <a:noAutofit/>
                  </a:bodyPr>
                  <a:p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44" name="TextBox 92"/>
                  <p:cNvSpPr/>
                  <p:nvPr/>
                </p:nvSpPr>
                <p:spPr>
                  <a:xfrm>
                    <a:off x="6096240" y="7145640"/>
                    <a:ext cx="910440" cy="4597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Double-positive cells with polarized mitochondrial membrane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45" name="Oval 154"/>
                  <p:cNvSpPr/>
                  <p:nvPr/>
                </p:nvSpPr>
                <p:spPr>
                  <a:xfrm>
                    <a:off x="5295960" y="7438320"/>
                    <a:ext cx="444600" cy="4946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46" name="Freeform 155"/>
                  <p:cNvSpPr/>
                  <p:nvPr/>
                </p:nvSpPr>
                <p:spPr>
                  <a:xfrm>
                    <a:off x="5740560" y="7639560"/>
                    <a:ext cx="442800" cy="90360"/>
                  </a:xfrm>
                  <a:custGeom>
                    <a:avLst/>
                    <a:gdLst/>
                    <a:ahLst/>
                    <a:rect l="l" t="t" r="r" b="b"/>
                    <a:pathLst>
                      <a:path w="443831" h="91035">
                        <a:moveTo>
                          <a:pt x="0" y="91035"/>
                        </a:moveTo>
                        <a:cubicBezTo>
                          <a:pt x="72635" y="46919"/>
                          <a:pt x="145270" y="2804"/>
                          <a:pt x="219242" y="130"/>
                        </a:cubicBezTo>
                        <a:cubicBezTo>
                          <a:pt x="293214" y="-2544"/>
                          <a:pt x="368522" y="36224"/>
                          <a:pt x="443831" y="74993"/>
                        </a:cubicBez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  <a:tailEnd len="med" type="stealth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560" bIns="43560" anchor="ctr">
                    <a:noAutofit/>
                  </a:bodyPr>
                  <a:p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47" name="TextBox 98"/>
                  <p:cNvSpPr/>
                  <p:nvPr/>
                </p:nvSpPr>
                <p:spPr>
                  <a:xfrm>
                    <a:off x="6099840" y="7634520"/>
                    <a:ext cx="910440" cy="4597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FITC positive cells with depolarized mitochondrial membrane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948" name="Rectangle 149"/>
                <p:cNvSpPr/>
                <p:nvPr/>
              </p:nvSpPr>
              <p:spPr>
                <a:xfrm>
                  <a:off x="3786120" y="5368320"/>
                  <a:ext cx="255600" cy="188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g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949" name="TextBox 160"/>
              <p:cNvGrpSpPr/>
              <p:nvPr/>
            </p:nvGrpSpPr>
            <p:grpSpPr>
              <a:xfrm>
                <a:off x="4096440" y="5361120"/>
                <a:ext cx="2402280" cy="194760"/>
                <a:chOff x="4096440" y="5361120"/>
                <a:chExt cx="2402280" cy="194760"/>
              </a:xfrm>
            </p:grpSpPr>
            <p:pic>
              <p:nvPicPr>
                <p:cNvPr id="950" name="TextBox 160" descr=""/>
                <p:cNvPicPr/>
                <p:nvPr/>
              </p:nvPicPr>
              <p:blipFill>
                <a:blip r:embed="rId35"/>
                <a:stretch/>
              </p:blipFill>
              <p:spPr>
                <a:xfrm>
                  <a:off x="4096440" y="5361120"/>
                  <a:ext cx="2402280" cy="1947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951" name=""/>
                <p:cNvSpPr/>
                <p:nvPr/>
              </p:nvSpPr>
              <p:spPr>
                <a:xfrm>
                  <a:off x="4098240" y="5363640"/>
                  <a:ext cx="23950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1017720"/>
                      <a:tab algn="l" pos="2035080"/>
                      <a:tab algn="l" pos="3052800"/>
                      <a:tab algn="l" pos="4070520"/>
                      <a:tab algn="l" pos="5087880"/>
                      <a:tab algn="l" pos="6105600"/>
                      <a:tab algn="l" pos="7122960"/>
                      <a:tab algn="l" pos="8140680"/>
                      <a:tab algn="l" pos="9158400"/>
                      <a:tab algn="l" pos="10175760"/>
                    </a:tabLst>
                  </a:pPr>
                  <a:r>
                    <a:rPr b="1" lang="en-IN" sz="600" spc="-1" strike="noStrike" u="sng">
                      <a:solidFill>
                        <a:srgbClr val="540054"/>
                      </a:solidFill>
                      <a:uFillTx/>
                      <a:latin typeface="Arial"/>
                    </a:rPr>
                    <a:t>Figure4D &amp; 4M</a:t>
                  </a:r>
                  <a:r>
                    <a:rPr b="1" lang="en-IN" sz="600" spc="-1" strike="noStrike">
                      <a:solidFill>
                        <a:srgbClr val="540054"/>
                      </a:solidFill>
                      <a:latin typeface="Arial"/>
                    </a:rPr>
                    <a:t>:JC-1 Gating pattern</a:t>
                  </a:r>
                  <a:endParaRPr b="0" lang="en-US" sz="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952" name="Rectangle 22"/>
            <p:cNvSpPr/>
            <p:nvPr/>
          </p:nvSpPr>
          <p:spPr>
            <a:xfrm flipH="1" flipV="1" rot="16200000">
              <a:off x="6188400" y="6572160"/>
              <a:ext cx="1933560" cy="353880"/>
            </a:xfrm>
            <a:prstGeom prst="rect">
              <a:avLst/>
            </a:prstGeom>
            <a:gradFill rotWithShape="0">
              <a:gsLst>
                <a:gs pos="0">
                  <a:srgbClr val="31859c">
                    <a:alpha val="30196"/>
                  </a:srgbClr>
                </a:gs>
                <a:gs pos="100000">
                  <a:srgbClr val="f2f2f2"/>
                </a:gs>
              </a:gsLst>
              <a:lin ang="8100000"/>
            </a:gradFill>
            <a:ln cap="rnd" w="6480">
              <a:solidFill>
                <a:srgbClr val="1f497d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017720"/>
                  <a:tab algn="l" pos="2035080"/>
                  <a:tab algn="l" pos="3052800"/>
                  <a:tab algn="l" pos="4070520"/>
                  <a:tab algn="l" pos="5087880"/>
                  <a:tab algn="l" pos="6105600"/>
                  <a:tab algn="l" pos="7122960"/>
                  <a:tab algn="l" pos="8140680"/>
                  <a:tab algn="l" pos="9158400"/>
                  <a:tab algn="l" pos="10175760"/>
                </a:tabLst>
              </a:pPr>
              <a:r>
                <a:rPr b="1" lang="en-IN" sz="600" spc="-1" strike="noStrike">
                  <a:solidFill>
                    <a:srgbClr val="10253f"/>
                  </a:solidFill>
                  <a:latin typeface="Arial"/>
                </a:rPr>
                <a:t>RED/GREEN Ratio= (Percentage of Cells in Q2)/ (Percentage of Cells in Q4)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53" name="Rectangle 182"/>
          <p:cNvSpPr/>
          <p:nvPr/>
        </p:nvSpPr>
        <p:spPr>
          <a:xfrm>
            <a:off x="468360" y="4502160"/>
            <a:ext cx="255600" cy="18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1" lang="en-IN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54" name="Group 50"/>
          <p:cNvGrpSpPr/>
          <p:nvPr/>
        </p:nvGrpSpPr>
        <p:grpSpPr>
          <a:xfrm>
            <a:off x="376200" y="4770360"/>
            <a:ext cx="3456000" cy="4064040"/>
            <a:chOff x="376200" y="4770360"/>
            <a:chExt cx="3456000" cy="4064040"/>
          </a:xfrm>
        </p:grpSpPr>
        <p:grpSp>
          <p:nvGrpSpPr>
            <p:cNvPr id="955" name="Group 34"/>
            <p:cNvGrpSpPr/>
            <p:nvPr/>
          </p:nvGrpSpPr>
          <p:grpSpPr>
            <a:xfrm>
              <a:off x="376200" y="5115600"/>
              <a:ext cx="3456000" cy="3718800"/>
              <a:chOff x="376200" y="5115600"/>
              <a:chExt cx="3456000" cy="3718800"/>
            </a:xfrm>
          </p:grpSpPr>
          <p:sp>
            <p:nvSpPr>
              <p:cNvPr id="956" name="TextBox 98"/>
              <p:cNvSpPr/>
              <p:nvPr/>
            </p:nvSpPr>
            <p:spPr>
              <a:xfrm>
                <a:off x="1824480" y="7932960"/>
                <a:ext cx="9108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ITC positive cells with intracellular ROS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957" name="Group 31"/>
              <p:cNvGrpSpPr/>
              <p:nvPr/>
            </p:nvGrpSpPr>
            <p:grpSpPr>
              <a:xfrm>
                <a:off x="376200" y="5115600"/>
                <a:ext cx="3456000" cy="3718800"/>
                <a:chOff x="376200" y="5115600"/>
                <a:chExt cx="3456000" cy="3718800"/>
              </a:xfrm>
            </p:grpSpPr>
            <p:grpSp>
              <p:nvGrpSpPr>
                <p:cNvPr id="958" name="Group 28"/>
                <p:cNvGrpSpPr/>
                <p:nvPr/>
              </p:nvGrpSpPr>
              <p:grpSpPr>
                <a:xfrm>
                  <a:off x="376200" y="5115600"/>
                  <a:ext cx="1531800" cy="3718800"/>
                  <a:chOff x="376200" y="5115600"/>
                  <a:chExt cx="1531800" cy="3718800"/>
                </a:xfrm>
              </p:grpSpPr>
              <p:grpSp>
                <p:nvGrpSpPr>
                  <p:cNvPr id="959" name="Group 27"/>
                  <p:cNvGrpSpPr/>
                  <p:nvPr/>
                </p:nvGrpSpPr>
                <p:grpSpPr>
                  <a:xfrm>
                    <a:off x="376200" y="5115600"/>
                    <a:ext cx="1392480" cy="3718800"/>
                    <a:chOff x="376200" y="5115600"/>
                    <a:chExt cx="1392480" cy="3718800"/>
                  </a:xfrm>
                </p:grpSpPr>
                <p:grpSp>
                  <p:nvGrpSpPr>
                    <p:cNvPr id="960" name="Group 165"/>
                    <p:cNvGrpSpPr/>
                    <p:nvPr/>
                  </p:nvGrpSpPr>
                  <p:grpSpPr>
                    <a:xfrm>
                      <a:off x="393120" y="5115600"/>
                      <a:ext cx="1375560" cy="2514240"/>
                      <a:chOff x="393120" y="5115600"/>
                      <a:chExt cx="1375560" cy="2514240"/>
                    </a:xfrm>
                  </p:grpSpPr>
                  <p:pic>
                    <p:nvPicPr>
                      <p:cNvPr id="961" name="Picture 166" descr=""/>
                      <p:cNvPicPr/>
                      <p:nvPr/>
                    </p:nvPicPr>
                    <p:blipFill>
                      <a:blip r:embed="rId36"/>
                      <a:srcRect l="27859" t="2303" r="47197" b="65801"/>
                      <a:stretch/>
                    </p:blipFill>
                    <p:spPr>
                      <a:xfrm>
                        <a:off x="393120" y="6402960"/>
                        <a:ext cx="1375560" cy="12268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  <p:pic>
                    <p:nvPicPr>
                      <p:cNvPr id="962" name="Picture 2" descr=""/>
                      <p:cNvPicPr/>
                      <p:nvPr/>
                    </p:nvPicPr>
                    <p:blipFill>
                      <a:blip r:embed="rId37"/>
                      <a:srcRect l="1015" t="2842" r="74080" b="65801"/>
                      <a:stretch/>
                    </p:blipFill>
                    <p:spPr>
                      <a:xfrm>
                        <a:off x="393120" y="5115600"/>
                        <a:ext cx="1336680" cy="12081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grpSp>
                <p:pic>
                  <p:nvPicPr>
                    <p:cNvPr id="963" name="Picture 168" descr=""/>
                    <p:cNvPicPr/>
                    <p:nvPr/>
                  </p:nvPicPr>
                  <p:blipFill>
                    <a:blip r:embed="rId38"/>
                    <a:srcRect l="54909" t="2888" r="20426" b="67095"/>
                    <a:stretch/>
                  </p:blipFill>
                  <p:spPr>
                    <a:xfrm>
                      <a:off x="376200" y="7674840"/>
                      <a:ext cx="1384560" cy="1159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grpSp>
              <p:sp>
                <p:nvSpPr>
                  <p:cNvPr id="964" name="Oval 170"/>
                  <p:cNvSpPr/>
                  <p:nvPr/>
                </p:nvSpPr>
                <p:spPr>
                  <a:xfrm>
                    <a:off x="855360" y="7781040"/>
                    <a:ext cx="770040" cy="86580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65" name="Freeform 171"/>
                  <p:cNvSpPr/>
                  <p:nvPr/>
                </p:nvSpPr>
                <p:spPr>
                  <a:xfrm>
                    <a:off x="1465200" y="8010000"/>
                    <a:ext cx="442800" cy="90360"/>
                  </a:xfrm>
                  <a:custGeom>
                    <a:avLst/>
                    <a:gdLst/>
                    <a:ahLst/>
                    <a:rect l="l" t="t" r="r" b="b"/>
                    <a:pathLst>
                      <a:path w="443831" h="91035">
                        <a:moveTo>
                          <a:pt x="0" y="91035"/>
                        </a:moveTo>
                        <a:cubicBezTo>
                          <a:pt x="72635" y="46919"/>
                          <a:pt x="145270" y="2804"/>
                          <a:pt x="219242" y="130"/>
                        </a:cubicBezTo>
                        <a:cubicBezTo>
                          <a:pt x="293214" y="-2544"/>
                          <a:pt x="368522" y="36224"/>
                          <a:pt x="443831" y="74993"/>
                        </a:cubicBezTo>
                      </a:path>
                    </a:pathLst>
                  </a:custGeom>
                  <a:noFill/>
                  <a:ln cap="rnd" w="12600">
                    <a:solidFill>
                      <a:srgbClr val="000000"/>
                    </a:solidFill>
                    <a:round/>
                    <a:tailEnd len="med" type="stealth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560" bIns="43560" anchor="ctr">
                    <a:noAutofit/>
                  </a:bodyPr>
                  <a:p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966" name="Group 30"/>
                <p:cNvGrpSpPr/>
                <p:nvPr/>
              </p:nvGrpSpPr>
              <p:grpSpPr>
                <a:xfrm>
                  <a:off x="1864440" y="5482800"/>
                  <a:ext cx="1967760" cy="2128320"/>
                  <a:chOff x="1864440" y="5482800"/>
                  <a:chExt cx="1967760" cy="2128320"/>
                </a:xfrm>
              </p:grpSpPr>
              <p:pic>
                <p:nvPicPr>
                  <p:cNvPr id="967" name="Picture 174" descr=""/>
                  <p:cNvPicPr/>
                  <p:nvPr/>
                </p:nvPicPr>
                <p:blipFill>
                  <a:blip r:embed="rId39"/>
                  <a:srcRect l="1468" t="37146" r="60957" b="32777"/>
                  <a:stretch/>
                </p:blipFill>
                <p:spPr>
                  <a:xfrm>
                    <a:off x="1864440" y="6414120"/>
                    <a:ext cx="1967760" cy="1197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968" name="TextBox 98"/>
                  <p:cNvSpPr/>
                  <p:nvPr/>
                </p:nvSpPr>
                <p:spPr>
                  <a:xfrm>
                    <a:off x="2531520" y="7012800"/>
                    <a:ext cx="91080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ROS Positive Cells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69" name="TextBox 98"/>
                  <p:cNvSpPr/>
                  <p:nvPr/>
                </p:nvSpPr>
                <p:spPr>
                  <a:xfrm rot="16200000">
                    <a:off x="1787760" y="5845680"/>
                    <a:ext cx="91116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1017720"/>
                        <a:tab algn="l" pos="2035080"/>
                        <a:tab algn="l" pos="3052800"/>
                        <a:tab algn="l" pos="4070520"/>
                        <a:tab algn="l" pos="5087880"/>
                        <a:tab algn="l" pos="6105600"/>
                        <a:tab algn="l" pos="7122960"/>
                        <a:tab algn="l" pos="8140680"/>
                        <a:tab algn="l" pos="9158400"/>
                        <a:tab algn="l" pos="10175760"/>
                      </a:tabLst>
                    </a:pPr>
                    <a:r>
                      <a:rPr b="1" lang="en-IN" sz="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ROS Negative Cells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cxnSp>
                <p:nvCxnSpPr>
                  <p:cNvPr id="970" name="Straight Arrow Connector 177"/>
                  <p:cNvCxnSpPr/>
                  <p:nvPr/>
                </p:nvCxnSpPr>
                <p:spPr>
                  <a:xfrm flipV="1">
                    <a:off x="2229840" y="6368400"/>
                    <a:ext cx="1080" cy="144720"/>
                  </a:xfrm>
                  <a:prstGeom prst="straightConnector1">
                    <a:avLst/>
                  </a:prstGeom>
                  <a:ln cap="rnd" w="12600">
                    <a:solidFill>
                      <a:srgbClr val="1f497d"/>
                    </a:solidFill>
                    <a:miter/>
                    <a:tailEnd len="med" type="stealth" w="med"/>
                  </a:ln>
                </p:spPr>
              </p:cxnSp>
              <p:cxnSp>
                <p:nvCxnSpPr>
                  <p:cNvPr id="971" name="Straight Arrow Connector 178"/>
                  <p:cNvCxnSpPr/>
                  <p:nvPr/>
                </p:nvCxnSpPr>
                <p:spPr>
                  <a:xfrm>
                    <a:off x="2479320" y="7103880"/>
                    <a:ext cx="99000" cy="1080"/>
                  </a:xfrm>
                  <a:prstGeom prst="straightConnector1">
                    <a:avLst/>
                  </a:prstGeom>
                  <a:ln cap="rnd" w="12600">
                    <a:solidFill>
                      <a:srgbClr val="1f497d"/>
                    </a:solidFill>
                    <a:miter/>
                    <a:tailEnd len="med" type="stealth" w="med"/>
                  </a:ln>
                </p:spPr>
              </p:cxnSp>
            </p:grpSp>
          </p:grpSp>
        </p:grpSp>
        <p:grpSp>
          <p:nvGrpSpPr>
            <p:cNvPr id="972" name="TextBox 185"/>
            <p:cNvGrpSpPr/>
            <p:nvPr/>
          </p:nvGrpSpPr>
          <p:grpSpPr>
            <a:xfrm>
              <a:off x="566640" y="4770360"/>
              <a:ext cx="3224880" cy="189000"/>
              <a:chOff x="566640" y="4770360"/>
              <a:chExt cx="3224880" cy="189000"/>
            </a:xfrm>
          </p:grpSpPr>
          <p:pic>
            <p:nvPicPr>
              <p:cNvPr id="973" name="TextBox 185" descr=""/>
              <p:cNvPicPr/>
              <p:nvPr/>
            </p:nvPicPr>
            <p:blipFill>
              <a:blip r:embed="rId40"/>
              <a:stretch/>
            </p:blipFill>
            <p:spPr>
              <a:xfrm>
                <a:off x="568440" y="4772880"/>
                <a:ext cx="3223080" cy="1864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74" name=""/>
              <p:cNvSpPr/>
              <p:nvPr/>
            </p:nvSpPr>
            <p:spPr>
              <a:xfrm>
                <a:off x="566640" y="4770360"/>
                <a:ext cx="32198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017720"/>
                    <a:tab algn="l" pos="2035080"/>
                    <a:tab algn="l" pos="3052800"/>
                    <a:tab algn="l" pos="4070520"/>
                    <a:tab algn="l" pos="5087880"/>
                    <a:tab algn="l" pos="6105600"/>
                    <a:tab algn="l" pos="7122960"/>
                    <a:tab algn="l" pos="8140680"/>
                    <a:tab algn="l" pos="9158400"/>
                    <a:tab algn="l" pos="10175760"/>
                  </a:tabLst>
                </a:pPr>
                <a:r>
                  <a:rPr b="1" lang="en-IN" sz="600" spc="-1" strike="noStrike" u="sng">
                    <a:solidFill>
                      <a:srgbClr val="540054"/>
                    </a:solidFill>
                    <a:uFillTx/>
                    <a:latin typeface="Arial"/>
                  </a:rPr>
                  <a:t>Figure4C &amp; 4L</a:t>
                </a:r>
                <a:r>
                  <a:rPr b="1" lang="en-IN" sz="600" spc="-1" strike="noStrike">
                    <a:solidFill>
                      <a:srgbClr val="540054"/>
                    </a:solidFill>
                    <a:latin typeface="Arial"/>
                  </a:rPr>
                  <a:t>:ROS Gating pattern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aphicFrame>
        <p:nvGraphicFramePr>
          <p:cNvPr id="975" name=""/>
          <p:cNvGraphicFramePr/>
          <p:nvPr/>
        </p:nvGraphicFramePr>
        <p:xfrm>
          <a:off x="2651040" y="8269200"/>
          <a:ext cx="2774880" cy="1165320"/>
        </p:xfrm>
        <a:graphic>
          <a:graphicData uri="http://schemas.openxmlformats.org/drawingml/2006/table">
            <a:tbl>
              <a:tblPr/>
              <a:tblGrid>
                <a:gridCol w="673200"/>
                <a:gridCol w="727200"/>
                <a:gridCol w="777600"/>
                <a:gridCol w="596880"/>
              </a:tblGrid>
              <a:tr h="36612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2200"/>
                          </a:solidFill>
                          <a:latin typeface="Arial"/>
                        </a:rPr>
                        <a:t>Cohorts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gradFill rotWithShape="0">
                      <a:gsLst>
                        <a:gs pos="0">
                          <a:srgbClr val="4f6228"/>
                        </a:gs>
                        <a:gs pos="100000">
                          <a:srgbClr val="ffffff"/>
                        </a:gs>
                      </a:gsLst>
                      <a:lin ang="18900000"/>
                    </a:gra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2200"/>
                          </a:solidFill>
                          <a:latin typeface="Arial"/>
                        </a:rPr>
                        <a:t> </a:t>
                      </a:r>
                      <a:r>
                        <a:rPr b="1" lang="en-IN" sz="600" spc="-1" strike="noStrike">
                          <a:solidFill>
                            <a:srgbClr val="002200"/>
                          </a:solidFill>
                          <a:latin typeface="Arial"/>
                        </a:rPr>
                        <a:t>IC</a:t>
                      </a:r>
                      <a:r>
                        <a:rPr b="1" lang="en-IN" sz="600" spc="-1" strike="noStrike" baseline="-25000">
                          <a:solidFill>
                            <a:srgbClr val="002200"/>
                          </a:solidFill>
                          <a:latin typeface="Arial"/>
                        </a:rPr>
                        <a:t>50</a:t>
                      </a:r>
                      <a:r>
                        <a:rPr b="1" lang="en-IN" sz="600" spc="-1" strike="noStrike">
                          <a:solidFill>
                            <a:srgbClr val="002200"/>
                          </a:solidFill>
                          <a:latin typeface="Arial"/>
                        </a:rPr>
                        <a:t> Value Rang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gradFill rotWithShape="0">
                      <a:gsLst>
                        <a:gs pos="0">
                          <a:srgbClr val="4f6228"/>
                        </a:gs>
                        <a:gs pos="100000">
                          <a:srgbClr val="ffffff"/>
                        </a:gs>
                      </a:gsLst>
                      <a:lin ang="18900000"/>
                    </a:gra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2200"/>
                          </a:solidFill>
                          <a:latin typeface="Arial"/>
                        </a:rPr>
                        <a:t>Response Status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gradFill rotWithShape="0">
                      <a:gsLst>
                        <a:gs pos="0">
                          <a:srgbClr val="4f6228"/>
                        </a:gs>
                        <a:gs pos="100000">
                          <a:srgbClr val="ffffff"/>
                        </a:gs>
                      </a:gsLst>
                      <a:lin ang="18900000"/>
                    </a:gra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2200"/>
                          </a:solidFill>
                          <a:latin typeface="Arial"/>
                        </a:rPr>
                        <a:t>Sensitivity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2200"/>
                          </a:solidFill>
                          <a:latin typeface="Arial"/>
                        </a:rPr>
                        <a:t>Status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gradFill rotWithShape="0">
                      <a:gsLst>
                        <a:gs pos="0">
                          <a:srgbClr val="4f6228"/>
                        </a:gs>
                        <a:gs pos="100000">
                          <a:srgbClr val="ffffff"/>
                        </a:gs>
                      </a:gsLst>
                      <a:lin ang="18900000"/>
                    </a:gradFill>
                  </a:tcPr>
                </a:tc>
              </a:tr>
              <a:tr h="249840"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ptimum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-1.9µM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sponder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nsitiv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4680"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orderlin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-3.5µM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ermediate Responder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derately Sensitiv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4680"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gh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5-6µM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n-Responder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017720"/>
                          <a:tab algn="l" pos="2035080"/>
                          <a:tab algn="l" pos="3052800"/>
                          <a:tab algn="l" pos="4070520"/>
                          <a:tab algn="l" pos="5087880"/>
                          <a:tab algn="l" pos="6105600"/>
                          <a:tab algn="l" pos="7122960"/>
                          <a:tab algn="l" pos="8140680"/>
                          <a:tab algn="l" pos="9158400"/>
                          <a:tab algn="l" pos="10175760"/>
                        </a:tabLst>
                      </a:pPr>
                      <a:r>
                        <a:rPr b="1" lang="en-IN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sensitiv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976" name="Rectangle 179"/>
          <p:cNvSpPr/>
          <p:nvPr/>
        </p:nvSpPr>
        <p:spPr>
          <a:xfrm>
            <a:off x="2382840" y="8259840"/>
            <a:ext cx="279360" cy="18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1" lang="en-IN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3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7-15T04:42:30Z</dcterms:created>
  <dc:creator>ELIZABETH</dc:creator>
  <dc:description/>
  <dc:language>en-US</dc:language>
  <cp:lastModifiedBy>hp</cp:lastModifiedBy>
  <dcterms:modified xsi:type="dcterms:W3CDTF">2024-08-17T08:54:10Z</dcterms:modified>
  <cp:revision>761</cp:revision>
  <dc:subject/>
  <dc:title>PowerPoint Presentation</dc:title>
</cp:coreProperties>
</file>